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C8C380-F2F4-4F88-AF51-FE3EDEEC40B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B688A5-200C-4FEB-A62F-488D81D22CF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676984-3A85-433B-AF25-4F6D324C516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A49937-B6A8-4F9F-924A-B6822AF4048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CB6CCF-B33F-4090-9391-2D4C03093EB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3B052D-3775-4EFA-B453-5E70553F6D4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D312D7-0CDC-4FA7-AB48-48CA12A5828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D01E9A-AE04-4107-983E-4F7E955EB4E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12520"/>
            <a:ext cx="58291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44B2F7-8995-4E20-AB87-D56CABB34D2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E8BEB7-2954-4467-887F-003630B60CE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889D60-2BA3-4BE9-A400-21B66060D6E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1C1EB5-75EA-481C-9484-0A6247A5BD5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2884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31120"/>
            <a:ext cx="217152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411E8C2-3EE2-41F0-8F73-20B685B01734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1335240" y="853920"/>
            <a:ext cx="1440" cy="399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" name=""/>
          <p:cNvSpPr/>
          <p:nvPr/>
        </p:nvSpPr>
        <p:spPr>
          <a:xfrm>
            <a:off x="2386080" y="853920"/>
            <a:ext cx="1440" cy="399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" name=""/>
          <p:cNvSpPr/>
          <p:nvPr/>
        </p:nvSpPr>
        <p:spPr>
          <a:xfrm>
            <a:off x="2408400" y="853920"/>
            <a:ext cx="1440" cy="399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"/>
          <p:cNvSpPr/>
          <p:nvPr/>
        </p:nvSpPr>
        <p:spPr>
          <a:xfrm>
            <a:off x="2438280" y="853920"/>
            <a:ext cx="1800" cy="399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" name=""/>
          <p:cNvSpPr/>
          <p:nvPr/>
        </p:nvSpPr>
        <p:spPr>
          <a:xfrm>
            <a:off x="3013200" y="853920"/>
            <a:ext cx="1440" cy="399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" name=""/>
          <p:cNvSpPr/>
          <p:nvPr/>
        </p:nvSpPr>
        <p:spPr>
          <a:xfrm>
            <a:off x="3122640" y="853920"/>
            <a:ext cx="1440" cy="399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" name=""/>
          <p:cNvSpPr/>
          <p:nvPr/>
        </p:nvSpPr>
        <p:spPr>
          <a:xfrm>
            <a:off x="3122640" y="853920"/>
            <a:ext cx="1440" cy="399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8" name=""/>
          <p:cNvSpPr/>
          <p:nvPr/>
        </p:nvSpPr>
        <p:spPr>
          <a:xfrm>
            <a:off x="3165480" y="853920"/>
            <a:ext cx="1440" cy="399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9" name=""/>
          <p:cNvSpPr/>
          <p:nvPr/>
        </p:nvSpPr>
        <p:spPr>
          <a:xfrm>
            <a:off x="3233880" y="853920"/>
            <a:ext cx="1440" cy="399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0" name=""/>
          <p:cNvSpPr/>
          <p:nvPr/>
        </p:nvSpPr>
        <p:spPr>
          <a:xfrm>
            <a:off x="3240000" y="853920"/>
            <a:ext cx="1800" cy="399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1" name=""/>
          <p:cNvSpPr/>
          <p:nvPr/>
        </p:nvSpPr>
        <p:spPr>
          <a:xfrm>
            <a:off x="3240000" y="853920"/>
            <a:ext cx="1800" cy="399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2" name=""/>
          <p:cNvSpPr/>
          <p:nvPr/>
        </p:nvSpPr>
        <p:spPr>
          <a:xfrm>
            <a:off x="3255840" y="853920"/>
            <a:ext cx="0" cy="399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3" name=""/>
          <p:cNvSpPr/>
          <p:nvPr/>
        </p:nvSpPr>
        <p:spPr>
          <a:xfrm>
            <a:off x="3262320" y="853920"/>
            <a:ext cx="1440" cy="399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4" name=""/>
          <p:cNvSpPr/>
          <p:nvPr/>
        </p:nvSpPr>
        <p:spPr>
          <a:xfrm>
            <a:off x="3270240" y="853920"/>
            <a:ext cx="1440" cy="399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5" name=""/>
          <p:cNvSpPr/>
          <p:nvPr/>
        </p:nvSpPr>
        <p:spPr>
          <a:xfrm>
            <a:off x="3424320" y="853920"/>
            <a:ext cx="1440" cy="399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6" name=""/>
          <p:cNvSpPr/>
          <p:nvPr/>
        </p:nvSpPr>
        <p:spPr>
          <a:xfrm>
            <a:off x="3460680" y="853920"/>
            <a:ext cx="1800" cy="399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7" name=""/>
          <p:cNvSpPr/>
          <p:nvPr/>
        </p:nvSpPr>
        <p:spPr>
          <a:xfrm>
            <a:off x="3475080" y="853920"/>
            <a:ext cx="1440" cy="399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8" name=""/>
          <p:cNvSpPr/>
          <p:nvPr/>
        </p:nvSpPr>
        <p:spPr>
          <a:xfrm>
            <a:off x="3533760" y="853920"/>
            <a:ext cx="1440" cy="399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9" name=""/>
          <p:cNvSpPr/>
          <p:nvPr/>
        </p:nvSpPr>
        <p:spPr>
          <a:xfrm>
            <a:off x="3645000" y="853920"/>
            <a:ext cx="1440" cy="399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0" name=""/>
          <p:cNvSpPr/>
          <p:nvPr/>
        </p:nvSpPr>
        <p:spPr>
          <a:xfrm>
            <a:off x="3778200" y="853920"/>
            <a:ext cx="1800" cy="399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1" name=""/>
          <p:cNvSpPr/>
          <p:nvPr/>
        </p:nvSpPr>
        <p:spPr>
          <a:xfrm>
            <a:off x="3792600" y="853920"/>
            <a:ext cx="1440" cy="399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2" name=""/>
          <p:cNvSpPr/>
          <p:nvPr/>
        </p:nvSpPr>
        <p:spPr>
          <a:xfrm>
            <a:off x="3873600" y="853920"/>
            <a:ext cx="1440" cy="399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3" name=""/>
          <p:cNvSpPr/>
          <p:nvPr/>
        </p:nvSpPr>
        <p:spPr>
          <a:xfrm>
            <a:off x="4102200" y="853920"/>
            <a:ext cx="1440" cy="399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4" name=""/>
          <p:cNvSpPr/>
          <p:nvPr/>
        </p:nvSpPr>
        <p:spPr>
          <a:xfrm>
            <a:off x="4994280" y="777960"/>
            <a:ext cx="9716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Breakpoint number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5" name=""/>
          <p:cNvSpPr/>
          <p:nvPr/>
        </p:nvSpPr>
        <p:spPr>
          <a:xfrm>
            <a:off x="4990320" y="898560"/>
            <a:ext cx="15325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Local 95% confidence interval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6" name=""/>
          <p:cNvSpPr/>
          <p:nvPr/>
        </p:nvSpPr>
        <p:spPr>
          <a:xfrm>
            <a:off x="4990320" y="1017720"/>
            <a:ext cx="15325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Local 99% confidence interval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7" name=""/>
          <p:cNvSpPr/>
          <p:nvPr/>
        </p:nvSpPr>
        <p:spPr>
          <a:xfrm>
            <a:off x="4992120" y="1138320"/>
            <a:ext cx="14209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Global 95% confidence limit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8" name=""/>
          <p:cNvSpPr/>
          <p:nvPr/>
        </p:nvSpPr>
        <p:spPr>
          <a:xfrm>
            <a:off x="4992120" y="1258920"/>
            <a:ext cx="14209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Global 99% confidence limit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9" name=""/>
          <p:cNvSpPr/>
          <p:nvPr/>
        </p:nvSpPr>
        <p:spPr>
          <a:xfrm>
            <a:off x="4610160" y="762120"/>
            <a:ext cx="1981080" cy="623880"/>
          </a:xfrm>
          <a:prstGeom prst="rect">
            <a:avLst/>
          </a:prstGeom>
          <a:noFill/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0" name=""/>
          <p:cNvSpPr/>
          <p:nvPr/>
        </p:nvSpPr>
        <p:spPr>
          <a:xfrm>
            <a:off x="4762440" y="846000"/>
            <a:ext cx="1904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71" name="" descr=""/>
          <p:cNvPicPr/>
          <p:nvPr/>
        </p:nvPicPr>
        <p:blipFill>
          <a:blip r:embed="rId1"/>
          <a:stretch/>
        </p:blipFill>
        <p:spPr>
          <a:xfrm>
            <a:off x="1019160" y="380880"/>
            <a:ext cx="3962520" cy="195480"/>
          </a:xfrm>
          <a:prstGeom prst="rect">
            <a:avLst/>
          </a:prstGeom>
          <a:ln w="0">
            <a:noFill/>
          </a:ln>
        </p:spPr>
      </p:pic>
      <p:grpSp>
        <p:nvGrpSpPr>
          <p:cNvPr id="72" name=""/>
          <p:cNvGrpSpPr/>
          <p:nvPr/>
        </p:nvGrpSpPr>
        <p:grpSpPr>
          <a:xfrm>
            <a:off x="417600" y="914400"/>
            <a:ext cx="4759200" cy="2117160"/>
            <a:chOff x="417600" y="914400"/>
            <a:chExt cx="4759200" cy="2117160"/>
          </a:xfrm>
        </p:grpSpPr>
        <p:sp>
          <p:nvSpPr>
            <p:cNvPr id="73" name=""/>
            <p:cNvSpPr/>
            <p:nvPr/>
          </p:nvSpPr>
          <p:spPr>
            <a:xfrm>
              <a:off x="936720" y="933480"/>
              <a:ext cx="4160880" cy="1760400"/>
            </a:xfrm>
            <a:custGeom>
              <a:avLst/>
              <a:gdLst/>
              <a:ahLst/>
              <a:rect l="l" t="t" r="r" b="b"/>
              <a:pathLst>
                <a:path w="520" h="220">
                  <a:moveTo>
                    <a:pt x="0" y="0"/>
                  </a:moveTo>
                  <a:lnTo>
                    <a:pt x="0" y="10"/>
                  </a:lnTo>
                  <a:lnTo>
                    <a:pt x="5" y="10"/>
                  </a:lnTo>
                  <a:lnTo>
                    <a:pt x="0" y="10"/>
                  </a:lnTo>
                  <a:lnTo>
                    <a:pt x="0" y="60"/>
                  </a:lnTo>
                  <a:lnTo>
                    <a:pt x="5" y="60"/>
                  </a:lnTo>
                  <a:lnTo>
                    <a:pt x="0" y="60"/>
                  </a:lnTo>
                  <a:lnTo>
                    <a:pt x="0" y="110"/>
                  </a:lnTo>
                  <a:lnTo>
                    <a:pt x="5" y="110"/>
                  </a:lnTo>
                  <a:lnTo>
                    <a:pt x="0" y="110"/>
                  </a:lnTo>
                  <a:lnTo>
                    <a:pt x="0" y="160"/>
                  </a:lnTo>
                  <a:lnTo>
                    <a:pt x="5" y="160"/>
                  </a:lnTo>
                  <a:lnTo>
                    <a:pt x="0" y="160"/>
                  </a:lnTo>
                  <a:lnTo>
                    <a:pt x="0" y="210"/>
                  </a:lnTo>
                  <a:lnTo>
                    <a:pt x="5" y="210"/>
                  </a:lnTo>
                  <a:lnTo>
                    <a:pt x="0" y="210"/>
                  </a:lnTo>
                  <a:lnTo>
                    <a:pt x="0" y="220"/>
                  </a:lnTo>
                  <a:lnTo>
                    <a:pt x="10" y="220"/>
                  </a:lnTo>
                  <a:lnTo>
                    <a:pt x="10" y="215"/>
                  </a:lnTo>
                  <a:lnTo>
                    <a:pt x="10" y="220"/>
                  </a:lnTo>
                  <a:lnTo>
                    <a:pt x="135" y="220"/>
                  </a:lnTo>
                  <a:lnTo>
                    <a:pt x="135" y="215"/>
                  </a:lnTo>
                  <a:lnTo>
                    <a:pt x="135" y="220"/>
                  </a:lnTo>
                  <a:lnTo>
                    <a:pt x="260" y="220"/>
                  </a:lnTo>
                  <a:lnTo>
                    <a:pt x="260" y="215"/>
                  </a:lnTo>
                  <a:lnTo>
                    <a:pt x="260" y="220"/>
                  </a:lnTo>
                  <a:lnTo>
                    <a:pt x="385" y="220"/>
                  </a:lnTo>
                  <a:lnTo>
                    <a:pt x="385" y="215"/>
                  </a:lnTo>
                  <a:lnTo>
                    <a:pt x="385" y="220"/>
                  </a:lnTo>
                  <a:lnTo>
                    <a:pt x="510" y="220"/>
                  </a:lnTo>
                  <a:lnTo>
                    <a:pt x="510" y="215"/>
                  </a:lnTo>
                  <a:lnTo>
                    <a:pt x="510" y="220"/>
                  </a:lnTo>
                  <a:lnTo>
                    <a:pt x="520" y="220"/>
                  </a:ln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1001160" y="2733840"/>
              <a:ext cx="648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9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1943640" y="2733840"/>
              <a:ext cx="192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258</a:t>
              </a:r>
              <a:endParaRPr b="0" lang="en-US" sz="9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2943720" y="2733840"/>
              <a:ext cx="192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517</a:t>
              </a:r>
              <a:endParaRPr b="0" lang="en-US" sz="9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3943800" y="2733840"/>
              <a:ext cx="192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776</a:t>
              </a:r>
              <a:endParaRPr b="0" lang="en-US" sz="9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4920120" y="2733840"/>
              <a:ext cx="2566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1035</a:t>
              </a:r>
              <a:endParaRPr b="0" lang="en-US" sz="9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1968840" y="2894040"/>
              <a:ext cx="22791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900" spc="-1" strike="noStrike">
                  <a:solidFill>
                    <a:srgbClr val="000000"/>
                  </a:solidFill>
                  <a:latin typeface="Arial"/>
                </a:rPr>
                <a:t>Nucleotide position in relation to </a:t>
              </a:r>
              <a:r>
                <a:rPr b="0" lang="en-ZA" sz="900" spc="-1" strike="noStrike">
                  <a:solidFill>
                    <a:srgbClr val="000000"/>
                  </a:solidFill>
                  <a:latin typeface="Arial"/>
                </a:rPr>
                <a:t>strain HXB2</a:t>
              </a:r>
              <a:endParaRPr b="0" lang="en-US" sz="9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648360" y="965160"/>
              <a:ext cx="1288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endParaRPr b="0" lang="en-US" sz="9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616320" y="1365120"/>
              <a:ext cx="1609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7.5</a:t>
              </a:r>
              <a:endParaRPr b="0" lang="en-US" sz="9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712080" y="1765440"/>
              <a:ext cx="648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5</a:t>
              </a:r>
              <a:endParaRPr b="0" lang="en-US" sz="9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616320" y="2165400"/>
              <a:ext cx="1609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2.5</a:t>
              </a:r>
              <a:endParaRPr b="0" lang="en-US" sz="9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616320" y="2565360"/>
              <a:ext cx="1609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0.0</a:t>
              </a:r>
              <a:endParaRPr b="0" lang="en-US" sz="9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936720" y="1494000"/>
              <a:ext cx="4160880" cy="1440"/>
            </a:xfrm>
            <a:prstGeom prst="line">
              <a:avLst/>
            </a:prstGeom>
            <a:ln w="936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936720" y="1654200"/>
              <a:ext cx="4160880" cy="1440"/>
            </a:xfrm>
            <a:prstGeom prst="line">
              <a:avLst/>
            </a:prstGeom>
            <a:ln w="9360">
              <a:solidFill>
                <a:srgbClr val="000000"/>
              </a:solidFill>
              <a:prstDash val="lgDash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4762440" y="1200240"/>
              <a:ext cx="181080" cy="3240"/>
            </a:xfrm>
            <a:prstGeom prst="line">
              <a:avLst/>
            </a:prstGeom>
            <a:ln w="0">
              <a:solidFill>
                <a:srgbClr val="000000"/>
              </a:solidFill>
              <a:prstDash val="dash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4762440" y="1320840"/>
              <a:ext cx="181080" cy="3240"/>
            </a:xfrm>
            <a:prstGeom prst="line">
              <a:avLst/>
            </a:prstGeom>
            <a:ln w="0">
              <a:solidFill>
                <a:srgbClr val="000000"/>
              </a:solidFill>
              <a:prstDash val="lgDashDot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1017720" y="1494000"/>
              <a:ext cx="4000320" cy="1118880"/>
            </a:xfrm>
            <a:custGeom>
              <a:avLst/>
              <a:gdLst/>
              <a:ahLst/>
              <a:rect l="l" t="t" r="r" b="b"/>
              <a:pathLst>
                <a:path w="2335" h="705">
                  <a:moveTo>
                    <a:pt x="0" y="705"/>
                  </a:moveTo>
                  <a:lnTo>
                    <a:pt x="5" y="705"/>
                  </a:lnTo>
                  <a:lnTo>
                    <a:pt x="5" y="705"/>
                  </a:lnTo>
                  <a:lnTo>
                    <a:pt x="9" y="705"/>
                  </a:lnTo>
                  <a:lnTo>
                    <a:pt x="9" y="705"/>
                  </a:lnTo>
                  <a:lnTo>
                    <a:pt x="14" y="705"/>
                  </a:lnTo>
                  <a:lnTo>
                    <a:pt x="14" y="705"/>
                  </a:lnTo>
                  <a:lnTo>
                    <a:pt x="19" y="705"/>
                  </a:lnTo>
                  <a:lnTo>
                    <a:pt x="19" y="705"/>
                  </a:lnTo>
                  <a:lnTo>
                    <a:pt x="23" y="705"/>
                  </a:lnTo>
                  <a:lnTo>
                    <a:pt x="23" y="705"/>
                  </a:lnTo>
                  <a:lnTo>
                    <a:pt x="28" y="705"/>
                  </a:lnTo>
                  <a:lnTo>
                    <a:pt x="28" y="705"/>
                  </a:lnTo>
                  <a:lnTo>
                    <a:pt x="32" y="705"/>
                  </a:lnTo>
                  <a:lnTo>
                    <a:pt x="32" y="705"/>
                  </a:lnTo>
                  <a:lnTo>
                    <a:pt x="37" y="705"/>
                  </a:lnTo>
                  <a:lnTo>
                    <a:pt x="37" y="705"/>
                  </a:lnTo>
                  <a:lnTo>
                    <a:pt x="42" y="705"/>
                  </a:lnTo>
                  <a:lnTo>
                    <a:pt x="42" y="705"/>
                  </a:lnTo>
                  <a:lnTo>
                    <a:pt x="46" y="705"/>
                  </a:lnTo>
                  <a:lnTo>
                    <a:pt x="46" y="705"/>
                  </a:lnTo>
                  <a:lnTo>
                    <a:pt x="51" y="705"/>
                  </a:lnTo>
                  <a:lnTo>
                    <a:pt x="51" y="705"/>
                  </a:lnTo>
                  <a:lnTo>
                    <a:pt x="56" y="705"/>
                  </a:lnTo>
                  <a:lnTo>
                    <a:pt x="56" y="705"/>
                  </a:lnTo>
                  <a:lnTo>
                    <a:pt x="60" y="705"/>
                  </a:lnTo>
                  <a:lnTo>
                    <a:pt x="60" y="705"/>
                  </a:lnTo>
                  <a:lnTo>
                    <a:pt x="65" y="705"/>
                  </a:lnTo>
                  <a:lnTo>
                    <a:pt x="65" y="705"/>
                  </a:lnTo>
                  <a:lnTo>
                    <a:pt x="65" y="705"/>
                  </a:lnTo>
                  <a:lnTo>
                    <a:pt x="70" y="705"/>
                  </a:lnTo>
                  <a:lnTo>
                    <a:pt x="70" y="705"/>
                  </a:lnTo>
                  <a:lnTo>
                    <a:pt x="74" y="705"/>
                  </a:lnTo>
                  <a:lnTo>
                    <a:pt x="74" y="705"/>
                  </a:lnTo>
                  <a:lnTo>
                    <a:pt x="79" y="705"/>
                  </a:lnTo>
                  <a:lnTo>
                    <a:pt x="79" y="705"/>
                  </a:lnTo>
                  <a:lnTo>
                    <a:pt x="83" y="705"/>
                  </a:lnTo>
                  <a:lnTo>
                    <a:pt x="83" y="705"/>
                  </a:lnTo>
                  <a:lnTo>
                    <a:pt x="88" y="705"/>
                  </a:lnTo>
                  <a:lnTo>
                    <a:pt x="88" y="705"/>
                  </a:lnTo>
                  <a:lnTo>
                    <a:pt x="93" y="705"/>
                  </a:lnTo>
                  <a:lnTo>
                    <a:pt x="93" y="705"/>
                  </a:lnTo>
                  <a:lnTo>
                    <a:pt x="97" y="705"/>
                  </a:lnTo>
                  <a:lnTo>
                    <a:pt x="97" y="705"/>
                  </a:lnTo>
                  <a:lnTo>
                    <a:pt x="102" y="705"/>
                  </a:lnTo>
                  <a:lnTo>
                    <a:pt x="102" y="705"/>
                  </a:lnTo>
                  <a:lnTo>
                    <a:pt x="107" y="705"/>
                  </a:lnTo>
                  <a:lnTo>
                    <a:pt x="107" y="705"/>
                  </a:lnTo>
                  <a:lnTo>
                    <a:pt x="111" y="705"/>
                  </a:lnTo>
                  <a:lnTo>
                    <a:pt x="111" y="705"/>
                  </a:lnTo>
                  <a:lnTo>
                    <a:pt x="116" y="705"/>
                  </a:lnTo>
                  <a:lnTo>
                    <a:pt x="116" y="705"/>
                  </a:lnTo>
                  <a:lnTo>
                    <a:pt x="121" y="705"/>
                  </a:lnTo>
                  <a:lnTo>
                    <a:pt x="121" y="705"/>
                  </a:lnTo>
                  <a:lnTo>
                    <a:pt x="125" y="705"/>
                  </a:lnTo>
                  <a:lnTo>
                    <a:pt x="125" y="705"/>
                  </a:lnTo>
                  <a:lnTo>
                    <a:pt x="130" y="705"/>
                  </a:lnTo>
                  <a:lnTo>
                    <a:pt x="130" y="705"/>
                  </a:lnTo>
                  <a:lnTo>
                    <a:pt x="135" y="705"/>
                  </a:lnTo>
                  <a:lnTo>
                    <a:pt x="135" y="705"/>
                  </a:lnTo>
                  <a:lnTo>
                    <a:pt x="135" y="705"/>
                  </a:lnTo>
                  <a:lnTo>
                    <a:pt x="139" y="705"/>
                  </a:lnTo>
                  <a:lnTo>
                    <a:pt x="139" y="705"/>
                  </a:lnTo>
                  <a:lnTo>
                    <a:pt x="144" y="705"/>
                  </a:lnTo>
                  <a:lnTo>
                    <a:pt x="144" y="705"/>
                  </a:lnTo>
                  <a:lnTo>
                    <a:pt x="148" y="705"/>
                  </a:lnTo>
                  <a:lnTo>
                    <a:pt x="148" y="705"/>
                  </a:lnTo>
                  <a:lnTo>
                    <a:pt x="153" y="705"/>
                  </a:lnTo>
                  <a:lnTo>
                    <a:pt x="153" y="705"/>
                  </a:lnTo>
                  <a:lnTo>
                    <a:pt x="158" y="604"/>
                  </a:lnTo>
                  <a:lnTo>
                    <a:pt x="158" y="604"/>
                  </a:lnTo>
                  <a:lnTo>
                    <a:pt x="162" y="604"/>
                  </a:lnTo>
                  <a:lnTo>
                    <a:pt x="162" y="604"/>
                  </a:lnTo>
                  <a:lnTo>
                    <a:pt x="167" y="604"/>
                  </a:lnTo>
                  <a:lnTo>
                    <a:pt x="167" y="604"/>
                  </a:lnTo>
                  <a:lnTo>
                    <a:pt x="172" y="604"/>
                  </a:lnTo>
                  <a:lnTo>
                    <a:pt x="172" y="604"/>
                  </a:lnTo>
                  <a:lnTo>
                    <a:pt x="176" y="604"/>
                  </a:lnTo>
                  <a:lnTo>
                    <a:pt x="176" y="604"/>
                  </a:lnTo>
                  <a:lnTo>
                    <a:pt x="181" y="604"/>
                  </a:lnTo>
                  <a:lnTo>
                    <a:pt x="181" y="604"/>
                  </a:lnTo>
                  <a:lnTo>
                    <a:pt x="186" y="604"/>
                  </a:lnTo>
                  <a:lnTo>
                    <a:pt x="186" y="604"/>
                  </a:lnTo>
                  <a:lnTo>
                    <a:pt x="190" y="604"/>
                  </a:lnTo>
                  <a:lnTo>
                    <a:pt x="190" y="604"/>
                  </a:lnTo>
                  <a:lnTo>
                    <a:pt x="195" y="604"/>
                  </a:lnTo>
                  <a:lnTo>
                    <a:pt x="195" y="604"/>
                  </a:lnTo>
                  <a:lnTo>
                    <a:pt x="199" y="604"/>
                  </a:lnTo>
                  <a:lnTo>
                    <a:pt x="199" y="604"/>
                  </a:lnTo>
                  <a:lnTo>
                    <a:pt x="199" y="604"/>
                  </a:lnTo>
                  <a:lnTo>
                    <a:pt x="204" y="604"/>
                  </a:lnTo>
                  <a:lnTo>
                    <a:pt x="204" y="604"/>
                  </a:lnTo>
                  <a:lnTo>
                    <a:pt x="209" y="604"/>
                  </a:lnTo>
                  <a:lnTo>
                    <a:pt x="209" y="604"/>
                  </a:lnTo>
                  <a:lnTo>
                    <a:pt x="213" y="604"/>
                  </a:lnTo>
                  <a:lnTo>
                    <a:pt x="213" y="604"/>
                  </a:lnTo>
                  <a:lnTo>
                    <a:pt x="218" y="604"/>
                  </a:lnTo>
                  <a:lnTo>
                    <a:pt x="218" y="604"/>
                  </a:lnTo>
                  <a:lnTo>
                    <a:pt x="223" y="604"/>
                  </a:lnTo>
                  <a:lnTo>
                    <a:pt x="223" y="604"/>
                  </a:lnTo>
                  <a:lnTo>
                    <a:pt x="227" y="604"/>
                  </a:lnTo>
                  <a:lnTo>
                    <a:pt x="227" y="604"/>
                  </a:lnTo>
                  <a:lnTo>
                    <a:pt x="232" y="604"/>
                  </a:lnTo>
                  <a:lnTo>
                    <a:pt x="232" y="604"/>
                  </a:lnTo>
                  <a:lnTo>
                    <a:pt x="237" y="604"/>
                  </a:lnTo>
                  <a:lnTo>
                    <a:pt x="237" y="604"/>
                  </a:lnTo>
                  <a:lnTo>
                    <a:pt x="241" y="604"/>
                  </a:lnTo>
                  <a:lnTo>
                    <a:pt x="241" y="604"/>
                  </a:lnTo>
                  <a:lnTo>
                    <a:pt x="246" y="604"/>
                  </a:lnTo>
                  <a:lnTo>
                    <a:pt x="246" y="604"/>
                  </a:lnTo>
                  <a:lnTo>
                    <a:pt x="250" y="604"/>
                  </a:lnTo>
                  <a:lnTo>
                    <a:pt x="250" y="504"/>
                  </a:lnTo>
                  <a:lnTo>
                    <a:pt x="255" y="504"/>
                  </a:lnTo>
                  <a:lnTo>
                    <a:pt x="255" y="504"/>
                  </a:lnTo>
                  <a:lnTo>
                    <a:pt x="260" y="504"/>
                  </a:lnTo>
                  <a:lnTo>
                    <a:pt x="260" y="504"/>
                  </a:lnTo>
                  <a:lnTo>
                    <a:pt x="264" y="504"/>
                  </a:lnTo>
                  <a:lnTo>
                    <a:pt x="264" y="504"/>
                  </a:lnTo>
                  <a:lnTo>
                    <a:pt x="264" y="504"/>
                  </a:lnTo>
                  <a:lnTo>
                    <a:pt x="269" y="504"/>
                  </a:lnTo>
                  <a:lnTo>
                    <a:pt x="269" y="504"/>
                  </a:lnTo>
                  <a:lnTo>
                    <a:pt x="274" y="504"/>
                  </a:lnTo>
                  <a:lnTo>
                    <a:pt x="274" y="504"/>
                  </a:lnTo>
                  <a:lnTo>
                    <a:pt x="278" y="504"/>
                  </a:lnTo>
                  <a:lnTo>
                    <a:pt x="278" y="504"/>
                  </a:lnTo>
                  <a:lnTo>
                    <a:pt x="283" y="504"/>
                  </a:lnTo>
                  <a:lnTo>
                    <a:pt x="283" y="504"/>
                  </a:lnTo>
                  <a:lnTo>
                    <a:pt x="288" y="504"/>
                  </a:lnTo>
                  <a:lnTo>
                    <a:pt x="288" y="504"/>
                  </a:lnTo>
                  <a:lnTo>
                    <a:pt x="292" y="504"/>
                  </a:lnTo>
                  <a:lnTo>
                    <a:pt x="292" y="504"/>
                  </a:lnTo>
                  <a:lnTo>
                    <a:pt x="297" y="504"/>
                  </a:lnTo>
                  <a:lnTo>
                    <a:pt x="297" y="504"/>
                  </a:lnTo>
                  <a:lnTo>
                    <a:pt x="301" y="504"/>
                  </a:lnTo>
                  <a:lnTo>
                    <a:pt x="301" y="504"/>
                  </a:lnTo>
                  <a:lnTo>
                    <a:pt x="306" y="504"/>
                  </a:lnTo>
                  <a:lnTo>
                    <a:pt x="306" y="504"/>
                  </a:lnTo>
                  <a:lnTo>
                    <a:pt x="311" y="504"/>
                  </a:lnTo>
                  <a:lnTo>
                    <a:pt x="311" y="504"/>
                  </a:lnTo>
                  <a:lnTo>
                    <a:pt x="315" y="504"/>
                  </a:lnTo>
                  <a:lnTo>
                    <a:pt x="315" y="504"/>
                  </a:lnTo>
                  <a:lnTo>
                    <a:pt x="320" y="504"/>
                  </a:lnTo>
                  <a:lnTo>
                    <a:pt x="320" y="504"/>
                  </a:lnTo>
                  <a:lnTo>
                    <a:pt x="325" y="504"/>
                  </a:lnTo>
                  <a:lnTo>
                    <a:pt x="325" y="504"/>
                  </a:lnTo>
                  <a:lnTo>
                    <a:pt x="329" y="504"/>
                  </a:lnTo>
                  <a:lnTo>
                    <a:pt x="329" y="504"/>
                  </a:lnTo>
                  <a:lnTo>
                    <a:pt x="329" y="504"/>
                  </a:lnTo>
                  <a:lnTo>
                    <a:pt x="334" y="504"/>
                  </a:lnTo>
                  <a:lnTo>
                    <a:pt x="334" y="504"/>
                  </a:lnTo>
                  <a:lnTo>
                    <a:pt x="339" y="504"/>
                  </a:lnTo>
                  <a:lnTo>
                    <a:pt x="339" y="504"/>
                  </a:lnTo>
                  <a:lnTo>
                    <a:pt x="343" y="504"/>
                  </a:lnTo>
                  <a:lnTo>
                    <a:pt x="343" y="504"/>
                  </a:lnTo>
                  <a:lnTo>
                    <a:pt x="348" y="504"/>
                  </a:lnTo>
                  <a:lnTo>
                    <a:pt x="348" y="504"/>
                  </a:lnTo>
                  <a:lnTo>
                    <a:pt x="352" y="504"/>
                  </a:lnTo>
                  <a:lnTo>
                    <a:pt x="352" y="504"/>
                  </a:lnTo>
                  <a:lnTo>
                    <a:pt x="357" y="504"/>
                  </a:lnTo>
                  <a:lnTo>
                    <a:pt x="357" y="504"/>
                  </a:lnTo>
                  <a:lnTo>
                    <a:pt x="362" y="504"/>
                  </a:lnTo>
                  <a:lnTo>
                    <a:pt x="362" y="504"/>
                  </a:lnTo>
                  <a:lnTo>
                    <a:pt x="366" y="504"/>
                  </a:lnTo>
                  <a:lnTo>
                    <a:pt x="366" y="504"/>
                  </a:lnTo>
                  <a:lnTo>
                    <a:pt x="371" y="504"/>
                  </a:lnTo>
                  <a:lnTo>
                    <a:pt x="371" y="504"/>
                  </a:lnTo>
                  <a:lnTo>
                    <a:pt x="376" y="504"/>
                  </a:lnTo>
                  <a:lnTo>
                    <a:pt x="376" y="504"/>
                  </a:lnTo>
                  <a:lnTo>
                    <a:pt x="380" y="504"/>
                  </a:lnTo>
                  <a:lnTo>
                    <a:pt x="380" y="504"/>
                  </a:lnTo>
                  <a:lnTo>
                    <a:pt x="385" y="504"/>
                  </a:lnTo>
                  <a:lnTo>
                    <a:pt x="385" y="504"/>
                  </a:lnTo>
                  <a:lnTo>
                    <a:pt x="390" y="504"/>
                  </a:lnTo>
                  <a:lnTo>
                    <a:pt x="390" y="504"/>
                  </a:lnTo>
                  <a:lnTo>
                    <a:pt x="394" y="504"/>
                  </a:lnTo>
                  <a:lnTo>
                    <a:pt x="394" y="504"/>
                  </a:lnTo>
                  <a:lnTo>
                    <a:pt x="399" y="504"/>
                  </a:lnTo>
                  <a:lnTo>
                    <a:pt x="399" y="504"/>
                  </a:lnTo>
                  <a:lnTo>
                    <a:pt x="399" y="504"/>
                  </a:lnTo>
                  <a:lnTo>
                    <a:pt x="404" y="504"/>
                  </a:lnTo>
                  <a:lnTo>
                    <a:pt x="404" y="504"/>
                  </a:lnTo>
                  <a:lnTo>
                    <a:pt x="408" y="504"/>
                  </a:lnTo>
                  <a:lnTo>
                    <a:pt x="408" y="504"/>
                  </a:lnTo>
                  <a:lnTo>
                    <a:pt x="413" y="504"/>
                  </a:lnTo>
                  <a:lnTo>
                    <a:pt x="413" y="504"/>
                  </a:lnTo>
                  <a:lnTo>
                    <a:pt x="417" y="504"/>
                  </a:lnTo>
                  <a:lnTo>
                    <a:pt x="417" y="504"/>
                  </a:lnTo>
                  <a:lnTo>
                    <a:pt x="422" y="504"/>
                  </a:lnTo>
                  <a:lnTo>
                    <a:pt x="422" y="504"/>
                  </a:lnTo>
                  <a:lnTo>
                    <a:pt x="427" y="504"/>
                  </a:lnTo>
                  <a:lnTo>
                    <a:pt x="427" y="504"/>
                  </a:lnTo>
                  <a:lnTo>
                    <a:pt x="431" y="504"/>
                  </a:lnTo>
                  <a:lnTo>
                    <a:pt x="431" y="504"/>
                  </a:lnTo>
                  <a:lnTo>
                    <a:pt x="436" y="504"/>
                  </a:lnTo>
                  <a:lnTo>
                    <a:pt x="436" y="504"/>
                  </a:lnTo>
                  <a:lnTo>
                    <a:pt x="441" y="504"/>
                  </a:lnTo>
                  <a:lnTo>
                    <a:pt x="441" y="504"/>
                  </a:lnTo>
                  <a:lnTo>
                    <a:pt x="445" y="504"/>
                  </a:lnTo>
                  <a:lnTo>
                    <a:pt x="445" y="504"/>
                  </a:lnTo>
                  <a:lnTo>
                    <a:pt x="450" y="504"/>
                  </a:lnTo>
                  <a:lnTo>
                    <a:pt x="450" y="504"/>
                  </a:lnTo>
                  <a:lnTo>
                    <a:pt x="455" y="504"/>
                  </a:lnTo>
                  <a:lnTo>
                    <a:pt x="455" y="504"/>
                  </a:lnTo>
                  <a:lnTo>
                    <a:pt x="459" y="403"/>
                  </a:lnTo>
                  <a:lnTo>
                    <a:pt x="459" y="403"/>
                  </a:lnTo>
                  <a:lnTo>
                    <a:pt x="464" y="403"/>
                  </a:lnTo>
                  <a:lnTo>
                    <a:pt x="464" y="403"/>
                  </a:lnTo>
                  <a:lnTo>
                    <a:pt x="464" y="403"/>
                  </a:lnTo>
                  <a:lnTo>
                    <a:pt x="468" y="403"/>
                  </a:lnTo>
                  <a:lnTo>
                    <a:pt x="468" y="403"/>
                  </a:lnTo>
                  <a:lnTo>
                    <a:pt x="473" y="403"/>
                  </a:lnTo>
                  <a:lnTo>
                    <a:pt x="473" y="403"/>
                  </a:lnTo>
                  <a:lnTo>
                    <a:pt x="478" y="403"/>
                  </a:lnTo>
                  <a:lnTo>
                    <a:pt x="478" y="403"/>
                  </a:lnTo>
                  <a:lnTo>
                    <a:pt x="482" y="504"/>
                  </a:lnTo>
                  <a:lnTo>
                    <a:pt x="482" y="504"/>
                  </a:lnTo>
                  <a:lnTo>
                    <a:pt x="487" y="504"/>
                  </a:lnTo>
                  <a:lnTo>
                    <a:pt x="487" y="504"/>
                  </a:lnTo>
                  <a:lnTo>
                    <a:pt x="492" y="504"/>
                  </a:lnTo>
                  <a:lnTo>
                    <a:pt x="492" y="504"/>
                  </a:lnTo>
                  <a:lnTo>
                    <a:pt x="496" y="504"/>
                  </a:lnTo>
                  <a:lnTo>
                    <a:pt x="496" y="504"/>
                  </a:lnTo>
                  <a:lnTo>
                    <a:pt x="501" y="504"/>
                  </a:lnTo>
                  <a:lnTo>
                    <a:pt x="501" y="504"/>
                  </a:lnTo>
                  <a:lnTo>
                    <a:pt x="506" y="504"/>
                  </a:lnTo>
                  <a:lnTo>
                    <a:pt x="506" y="504"/>
                  </a:lnTo>
                  <a:lnTo>
                    <a:pt x="510" y="504"/>
                  </a:lnTo>
                  <a:lnTo>
                    <a:pt x="510" y="504"/>
                  </a:lnTo>
                  <a:lnTo>
                    <a:pt x="515" y="504"/>
                  </a:lnTo>
                  <a:lnTo>
                    <a:pt x="515" y="504"/>
                  </a:lnTo>
                  <a:lnTo>
                    <a:pt x="519" y="504"/>
                  </a:lnTo>
                  <a:lnTo>
                    <a:pt x="519" y="504"/>
                  </a:lnTo>
                  <a:lnTo>
                    <a:pt x="524" y="504"/>
                  </a:lnTo>
                  <a:lnTo>
                    <a:pt x="524" y="504"/>
                  </a:lnTo>
                  <a:lnTo>
                    <a:pt x="529" y="504"/>
                  </a:lnTo>
                  <a:lnTo>
                    <a:pt x="529" y="504"/>
                  </a:lnTo>
                  <a:lnTo>
                    <a:pt x="529" y="504"/>
                  </a:lnTo>
                  <a:lnTo>
                    <a:pt x="533" y="504"/>
                  </a:lnTo>
                  <a:lnTo>
                    <a:pt x="533" y="504"/>
                  </a:lnTo>
                  <a:lnTo>
                    <a:pt x="538" y="504"/>
                  </a:lnTo>
                  <a:lnTo>
                    <a:pt x="538" y="504"/>
                  </a:lnTo>
                  <a:lnTo>
                    <a:pt x="543" y="504"/>
                  </a:lnTo>
                  <a:lnTo>
                    <a:pt x="543" y="504"/>
                  </a:lnTo>
                  <a:lnTo>
                    <a:pt x="547" y="504"/>
                  </a:lnTo>
                  <a:lnTo>
                    <a:pt x="547" y="504"/>
                  </a:lnTo>
                  <a:lnTo>
                    <a:pt x="552" y="504"/>
                  </a:lnTo>
                  <a:lnTo>
                    <a:pt x="552" y="504"/>
                  </a:lnTo>
                  <a:lnTo>
                    <a:pt x="557" y="504"/>
                  </a:lnTo>
                  <a:lnTo>
                    <a:pt x="557" y="504"/>
                  </a:lnTo>
                  <a:lnTo>
                    <a:pt x="561" y="504"/>
                  </a:lnTo>
                  <a:lnTo>
                    <a:pt x="561" y="504"/>
                  </a:lnTo>
                  <a:lnTo>
                    <a:pt x="566" y="504"/>
                  </a:lnTo>
                  <a:lnTo>
                    <a:pt x="566" y="504"/>
                  </a:lnTo>
                  <a:lnTo>
                    <a:pt x="570" y="504"/>
                  </a:lnTo>
                  <a:lnTo>
                    <a:pt x="570" y="504"/>
                  </a:lnTo>
                  <a:lnTo>
                    <a:pt x="575" y="504"/>
                  </a:lnTo>
                  <a:lnTo>
                    <a:pt x="575" y="504"/>
                  </a:lnTo>
                  <a:lnTo>
                    <a:pt x="580" y="504"/>
                  </a:lnTo>
                  <a:lnTo>
                    <a:pt x="580" y="504"/>
                  </a:lnTo>
                  <a:lnTo>
                    <a:pt x="584" y="504"/>
                  </a:lnTo>
                  <a:lnTo>
                    <a:pt x="584" y="504"/>
                  </a:lnTo>
                  <a:lnTo>
                    <a:pt x="589" y="403"/>
                  </a:lnTo>
                  <a:lnTo>
                    <a:pt x="589" y="403"/>
                  </a:lnTo>
                  <a:lnTo>
                    <a:pt x="594" y="403"/>
                  </a:lnTo>
                  <a:lnTo>
                    <a:pt x="594" y="403"/>
                  </a:lnTo>
                  <a:lnTo>
                    <a:pt x="598" y="403"/>
                  </a:lnTo>
                  <a:lnTo>
                    <a:pt x="598" y="403"/>
                  </a:lnTo>
                  <a:lnTo>
                    <a:pt x="598" y="403"/>
                  </a:lnTo>
                  <a:lnTo>
                    <a:pt x="603" y="403"/>
                  </a:lnTo>
                  <a:lnTo>
                    <a:pt x="603" y="403"/>
                  </a:lnTo>
                  <a:lnTo>
                    <a:pt x="608" y="403"/>
                  </a:lnTo>
                  <a:lnTo>
                    <a:pt x="608" y="403"/>
                  </a:lnTo>
                  <a:lnTo>
                    <a:pt x="612" y="403"/>
                  </a:lnTo>
                  <a:lnTo>
                    <a:pt x="612" y="403"/>
                  </a:lnTo>
                  <a:lnTo>
                    <a:pt x="617" y="403"/>
                  </a:lnTo>
                  <a:lnTo>
                    <a:pt x="617" y="403"/>
                  </a:lnTo>
                  <a:lnTo>
                    <a:pt x="621" y="403"/>
                  </a:lnTo>
                  <a:lnTo>
                    <a:pt x="621" y="403"/>
                  </a:lnTo>
                  <a:lnTo>
                    <a:pt x="626" y="403"/>
                  </a:lnTo>
                  <a:lnTo>
                    <a:pt x="626" y="403"/>
                  </a:lnTo>
                  <a:lnTo>
                    <a:pt x="631" y="403"/>
                  </a:lnTo>
                  <a:lnTo>
                    <a:pt x="631" y="403"/>
                  </a:lnTo>
                  <a:lnTo>
                    <a:pt x="635" y="403"/>
                  </a:lnTo>
                  <a:lnTo>
                    <a:pt x="635" y="403"/>
                  </a:lnTo>
                  <a:lnTo>
                    <a:pt x="640" y="403"/>
                  </a:lnTo>
                  <a:lnTo>
                    <a:pt x="640" y="403"/>
                  </a:lnTo>
                  <a:lnTo>
                    <a:pt x="645" y="403"/>
                  </a:lnTo>
                  <a:lnTo>
                    <a:pt x="645" y="403"/>
                  </a:lnTo>
                  <a:lnTo>
                    <a:pt x="649" y="403"/>
                  </a:lnTo>
                  <a:lnTo>
                    <a:pt x="649" y="403"/>
                  </a:lnTo>
                  <a:lnTo>
                    <a:pt x="654" y="403"/>
                  </a:lnTo>
                  <a:lnTo>
                    <a:pt x="654" y="403"/>
                  </a:lnTo>
                  <a:lnTo>
                    <a:pt x="659" y="403"/>
                  </a:lnTo>
                  <a:lnTo>
                    <a:pt x="659" y="403"/>
                  </a:lnTo>
                  <a:lnTo>
                    <a:pt x="663" y="403"/>
                  </a:lnTo>
                  <a:lnTo>
                    <a:pt x="663" y="403"/>
                  </a:lnTo>
                  <a:lnTo>
                    <a:pt x="663" y="403"/>
                  </a:lnTo>
                  <a:lnTo>
                    <a:pt x="668" y="403"/>
                  </a:lnTo>
                  <a:lnTo>
                    <a:pt x="668" y="403"/>
                  </a:lnTo>
                  <a:lnTo>
                    <a:pt x="673" y="403"/>
                  </a:lnTo>
                  <a:lnTo>
                    <a:pt x="673" y="403"/>
                  </a:lnTo>
                  <a:lnTo>
                    <a:pt x="677" y="302"/>
                  </a:lnTo>
                  <a:lnTo>
                    <a:pt x="677" y="302"/>
                  </a:lnTo>
                  <a:lnTo>
                    <a:pt x="682" y="302"/>
                  </a:lnTo>
                  <a:lnTo>
                    <a:pt x="682" y="201"/>
                  </a:lnTo>
                  <a:lnTo>
                    <a:pt x="686" y="201"/>
                  </a:lnTo>
                  <a:lnTo>
                    <a:pt x="686" y="201"/>
                  </a:lnTo>
                  <a:lnTo>
                    <a:pt x="691" y="201"/>
                  </a:lnTo>
                  <a:lnTo>
                    <a:pt x="691" y="201"/>
                  </a:lnTo>
                  <a:lnTo>
                    <a:pt x="696" y="201"/>
                  </a:lnTo>
                  <a:lnTo>
                    <a:pt x="696" y="201"/>
                  </a:lnTo>
                  <a:lnTo>
                    <a:pt x="700" y="201"/>
                  </a:lnTo>
                  <a:lnTo>
                    <a:pt x="700" y="201"/>
                  </a:lnTo>
                  <a:lnTo>
                    <a:pt x="705" y="201"/>
                  </a:lnTo>
                  <a:lnTo>
                    <a:pt x="705" y="201"/>
                  </a:lnTo>
                  <a:lnTo>
                    <a:pt x="710" y="201"/>
                  </a:lnTo>
                  <a:lnTo>
                    <a:pt x="710" y="201"/>
                  </a:lnTo>
                  <a:lnTo>
                    <a:pt x="714" y="201"/>
                  </a:lnTo>
                  <a:lnTo>
                    <a:pt x="714" y="201"/>
                  </a:lnTo>
                  <a:lnTo>
                    <a:pt x="719" y="302"/>
                  </a:lnTo>
                  <a:lnTo>
                    <a:pt x="719" y="302"/>
                  </a:lnTo>
                  <a:lnTo>
                    <a:pt x="724" y="302"/>
                  </a:lnTo>
                  <a:lnTo>
                    <a:pt x="724" y="302"/>
                  </a:lnTo>
                  <a:lnTo>
                    <a:pt x="728" y="302"/>
                  </a:lnTo>
                  <a:lnTo>
                    <a:pt x="728" y="302"/>
                  </a:lnTo>
                  <a:lnTo>
                    <a:pt x="728" y="302"/>
                  </a:lnTo>
                  <a:lnTo>
                    <a:pt x="733" y="302"/>
                  </a:lnTo>
                  <a:lnTo>
                    <a:pt x="733" y="302"/>
                  </a:lnTo>
                  <a:lnTo>
                    <a:pt x="737" y="201"/>
                  </a:lnTo>
                  <a:lnTo>
                    <a:pt x="737" y="201"/>
                  </a:lnTo>
                  <a:lnTo>
                    <a:pt x="742" y="201"/>
                  </a:lnTo>
                  <a:lnTo>
                    <a:pt x="742" y="201"/>
                  </a:lnTo>
                  <a:lnTo>
                    <a:pt x="747" y="201"/>
                  </a:lnTo>
                  <a:lnTo>
                    <a:pt x="747" y="201"/>
                  </a:lnTo>
                  <a:lnTo>
                    <a:pt x="751" y="201"/>
                  </a:lnTo>
                  <a:lnTo>
                    <a:pt x="751" y="201"/>
                  </a:lnTo>
                  <a:lnTo>
                    <a:pt x="756" y="201"/>
                  </a:lnTo>
                  <a:lnTo>
                    <a:pt x="756" y="201"/>
                  </a:lnTo>
                  <a:lnTo>
                    <a:pt x="761" y="201"/>
                  </a:lnTo>
                  <a:lnTo>
                    <a:pt x="761" y="201"/>
                  </a:lnTo>
                  <a:lnTo>
                    <a:pt x="765" y="201"/>
                  </a:lnTo>
                  <a:lnTo>
                    <a:pt x="765" y="201"/>
                  </a:lnTo>
                  <a:lnTo>
                    <a:pt x="770" y="302"/>
                  </a:lnTo>
                  <a:lnTo>
                    <a:pt x="770" y="302"/>
                  </a:lnTo>
                  <a:lnTo>
                    <a:pt x="775" y="302"/>
                  </a:lnTo>
                  <a:lnTo>
                    <a:pt x="775" y="302"/>
                  </a:lnTo>
                  <a:lnTo>
                    <a:pt x="779" y="302"/>
                  </a:lnTo>
                  <a:lnTo>
                    <a:pt x="779" y="302"/>
                  </a:lnTo>
                  <a:lnTo>
                    <a:pt x="784" y="302"/>
                  </a:lnTo>
                  <a:lnTo>
                    <a:pt x="784" y="302"/>
                  </a:lnTo>
                  <a:lnTo>
                    <a:pt x="788" y="302"/>
                  </a:lnTo>
                  <a:lnTo>
                    <a:pt x="788" y="302"/>
                  </a:lnTo>
                  <a:lnTo>
                    <a:pt x="793" y="302"/>
                  </a:lnTo>
                  <a:lnTo>
                    <a:pt x="793" y="302"/>
                  </a:lnTo>
                  <a:lnTo>
                    <a:pt x="793" y="403"/>
                  </a:lnTo>
                  <a:lnTo>
                    <a:pt x="798" y="403"/>
                  </a:lnTo>
                  <a:lnTo>
                    <a:pt x="798" y="403"/>
                  </a:lnTo>
                  <a:lnTo>
                    <a:pt x="802" y="403"/>
                  </a:lnTo>
                  <a:lnTo>
                    <a:pt x="802" y="403"/>
                  </a:lnTo>
                  <a:lnTo>
                    <a:pt x="807" y="403"/>
                  </a:lnTo>
                  <a:lnTo>
                    <a:pt x="807" y="302"/>
                  </a:lnTo>
                  <a:lnTo>
                    <a:pt x="812" y="302"/>
                  </a:lnTo>
                  <a:lnTo>
                    <a:pt x="812" y="302"/>
                  </a:lnTo>
                  <a:lnTo>
                    <a:pt x="816" y="302"/>
                  </a:lnTo>
                  <a:lnTo>
                    <a:pt x="816" y="302"/>
                  </a:lnTo>
                  <a:lnTo>
                    <a:pt x="821" y="302"/>
                  </a:lnTo>
                  <a:lnTo>
                    <a:pt x="821" y="302"/>
                  </a:lnTo>
                  <a:lnTo>
                    <a:pt x="826" y="302"/>
                  </a:lnTo>
                  <a:lnTo>
                    <a:pt x="826" y="302"/>
                  </a:lnTo>
                  <a:lnTo>
                    <a:pt x="830" y="302"/>
                  </a:lnTo>
                  <a:lnTo>
                    <a:pt x="830" y="302"/>
                  </a:lnTo>
                  <a:lnTo>
                    <a:pt x="835" y="302"/>
                  </a:lnTo>
                  <a:lnTo>
                    <a:pt x="835" y="302"/>
                  </a:lnTo>
                  <a:lnTo>
                    <a:pt x="839" y="201"/>
                  </a:lnTo>
                  <a:lnTo>
                    <a:pt x="839" y="201"/>
                  </a:lnTo>
                  <a:lnTo>
                    <a:pt x="844" y="201"/>
                  </a:lnTo>
                  <a:lnTo>
                    <a:pt x="844" y="201"/>
                  </a:lnTo>
                  <a:lnTo>
                    <a:pt x="849" y="201"/>
                  </a:lnTo>
                  <a:lnTo>
                    <a:pt x="849" y="201"/>
                  </a:lnTo>
                  <a:lnTo>
                    <a:pt x="853" y="201"/>
                  </a:lnTo>
                  <a:lnTo>
                    <a:pt x="853" y="201"/>
                  </a:lnTo>
                  <a:lnTo>
                    <a:pt x="858" y="201"/>
                  </a:lnTo>
                  <a:lnTo>
                    <a:pt x="858" y="201"/>
                  </a:lnTo>
                  <a:lnTo>
                    <a:pt x="863" y="201"/>
                  </a:lnTo>
                  <a:lnTo>
                    <a:pt x="863" y="201"/>
                  </a:lnTo>
                  <a:lnTo>
                    <a:pt x="863" y="201"/>
                  </a:lnTo>
                  <a:lnTo>
                    <a:pt x="867" y="201"/>
                  </a:lnTo>
                  <a:lnTo>
                    <a:pt x="867" y="201"/>
                  </a:lnTo>
                  <a:lnTo>
                    <a:pt x="872" y="201"/>
                  </a:lnTo>
                  <a:lnTo>
                    <a:pt x="872" y="201"/>
                  </a:lnTo>
                  <a:lnTo>
                    <a:pt x="877" y="201"/>
                  </a:lnTo>
                  <a:lnTo>
                    <a:pt x="877" y="201"/>
                  </a:lnTo>
                  <a:lnTo>
                    <a:pt x="881" y="201"/>
                  </a:lnTo>
                  <a:lnTo>
                    <a:pt x="881" y="201"/>
                  </a:lnTo>
                  <a:lnTo>
                    <a:pt x="886" y="201"/>
                  </a:lnTo>
                  <a:lnTo>
                    <a:pt x="886" y="201"/>
                  </a:lnTo>
                  <a:lnTo>
                    <a:pt x="890" y="201"/>
                  </a:lnTo>
                  <a:lnTo>
                    <a:pt x="890" y="101"/>
                  </a:lnTo>
                  <a:lnTo>
                    <a:pt x="895" y="101"/>
                  </a:lnTo>
                  <a:lnTo>
                    <a:pt x="895" y="101"/>
                  </a:lnTo>
                  <a:lnTo>
                    <a:pt x="900" y="101"/>
                  </a:lnTo>
                  <a:lnTo>
                    <a:pt x="900" y="101"/>
                  </a:lnTo>
                  <a:lnTo>
                    <a:pt x="904" y="201"/>
                  </a:lnTo>
                  <a:lnTo>
                    <a:pt x="904" y="201"/>
                  </a:lnTo>
                  <a:lnTo>
                    <a:pt x="909" y="201"/>
                  </a:lnTo>
                  <a:lnTo>
                    <a:pt x="909" y="201"/>
                  </a:lnTo>
                  <a:lnTo>
                    <a:pt x="914" y="201"/>
                  </a:lnTo>
                  <a:lnTo>
                    <a:pt x="914" y="201"/>
                  </a:lnTo>
                  <a:lnTo>
                    <a:pt x="918" y="201"/>
                  </a:lnTo>
                  <a:lnTo>
                    <a:pt x="918" y="201"/>
                  </a:lnTo>
                  <a:lnTo>
                    <a:pt x="923" y="201"/>
                  </a:lnTo>
                  <a:lnTo>
                    <a:pt x="923" y="201"/>
                  </a:lnTo>
                  <a:lnTo>
                    <a:pt x="928" y="201"/>
                  </a:lnTo>
                  <a:lnTo>
                    <a:pt x="928" y="201"/>
                  </a:lnTo>
                  <a:lnTo>
                    <a:pt x="928" y="201"/>
                  </a:lnTo>
                  <a:lnTo>
                    <a:pt x="932" y="201"/>
                  </a:lnTo>
                  <a:lnTo>
                    <a:pt x="932" y="201"/>
                  </a:lnTo>
                  <a:lnTo>
                    <a:pt x="937" y="201"/>
                  </a:lnTo>
                  <a:lnTo>
                    <a:pt x="937" y="201"/>
                  </a:lnTo>
                  <a:lnTo>
                    <a:pt x="942" y="201"/>
                  </a:lnTo>
                  <a:lnTo>
                    <a:pt x="942" y="201"/>
                  </a:lnTo>
                  <a:lnTo>
                    <a:pt x="946" y="201"/>
                  </a:lnTo>
                  <a:lnTo>
                    <a:pt x="946" y="201"/>
                  </a:lnTo>
                  <a:lnTo>
                    <a:pt x="951" y="201"/>
                  </a:lnTo>
                  <a:lnTo>
                    <a:pt x="951" y="201"/>
                  </a:lnTo>
                  <a:lnTo>
                    <a:pt x="955" y="201"/>
                  </a:lnTo>
                  <a:lnTo>
                    <a:pt x="955" y="201"/>
                  </a:lnTo>
                  <a:lnTo>
                    <a:pt x="960" y="201"/>
                  </a:lnTo>
                  <a:lnTo>
                    <a:pt x="960" y="201"/>
                  </a:lnTo>
                  <a:lnTo>
                    <a:pt x="965" y="201"/>
                  </a:lnTo>
                  <a:lnTo>
                    <a:pt x="965" y="201"/>
                  </a:lnTo>
                  <a:lnTo>
                    <a:pt x="969" y="201"/>
                  </a:lnTo>
                  <a:lnTo>
                    <a:pt x="969" y="201"/>
                  </a:lnTo>
                  <a:lnTo>
                    <a:pt x="974" y="201"/>
                  </a:lnTo>
                  <a:lnTo>
                    <a:pt x="974" y="302"/>
                  </a:lnTo>
                  <a:lnTo>
                    <a:pt x="979" y="302"/>
                  </a:lnTo>
                  <a:lnTo>
                    <a:pt x="979" y="302"/>
                  </a:lnTo>
                  <a:lnTo>
                    <a:pt x="983" y="302"/>
                  </a:lnTo>
                  <a:lnTo>
                    <a:pt x="983" y="302"/>
                  </a:lnTo>
                  <a:lnTo>
                    <a:pt x="988" y="302"/>
                  </a:lnTo>
                  <a:lnTo>
                    <a:pt x="988" y="302"/>
                  </a:lnTo>
                  <a:lnTo>
                    <a:pt x="993" y="302"/>
                  </a:lnTo>
                  <a:lnTo>
                    <a:pt x="993" y="302"/>
                  </a:lnTo>
                  <a:lnTo>
                    <a:pt x="993" y="302"/>
                  </a:lnTo>
                  <a:lnTo>
                    <a:pt x="997" y="302"/>
                  </a:lnTo>
                  <a:lnTo>
                    <a:pt x="997" y="302"/>
                  </a:lnTo>
                  <a:lnTo>
                    <a:pt x="1002" y="302"/>
                  </a:lnTo>
                  <a:lnTo>
                    <a:pt x="1002" y="302"/>
                  </a:lnTo>
                  <a:lnTo>
                    <a:pt x="1006" y="201"/>
                  </a:lnTo>
                  <a:lnTo>
                    <a:pt x="1006" y="201"/>
                  </a:lnTo>
                  <a:lnTo>
                    <a:pt x="1011" y="201"/>
                  </a:lnTo>
                  <a:lnTo>
                    <a:pt x="1011" y="201"/>
                  </a:lnTo>
                  <a:lnTo>
                    <a:pt x="1016" y="201"/>
                  </a:lnTo>
                  <a:lnTo>
                    <a:pt x="1016" y="201"/>
                  </a:lnTo>
                  <a:lnTo>
                    <a:pt x="1020" y="201"/>
                  </a:lnTo>
                  <a:lnTo>
                    <a:pt x="1020" y="302"/>
                  </a:lnTo>
                  <a:lnTo>
                    <a:pt x="1025" y="302"/>
                  </a:lnTo>
                  <a:lnTo>
                    <a:pt x="1025" y="302"/>
                  </a:lnTo>
                  <a:lnTo>
                    <a:pt x="1030" y="302"/>
                  </a:lnTo>
                  <a:lnTo>
                    <a:pt x="1030" y="302"/>
                  </a:lnTo>
                  <a:lnTo>
                    <a:pt x="1034" y="302"/>
                  </a:lnTo>
                  <a:lnTo>
                    <a:pt x="1034" y="302"/>
                  </a:lnTo>
                  <a:lnTo>
                    <a:pt x="1039" y="201"/>
                  </a:lnTo>
                  <a:lnTo>
                    <a:pt x="1039" y="201"/>
                  </a:lnTo>
                  <a:lnTo>
                    <a:pt x="1044" y="302"/>
                  </a:lnTo>
                  <a:lnTo>
                    <a:pt x="1044" y="302"/>
                  </a:lnTo>
                  <a:lnTo>
                    <a:pt x="1048" y="302"/>
                  </a:lnTo>
                  <a:lnTo>
                    <a:pt x="1048" y="302"/>
                  </a:lnTo>
                  <a:lnTo>
                    <a:pt x="1053" y="302"/>
                  </a:lnTo>
                  <a:lnTo>
                    <a:pt x="1053" y="302"/>
                  </a:lnTo>
                  <a:lnTo>
                    <a:pt x="1057" y="302"/>
                  </a:lnTo>
                  <a:lnTo>
                    <a:pt x="1057" y="302"/>
                  </a:lnTo>
                  <a:lnTo>
                    <a:pt x="1062" y="201"/>
                  </a:lnTo>
                  <a:lnTo>
                    <a:pt x="1062" y="201"/>
                  </a:lnTo>
                  <a:lnTo>
                    <a:pt x="1062" y="201"/>
                  </a:lnTo>
                  <a:lnTo>
                    <a:pt x="1067" y="201"/>
                  </a:lnTo>
                  <a:lnTo>
                    <a:pt x="1067" y="201"/>
                  </a:lnTo>
                  <a:lnTo>
                    <a:pt x="1071" y="201"/>
                  </a:lnTo>
                  <a:lnTo>
                    <a:pt x="1071" y="201"/>
                  </a:lnTo>
                  <a:lnTo>
                    <a:pt x="1076" y="201"/>
                  </a:lnTo>
                  <a:lnTo>
                    <a:pt x="1076" y="201"/>
                  </a:lnTo>
                  <a:lnTo>
                    <a:pt x="1081" y="201"/>
                  </a:lnTo>
                  <a:lnTo>
                    <a:pt x="1081" y="201"/>
                  </a:lnTo>
                  <a:lnTo>
                    <a:pt x="1085" y="201"/>
                  </a:lnTo>
                  <a:lnTo>
                    <a:pt x="1085" y="302"/>
                  </a:lnTo>
                  <a:lnTo>
                    <a:pt x="1090" y="302"/>
                  </a:lnTo>
                  <a:lnTo>
                    <a:pt x="1090" y="302"/>
                  </a:lnTo>
                  <a:lnTo>
                    <a:pt x="1095" y="302"/>
                  </a:lnTo>
                  <a:lnTo>
                    <a:pt x="1095" y="302"/>
                  </a:lnTo>
                  <a:lnTo>
                    <a:pt x="1099" y="201"/>
                  </a:lnTo>
                  <a:lnTo>
                    <a:pt x="1099" y="201"/>
                  </a:lnTo>
                  <a:lnTo>
                    <a:pt x="1104" y="201"/>
                  </a:lnTo>
                  <a:lnTo>
                    <a:pt x="1104" y="302"/>
                  </a:lnTo>
                  <a:lnTo>
                    <a:pt x="1108" y="302"/>
                  </a:lnTo>
                  <a:lnTo>
                    <a:pt x="1108" y="302"/>
                  </a:lnTo>
                  <a:lnTo>
                    <a:pt x="1113" y="302"/>
                  </a:lnTo>
                  <a:lnTo>
                    <a:pt x="1113" y="302"/>
                  </a:lnTo>
                  <a:lnTo>
                    <a:pt x="1118" y="302"/>
                  </a:lnTo>
                  <a:lnTo>
                    <a:pt x="1118" y="302"/>
                  </a:lnTo>
                  <a:lnTo>
                    <a:pt x="1122" y="302"/>
                  </a:lnTo>
                  <a:lnTo>
                    <a:pt x="1122" y="302"/>
                  </a:lnTo>
                  <a:lnTo>
                    <a:pt x="1127" y="302"/>
                  </a:lnTo>
                  <a:lnTo>
                    <a:pt x="1127" y="302"/>
                  </a:lnTo>
                  <a:lnTo>
                    <a:pt x="1127" y="302"/>
                  </a:lnTo>
                  <a:lnTo>
                    <a:pt x="1132" y="302"/>
                  </a:lnTo>
                  <a:lnTo>
                    <a:pt x="1132" y="302"/>
                  </a:lnTo>
                  <a:lnTo>
                    <a:pt x="1136" y="302"/>
                  </a:lnTo>
                  <a:lnTo>
                    <a:pt x="1136" y="302"/>
                  </a:lnTo>
                  <a:lnTo>
                    <a:pt x="1141" y="302"/>
                  </a:lnTo>
                  <a:lnTo>
                    <a:pt x="1141" y="302"/>
                  </a:lnTo>
                  <a:lnTo>
                    <a:pt x="1146" y="302"/>
                  </a:lnTo>
                  <a:lnTo>
                    <a:pt x="1146" y="302"/>
                  </a:lnTo>
                  <a:lnTo>
                    <a:pt x="1150" y="302"/>
                  </a:lnTo>
                  <a:lnTo>
                    <a:pt x="1150" y="302"/>
                  </a:lnTo>
                  <a:lnTo>
                    <a:pt x="1155" y="302"/>
                  </a:lnTo>
                  <a:lnTo>
                    <a:pt x="1155" y="302"/>
                  </a:lnTo>
                  <a:lnTo>
                    <a:pt x="1160" y="302"/>
                  </a:lnTo>
                  <a:lnTo>
                    <a:pt x="1160" y="302"/>
                  </a:lnTo>
                  <a:lnTo>
                    <a:pt x="1164" y="302"/>
                  </a:lnTo>
                  <a:lnTo>
                    <a:pt x="1164" y="302"/>
                  </a:lnTo>
                  <a:lnTo>
                    <a:pt x="1169" y="302"/>
                  </a:lnTo>
                  <a:lnTo>
                    <a:pt x="1169" y="302"/>
                  </a:lnTo>
                  <a:lnTo>
                    <a:pt x="1173" y="302"/>
                  </a:lnTo>
                  <a:lnTo>
                    <a:pt x="1173" y="302"/>
                  </a:lnTo>
                  <a:lnTo>
                    <a:pt x="1178" y="302"/>
                  </a:lnTo>
                  <a:lnTo>
                    <a:pt x="1178" y="302"/>
                  </a:lnTo>
                  <a:lnTo>
                    <a:pt x="1183" y="302"/>
                  </a:lnTo>
                  <a:lnTo>
                    <a:pt x="1183" y="302"/>
                  </a:lnTo>
                  <a:lnTo>
                    <a:pt x="1187" y="302"/>
                  </a:lnTo>
                  <a:lnTo>
                    <a:pt x="1187" y="302"/>
                  </a:lnTo>
                  <a:lnTo>
                    <a:pt x="1192" y="302"/>
                  </a:lnTo>
                  <a:lnTo>
                    <a:pt x="1192" y="302"/>
                  </a:lnTo>
                  <a:lnTo>
                    <a:pt x="1192" y="302"/>
                  </a:lnTo>
                  <a:lnTo>
                    <a:pt x="1197" y="302"/>
                  </a:lnTo>
                  <a:lnTo>
                    <a:pt x="1197" y="302"/>
                  </a:lnTo>
                  <a:lnTo>
                    <a:pt x="1201" y="302"/>
                  </a:lnTo>
                  <a:lnTo>
                    <a:pt x="1201" y="302"/>
                  </a:lnTo>
                  <a:lnTo>
                    <a:pt x="1206" y="302"/>
                  </a:lnTo>
                  <a:lnTo>
                    <a:pt x="1206" y="302"/>
                  </a:lnTo>
                  <a:lnTo>
                    <a:pt x="1211" y="302"/>
                  </a:lnTo>
                  <a:lnTo>
                    <a:pt x="1211" y="302"/>
                  </a:lnTo>
                  <a:lnTo>
                    <a:pt x="1215" y="302"/>
                  </a:lnTo>
                  <a:lnTo>
                    <a:pt x="1215" y="403"/>
                  </a:lnTo>
                  <a:lnTo>
                    <a:pt x="1220" y="403"/>
                  </a:lnTo>
                  <a:lnTo>
                    <a:pt x="1220" y="403"/>
                  </a:lnTo>
                  <a:lnTo>
                    <a:pt x="1224" y="403"/>
                  </a:lnTo>
                  <a:lnTo>
                    <a:pt x="1224" y="403"/>
                  </a:lnTo>
                  <a:lnTo>
                    <a:pt x="1229" y="403"/>
                  </a:lnTo>
                  <a:lnTo>
                    <a:pt x="1229" y="302"/>
                  </a:lnTo>
                  <a:lnTo>
                    <a:pt x="1234" y="302"/>
                  </a:lnTo>
                  <a:lnTo>
                    <a:pt x="1234" y="302"/>
                  </a:lnTo>
                  <a:lnTo>
                    <a:pt x="1238" y="302"/>
                  </a:lnTo>
                  <a:lnTo>
                    <a:pt x="1238" y="302"/>
                  </a:lnTo>
                  <a:lnTo>
                    <a:pt x="1243" y="302"/>
                  </a:lnTo>
                  <a:lnTo>
                    <a:pt x="1243" y="302"/>
                  </a:lnTo>
                  <a:lnTo>
                    <a:pt x="1248" y="302"/>
                  </a:lnTo>
                  <a:lnTo>
                    <a:pt x="1248" y="302"/>
                  </a:lnTo>
                  <a:lnTo>
                    <a:pt x="1252" y="302"/>
                  </a:lnTo>
                  <a:lnTo>
                    <a:pt x="1252" y="201"/>
                  </a:lnTo>
                  <a:lnTo>
                    <a:pt x="1257" y="302"/>
                  </a:lnTo>
                  <a:lnTo>
                    <a:pt x="1257" y="302"/>
                  </a:lnTo>
                  <a:lnTo>
                    <a:pt x="1257" y="302"/>
                  </a:lnTo>
                  <a:lnTo>
                    <a:pt x="1262" y="302"/>
                  </a:lnTo>
                  <a:lnTo>
                    <a:pt x="1262" y="302"/>
                  </a:lnTo>
                  <a:lnTo>
                    <a:pt x="1266" y="302"/>
                  </a:lnTo>
                  <a:lnTo>
                    <a:pt x="1266" y="302"/>
                  </a:lnTo>
                  <a:lnTo>
                    <a:pt x="1271" y="302"/>
                  </a:lnTo>
                  <a:lnTo>
                    <a:pt x="1271" y="302"/>
                  </a:lnTo>
                  <a:lnTo>
                    <a:pt x="1275" y="302"/>
                  </a:lnTo>
                  <a:lnTo>
                    <a:pt x="1275" y="302"/>
                  </a:lnTo>
                  <a:lnTo>
                    <a:pt x="1280" y="302"/>
                  </a:lnTo>
                  <a:lnTo>
                    <a:pt x="1280" y="302"/>
                  </a:lnTo>
                  <a:lnTo>
                    <a:pt x="1285" y="302"/>
                  </a:lnTo>
                  <a:lnTo>
                    <a:pt x="1285" y="302"/>
                  </a:lnTo>
                  <a:lnTo>
                    <a:pt x="1289" y="302"/>
                  </a:lnTo>
                  <a:lnTo>
                    <a:pt x="1289" y="302"/>
                  </a:lnTo>
                  <a:lnTo>
                    <a:pt x="1294" y="302"/>
                  </a:lnTo>
                  <a:lnTo>
                    <a:pt x="1294" y="302"/>
                  </a:lnTo>
                  <a:lnTo>
                    <a:pt x="1299" y="302"/>
                  </a:lnTo>
                  <a:lnTo>
                    <a:pt x="1299" y="302"/>
                  </a:lnTo>
                  <a:lnTo>
                    <a:pt x="1303" y="302"/>
                  </a:lnTo>
                  <a:lnTo>
                    <a:pt x="1303" y="302"/>
                  </a:lnTo>
                  <a:lnTo>
                    <a:pt x="1308" y="302"/>
                  </a:lnTo>
                  <a:lnTo>
                    <a:pt x="1308" y="302"/>
                  </a:lnTo>
                  <a:lnTo>
                    <a:pt x="1313" y="302"/>
                  </a:lnTo>
                  <a:lnTo>
                    <a:pt x="1313" y="302"/>
                  </a:lnTo>
                  <a:lnTo>
                    <a:pt x="1317" y="302"/>
                  </a:lnTo>
                  <a:lnTo>
                    <a:pt x="1317" y="302"/>
                  </a:lnTo>
                  <a:lnTo>
                    <a:pt x="1322" y="302"/>
                  </a:lnTo>
                  <a:lnTo>
                    <a:pt x="1322" y="302"/>
                  </a:lnTo>
                  <a:lnTo>
                    <a:pt x="1326" y="302"/>
                  </a:lnTo>
                  <a:lnTo>
                    <a:pt x="1326" y="302"/>
                  </a:lnTo>
                  <a:lnTo>
                    <a:pt x="1326" y="302"/>
                  </a:lnTo>
                  <a:lnTo>
                    <a:pt x="1331" y="302"/>
                  </a:lnTo>
                  <a:lnTo>
                    <a:pt x="1331" y="302"/>
                  </a:lnTo>
                  <a:lnTo>
                    <a:pt x="1336" y="302"/>
                  </a:lnTo>
                  <a:lnTo>
                    <a:pt x="1336" y="302"/>
                  </a:lnTo>
                  <a:lnTo>
                    <a:pt x="1340" y="302"/>
                  </a:lnTo>
                  <a:lnTo>
                    <a:pt x="1340" y="302"/>
                  </a:lnTo>
                  <a:lnTo>
                    <a:pt x="1345" y="302"/>
                  </a:lnTo>
                  <a:lnTo>
                    <a:pt x="1345" y="302"/>
                  </a:lnTo>
                  <a:lnTo>
                    <a:pt x="1350" y="302"/>
                  </a:lnTo>
                  <a:lnTo>
                    <a:pt x="1350" y="302"/>
                  </a:lnTo>
                  <a:lnTo>
                    <a:pt x="1354" y="302"/>
                  </a:lnTo>
                  <a:lnTo>
                    <a:pt x="1354" y="302"/>
                  </a:lnTo>
                  <a:lnTo>
                    <a:pt x="1359" y="302"/>
                  </a:lnTo>
                  <a:lnTo>
                    <a:pt x="1359" y="302"/>
                  </a:lnTo>
                  <a:lnTo>
                    <a:pt x="1364" y="302"/>
                  </a:lnTo>
                  <a:lnTo>
                    <a:pt x="1364" y="201"/>
                  </a:lnTo>
                  <a:lnTo>
                    <a:pt x="1368" y="201"/>
                  </a:lnTo>
                  <a:lnTo>
                    <a:pt x="1368" y="201"/>
                  </a:lnTo>
                  <a:lnTo>
                    <a:pt x="1373" y="201"/>
                  </a:lnTo>
                  <a:lnTo>
                    <a:pt x="1373" y="201"/>
                  </a:lnTo>
                  <a:lnTo>
                    <a:pt x="1377" y="201"/>
                  </a:lnTo>
                  <a:lnTo>
                    <a:pt x="1377" y="201"/>
                  </a:lnTo>
                  <a:lnTo>
                    <a:pt x="1382" y="201"/>
                  </a:lnTo>
                  <a:lnTo>
                    <a:pt x="1382" y="302"/>
                  </a:lnTo>
                  <a:lnTo>
                    <a:pt x="1387" y="302"/>
                  </a:lnTo>
                  <a:lnTo>
                    <a:pt x="1387" y="201"/>
                  </a:lnTo>
                  <a:lnTo>
                    <a:pt x="1391" y="201"/>
                  </a:lnTo>
                  <a:lnTo>
                    <a:pt x="1391" y="201"/>
                  </a:lnTo>
                  <a:lnTo>
                    <a:pt x="1391" y="201"/>
                  </a:lnTo>
                  <a:lnTo>
                    <a:pt x="1396" y="101"/>
                  </a:lnTo>
                  <a:lnTo>
                    <a:pt x="1396" y="101"/>
                  </a:lnTo>
                  <a:lnTo>
                    <a:pt x="1401" y="101"/>
                  </a:lnTo>
                  <a:lnTo>
                    <a:pt x="1401" y="201"/>
                  </a:lnTo>
                  <a:lnTo>
                    <a:pt x="1405" y="201"/>
                  </a:lnTo>
                  <a:lnTo>
                    <a:pt x="1405" y="201"/>
                  </a:lnTo>
                  <a:lnTo>
                    <a:pt x="1410" y="201"/>
                  </a:lnTo>
                  <a:lnTo>
                    <a:pt x="1410" y="201"/>
                  </a:lnTo>
                  <a:lnTo>
                    <a:pt x="1415" y="201"/>
                  </a:lnTo>
                  <a:lnTo>
                    <a:pt x="1415" y="201"/>
                  </a:lnTo>
                  <a:lnTo>
                    <a:pt x="1419" y="201"/>
                  </a:lnTo>
                  <a:lnTo>
                    <a:pt x="1419" y="101"/>
                  </a:lnTo>
                  <a:lnTo>
                    <a:pt x="1424" y="101"/>
                  </a:lnTo>
                  <a:lnTo>
                    <a:pt x="1424" y="101"/>
                  </a:lnTo>
                  <a:lnTo>
                    <a:pt x="1429" y="101"/>
                  </a:lnTo>
                  <a:lnTo>
                    <a:pt x="1429" y="101"/>
                  </a:lnTo>
                  <a:lnTo>
                    <a:pt x="1433" y="101"/>
                  </a:lnTo>
                  <a:lnTo>
                    <a:pt x="1433" y="101"/>
                  </a:lnTo>
                  <a:lnTo>
                    <a:pt x="1438" y="201"/>
                  </a:lnTo>
                  <a:lnTo>
                    <a:pt x="1438" y="201"/>
                  </a:lnTo>
                  <a:lnTo>
                    <a:pt x="1442" y="201"/>
                  </a:lnTo>
                  <a:lnTo>
                    <a:pt x="1442" y="201"/>
                  </a:lnTo>
                  <a:lnTo>
                    <a:pt x="1447" y="201"/>
                  </a:lnTo>
                  <a:lnTo>
                    <a:pt x="1447" y="201"/>
                  </a:lnTo>
                  <a:lnTo>
                    <a:pt x="1452" y="201"/>
                  </a:lnTo>
                  <a:lnTo>
                    <a:pt x="1452" y="201"/>
                  </a:lnTo>
                  <a:lnTo>
                    <a:pt x="1456" y="201"/>
                  </a:lnTo>
                  <a:lnTo>
                    <a:pt x="1456" y="201"/>
                  </a:lnTo>
                  <a:lnTo>
                    <a:pt x="1456" y="201"/>
                  </a:lnTo>
                  <a:lnTo>
                    <a:pt x="1461" y="201"/>
                  </a:lnTo>
                  <a:lnTo>
                    <a:pt x="1461" y="201"/>
                  </a:lnTo>
                  <a:lnTo>
                    <a:pt x="1466" y="201"/>
                  </a:lnTo>
                  <a:lnTo>
                    <a:pt x="1466" y="201"/>
                  </a:lnTo>
                  <a:lnTo>
                    <a:pt x="1470" y="201"/>
                  </a:lnTo>
                  <a:lnTo>
                    <a:pt x="1470" y="201"/>
                  </a:lnTo>
                  <a:lnTo>
                    <a:pt x="1475" y="201"/>
                  </a:lnTo>
                  <a:lnTo>
                    <a:pt x="1475" y="201"/>
                  </a:lnTo>
                  <a:lnTo>
                    <a:pt x="1480" y="201"/>
                  </a:lnTo>
                  <a:lnTo>
                    <a:pt x="1480" y="201"/>
                  </a:lnTo>
                  <a:lnTo>
                    <a:pt x="1484" y="201"/>
                  </a:lnTo>
                  <a:lnTo>
                    <a:pt x="1484" y="201"/>
                  </a:lnTo>
                  <a:lnTo>
                    <a:pt x="1489" y="201"/>
                  </a:lnTo>
                  <a:lnTo>
                    <a:pt x="1489" y="201"/>
                  </a:lnTo>
                  <a:lnTo>
                    <a:pt x="1493" y="302"/>
                  </a:lnTo>
                  <a:lnTo>
                    <a:pt x="1493" y="201"/>
                  </a:lnTo>
                  <a:lnTo>
                    <a:pt x="1498" y="201"/>
                  </a:lnTo>
                  <a:lnTo>
                    <a:pt x="1498" y="201"/>
                  </a:lnTo>
                  <a:lnTo>
                    <a:pt x="1503" y="201"/>
                  </a:lnTo>
                  <a:lnTo>
                    <a:pt x="1503" y="201"/>
                  </a:lnTo>
                  <a:lnTo>
                    <a:pt x="1507" y="201"/>
                  </a:lnTo>
                  <a:lnTo>
                    <a:pt x="1507" y="201"/>
                  </a:lnTo>
                  <a:lnTo>
                    <a:pt x="1512" y="201"/>
                  </a:lnTo>
                  <a:lnTo>
                    <a:pt x="1512" y="201"/>
                  </a:lnTo>
                  <a:lnTo>
                    <a:pt x="1517" y="201"/>
                  </a:lnTo>
                  <a:lnTo>
                    <a:pt x="1517" y="201"/>
                  </a:lnTo>
                  <a:lnTo>
                    <a:pt x="1521" y="201"/>
                  </a:lnTo>
                  <a:lnTo>
                    <a:pt x="1521" y="201"/>
                  </a:lnTo>
                  <a:lnTo>
                    <a:pt x="1526" y="201"/>
                  </a:lnTo>
                  <a:lnTo>
                    <a:pt x="1526" y="201"/>
                  </a:lnTo>
                  <a:lnTo>
                    <a:pt x="1526" y="201"/>
                  </a:lnTo>
                  <a:lnTo>
                    <a:pt x="1531" y="201"/>
                  </a:lnTo>
                  <a:lnTo>
                    <a:pt x="1531" y="201"/>
                  </a:lnTo>
                  <a:lnTo>
                    <a:pt x="1535" y="201"/>
                  </a:lnTo>
                  <a:lnTo>
                    <a:pt x="1535" y="201"/>
                  </a:lnTo>
                  <a:lnTo>
                    <a:pt x="1540" y="201"/>
                  </a:lnTo>
                  <a:lnTo>
                    <a:pt x="1540" y="201"/>
                  </a:lnTo>
                  <a:lnTo>
                    <a:pt x="1544" y="201"/>
                  </a:lnTo>
                  <a:lnTo>
                    <a:pt x="1544" y="201"/>
                  </a:lnTo>
                  <a:lnTo>
                    <a:pt x="1549" y="201"/>
                  </a:lnTo>
                  <a:lnTo>
                    <a:pt x="1549" y="201"/>
                  </a:lnTo>
                  <a:lnTo>
                    <a:pt x="1554" y="201"/>
                  </a:lnTo>
                  <a:lnTo>
                    <a:pt x="1554" y="201"/>
                  </a:lnTo>
                  <a:lnTo>
                    <a:pt x="1558" y="201"/>
                  </a:lnTo>
                  <a:lnTo>
                    <a:pt x="1558" y="201"/>
                  </a:lnTo>
                  <a:lnTo>
                    <a:pt x="1563" y="201"/>
                  </a:lnTo>
                  <a:lnTo>
                    <a:pt x="1563" y="201"/>
                  </a:lnTo>
                  <a:lnTo>
                    <a:pt x="1568" y="201"/>
                  </a:lnTo>
                  <a:lnTo>
                    <a:pt x="1568" y="201"/>
                  </a:lnTo>
                  <a:lnTo>
                    <a:pt x="1572" y="201"/>
                  </a:lnTo>
                  <a:lnTo>
                    <a:pt x="1572" y="201"/>
                  </a:lnTo>
                  <a:lnTo>
                    <a:pt x="1577" y="101"/>
                  </a:lnTo>
                  <a:lnTo>
                    <a:pt x="1577" y="101"/>
                  </a:lnTo>
                  <a:lnTo>
                    <a:pt x="1582" y="101"/>
                  </a:lnTo>
                  <a:lnTo>
                    <a:pt x="1582" y="101"/>
                  </a:lnTo>
                  <a:lnTo>
                    <a:pt x="1586" y="101"/>
                  </a:lnTo>
                  <a:lnTo>
                    <a:pt x="1586" y="101"/>
                  </a:lnTo>
                  <a:lnTo>
                    <a:pt x="1591" y="101"/>
                  </a:lnTo>
                  <a:lnTo>
                    <a:pt x="1591" y="101"/>
                  </a:lnTo>
                  <a:lnTo>
                    <a:pt x="1591" y="201"/>
                  </a:lnTo>
                  <a:lnTo>
                    <a:pt x="1595" y="201"/>
                  </a:lnTo>
                  <a:lnTo>
                    <a:pt x="1595" y="201"/>
                  </a:lnTo>
                  <a:lnTo>
                    <a:pt x="1600" y="201"/>
                  </a:lnTo>
                  <a:lnTo>
                    <a:pt x="1600" y="201"/>
                  </a:lnTo>
                  <a:lnTo>
                    <a:pt x="1605" y="101"/>
                  </a:lnTo>
                  <a:lnTo>
                    <a:pt x="1605" y="101"/>
                  </a:lnTo>
                  <a:lnTo>
                    <a:pt x="1609" y="101"/>
                  </a:lnTo>
                  <a:lnTo>
                    <a:pt x="1609" y="101"/>
                  </a:lnTo>
                  <a:lnTo>
                    <a:pt x="1614" y="101"/>
                  </a:lnTo>
                  <a:lnTo>
                    <a:pt x="1614" y="101"/>
                  </a:lnTo>
                  <a:lnTo>
                    <a:pt x="1619" y="101"/>
                  </a:lnTo>
                  <a:lnTo>
                    <a:pt x="1619" y="101"/>
                  </a:lnTo>
                  <a:lnTo>
                    <a:pt x="1623" y="101"/>
                  </a:lnTo>
                  <a:lnTo>
                    <a:pt x="1623" y="101"/>
                  </a:lnTo>
                  <a:lnTo>
                    <a:pt x="1628" y="101"/>
                  </a:lnTo>
                  <a:lnTo>
                    <a:pt x="1628" y="101"/>
                  </a:lnTo>
                  <a:lnTo>
                    <a:pt x="1633" y="101"/>
                  </a:lnTo>
                  <a:lnTo>
                    <a:pt x="1633" y="101"/>
                  </a:lnTo>
                  <a:lnTo>
                    <a:pt x="1637" y="101"/>
                  </a:lnTo>
                  <a:lnTo>
                    <a:pt x="1637" y="101"/>
                  </a:lnTo>
                  <a:lnTo>
                    <a:pt x="1642" y="101"/>
                  </a:lnTo>
                  <a:lnTo>
                    <a:pt x="1642" y="101"/>
                  </a:lnTo>
                  <a:lnTo>
                    <a:pt x="1646" y="201"/>
                  </a:lnTo>
                  <a:lnTo>
                    <a:pt x="1646" y="201"/>
                  </a:lnTo>
                  <a:lnTo>
                    <a:pt x="1651" y="201"/>
                  </a:lnTo>
                  <a:lnTo>
                    <a:pt x="1651" y="201"/>
                  </a:lnTo>
                  <a:lnTo>
                    <a:pt x="1656" y="201"/>
                  </a:lnTo>
                  <a:lnTo>
                    <a:pt x="1656" y="201"/>
                  </a:lnTo>
                  <a:lnTo>
                    <a:pt x="1656" y="201"/>
                  </a:lnTo>
                  <a:lnTo>
                    <a:pt x="1660" y="101"/>
                  </a:lnTo>
                  <a:lnTo>
                    <a:pt x="1660" y="101"/>
                  </a:lnTo>
                  <a:lnTo>
                    <a:pt x="1665" y="101"/>
                  </a:lnTo>
                  <a:lnTo>
                    <a:pt x="1665" y="101"/>
                  </a:lnTo>
                  <a:lnTo>
                    <a:pt x="1670" y="101"/>
                  </a:lnTo>
                  <a:lnTo>
                    <a:pt x="1670" y="101"/>
                  </a:lnTo>
                  <a:lnTo>
                    <a:pt x="1674" y="101"/>
                  </a:lnTo>
                  <a:lnTo>
                    <a:pt x="1674" y="101"/>
                  </a:lnTo>
                  <a:lnTo>
                    <a:pt x="1679" y="101"/>
                  </a:lnTo>
                  <a:lnTo>
                    <a:pt x="1679" y="101"/>
                  </a:lnTo>
                  <a:lnTo>
                    <a:pt x="1684" y="101"/>
                  </a:lnTo>
                  <a:lnTo>
                    <a:pt x="1684" y="101"/>
                  </a:lnTo>
                  <a:lnTo>
                    <a:pt x="1688" y="101"/>
                  </a:lnTo>
                  <a:lnTo>
                    <a:pt x="1688" y="101"/>
                  </a:lnTo>
                  <a:lnTo>
                    <a:pt x="1693" y="201"/>
                  </a:lnTo>
                  <a:lnTo>
                    <a:pt x="1693" y="201"/>
                  </a:lnTo>
                  <a:lnTo>
                    <a:pt x="1698" y="201"/>
                  </a:lnTo>
                  <a:lnTo>
                    <a:pt x="1698" y="201"/>
                  </a:lnTo>
                  <a:lnTo>
                    <a:pt x="1702" y="201"/>
                  </a:lnTo>
                  <a:lnTo>
                    <a:pt x="1702" y="201"/>
                  </a:lnTo>
                  <a:lnTo>
                    <a:pt x="1707" y="302"/>
                  </a:lnTo>
                  <a:lnTo>
                    <a:pt x="1707" y="302"/>
                  </a:lnTo>
                  <a:lnTo>
                    <a:pt x="1711" y="302"/>
                  </a:lnTo>
                  <a:lnTo>
                    <a:pt x="1711" y="302"/>
                  </a:lnTo>
                  <a:lnTo>
                    <a:pt x="1716" y="201"/>
                  </a:lnTo>
                  <a:lnTo>
                    <a:pt x="1716" y="201"/>
                  </a:lnTo>
                  <a:lnTo>
                    <a:pt x="1721" y="201"/>
                  </a:lnTo>
                  <a:lnTo>
                    <a:pt x="1721" y="201"/>
                  </a:lnTo>
                  <a:lnTo>
                    <a:pt x="1721" y="201"/>
                  </a:lnTo>
                  <a:lnTo>
                    <a:pt x="1725" y="201"/>
                  </a:lnTo>
                  <a:lnTo>
                    <a:pt x="1725" y="201"/>
                  </a:lnTo>
                  <a:lnTo>
                    <a:pt x="1730" y="201"/>
                  </a:lnTo>
                  <a:lnTo>
                    <a:pt x="1730" y="201"/>
                  </a:lnTo>
                  <a:lnTo>
                    <a:pt x="1735" y="302"/>
                  </a:lnTo>
                  <a:lnTo>
                    <a:pt x="1735" y="302"/>
                  </a:lnTo>
                  <a:lnTo>
                    <a:pt x="1739" y="302"/>
                  </a:lnTo>
                  <a:lnTo>
                    <a:pt x="1739" y="302"/>
                  </a:lnTo>
                  <a:lnTo>
                    <a:pt x="1744" y="302"/>
                  </a:lnTo>
                  <a:lnTo>
                    <a:pt x="1744" y="201"/>
                  </a:lnTo>
                  <a:lnTo>
                    <a:pt x="1749" y="201"/>
                  </a:lnTo>
                  <a:lnTo>
                    <a:pt x="1749" y="201"/>
                  </a:lnTo>
                  <a:lnTo>
                    <a:pt x="1753" y="201"/>
                  </a:lnTo>
                  <a:lnTo>
                    <a:pt x="1753" y="201"/>
                  </a:lnTo>
                  <a:lnTo>
                    <a:pt x="1758" y="201"/>
                  </a:lnTo>
                  <a:lnTo>
                    <a:pt x="1758" y="201"/>
                  </a:lnTo>
                  <a:lnTo>
                    <a:pt x="1762" y="302"/>
                  </a:lnTo>
                  <a:lnTo>
                    <a:pt x="1762" y="201"/>
                  </a:lnTo>
                  <a:lnTo>
                    <a:pt x="1767" y="201"/>
                  </a:lnTo>
                  <a:lnTo>
                    <a:pt x="1767" y="201"/>
                  </a:lnTo>
                  <a:lnTo>
                    <a:pt x="1772" y="201"/>
                  </a:lnTo>
                  <a:lnTo>
                    <a:pt x="1772" y="201"/>
                  </a:lnTo>
                  <a:lnTo>
                    <a:pt x="1776" y="201"/>
                  </a:lnTo>
                  <a:lnTo>
                    <a:pt x="1776" y="201"/>
                  </a:lnTo>
                  <a:lnTo>
                    <a:pt x="1781" y="201"/>
                  </a:lnTo>
                  <a:lnTo>
                    <a:pt x="1781" y="201"/>
                  </a:lnTo>
                  <a:lnTo>
                    <a:pt x="1786" y="201"/>
                  </a:lnTo>
                  <a:lnTo>
                    <a:pt x="1786" y="101"/>
                  </a:lnTo>
                  <a:lnTo>
                    <a:pt x="1790" y="101"/>
                  </a:lnTo>
                  <a:lnTo>
                    <a:pt x="1790" y="101"/>
                  </a:lnTo>
                  <a:lnTo>
                    <a:pt x="1790" y="101"/>
                  </a:lnTo>
                  <a:lnTo>
                    <a:pt x="1795" y="101"/>
                  </a:lnTo>
                  <a:lnTo>
                    <a:pt x="1795" y="101"/>
                  </a:lnTo>
                  <a:lnTo>
                    <a:pt x="1800" y="101"/>
                  </a:lnTo>
                  <a:lnTo>
                    <a:pt x="1800" y="101"/>
                  </a:lnTo>
                  <a:lnTo>
                    <a:pt x="1804" y="101"/>
                  </a:lnTo>
                  <a:lnTo>
                    <a:pt x="1804" y="101"/>
                  </a:lnTo>
                  <a:lnTo>
                    <a:pt x="1809" y="101"/>
                  </a:lnTo>
                  <a:lnTo>
                    <a:pt x="1809" y="0"/>
                  </a:lnTo>
                  <a:lnTo>
                    <a:pt x="1813" y="0"/>
                  </a:lnTo>
                  <a:lnTo>
                    <a:pt x="1813" y="0"/>
                  </a:lnTo>
                  <a:lnTo>
                    <a:pt x="1818" y="0"/>
                  </a:lnTo>
                  <a:lnTo>
                    <a:pt x="1818" y="0"/>
                  </a:lnTo>
                  <a:lnTo>
                    <a:pt x="1823" y="0"/>
                  </a:lnTo>
                  <a:lnTo>
                    <a:pt x="1823" y="0"/>
                  </a:lnTo>
                  <a:lnTo>
                    <a:pt x="1827" y="0"/>
                  </a:lnTo>
                  <a:lnTo>
                    <a:pt x="1827" y="101"/>
                  </a:lnTo>
                  <a:lnTo>
                    <a:pt x="1832" y="101"/>
                  </a:lnTo>
                  <a:lnTo>
                    <a:pt x="1832" y="101"/>
                  </a:lnTo>
                  <a:lnTo>
                    <a:pt x="1837" y="101"/>
                  </a:lnTo>
                  <a:lnTo>
                    <a:pt x="1837" y="201"/>
                  </a:lnTo>
                  <a:lnTo>
                    <a:pt x="1841" y="201"/>
                  </a:lnTo>
                  <a:lnTo>
                    <a:pt x="1841" y="201"/>
                  </a:lnTo>
                  <a:lnTo>
                    <a:pt x="1846" y="201"/>
                  </a:lnTo>
                  <a:lnTo>
                    <a:pt x="1846" y="201"/>
                  </a:lnTo>
                  <a:lnTo>
                    <a:pt x="1851" y="201"/>
                  </a:lnTo>
                  <a:lnTo>
                    <a:pt x="1851" y="201"/>
                  </a:lnTo>
                  <a:lnTo>
                    <a:pt x="1855" y="201"/>
                  </a:lnTo>
                  <a:lnTo>
                    <a:pt x="1855" y="201"/>
                  </a:lnTo>
                  <a:lnTo>
                    <a:pt x="1855" y="201"/>
                  </a:lnTo>
                  <a:lnTo>
                    <a:pt x="1860" y="201"/>
                  </a:lnTo>
                  <a:lnTo>
                    <a:pt x="1860" y="201"/>
                  </a:lnTo>
                  <a:lnTo>
                    <a:pt x="1864" y="201"/>
                  </a:lnTo>
                  <a:lnTo>
                    <a:pt x="1864" y="201"/>
                  </a:lnTo>
                  <a:lnTo>
                    <a:pt x="1869" y="201"/>
                  </a:lnTo>
                  <a:lnTo>
                    <a:pt x="1869" y="201"/>
                  </a:lnTo>
                  <a:lnTo>
                    <a:pt x="1874" y="201"/>
                  </a:lnTo>
                  <a:lnTo>
                    <a:pt x="1874" y="201"/>
                  </a:lnTo>
                  <a:lnTo>
                    <a:pt x="1878" y="201"/>
                  </a:lnTo>
                  <a:lnTo>
                    <a:pt x="1878" y="101"/>
                  </a:lnTo>
                  <a:lnTo>
                    <a:pt x="1883" y="101"/>
                  </a:lnTo>
                  <a:lnTo>
                    <a:pt x="1883" y="201"/>
                  </a:lnTo>
                  <a:lnTo>
                    <a:pt x="1888" y="201"/>
                  </a:lnTo>
                  <a:lnTo>
                    <a:pt x="1888" y="201"/>
                  </a:lnTo>
                  <a:lnTo>
                    <a:pt x="1892" y="201"/>
                  </a:lnTo>
                  <a:lnTo>
                    <a:pt x="1892" y="201"/>
                  </a:lnTo>
                  <a:lnTo>
                    <a:pt x="1897" y="201"/>
                  </a:lnTo>
                  <a:lnTo>
                    <a:pt x="1897" y="201"/>
                  </a:lnTo>
                  <a:lnTo>
                    <a:pt x="1902" y="201"/>
                  </a:lnTo>
                  <a:lnTo>
                    <a:pt x="1902" y="201"/>
                  </a:lnTo>
                  <a:lnTo>
                    <a:pt x="1906" y="201"/>
                  </a:lnTo>
                  <a:lnTo>
                    <a:pt x="1906" y="201"/>
                  </a:lnTo>
                  <a:lnTo>
                    <a:pt x="1911" y="201"/>
                  </a:lnTo>
                  <a:lnTo>
                    <a:pt x="1911" y="201"/>
                  </a:lnTo>
                  <a:lnTo>
                    <a:pt x="1915" y="201"/>
                  </a:lnTo>
                  <a:lnTo>
                    <a:pt x="1915" y="201"/>
                  </a:lnTo>
                  <a:lnTo>
                    <a:pt x="1920" y="201"/>
                  </a:lnTo>
                  <a:lnTo>
                    <a:pt x="1920" y="201"/>
                  </a:lnTo>
                  <a:lnTo>
                    <a:pt x="1920" y="201"/>
                  </a:lnTo>
                  <a:lnTo>
                    <a:pt x="1925" y="201"/>
                  </a:lnTo>
                  <a:lnTo>
                    <a:pt x="1925" y="201"/>
                  </a:lnTo>
                  <a:lnTo>
                    <a:pt x="1929" y="201"/>
                  </a:lnTo>
                  <a:lnTo>
                    <a:pt x="1929" y="201"/>
                  </a:lnTo>
                  <a:lnTo>
                    <a:pt x="1934" y="201"/>
                  </a:lnTo>
                  <a:lnTo>
                    <a:pt x="1934" y="201"/>
                  </a:lnTo>
                  <a:lnTo>
                    <a:pt x="1939" y="201"/>
                  </a:lnTo>
                  <a:lnTo>
                    <a:pt x="1939" y="201"/>
                  </a:lnTo>
                  <a:lnTo>
                    <a:pt x="1943" y="101"/>
                  </a:lnTo>
                  <a:lnTo>
                    <a:pt x="1943" y="101"/>
                  </a:lnTo>
                  <a:lnTo>
                    <a:pt x="1948" y="101"/>
                  </a:lnTo>
                  <a:lnTo>
                    <a:pt x="1948" y="101"/>
                  </a:lnTo>
                  <a:lnTo>
                    <a:pt x="1953" y="101"/>
                  </a:lnTo>
                  <a:lnTo>
                    <a:pt x="1953" y="101"/>
                  </a:lnTo>
                  <a:lnTo>
                    <a:pt x="1957" y="101"/>
                  </a:lnTo>
                  <a:lnTo>
                    <a:pt x="1957" y="101"/>
                  </a:lnTo>
                  <a:lnTo>
                    <a:pt x="1962" y="101"/>
                  </a:lnTo>
                  <a:lnTo>
                    <a:pt x="1962" y="101"/>
                  </a:lnTo>
                  <a:lnTo>
                    <a:pt x="1967" y="101"/>
                  </a:lnTo>
                  <a:lnTo>
                    <a:pt x="1967" y="201"/>
                  </a:lnTo>
                  <a:lnTo>
                    <a:pt x="1971" y="201"/>
                  </a:lnTo>
                  <a:lnTo>
                    <a:pt x="1971" y="201"/>
                  </a:lnTo>
                  <a:lnTo>
                    <a:pt x="1976" y="201"/>
                  </a:lnTo>
                  <a:lnTo>
                    <a:pt x="1976" y="201"/>
                  </a:lnTo>
                  <a:lnTo>
                    <a:pt x="1980" y="201"/>
                  </a:lnTo>
                  <a:lnTo>
                    <a:pt x="1980" y="201"/>
                  </a:lnTo>
                  <a:lnTo>
                    <a:pt x="1985" y="201"/>
                  </a:lnTo>
                  <a:lnTo>
                    <a:pt x="1985" y="201"/>
                  </a:lnTo>
                  <a:lnTo>
                    <a:pt x="1990" y="201"/>
                  </a:lnTo>
                  <a:lnTo>
                    <a:pt x="1990" y="201"/>
                  </a:lnTo>
                  <a:lnTo>
                    <a:pt x="1990" y="201"/>
                  </a:lnTo>
                  <a:lnTo>
                    <a:pt x="1994" y="201"/>
                  </a:lnTo>
                  <a:lnTo>
                    <a:pt x="1994" y="201"/>
                  </a:lnTo>
                  <a:lnTo>
                    <a:pt x="1999" y="201"/>
                  </a:lnTo>
                  <a:lnTo>
                    <a:pt x="1999" y="201"/>
                  </a:lnTo>
                  <a:lnTo>
                    <a:pt x="2004" y="201"/>
                  </a:lnTo>
                  <a:lnTo>
                    <a:pt x="2004" y="302"/>
                  </a:lnTo>
                  <a:lnTo>
                    <a:pt x="2008" y="302"/>
                  </a:lnTo>
                  <a:lnTo>
                    <a:pt x="2008" y="302"/>
                  </a:lnTo>
                  <a:lnTo>
                    <a:pt x="2013" y="302"/>
                  </a:lnTo>
                  <a:lnTo>
                    <a:pt x="2013" y="302"/>
                  </a:lnTo>
                  <a:lnTo>
                    <a:pt x="2018" y="302"/>
                  </a:lnTo>
                  <a:lnTo>
                    <a:pt x="2018" y="302"/>
                  </a:lnTo>
                  <a:lnTo>
                    <a:pt x="2022" y="302"/>
                  </a:lnTo>
                  <a:lnTo>
                    <a:pt x="2022" y="302"/>
                  </a:lnTo>
                  <a:lnTo>
                    <a:pt x="2027" y="302"/>
                  </a:lnTo>
                  <a:lnTo>
                    <a:pt x="2027" y="302"/>
                  </a:lnTo>
                  <a:lnTo>
                    <a:pt x="2031" y="302"/>
                  </a:lnTo>
                  <a:lnTo>
                    <a:pt x="2031" y="302"/>
                  </a:lnTo>
                  <a:lnTo>
                    <a:pt x="2036" y="302"/>
                  </a:lnTo>
                  <a:lnTo>
                    <a:pt x="2036" y="302"/>
                  </a:lnTo>
                  <a:lnTo>
                    <a:pt x="2041" y="302"/>
                  </a:lnTo>
                  <a:lnTo>
                    <a:pt x="2041" y="302"/>
                  </a:lnTo>
                  <a:lnTo>
                    <a:pt x="2045" y="302"/>
                  </a:lnTo>
                  <a:lnTo>
                    <a:pt x="2045" y="302"/>
                  </a:lnTo>
                  <a:lnTo>
                    <a:pt x="2050" y="201"/>
                  </a:lnTo>
                  <a:lnTo>
                    <a:pt x="2050" y="201"/>
                  </a:lnTo>
                  <a:lnTo>
                    <a:pt x="2055" y="201"/>
                  </a:lnTo>
                  <a:lnTo>
                    <a:pt x="2055" y="201"/>
                  </a:lnTo>
                  <a:lnTo>
                    <a:pt x="2055" y="201"/>
                  </a:lnTo>
                  <a:lnTo>
                    <a:pt x="2059" y="201"/>
                  </a:lnTo>
                  <a:lnTo>
                    <a:pt x="2059" y="201"/>
                  </a:lnTo>
                  <a:lnTo>
                    <a:pt x="2064" y="201"/>
                  </a:lnTo>
                  <a:lnTo>
                    <a:pt x="2064" y="201"/>
                  </a:lnTo>
                  <a:lnTo>
                    <a:pt x="2069" y="201"/>
                  </a:lnTo>
                  <a:lnTo>
                    <a:pt x="2069" y="201"/>
                  </a:lnTo>
                  <a:lnTo>
                    <a:pt x="2073" y="201"/>
                  </a:lnTo>
                  <a:lnTo>
                    <a:pt x="2073" y="201"/>
                  </a:lnTo>
                  <a:lnTo>
                    <a:pt x="2078" y="201"/>
                  </a:lnTo>
                  <a:lnTo>
                    <a:pt x="2078" y="201"/>
                  </a:lnTo>
                  <a:lnTo>
                    <a:pt x="2082" y="201"/>
                  </a:lnTo>
                  <a:lnTo>
                    <a:pt x="2082" y="201"/>
                  </a:lnTo>
                  <a:lnTo>
                    <a:pt x="2087" y="201"/>
                  </a:lnTo>
                  <a:lnTo>
                    <a:pt x="2087" y="201"/>
                  </a:lnTo>
                  <a:lnTo>
                    <a:pt x="2092" y="201"/>
                  </a:lnTo>
                  <a:lnTo>
                    <a:pt x="2092" y="201"/>
                  </a:lnTo>
                  <a:lnTo>
                    <a:pt x="2096" y="201"/>
                  </a:lnTo>
                  <a:lnTo>
                    <a:pt x="2096" y="201"/>
                  </a:lnTo>
                  <a:lnTo>
                    <a:pt x="2101" y="201"/>
                  </a:lnTo>
                  <a:lnTo>
                    <a:pt x="2101" y="201"/>
                  </a:lnTo>
                  <a:lnTo>
                    <a:pt x="2106" y="201"/>
                  </a:lnTo>
                  <a:lnTo>
                    <a:pt x="2106" y="201"/>
                  </a:lnTo>
                  <a:lnTo>
                    <a:pt x="2110" y="201"/>
                  </a:lnTo>
                  <a:lnTo>
                    <a:pt x="2110" y="302"/>
                  </a:lnTo>
                  <a:lnTo>
                    <a:pt x="2115" y="302"/>
                  </a:lnTo>
                  <a:lnTo>
                    <a:pt x="2115" y="302"/>
                  </a:lnTo>
                  <a:lnTo>
                    <a:pt x="2120" y="302"/>
                  </a:lnTo>
                  <a:lnTo>
                    <a:pt x="2120" y="302"/>
                  </a:lnTo>
                  <a:lnTo>
                    <a:pt x="2120" y="302"/>
                  </a:lnTo>
                  <a:lnTo>
                    <a:pt x="2124" y="302"/>
                  </a:lnTo>
                  <a:lnTo>
                    <a:pt x="2124" y="201"/>
                  </a:lnTo>
                  <a:lnTo>
                    <a:pt x="2129" y="201"/>
                  </a:lnTo>
                  <a:lnTo>
                    <a:pt x="2129" y="201"/>
                  </a:lnTo>
                  <a:lnTo>
                    <a:pt x="2133" y="201"/>
                  </a:lnTo>
                  <a:lnTo>
                    <a:pt x="2133" y="201"/>
                  </a:lnTo>
                  <a:lnTo>
                    <a:pt x="2138" y="201"/>
                  </a:lnTo>
                  <a:lnTo>
                    <a:pt x="2138" y="201"/>
                  </a:lnTo>
                  <a:lnTo>
                    <a:pt x="2143" y="201"/>
                  </a:lnTo>
                  <a:lnTo>
                    <a:pt x="2143" y="201"/>
                  </a:lnTo>
                  <a:lnTo>
                    <a:pt x="2147" y="201"/>
                  </a:lnTo>
                  <a:lnTo>
                    <a:pt x="2147" y="201"/>
                  </a:lnTo>
                  <a:lnTo>
                    <a:pt x="2152" y="201"/>
                  </a:lnTo>
                  <a:lnTo>
                    <a:pt x="2152" y="201"/>
                  </a:lnTo>
                  <a:lnTo>
                    <a:pt x="2157" y="201"/>
                  </a:lnTo>
                  <a:lnTo>
                    <a:pt x="2157" y="201"/>
                  </a:lnTo>
                  <a:lnTo>
                    <a:pt x="2161" y="201"/>
                  </a:lnTo>
                  <a:lnTo>
                    <a:pt x="2161" y="201"/>
                  </a:lnTo>
                  <a:lnTo>
                    <a:pt x="2166" y="302"/>
                  </a:lnTo>
                  <a:lnTo>
                    <a:pt x="2166" y="302"/>
                  </a:lnTo>
                  <a:lnTo>
                    <a:pt x="2171" y="302"/>
                  </a:lnTo>
                  <a:lnTo>
                    <a:pt x="2171" y="302"/>
                  </a:lnTo>
                  <a:lnTo>
                    <a:pt x="2175" y="302"/>
                  </a:lnTo>
                  <a:lnTo>
                    <a:pt x="2175" y="302"/>
                  </a:lnTo>
                  <a:lnTo>
                    <a:pt x="2180" y="302"/>
                  </a:lnTo>
                  <a:lnTo>
                    <a:pt x="2180" y="302"/>
                  </a:lnTo>
                  <a:lnTo>
                    <a:pt x="2184" y="302"/>
                  </a:lnTo>
                  <a:lnTo>
                    <a:pt x="2184" y="302"/>
                  </a:lnTo>
                  <a:lnTo>
                    <a:pt x="2184" y="302"/>
                  </a:lnTo>
                  <a:lnTo>
                    <a:pt x="2189" y="302"/>
                  </a:lnTo>
                  <a:lnTo>
                    <a:pt x="2189" y="302"/>
                  </a:lnTo>
                  <a:lnTo>
                    <a:pt x="2194" y="302"/>
                  </a:lnTo>
                  <a:lnTo>
                    <a:pt x="2194" y="302"/>
                  </a:lnTo>
                  <a:lnTo>
                    <a:pt x="2198" y="403"/>
                  </a:lnTo>
                  <a:lnTo>
                    <a:pt x="2198" y="403"/>
                  </a:lnTo>
                  <a:lnTo>
                    <a:pt x="2203" y="403"/>
                  </a:lnTo>
                  <a:lnTo>
                    <a:pt x="2203" y="504"/>
                  </a:lnTo>
                  <a:lnTo>
                    <a:pt x="2208" y="504"/>
                  </a:lnTo>
                  <a:lnTo>
                    <a:pt x="2208" y="504"/>
                  </a:lnTo>
                  <a:lnTo>
                    <a:pt x="2212" y="504"/>
                  </a:lnTo>
                  <a:lnTo>
                    <a:pt x="2212" y="504"/>
                  </a:lnTo>
                  <a:lnTo>
                    <a:pt x="2217" y="504"/>
                  </a:lnTo>
                  <a:lnTo>
                    <a:pt x="2217" y="504"/>
                  </a:lnTo>
                  <a:lnTo>
                    <a:pt x="2222" y="504"/>
                  </a:lnTo>
                  <a:lnTo>
                    <a:pt x="2222" y="504"/>
                  </a:lnTo>
                  <a:lnTo>
                    <a:pt x="2226" y="504"/>
                  </a:lnTo>
                  <a:lnTo>
                    <a:pt x="2226" y="504"/>
                  </a:lnTo>
                  <a:lnTo>
                    <a:pt x="2231" y="504"/>
                  </a:lnTo>
                  <a:lnTo>
                    <a:pt x="2231" y="504"/>
                  </a:lnTo>
                  <a:lnTo>
                    <a:pt x="2236" y="504"/>
                  </a:lnTo>
                  <a:lnTo>
                    <a:pt x="2236" y="504"/>
                  </a:lnTo>
                  <a:lnTo>
                    <a:pt x="2240" y="604"/>
                  </a:lnTo>
                  <a:lnTo>
                    <a:pt x="2240" y="604"/>
                  </a:lnTo>
                  <a:lnTo>
                    <a:pt x="2245" y="604"/>
                  </a:lnTo>
                  <a:lnTo>
                    <a:pt x="2245" y="604"/>
                  </a:lnTo>
                  <a:lnTo>
                    <a:pt x="2249" y="705"/>
                  </a:lnTo>
                  <a:lnTo>
                    <a:pt x="2249" y="705"/>
                  </a:lnTo>
                  <a:lnTo>
                    <a:pt x="2254" y="705"/>
                  </a:lnTo>
                  <a:lnTo>
                    <a:pt x="2254" y="705"/>
                  </a:lnTo>
                  <a:lnTo>
                    <a:pt x="2254" y="705"/>
                  </a:lnTo>
                  <a:lnTo>
                    <a:pt x="2259" y="705"/>
                  </a:lnTo>
                  <a:lnTo>
                    <a:pt x="2259" y="705"/>
                  </a:lnTo>
                  <a:lnTo>
                    <a:pt x="2263" y="705"/>
                  </a:lnTo>
                  <a:lnTo>
                    <a:pt x="2263" y="705"/>
                  </a:lnTo>
                  <a:lnTo>
                    <a:pt x="2268" y="705"/>
                  </a:lnTo>
                  <a:lnTo>
                    <a:pt x="2268" y="705"/>
                  </a:lnTo>
                  <a:lnTo>
                    <a:pt x="2273" y="705"/>
                  </a:lnTo>
                  <a:lnTo>
                    <a:pt x="2273" y="705"/>
                  </a:lnTo>
                  <a:lnTo>
                    <a:pt x="2277" y="705"/>
                  </a:lnTo>
                  <a:lnTo>
                    <a:pt x="2277" y="705"/>
                  </a:lnTo>
                  <a:lnTo>
                    <a:pt x="2282" y="705"/>
                  </a:lnTo>
                  <a:lnTo>
                    <a:pt x="2282" y="705"/>
                  </a:lnTo>
                  <a:lnTo>
                    <a:pt x="2287" y="705"/>
                  </a:lnTo>
                  <a:lnTo>
                    <a:pt x="2287" y="705"/>
                  </a:lnTo>
                  <a:lnTo>
                    <a:pt x="2291" y="705"/>
                  </a:lnTo>
                  <a:lnTo>
                    <a:pt x="2291" y="705"/>
                  </a:lnTo>
                  <a:lnTo>
                    <a:pt x="2296" y="705"/>
                  </a:lnTo>
                  <a:lnTo>
                    <a:pt x="2296" y="705"/>
                  </a:lnTo>
                  <a:lnTo>
                    <a:pt x="2300" y="705"/>
                  </a:lnTo>
                  <a:lnTo>
                    <a:pt x="2300" y="705"/>
                  </a:lnTo>
                  <a:lnTo>
                    <a:pt x="2305" y="705"/>
                  </a:lnTo>
                  <a:lnTo>
                    <a:pt x="2305" y="705"/>
                  </a:lnTo>
                  <a:lnTo>
                    <a:pt x="2310" y="705"/>
                  </a:lnTo>
                  <a:lnTo>
                    <a:pt x="2310" y="705"/>
                  </a:lnTo>
                  <a:lnTo>
                    <a:pt x="2335" y="705"/>
                  </a:lnTo>
                  <a:lnTo>
                    <a:pt x="2314" y="705"/>
                  </a:lnTo>
                  <a:lnTo>
                    <a:pt x="2319" y="705"/>
                  </a:lnTo>
                  <a:lnTo>
                    <a:pt x="2319" y="705"/>
                  </a:lnTo>
                  <a:lnTo>
                    <a:pt x="2319" y="705"/>
                  </a:lnTo>
                  <a:lnTo>
                    <a:pt x="2319" y="705"/>
                  </a:lnTo>
                  <a:lnTo>
                    <a:pt x="2314" y="705"/>
                  </a:lnTo>
                  <a:lnTo>
                    <a:pt x="2314" y="705"/>
                  </a:lnTo>
                  <a:lnTo>
                    <a:pt x="2310" y="705"/>
                  </a:lnTo>
                  <a:lnTo>
                    <a:pt x="2310" y="705"/>
                  </a:lnTo>
                  <a:lnTo>
                    <a:pt x="2305" y="705"/>
                  </a:lnTo>
                  <a:lnTo>
                    <a:pt x="2305" y="705"/>
                  </a:lnTo>
                  <a:lnTo>
                    <a:pt x="2300" y="705"/>
                  </a:lnTo>
                  <a:lnTo>
                    <a:pt x="2300" y="705"/>
                  </a:lnTo>
                  <a:lnTo>
                    <a:pt x="2296" y="705"/>
                  </a:lnTo>
                  <a:lnTo>
                    <a:pt x="2296" y="705"/>
                  </a:lnTo>
                  <a:lnTo>
                    <a:pt x="2291" y="705"/>
                  </a:lnTo>
                  <a:lnTo>
                    <a:pt x="2291" y="705"/>
                  </a:lnTo>
                  <a:lnTo>
                    <a:pt x="2287" y="705"/>
                  </a:lnTo>
                  <a:lnTo>
                    <a:pt x="2287" y="705"/>
                  </a:lnTo>
                  <a:lnTo>
                    <a:pt x="2282" y="705"/>
                  </a:lnTo>
                  <a:lnTo>
                    <a:pt x="2282" y="705"/>
                  </a:lnTo>
                  <a:lnTo>
                    <a:pt x="2277" y="705"/>
                  </a:lnTo>
                  <a:lnTo>
                    <a:pt x="2277" y="705"/>
                  </a:lnTo>
                  <a:lnTo>
                    <a:pt x="2273" y="705"/>
                  </a:lnTo>
                  <a:lnTo>
                    <a:pt x="2273" y="705"/>
                  </a:lnTo>
                  <a:lnTo>
                    <a:pt x="2268" y="705"/>
                  </a:lnTo>
                  <a:lnTo>
                    <a:pt x="2268" y="705"/>
                  </a:lnTo>
                  <a:lnTo>
                    <a:pt x="2263" y="705"/>
                  </a:lnTo>
                  <a:lnTo>
                    <a:pt x="2263" y="705"/>
                  </a:lnTo>
                  <a:lnTo>
                    <a:pt x="2259" y="705"/>
                  </a:lnTo>
                  <a:lnTo>
                    <a:pt x="2259" y="705"/>
                  </a:lnTo>
                  <a:lnTo>
                    <a:pt x="2254" y="705"/>
                  </a:lnTo>
                  <a:lnTo>
                    <a:pt x="2254" y="705"/>
                  </a:lnTo>
                  <a:lnTo>
                    <a:pt x="2254" y="705"/>
                  </a:lnTo>
                  <a:lnTo>
                    <a:pt x="2249" y="705"/>
                  </a:lnTo>
                  <a:lnTo>
                    <a:pt x="2249" y="705"/>
                  </a:lnTo>
                  <a:lnTo>
                    <a:pt x="2245" y="705"/>
                  </a:lnTo>
                  <a:lnTo>
                    <a:pt x="2245" y="705"/>
                  </a:lnTo>
                  <a:lnTo>
                    <a:pt x="2240" y="705"/>
                  </a:lnTo>
                  <a:lnTo>
                    <a:pt x="2240" y="705"/>
                  </a:lnTo>
                  <a:lnTo>
                    <a:pt x="2236" y="705"/>
                  </a:lnTo>
                  <a:lnTo>
                    <a:pt x="2236" y="705"/>
                  </a:lnTo>
                  <a:lnTo>
                    <a:pt x="2231" y="705"/>
                  </a:lnTo>
                  <a:lnTo>
                    <a:pt x="2231" y="705"/>
                  </a:lnTo>
                  <a:lnTo>
                    <a:pt x="2226" y="705"/>
                  </a:lnTo>
                  <a:lnTo>
                    <a:pt x="2226" y="705"/>
                  </a:lnTo>
                  <a:lnTo>
                    <a:pt x="2222" y="705"/>
                  </a:lnTo>
                  <a:lnTo>
                    <a:pt x="2222" y="705"/>
                  </a:lnTo>
                  <a:lnTo>
                    <a:pt x="2217" y="705"/>
                  </a:lnTo>
                  <a:lnTo>
                    <a:pt x="2217" y="705"/>
                  </a:lnTo>
                  <a:lnTo>
                    <a:pt x="2212" y="705"/>
                  </a:lnTo>
                  <a:lnTo>
                    <a:pt x="2212" y="705"/>
                  </a:lnTo>
                  <a:lnTo>
                    <a:pt x="2208" y="705"/>
                  </a:lnTo>
                  <a:lnTo>
                    <a:pt x="2208" y="705"/>
                  </a:lnTo>
                  <a:lnTo>
                    <a:pt x="2203" y="705"/>
                  </a:lnTo>
                  <a:lnTo>
                    <a:pt x="2203" y="705"/>
                  </a:lnTo>
                  <a:lnTo>
                    <a:pt x="2198" y="705"/>
                  </a:lnTo>
                  <a:lnTo>
                    <a:pt x="2198" y="705"/>
                  </a:lnTo>
                  <a:lnTo>
                    <a:pt x="2194" y="705"/>
                  </a:lnTo>
                  <a:lnTo>
                    <a:pt x="2194" y="705"/>
                  </a:lnTo>
                  <a:lnTo>
                    <a:pt x="2189" y="705"/>
                  </a:lnTo>
                  <a:lnTo>
                    <a:pt x="2189" y="705"/>
                  </a:lnTo>
                  <a:lnTo>
                    <a:pt x="2184" y="705"/>
                  </a:lnTo>
                  <a:lnTo>
                    <a:pt x="2184" y="705"/>
                  </a:lnTo>
                  <a:lnTo>
                    <a:pt x="2184" y="705"/>
                  </a:lnTo>
                  <a:lnTo>
                    <a:pt x="2180" y="705"/>
                  </a:lnTo>
                  <a:lnTo>
                    <a:pt x="2180" y="705"/>
                  </a:lnTo>
                  <a:lnTo>
                    <a:pt x="2175" y="705"/>
                  </a:lnTo>
                  <a:lnTo>
                    <a:pt x="2175" y="705"/>
                  </a:lnTo>
                  <a:lnTo>
                    <a:pt x="2171" y="705"/>
                  </a:lnTo>
                  <a:lnTo>
                    <a:pt x="2171" y="705"/>
                  </a:lnTo>
                  <a:lnTo>
                    <a:pt x="2166" y="705"/>
                  </a:lnTo>
                  <a:lnTo>
                    <a:pt x="2166" y="705"/>
                  </a:lnTo>
                  <a:lnTo>
                    <a:pt x="2161" y="705"/>
                  </a:lnTo>
                  <a:lnTo>
                    <a:pt x="2161" y="705"/>
                  </a:lnTo>
                  <a:lnTo>
                    <a:pt x="2157" y="705"/>
                  </a:lnTo>
                  <a:lnTo>
                    <a:pt x="2157" y="705"/>
                  </a:lnTo>
                  <a:lnTo>
                    <a:pt x="2152" y="705"/>
                  </a:lnTo>
                  <a:lnTo>
                    <a:pt x="2152" y="705"/>
                  </a:lnTo>
                  <a:lnTo>
                    <a:pt x="2147" y="705"/>
                  </a:lnTo>
                  <a:lnTo>
                    <a:pt x="2147" y="705"/>
                  </a:lnTo>
                  <a:lnTo>
                    <a:pt x="2143" y="705"/>
                  </a:lnTo>
                  <a:lnTo>
                    <a:pt x="2143" y="705"/>
                  </a:lnTo>
                  <a:lnTo>
                    <a:pt x="2138" y="705"/>
                  </a:lnTo>
                  <a:lnTo>
                    <a:pt x="2138" y="705"/>
                  </a:lnTo>
                  <a:lnTo>
                    <a:pt x="2133" y="705"/>
                  </a:lnTo>
                  <a:lnTo>
                    <a:pt x="2133" y="705"/>
                  </a:lnTo>
                  <a:lnTo>
                    <a:pt x="2129" y="705"/>
                  </a:lnTo>
                  <a:lnTo>
                    <a:pt x="2129" y="705"/>
                  </a:lnTo>
                  <a:lnTo>
                    <a:pt x="2124" y="705"/>
                  </a:lnTo>
                  <a:lnTo>
                    <a:pt x="2124" y="705"/>
                  </a:lnTo>
                  <a:lnTo>
                    <a:pt x="2120" y="705"/>
                  </a:lnTo>
                  <a:lnTo>
                    <a:pt x="2120" y="705"/>
                  </a:lnTo>
                  <a:lnTo>
                    <a:pt x="2120" y="705"/>
                  </a:lnTo>
                  <a:lnTo>
                    <a:pt x="2115" y="705"/>
                  </a:lnTo>
                  <a:lnTo>
                    <a:pt x="2115" y="705"/>
                  </a:lnTo>
                  <a:lnTo>
                    <a:pt x="2110" y="705"/>
                  </a:lnTo>
                  <a:lnTo>
                    <a:pt x="2110" y="705"/>
                  </a:lnTo>
                  <a:lnTo>
                    <a:pt x="2106" y="705"/>
                  </a:lnTo>
                  <a:lnTo>
                    <a:pt x="2106" y="705"/>
                  </a:lnTo>
                  <a:lnTo>
                    <a:pt x="2101" y="705"/>
                  </a:lnTo>
                  <a:lnTo>
                    <a:pt x="2101" y="705"/>
                  </a:lnTo>
                  <a:lnTo>
                    <a:pt x="2096" y="705"/>
                  </a:lnTo>
                  <a:lnTo>
                    <a:pt x="2096" y="705"/>
                  </a:lnTo>
                  <a:lnTo>
                    <a:pt x="2092" y="705"/>
                  </a:lnTo>
                  <a:lnTo>
                    <a:pt x="2092" y="705"/>
                  </a:lnTo>
                  <a:lnTo>
                    <a:pt x="2087" y="705"/>
                  </a:lnTo>
                  <a:lnTo>
                    <a:pt x="2087" y="705"/>
                  </a:lnTo>
                  <a:lnTo>
                    <a:pt x="2082" y="705"/>
                  </a:lnTo>
                  <a:lnTo>
                    <a:pt x="2082" y="705"/>
                  </a:lnTo>
                  <a:lnTo>
                    <a:pt x="2078" y="705"/>
                  </a:lnTo>
                  <a:lnTo>
                    <a:pt x="2078" y="705"/>
                  </a:lnTo>
                  <a:lnTo>
                    <a:pt x="2073" y="705"/>
                  </a:lnTo>
                  <a:lnTo>
                    <a:pt x="2073" y="705"/>
                  </a:lnTo>
                  <a:lnTo>
                    <a:pt x="2069" y="705"/>
                  </a:lnTo>
                  <a:lnTo>
                    <a:pt x="2069" y="705"/>
                  </a:lnTo>
                  <a:lnTo>
                    <a:pt x="2064" y="705"/>
                  </a:lnTo>
                  <a:lnTo>
                    <a:pt x="2064" y="705"/>
                  </a:lnTo>
                  <a:lnTo>
                    <a:pt x="2059" y="705"/>
                  </a:lnTo>
                  <a:lnTo>
                    <a:pt x="2059" y="705"/>
                  </a:lnTo>
                  <a:lnTo>
                    <a:pt x="2055" y="705"/>
                  </a:lnTo>
                  <a:lnTo>
                    <a:pt x="2055" y="705"/>
                  </a:lnTo>
                  <a:lnTo>
                    <a:pt x="2055" y="705"/>
                  </a:lnTo>
                  <a:lnTo>
                    <a:pt x="2050" y="705"/>
                  </a:lnTo>
                  <a:lnTo>
                    <a:pt x="2050" y="705"/>
                  </a:lnTo>
                  <a:lnTo>
                    <a:pt x="2045" y="705"/>
                  </a:lnTo>
                  <a:lnTo>
                    <a:pt x="2045" y="705"/>
                  </a:lnTo>
                  <a:lnTo>
                    <a:pt x="2041" y="705"/>
                  </a:lnTo>
                  <a:lnTo>
                    <a:pt x="2041" y="705"/>
                  </a:lnTo>
                  <a:lnTo>
                    <a:pt x="2036" y="705"/>
                  </a:lnTo>
                  <a:lnTo>
                    <a:pt x="2036" y="705"/>
                  </a:lnTo>
                  <a:lnTo>
                    <a:pt x="2031" y="705"/>
                  </a:lnTo>
                  <a:lnTo>
                    <a:pt x="2031" y="705"/>
                  </a:lnTo>
                  <a:lnTo>
                    <a:pt x="2027" y="705"/>
                  </a:lnTo>
                  <a:lnTo>
                    <a:pt x="2027" y="705"/>
                  </a:lnTo>
                  <a:lnTo>
                    <a:pt x="2022" y="705"/>
                  </a:lnTo>
                  <a:lnTo>
                    <a:pt x="2022" y="705"/>
                  </a:lnTo>
                  <a:lnTo>
                    <a:pt x="2018" y="705"/>
                  </a:lnTo>
                  <a:lnTo>
                    <a:pt x="2018" y="705"/>
                  </a:lnTo>
                  <a:lnTo>
                    <a:pt x="2013" y="705"/>
                  </a:lnTo>
                  <a:lnTo>
                    <a:pt x="2013" y="705"/>
                  </a:lnTo>
                  <a:lnTo>
                    <a:pt x="2008" y="705"/>
                  </a:lnTo>
                  <a:lnTo>
                    <a:pt x="2008" y="705"/>
                  </a:lnTo>
                  <a:lnTo>
                    <a:pt x="2004" y="705"/>
                  </a:lnTo>
                  <a:lnTo>
                    <a:pt x="2004" y="705"/>
                  </a:lnTo>
                  <a:lnTo>
                    <a:pt x="1999" y="705"/>
                  </a:lnTo>
                  <a:lnTo>
                    <a:pt x="1999" y="705"/>
                  </a:lnTo>
                  <a:lnTo>
                    <a:pt x="1994" y="705"/>
                  </a:lnTo>
                  <a:lnTo>
                    <a:pt x="1994" y="705"/>
                  </a:lnTo>
                  <a:lnTo>
                    <a:pt x="1990" y="705"/>
                  </a:lnTo>
                  <a:lnTo>
                    <a:pt x="1990" y="705"/>
                  </a:lnTo>
                  <a:lnTo>
                    <a:pt x="1990" y="705"/>
                  </a:lnTo>
                  <a:lnTo>
                    <a:pt x="1985" y="705"/>
                  </a:lnTo>
                  <a:lnTo>
                    <a:pt x="1985" y="705"/>
                  </a:lnTo>
                  <a:lnTo>
                    <a:pt x="1980" y="705"/>
                  </a:lnTo>
                  <a:lnTo>
                    <a:pt x="1980" y="705"/>
                  </a:lnTo>
                  <a:lnTo>
                    <a:pt x="1976" y="705"/>
                  </a:lnTo>
                  <a:lnTo>
                    <a:pt x="1976" y="705"/>
                  </a:lnTo>
                  <a:lnTo>
                    <a:pt x="1971" y="705"/>
                  </a:lnTo>
                  <a:lnTo>
                    <a:pt x="1971" y="705"/>
                  </a:lnTo>
                  <a:lnTo>
                    <a:pt x="1967" y="705"/>
                  </a:lnTo>
                  <a:lnTo>
                    <a:pt x="1967" y="705"/>
                  </a:lnTo>
                  <a:lnTo>
                    <a:pt x="1962" y="705"/>
                  </a:lnTo>
                  <a:lnTo>
                    <a:pt x="1962" y="705"/>
                  </a:lnTo>
                  <a:lnTo>
                    <a:pt x="1957" y="705"/>
                  </a:lnTo>
                  <a:lnTo>
                    <a:pt x="1957" y="705"/>
                  </a:lnTo>
                  <a:lnTo>
                    <a:pt x="1953" y="705"/>
                  </a:lnTo>
                  <a:lnTo>
                    <a:pt x="1953" y="705"/>
                  </a:lnTo>
                  <a:lnTo>
                    <a:pt x="1948" y="705"/>
                  </a:lnTo>
                  <a:lnTo>
                    <a:pt x="1948" y="705"/>
                  </a:lnTo>
                  <a:lnTo>
                    <a:pt x="1943" y="705"/>
                  </a:lnTo>
                  <a:lnTo>
                    <a:pt x="1943" y="705"/>
                  </a:lnTo>
                  <a:lnTo>
                    <a:pt x="1939" y="705"/>
                  </a:lnTo>
                  <a:lnTo>
                    <a:pt x="1939" y="705"/>
                  </a:lnTo>
                  <a:lnTo>
                    <a:pt x="1934" y="705"/>
                  </a:lnTo>
                  <a:lnTo>
                    <a:pt x="1934" y="705"/>
                  </a:lnTo>
                  <a:lnTo>
                    <a:pt x="1929" y="705"/>
                  </a:lnTo>
                  <a:lnTo>
                    <a:pt x="1929" y="705"/>
                  </a:lnTo>
                  <a:lnTo>
                    <a:pt x="1925" y="705"/>
                  </a:lnTo>
                  <a:lnTo>
                    <a:pt x="1925" y="705"/>
                  </a:lnTo>
                  <a:lnTo>
                    <a:pt x="1920" y="705"/>
                  </a:lnTo>
                  <a:lnTo>
                    <a:pt x="1920" y="705"/>
                  </a:lnTo>
                  <a:lnTo>
                    <a:pt x="1920" y="705"/>
                  </a:lnTo>
                  <a:lnTo>
                    <a:pt x="1915" y="705"/>
                  </a:lnTo>
                  <a:lnTo>
                    <a:pt x="1915" y="705"/>
                  </a:lnTo>
                  <a:lnTo>
                    <a:pt x="1911" y="705"/>
                  </a:lnTo>
                  <a:lnTo>
                    <a:pt x="1911" y="705"/>
                  </a:lnTo>
                  <a:lnTo>
                    <a:pt x="1906" y="705"/>
                  </a:lnTo>
                  <a:lnTo>
                    <a:pt x="1906" y="705"/>
                  </a:lnTo>
                  <a:lnTo>
                    <a:pt x="1902" y="705"/>
                  </a:lnTo>
                  <a:lnTo>
                    <a:pt x="1902" y="705"/>
                  </a:lnTo>
                  <a:lnTo>
                    <a:pt x="1897" y="705"/>
                  </a:lnTo>
                  <a:lnTo>
                    <a:pt x="1897" y="705"/>
                  </a:lnTo>
                  <a:lnTo>
                    <a:pt x="1892" y="705"/>
                  </a:lnTo>
                  <a:lnTo>
                    <a:pt x="1892" y="705"/>
                  </a:lnTo>
                  <a:lnTo>
                    <a:pt x="1888" y="705"/>
                  </a:lnTo>
                  <a:lnTo>
                    <a:pt x="1888" y="705"/>
                  </a:lnTo>
                  <a:lnTo>
                    <a:pt x="1883" y="705"/>
                  </a:lnTo>
                  <a:lnTo>
                    <a:pt x="1883" y="705"/>
                  </a:lnTo>
                  <a:lnTo>
                    <a:pt x="1878" y="705"/>
                  </a:lnTo>
                  <a:lnTo>
                    <a:pt x="1878" y="705"/>
                  </a:lnTo>
                  <a:lnTo>
                    <a:pt x="1874" y="705"/>
                  </a:lnTo>
                  <a:lnTo>
                    <a:pt x="1874" y="705"/>
                  </a:lnTo>
                  <a:lnTo>
                    <a:pt x="1869" y="705"/>
                  </a:lnTo>
                  <a:lnTo>
                    <a:pt x="1869" y="705"/>
                  </a:lnTo>
                  <a:lnTo>
                    <a:pt x="1864" y="705"/>
                  </a:lnTo>
                  <a:lnTo>
                    <a:pt x="1864" y="705"/>
                  </a:lnTo>
                  <a:lnTo>
                    <a:pt x="1860" y="705"/>
                  </a:lnTo>
                  <a:lnTo>
                    <a:pt x="1860" y="705"/>
                  </a:lnTo>
                  <a:lnTo>
                    <a:pt x="1855" y="705"/>
                  </a:lnTo>
                  <a:lnTo>
                    <a:pt x="1855" y="705"/>
                  </a:lnTo>
                  <a:lnTo>
                    <a:pt x="1855" y="705"/>
                  </a:lnTo>
                  <a:lnTo>
                    <a:pt x="1851" y="705"/>
                  </a:lnTo>
                  <a:lnTo>
                    <a:pt x="1851" y="705"/>
                  </a:lnTo>
                  <a:lnTo>
                    <a:pt x="1846" y="705"/>
                  </a:lnTo>
                  <a:lnTo>
                    <a:pt x="1846" y="705"/>
                  </a:lnTo>
                  <a:lnTo>
                    <a:pt x="1841" y="705"/>
                  </a:lnTo>
                  <a:lnTo>
                    <a:pt x="1841" y="705"/>
                  </a:lnTo>
                  <a:lnTo>
                    <a:pt x="1837" y="705"/>
                  </a:lnTo>
                  <a:lnTo>
                    <a:pt x="1837" y="705"/>
                  </a:lnTo>
                  <a:lnTo>
                    <a:pt x="1832" y="705"/>
                  </a:lnTo>
                  <a:lnTo>
                    <a:pt x="1832" y="705"/>
                  </a:lnTo>
                  <a:lnTo>
                    <a:pt x="1827" y="705"/>
                  </a:lnTo>
                  <a:lnTo>
                    <a:pt x="1827" y="705"/>
                  </a:lnTo>
                  <a:lnTo>
                    <a:pt x="1823" y="705"/>
                  </a:lnTo>
                  <a:lnTo>
                    <a:pt x="1823" y="705"/>
                  </a:lnTo>
                  <a:lnTo>
                    <a:pt x="1818" y="705"/>
                  </a:lnTo>
                  <a:lnTo>
                    <a:pt x="1818" y="705"/>
                  </a:lnTo>
                  <a:lnTo>
                    <a:pt x="1813" y="705"/>
                  </a:lnTo>
                  <a:lnTo>
                    <a:pt x="1813" y="705"/>
                  </a:lnTo>
                  <a:lnTo>
                    <a:pt x="1809" y="705"/>
                  </a:lnTo>
                  <a:lnTo>
                    <a:pt x="1809" y="705"/>
                  </a:lnTo>
                  <a:lnTo>
                    <a:pt x="1804" y="705"/>
                  </a:lnTo>
                  <a:lnTo>
                    <a:pt x="1804" y="705"/>
                  </a:lnTo>
                  <a:lnTo>
                    <a:pt x="1800" y="705"/>
                  </a:lnTo>
                  <a:lnTo>
                    <a:pt x="1800" y="705"/>
                  </a:lnTo>
                  <a:lnTo>
                    <a:pt x="1795" y="705"/>
                  </a:lnTo>
                  <a:lnTo>
                    <a:pt x="1795" y="705"/>
                  </a:lnTo>
                  <a:lnTo>
                    <a:pt x="1790" y="705"/>
                  </a:lnTo>
                  <a:lnTo>
                    <a:pt x="1790" y="705"/>
                  </a:lnTo>
                  <a:lnTo>
                    <a:pt x="1790" y="705"/>
                  </a:lnTo>
                  <a:lnTo>
                    <a:pt x="1786" y="705"/>
                  </a:lnTo>
                  <a:lnTo>
                    <a:pt x="1786" y="705"/>
                  </a:lnTo>
                  <a:lnTo>
                    <a:pt x="1781" y="705"/>
                  </a:lnTo>
                  <a:lnTo>
                    <a:pt x="1781" y="705"/>
                  </a:lnTo>
                  <a:lnTo>
                    <a:pt x="1776" y="705"/>
                  </a:lnTo>
                  <a:lnTo>
                    <a:pt x="1776" y="705"/>
                  </a:lnTo>
                  <a:lnTo>
                    <a:pt x="1772" y="705"/>
                  </a:lnTo>
                  <a:lnTo>
                    <a:pt x="1772" y="705"/>
                  </a:lnTo>
                  <a:lnTo>
                    <a:pt x="1767" y="705"/>
                  </a:lnTo>
                  <a:lnTo>
                    <a:pt x="1767" y="705"/>
                  </a:lnTo>
                  <a:lnTo>
                    <a:pt x="1762" y="705"/>
                  </a:lnTo>
                  <a:lnTo>
                    <a:pt x="1762" y="705"/>
                  </a:lnTo>
                  <a:lnTo>
                    <a:pt x="1758" y="705"/>
                  </a:lnTo>
                  <a:lnTo>
                    <a:pt x="1758" y="705"/>
                  </a:lnTo>
                  <a:lnTo>
                    <a:pt x="1753" y="705"/>
                  </a:lnTo>
                  <a:lnTo>
                    <a:pt x="1753" y="705"/>
                  </a:lnTo>
                  <a:lnTo>
                    <a:pt x="1749" y="705"/>
                  </a:lnTo>
                  <a:lnTo>
                    <a:pt x="1749" y="705"/>
                  </a:lnTo>
                  <a:lnTo>
                    <a:pt x="1744" y="705"/>
                  </a:lnTo>
                  <a:lnTo>
                    <a:pt x="1744" y="705"/>
                  </a:lnTo>
                  <a:lnTo>
                    <a:pt x="1739" y="705"/>
                  </a:lnTo>
                  <a:lnTo>
                    <a:pt x="1739" y="705"/>
                  </a:lnTo>
                  <a:lnTo>
                    <a:pt x="1735" y="705"/>
                  </a:lnTo>
                  <a:lnTo>
                    <a:pt x="1735" y="705"/>
                  </a:lnTo>
                  <a:lnTo>
                    <a:pt x="1730" y="705"/>
                  </a:lnTo>
                  <a:lnTo>
                    <a:pt x="1730" y="705"/>
                  </a:lnTo>
                  <a:lnTo>
                    <a:pt x="1725" y="705"/>
                  </a:lnTo>
                  <a:lnTo>
                    <a:pt x="1725" y="705"/>
                  </a:lnTo>
                  <a:lnTo>
                    <a:pt x="1721" y="705"/>
                  </a:lnTo>
                  <a:lnTo>
                    <a:pt x="1721" y="705"/>
                  </a:lnTo>
                  <a:lnTo>
                    <a:pt x="1721" y="705"/>
                  </a:lnTo>
                  <a:lnTo>
                    <a:pt x="1716" y="705"/>
                  </a:lnTo>
                  <a:lnTo>
                    <a:pt x="1716" y="705"/>
                  </a:lnTo>
                  <a:lnTo>
                    <a:pt x="1711" y="705"/>
                  </a:lnTo>
                  <a:lnTo>
                    <a:pt x="1711" y="705"/>
                  </a:lnTo>
                  <a:lnTo>
                    <a:pt x="1707" y="705"/>
                  </a:lnTo>
                  <a:lnTo>
                    <a:pt x="1707" y="705"/>
                  </a:lnTo>
                  <a:lnTo>
                    <a:pt x="1702" y="705"/>
                  </a:lnTo>
                  <a:lnTo>
                    <a:pt x="1702" y="705"/>
                  </a:lnTo>
                  <a:lnTo>
                    <a:pt x="1698" y="705"/>
                  </a:lnTo>
                  <a:lnTo>
                    <a:pt x="1698" y="705"/>
                  </a:lnTo>
                  <a:lnTo>
                    <a:pt x="1693" y="705"/>
                  </a:lnTo>
                  <a:lnTo>
                    <a:pt x="1693" y="705"/>
                  </a:lnTo>
                  <a:lnTo>
                    <a:pt x="1688" y="705"/>
                  </a:lnTo>
                  <a:lnTo>
                    <a:pt x="1688" y="705"/>
                  </a:lnTo>
                  <a:lnTo>
                    <a:pt x="1684" y="705"/>
                  </a:lnTo>
                  <a:lnTo>
                    <a:pt x="1684" y="705"/>
                  </a:lnTo>
                  <a:lnTo>
                    <a:pt x="1679" y="705"/>
                  </a:lnTo>
                  <a:lnTo>
                    <a:pt x="1679" y="705"/>
                  </a:lnTo>
                  <a:lnTo>
                    <a:pt x="1674" y="705"/>
                  </a:lnTo>
                  <a:lnTo>
                    <a:pt x="1674" y="705"/>
                  </a:lnTo>
                  <a:lnTo>
                    <a:pt x="1670" y="705"/>
                  </a:lnTo>
                  <a:lnTo>
                    <a:pt x="1670" y="705"/>
                  </a:lnTo>
                  <a:lnTo>
                    <a:pt x="1665" y="705"/>
                  </a:lnTo>
                  <a:lnTo>
                    <a:pt x="1665" y="705"/>
                  </a:lnTo>
                  <a:lnTo>
                    <a:pt x="1660" y="705"/>
                  </a:lnTo>
                  <a:lnTo>
                    <a:pt x="1660" y="705"/>
                  </a:lnTo>
                  <a:lnTo>
                    <a:pt x="1656" y="705"/>
                  </a:lnTo>
                  <a:lnTo>
                    <a:pt x="1656" y="705"/>
                  </a:lnTo>
                  <a:lnTo>
                    <a:pt x="1656" y="705"/>
                  </a:lnTo>
                  <a:lnTo>
                    <a:pt x="1651" y="705"/>
                  </a:lnTo>
                  <a:lnTo>
                    <a:pt x="1651" y="705"/>
                  </a:lnTo>
                  <a:lnTo>
                    <a:pt x="1646" y="705"/>
                  </a:lnTo>
                  <a:lnTo>
                    <a:pt x="1646" y="705"/>
                  </a:lnTo>
                  <a:lnTo>
                    <a:pt x="1642" y="705"/>
                  </a:lnTo>
                  <a:lnTo>
                    <a:pt x="1642" y="705"/>
                  </a:lnTo>
                  <a:lnTo>
                    <a:pt x="1637" y="705"/>
                  </a:lnTo>
                  <a:lnTo>
                    <a:pt x="1637" y="705"/>
                  </a:lnTo>
                  <a:lnTo>
                    <a:pt x="1633" y="705"/>
                  </a:lnTo>
                  <a:lnTo>
                    <a:pt x="1633" y="705"/>
                  </a:lnTo>
                  <a:lnTo>
                    <a:pt x="1628" y="705"/>
                  </a:lnTo>
                  <a:lnTo>
                    <a:pt x="1628" y="705"/>
                  </a:lnTo>
                  <a:lnTo>
                    <a:pt x="1623" y="705"/>
                  </a:lnTo>
                  <a:lnTo>
                    <a:pt x="1623" y="705"/>
                  </a:lnTo>
                  <a:lnTo>
                    <a:pt x="1619" y="705"/>
                  </a:lnTo>
                  <a:lnTo>
                    <a:pt x="1619" y="705"/>
                  </a:lnTo>
                  <a:lnTo>
                    <a:pt x="1614" y="705"/>
                  </a:lnTo>
                  <a:lnTo>
                    <a:pt x="1614" y="705"/>
                  </a:lnTo>
                  <a:lnTo>
                    <a:pt x="1609" y="705"/>
                  </a:lnTo>
                  <a:lnTo>
                    <a:pt x="1609" y="705"/>
                  </a:lnTo>
                  <a:lnTo>
                    <a:pt x="1605" y="705"/>
                  </a:lnTo>
                  <a:lnTo>
                    <a:pt x="1605" y="705"/>
                  </a:lnTo>
                  <a:lnTo>
                    <a:pt x="1600" y="705"/>
                  </a:lnTo>
                  <a:lnTo>
                    <a:pt x="1600" y="705"/>
                  </a:lnTo>
                  <a:lnTo>
                    <a:pt x="1595" y="705"/>
                  </a:lnTo>
                  <a:lnTo>
                    <a:pt x="1595" y="705"/>
                  </a:lnTo>
                  <a:lnTo>
                    <a:pt x="1591" y="705"/>
                  </a:lnTo>
                  <a:lnTo>
                    <a:pt x="1591" y="705"/>
                  </a:lnTo>
                  <a:lnTo>
                    <a:pt x="1591" y="705"/>
                  </a:lnTo>
                  <a:lnTo>
                    <a:pt x="1586" y="705"/>
                  </a:lnTo>
                  <a:lnTo>
                    <a:pt x="1586" y="705"/>
                  </a:lnTo>
                  <a:lnTo>
                    <a:pt x="1582" y="705"/>
                  </a:lnTo>
                  <a:lnTo>
                    <a:pt x="1582" y="705"/>
                  </a:lnTo>
                  <a:lnTo>
                    <a:pt x="1577" y="705"/>
                  </a:lnTo>
                  <a:lnTo>
                    <a:pt x="1577" y="705"/>
                  </a:lnTo>
                  <a:lnTo>
                    <a:pt x="1572" y="705"/>
                  </a:lnTo>
                  <a:lnTo>
                    <a:pt x="1572" y="705"/>
                  </a:lnTo>
                  <a:lnTo>
                    <a:pt x="1568" y="705"/>
                  </a:lnTo>
                  <a:lnTo>
                    <a:pt x="1568" y="705"/>
                  </a:lnTo>
                  <a:lnTo>
                    <a:pt x="1563" y="705"/>
                  </a:lnTo>
                  <a:lnTo>
                    <a:pt x="1563" y="705"/>
                  </a:lnTo>
                  <a:lnTo>
                    <a:pt x="1558" y="705"/>
                  </a:lnTo>
                  <a:lnTo>
                    <a:pt x="1558" y="705"/>
                  </a:lnTo>
                  <a:lnTo>
                    <a:pt x="1554" y="705"/>
                  </a:lnTo>
                  <a:lnTo>
                    <a:pt x="1554" y="705"/>
                  </a:lnTo>
                  <a:lnTo>
                    <a:pt x="1549" y="705"/>
                  </a:lnTo>
                  <a:lnTo>
                    <a:pt x="1549" y="705"/>
                  </a:lnTo>
                  <a:lnTo>
                    <a:pt x="1544" y="705"/>
                  </a:lnTo>
                  <a:lnTo>
                    <a:pt x="1544" y="705"/>
                  </a:lnTo>
                  <a:lnTo>
                    <a:pt x="1540" y="705"/>
                  </a:lnTo>
                  <a:lnTo>
                    <a:pt x="1540" y="705"/>
                  </a:lnTo>
                  <a:lnTo>
                    <a:pt x="1535" y="705"/>
                  </a:lnTo>
                  <a:lnTo>
                    <a:pt x="1535" y="705"/>
                  </a:lnTo>
                  <a:lnTo>
                    <a:pt x="1531" y="705"/>
                  </a:lnTo>
                  <a:lnTo>
                    <a:pt x="1531" y="705"/>
                  </a:lnTo>
                  <a:lnTo>
                    <a:pt x="1526" y="705"/>
                  </a:lnTo>
                  <a:lnTo>
                    <a:pt x="1526" y="705"/>
                  </a:lnTo>
                  <a:lnTo>
                    <a:pt x="1526" y="705"/>
                  </a:lnTo>
                  <a:lnTo>
                    <a:pt x="1521" y="705"/>
                  </a:lnTo>
                  <a:lnTo>
                    <a:pt x="1521" y="705"/>
                  </a:lnTo>
                  <a:lnTo>
                    <a:pt x="1517" y="705"/>
                  </a:lnTo>
                  <a:lnTo>
                    <a:pt x="1517" y="705"/>
                  </a:lnTo>
                  <a:lnTo>
                    <a:pt x="1512" y="705"/>
                  </a:lnTo>
                  <a:lnTo>
                    <a:pt x="1512" y="705"/>
                  </a:lnTo>
                  <a:lnTo>
                    <a:pt x="1507" y="705"/>
                  </a:lnTo>
                  <a:lnTo>
                    <a:pt x="1507" y="705"/>
                  </a:lnTo>
                  <a:lnTo>
                    <a:pt x="1503" y="705"/>
                  </a:lnTo>
                  <a:lnTo>
                    <a:pt x="1503" y="705"/>
                  </a:lnTo>
                  <a:lnTo>
                    <a:pt x="1498" y="705"/>
                  </a:lnTo>
                  <a:lnTo>
                    <a:pt x="1498" y="705"/>
                  </a:lnTo>
                  <a:lnTo>
                    <a:pt x="1493" y="705"/>
                  </a:lnTo>
                  <a:lnTo>
                    <a:pt x="1493" y="705"/>
                  </a:lnTo>
                  <a:lnTo>
                    <a:pt x="1489" y="705"/>
                  </a:lnTo>
                  <a:lnTo>
                    <a:pt x="1489" y="705"/>
                  </a:lnTo>
                  <a:lnTo>
                    <a:pt x="1484" y="705"/>
                  </a:lnTo>
                  <a:lnTo>
                    <a:pt x="1484" y="705"/>
                  </a:lnTo>
                  <a:lnTo>
                    <a:pt x="1480" y="705"/>
                  </a:lnTo>
                  <a:lnTo>
                    <a:pt x="1480" y="705"/>
                  </a:lnTo>
                  <a:lnTo>
                    <a:pt x="1475" y="705"/>
                  </a:lnTo>
                  <a:lnTo>
                    <a:pt x="1475" y="705"/>
                  </a:lnTo>
                  <a:lnTo>
                    <a:pt x="1470" y="705"/>
                  </a:lnTo>
                  <a:lnTo>
                    <a:pt x="1470" y="705"/>
                  </a:lnTo>
                  <a:lnTo>
                    <a:pt x="1466" y="705"/>
                  </a:lnTo>
                  <a:lnTo>
                    <a:pt x="1466" y="705"/>
                  </a:lnTo>
                  <a:lnTo>
                    <a:pt x="1461" y="705"/>
                  </a:lnTo>
                  <a:lnTo>
                    <a:pt x="1461" y="705"/>
                  </a:lnTo>
                  <a:lnTo>
                    <a:pt x="1456" y="705"/>
                  </a:lnTo>
                  <a:lnTo>
                    <a:pt x="1456" y="705"/>
                  </a:lnTo>
                  <a:lnTo>
                    <a:pt x="1456" y="705"/>
                  </a:lnTo>
                  <a:lnTo>
                    <a:pt x="1452" y="705"/>
                  </a:lnTo>
                  <a:lnTo>
                    <a:pt x="1452" y="705"/>
                  </a:lnTo>
                  <a:lnTo>
                    <a:pt x="1447" y="705"/>
                  </a:lnTo>
                  <a:lnTo>
                    <a:pt x="1447" y="705"/>
                  </a:lnTo>
                  <a:lnTo>
                    <a:pt x="1442" y="705"/>
                  </a:lnTo>
                  <a:lnTo>
                    <a:pt x="1442" y="705"/>
                  </a:lnTo>
                  <a:lnTo>
                    <a:pt x="1438" y="705"/>
                  </a:lnTo>
                  <a:lnTo>
                    <a:pt x="1438" y="705"/>
                  </a:lnTo>
                  <a:lnTo>
                    <a:pt x="1433" y="705"/>
                  </a:lnTo>
                  <a:lnTo>
                    <a:pt x="1433" y="705"/>
                  </a:lnTo>
                  <a:lnTo>
                    <a:pt x="1429" y="705"/>
                  </a:lnTo>
                  <a:lnTo>
                    <a:pt x="1429" y="705"/>
                  </a:lnTo>
                  <a:lnTo>
                    <a:pt x="1424" y="705"/>
                  </a:lnTo>
                  <a:lnTo>
                    <a:pt x="1424" y="705"/>
                  </a:lnTo>
                  <a:lnTo>
                    <a:pt x="1419" y="705"/>
                  </a:lnTo>
                  <a:lnTo>
                    <a:pt x="1419" y="705"/>
                  </a:lnTo>
                  <a:lnTo>
                    <a:pt x="1415" y="705"/>
                  </a:lnTo>
                  <a:lnTo>
                    <a:pt x="1415" y="705"/>
                  </a:lnTo>
                  <a:lnTo>
                    <a:pt x="1410" y="705"/>
                  </a:lnTo>
                  <a:lnTo>
                    <a:pt x="1410" y="705"/>
                  </a:lnTo>
                  <a:lnTo>
                    <a:pt x="1405" y="705"/>
                  </a:lnTo>
                  <a:lnTo>
                    <a:pt x="1405" y="705"/>
                  </a:lnTo>
                  <a:lnTo>
                    <a:pt x="1401" y="705"/>
                  </a:lnTo>
                  <a:lnTo>
                    <a:pt x="1401" y="705"/>
                  </a:lnTo>
                  <a:lnTo>
                    <a:pt x="1396" y="705"/>
                  </a:lnTo>
                  <a:lnTo>
                    <a:pt x="1396" y="705"/>
                  </a:lnTo>
                  <a:lnTo>
                    <a:pt x="1391" y="705"/>
                  </a:lnTo>
                  <a:lnTo>
                    <a:pt x="1391" y="705"/>
                  </a:lnTo>
                  <a:lnTo>
                    <a:pt x="1391" y="705"/>
                  </a:lnTo>
                  <a:lnTo>
                    <a:pt x="1387" y="705"/>
                  </a:lnTo>
                  <a:lnTo>
                    <a:pt x="1387" y="705"/>
                  </a:lnTo>
                  <a:lnTo>
                    <a:pt x="1382" y="705"/>
                  </a:lnTo>
                  <a:lnTo>
                    <a:pt x="1382" y="705"/>
                  </a:lnTo>
                  <a:lnTo>
                    <a:pt x="1377" y="705"/>
                  </a:lnTo>
                  <a:lnTo>
                    <a:pt x="1377" y="705"/>
                  </a:lnTo>
                  <a:lnTo>
                    <a:pt x="1373" y="705"/>
                  </a:lnTo>
                  <a:lnTo>
                    <a:pt x="1373" y="705"/>
                  </a:lnTo>
                  <a:lnTo>
                    <a:pt x="1368" y="705"/>
                  </a:lnTo>
                  <a:lnTo>
                    <a:pt x="1368" y="705"/>
                  </a:lnTo>
                  <a:lnTo>
                    <a:pt x="1364" y="705"/>
                  </a:lnTo>
                  <a:lnTo>
                    <a:pt x="1364" y="705"/>
                  </a:lnTo>
                  <a:lnTo>
                    <a:pt x="1359" y="705"/>
                  </a:lnTo>
                  <a:lnTo>
                    <a:pt x="1359" y="705"/>
                  </a:lnTo>
                  <a:lnTo>
                    <a:pt x="1354" y="705"/>
                  </a:lnTo>
                  <a:lnTo>
                    <a:pt x="1354" y="705"/>
                  </a:lnTo>
                  <a:lnTo>
                    <a:pt x="1350" y="705"/>
                  </a:lnTo>
                  <a:lnTo>
                    <a:pt x="1350" y="705"/>
                  </a:lnTo>
                  <a:lnTo>
                    <a:pt x="1345" y="705"/>
                  </a:lnTo>
                  <a:lnTo>
                    <a:pt x="1345" y="705"/>
                  </a:lnTo>
                  <a:lnTo>
                    <a:pt x="1340" y="705"/>
                  </a:lnTo>
                  <a:lnTo>
                    <a:pt x="1340" y="705"/>
                  </a:lnTo>
                  <a:lnTo>
                    <a:pt x="1336" y="705"/>
                  </a:lnTo>
                  <a:lnTo>
                    <a:pt x="1336" y="705"/>
                  </a:lnTo>
                  <a:lnTo>
                    <a:pt x="1331" y="705"/>
                  </a:lnTo>
                  <a:lnTo>
                    <a:pt x="1331" y="705"/>
                  </a:lnTo>
                  <a:lnTo>
                    <a:pt x="1326" y="705"/>
                  </a:lnTo>
                  <a:lnTo>
                    <a:pt x="1326" y="705"/>
                  </a:lnTo>
                  <a:lnTo>
                    <a:pt x="1326" y="705"/>
                  </a:lnTo>
                  <a:lnTo>
                    <a:pt x="1322" y="705"/>
                  </a:lnTo>
                  <a:lnTo>
                    <a:pt x="1322" y="705"/>
                  </a:lnTo>
                  <a:lnTo>
                    <a:pt x="1317" y="705"/>
                  </a:lnTo>
                  <a:lnTo>
                    <a:pt x="1317" y="705"/>
                  </a:lnTo>
                  <a:lnTo>
                    <a:pt x="1313" y="705"/>
                  </a:lnTo>
                  <a:lnTo>
                    <a:pt x="1313" y="705"/>
                  </a:lnTo>
                  <a:lnTo>
                    <a:pt x="1308" y="705"/>
                  </a:lnTo>
                  <a:lnTo>
                    <a:pt x="1308" y="705"/>
                  </a:lnTo>
                  <a:lnTo>
                    <a:pt x="1303" y="705"/>
                  </a:lnTo>
                  <a:lnTo>
                    <a:pt x="1303" y="705"/>
                  </a:lnTo>
                  <a:lnTo>
                    <a:pt x="1299" y="705"/>
                  </a:lnTo>
                  <a:lnTo>
                    <a:pt x="1299" y="705"/>
                  </a:lnTo>
                  <a:lnTo>
                    <a:pt x="1294" y="705"/>
                  </a:lnTo>
                  <a:lnTo>
                    <a:pt x="1294" y="705"/>
                  </a:lnTo>
                  <a:lnTo>
                    <a:pt x="1289" y="705"/>
                  </a:lnTo>
                  <a:lnTo>
                    <a:pt x="1289" y="705"/>
                  </a:lnTo>
                  <a:lnTo>
                    <a:pt x="1285" y="705"/>
                  </a:lnTo>
                  <a:lnTo>
                    <a:pt x="1285" y="705"/>
                  </a:lnTo>
                  <a:lnTo>
                    <a:pt x="1280" y="705"/>
                  </a:lnTo>
                  <a:lnTo>
                    <a:pt x="1280" y="705"/>
                  </a:lnTo>
                  <a:lnTo>
                    <a:pt x="1275" y="705"/>
                  </a:lnTo>
                  <a:lnTo>
                    <a:pt x="1275" y="705"/>
                  </a:lnTo>
                  <a:lnTo>
                    <a:pt x="1271" y="705"/>
                  </a:lnTo>
                  <a:lnTo>
                    <a:pt x="1271" y="705"/>
                  </a:lnTo>
                  <a:lnTo>
                    <a:pt x="1266" y="705"/>
                  </a:lnTo>
                  <a:lnTo>
                    <a:pt x="1266" y="705"/>
                  </a:lnTo>
                  <a:lnTo>
                    <a:pt x="1262" y="705"/>
                  </a:lnTo>
                  <a:lnTo>
                    <a:pt x="1262" y="705"/>
                  </a:lnTo>
                  <a:lnTo>
                    <a:pt x="1257" y="705"/>
                  </a:lnTo>
                  <a:lnTo>
                    <a:pt x="1257" y="705"/>
                  </a:lnTo>
                  <a:lnTo>
                    <a:pt x="1257" y="705"/>
                  </a:lnTo>
                  <a:lnTo>
                    <a:pt x="1252" y="705"/>
                  </a:lnTo>
                  <a:lnTo>
                    <a:pt x="1252" y="705"/>
                  </a:lnTo>
                  <a:lnTo>
                    <a:pt x="1248" y="705"/>
                  </a:lnTo>
                  <a:lnTo>
                    <a:pt x="1248" y="705"/>
                  </a:lnTo>
                  <a:lnTo>
                    <a:pt x="1243" y="705"/>
                  </a:lnTo>
                  <a:lnTo>
                    <a:pt x="1243" y="705"/>
                  </a:lnTo>
                  <a:lnTo>
                    <a:pt x="1238" y="705"/>
                  </a:lnTo>
                  <a:lnTo>
                    <a:pt x="1238" y="705"/>
                  </a:lnTo>
                  <a:lnTo>
                    <a:pt x="1234" y="705"/>
                  </a:lnTo>
                  <a:lnTo>
                    <a:pt x="1234" y="705"/>
                  </a:lnTo>
                  <a:lnTo>
                    <a:pt x="1229" y="705"/>
                  </a:lnTo>
                  <a:lnTo>
                    <a:pt x="1229" y="705"/>
                  </a:lnTo>
                  <a:lnTo>
                    <a:pt x="1224" y="705"/>
                  </a:lnTo>
                  <a:lnTo>
                    <a:pt x="1224" y="705"/>
                  </a:lnTo>
                  <a:lnTo>
                    <a:pt x="1220" y="705"/>
                  </a:lnTo>
                  <a:lnTo>
                    <a:pt x="1220" y="705"/>
                  </a:lnTo>
                  <a:lnTo>
                    <a:pt x="1215" y="705"/>
                  </a:lnTo>
                  <a:lnTo>
                    <a:pt x="1215" y="705"/>
                  </a:lnTo>
                  <a:lnTo>
                    <a:pt x="1211" y="705"/>
                  </a:lnTo>
                  <a:lnTo>
                    <a:pt x="1211" y="705"/>
                  </a:lnTo>
                  <a:lnTo>
                    <a:pt x="1206" y="705"/>
                  </a:lnTo>
                  <a:lnTo>
                    <a:pt x="1206" y="705"/>
                  </a:lnTo>
                  <a:lnTo>
                    <a:pt x="1201" y="705"/>
                  </a:lnTo>
                  <a:lnTo>
                    <a:pt x="1201" y="705"/>
                  </a:lnTo>
                  <a:lnTo>
                    <a:pt x="1197" y="705"/>
                  </a:lnTo>
                  <a:lnTo>
                    <a:pt x="1197" y="705"/>
                  </a:lnTo>
                  <a:lnTo>
                    <a:pt x="1192" y="705"/>
                  </a:lnTo>
                  <a:lnTo>
                    <a:pt x="1192" y="705"/>
                  </a:lnTo>
                  <a:lnTo>
                    <a:pt x="1192" y="705"/>
                  </a:lnTo>
                  <a:lnTo>
                    <a:pt x="1187" y="705"/>
                  </a:lnTo>
                  <a:lnTo>
                    <a:pt x="1187" y="705"/>
                  </a:lnTo>
                  <a:lnTo>
                    <a:pt x="1183" y="705"/>
                  </a:lnTo>
                  <a:lnTo>
                    <a:pt x="1183" y="705"/>
                  </a:lnTo>
                  <a:lnTo>
                    <a:pt x="1178" y="705"/>
                  </a:lnTo>
                  <a:lnTo>
                    <a:pt x="1178" y="705"/>
                  </a:lnTo>
                  <a:lnTo>
                    <a:pt x="1173" y="705"/>
                  </a:lnTo>
                  <a:lnTo>
                    <a:pt x="1173" y="705"/>
                  </a:lnTo>
                  <a:lnTo>
                    <a:pt x="1169" y="705"/>
                  </a:lnTo>
                  <a:lnTo>
                    <a:pt x="1169" y="705"/>
                  </a:lnTo>
                  <a:lnTo>
                    <a:pt x="1164" y="705"/>
                  </a:lnTo>
                  <a:lnTo>
                    <a:pt x="1164" y="705"/>
                  </a:lnTo>
                  <a:lnTo>
                    <a:pt x="1160" y="705"/>
                  </a:lnTo>
                  <a:lnTo>
                    <a:pt x="1160" y="705"/>
                  </a:lnTo>
                  <a:lnTo>
                    <a:pt x="1155" y="705"/>
                  </a:lnTo>
                  <a:lnTo>
                    <a:pt x="1155" y="705"/>
                  </a:lnTo>
                  <a:lnTo>
                    <a:pt x="1150" y="705"/>
                  </a:lnTo>
                  <a:lnTo>
                    <a:pt x="1150" y="705"/>
                  </a:lnTo>
                  <a:lnTo>
                    <a:pt x="1146" y="705"/>
                  </a:lnTo>
                  <a:lnTo>
                    <a:pt x="1146" y="705"/>
                  </a:lnTo>
                  <a:lnTo>
                    <a:pt x="1141" y="705"/>
                  </a:lnTo>
                  <a:lnTo>
                    <a:pt x="1141" y="705"/>
                  </a:lnTo>
                  <a:lnTo>
                    <a:pt x="1136" y="705"/>
                  </a:lnTo>
                  <a:lnTo>
                    <a:pt x="1136" y="705"/>
                  </a:lnTo>
                  <a:lnTo>
                    <a:pt x="1132" y="705"/>
                  </a:lnTo>
                  <a:lnTo>
                    <a:pt x="1132" y="705"/>
                  </a:lnTo>
                  <a:lnTo>
                    <a:pt x="1127" y="705"/>
                  </a:lnTo>
                  <a:lnTo>
                    <a:pt x="1127" y="705"/>
                  </a:lnTo>
                  <a:lnTo>
                    <a:pt x="1127" y="705"/>
                  </a:lnTo>
                  <a:lnTo>
                    <a:pt x="1122" y="705"/>
                  </a:lnTo>
                  <a:lnTo>
                    <a:pt x="1122" y="705"/>
                  </a:lnTo>
                  <a:lnTo>
                    <a:pt x="1118" y="705"/>
                  </a:lnTo>
                  <a:lnTo>
                    <a:pt x="1118" y="705"/>
                  </a:lnTo>
                  <a:lnTo>
                    <a:pt x="1113" y="705"/>
                  </a:lnTo>
                  <a:lnTo>
                    <a:pt x="1113" y="705"/>
                  </a:lnTo>
                  <a:lnTo>
                    <a:pt x="1108" y="705"/>
                  </a:lnTo>
                  <a:lnTo>
                    <a:pt x="1108" y="705"/>
                  </a:lnTo>
                  <a:lnTo>
                    <a:pt x="1104" y="705"/>
                  </a:lnTo>
                  <a:lnTo>
                    <a:pt x="1104" y="705"/>
                  </a:lnTo>
                  <a:lnTo>
                    <a:pt x="1099" y="705"/>
                  </a:lnTo>
                  <a:lnTo>
                    <a:pt x="1099" y="705"/>
                  </a:lnTo>
                  <a:lnTo>
                    <a:pt x="1095" y="705"/>
                  </a:lnTo>
                  <a:lnTo>
                    <a:pt x="1095" y="705"/>
                  </a:lnTo>
                  <a:lnTo>
                    <a:pt x="1090" y="705"/>
                  </a:lnTo>
                  <a:lnTo>
                    <a:pt x="1090" y="705"/>
                  </a:lnTo>
                  <a:lnTo>
                    <a:pt x="1085" y="705"/>
                  </a:lnTo>
                  <a:lnTo>
                    <a:pt x="1085" y="705"/>
                  </a:lnTo>
                  <a:lnTo>
                    <a:pt x="1081" y="705"/>
                  </a:lnTo>
                  <a:lnTo>
                    <a:pt x="1081" y="705"/>
                  </a:lnTo>
                  <a:lnTo>
                    <a:pt x="1076" y="705"/>
                  </a:lnTo>
                  <a:lnTo>
                    <a:pt x="1076" y="705"/>
                  </a:lnTo>
                  <a:lnTo>
                    <a:pt x="1071" y="705"/>
                  </a:lnTo>
                  <a:lnTo>
                    <a:pt x="1071" y="705"/>
                  </a:lnTo>
                  <a:lnTo>
                    <a:pt x="1067" y="705"/>
                  </a:lnTo>
                  <a:lnTo>
                    <a:pt x="1067" y="705"/>
                  </a:lnTo>
                  <a:lnTo>
                    <a:pt x="1062" y="705"/>
                  </a:lnTo>
                  <a:lnTo>
                    <a:pt x="1062" y="705"/>
                  </a:lnTo>
                  <a:lnTo>
                    <a:pt x="1062" y="705"/>
                  </a:lnTo>
                  <a:lnTo>
                    <a:pt x="1057" y="705"/>
                  </a:lnTo>
                  <a:lnTo>
                    <a:pt x="1057" y="705"/>
                  </a:lnTo>
                  <a:lnTo>
                    <a:pt x="1053" y="705"/>
                  </a:lnTo>
                  <a:lnTo>
                    <a:pt x="1053" y="705"/>
                  </a:lnTo>
                  <a:lnTo>
                    <a:pt x="1048" y="705"/>
                  </a:lnTo>
                  <a:lnTo>
                    <a:pt x="1048" y="705"/>
                  </a:lnTo>
                  <a:lnTo>
                    <a:pt x="1044" y="705"/>
                  </a:lnTo>
                  <a:lnTo>
                    <a:pt x="1044" y="705"/>
                  </a:lnTo>
                  <a:lnTo>
                    <a:pt x="1039" y="705"/>
                  </a:lnTo>
                  <a:lnTo>
                    <a:pt x="1039" y="705"/>
                  </a:lnTo>
                  <a:lnTo>
                    <a:pt x="1034" y="705"/>
                  </a:lnTo>
                  <a:lnTo>
                    <a:pt x="1034" y="705"/>
                  </a:lnTo>
                  <a:lnTo>
                    <a:pt x="1030" y="705"/>
                  </a:lnTo>
                  <a:lnTo>
                    <a:pt x="1030" y="705"/>
                  </a:lnTo>
                  <a:lnTo>
                    <a:pt x="1025" y="705"/>
                  </a:lnTo>
                  <a:lnTo>
                    <a:pt x="1025" y="705"/>
                  </a:lnTo>
                  <a:lnTo>
                    <a:pt x="1020" y="705"/>
                  </a:lnTo>
                  <a:lnTo>
                    <a:pt x="1020" y="705"/>
                  </a:lnTo>
                  <a:lnTo>
                    <a:pt x="1016" y="705"/>
                  </a:lnTo>
                  <a:lnTo>
                    <a:pt x="1016" y="705"/>
                  </a:lnTo>
                  <a:lnTo>
                    <a:pt x="1011" y="705"/>
                  </a:lnTo>
                  <a:lnTo>
                    <a:pt x="1011" y="705"/>
                  </a:lnTo>
                  <a:lnTo>
                    <a:pt x="1006" y="705"/>
                  </a:lnTo>
                  <a:lnTo>
                    <a:pt x="1006" y="705"/>
                  </a:lnTo>
                  <a:lnTo>
                    <a:pt x="1002" y="705"/>
                  </a:lnTo>
                  <a:lnTo>
                    <a:pt x="1002" y="705"/>
                  </a:lnTo>
                  <a:lnTo>
                    <a:pt x="997" y="705"/>
                  </a:lnTo>
                  <a:lnTo>
                    <a:pt x="997" y="705"/>
                  </a:lnTo>
                  <a:lnTo>
                    <a:pt x="993" y="705"/>
                  </a:lnTo>
                  <a:lnTo>
                    <a:pt x="993" y="705"/>
                  </a:lnTo>
                  <a:lnTo>
                    <a:pt x="993" y="705"/>
                  </a:lnTo>
                  <a:lnTo>
                    <a:pt x="988" y="705"/>
                  </a:lnTo>
                  <a:lnTo>
                    <a:pt x="988" y="705"/>
                  </a:lnTo>
                  <a:lnTo>
                    <a:pt x="983" y="705"/>
                  </a:lnTo>
                  <a:lnTo>
                    <a:pt x="983" y="705"/>
                  </a:lnTo>
                  <a:lnTo>
                    <a:pt x="979" y="705"/>
                  </a:lnTo>
                  <a:lnTo>
                    <a:pt x="979" y="705"/>
                  </a:lnTo>
                  <a:lnTo>
                    <a:pt x="974" y="705"/>
                  </a:lnTo>
                  <a:lnTo>
                    <a:pt x="974" y="705"/>
                  </a:lnTo>
                  <a:lnTo>
                    <a:pt x="969" y="705"/>
                  </a:lnTo>
                  <a:lnTo>
                    <a:pt x="969" y="705"/>
                  </a:lnTo>
                  <a:lnTo>
                    <a:pt x="965" y="705"/>
                  </a:lnTo>
                  <a:lnTo>
                    <a:pt x="965" y="705"/>
                  </a:lnTo>
                  <a:lnTo>
                    <a:pt x="960" y="705"/>
                  </a:lnTo>
                  <a:lnTo>
                    <a:pt x="960" y="705"/>
                  </a:lnTo>
                  <a:lnTo>
                    <a:pt x="955" y="705"/>
                  </a:lnTo>
                  <a:lnTo>
                    <a:pt x="955" y="705"/>
                  </a:lnTo>
                  <a:lnTo>
                    <a:pt x="951" y="705"/>
                  </a:lnTo>
                  <a:lnTo>
                    <a:pt x="951" y="705"/>
                  </a:lnTo>
                  <a:lnTo>
                    <a:pt x="946" y="705"/>
                  </a:lnTo>
                  <a:lnTo>
                    <a:pt x="946" y="705"/>
                  </a:lnTo>
                  <a:lnTo>
                    <a:pt x="942" y="705"/>
                  </a:lnTo>
                  <a:lnTo>
                    <a:pt x="942" y="705"/>
                  </a:lnTo>
                  <a:lnTo>
                    <a:pt x="937" y="705"/>
                  </a:lnTo>
                  <a:lnTo>
                    <a:pt x="937" y="705"/>
                  </a:lnTo>
                  <a:lnTo>
                    <a:pt x="932" y="705"/>
                  </a:lnTo>
                  <a:lnTo>
                    <a:pt x="932" y="705"/>
                  </a:lnTo>
                  <a:lnTo>
                    <a:pt x="928" y="705"/>
                  </a:lnTo>
                  <a:lnTo>
                    <a:pt x="928" y="705"/>
                  </a:lnTo>
                  <a:lnTo>
                    <a:pt x="928" y="705"/>
                  </a:lnTo>
                  <a:lnTo>
                    <a:pt x="923" y="705"/>
                  </a:lnTo>
                  <a:lnTo>
                    <a:pt x="923" y="705"/>
                  </a:lnTo>
                  <a:lnTo>
                    <a:pt x="918" y="705"/>
                  </a:lnTo>
                  <a:lnTo>
                    <a:pt x="918" y="705"/>
                  </a:lnTo>
                  <a:lnTo>
                    <a:pt x="914" y="705"/>
                  </a:lnTo>
                  <a:lnTo>
                    <a:pt x="914" y="705"/>
                  </a:lnTo>
                  <a:lnTo>
                    <a:pt x="909" y="705"/>
                  </a:lnTo>
                  <a:lnTo>
                    <a:pt x="909" y="705"/>
                  </a:lnTo>
                  <a:lnTo>
                    <a:pt x="904" y="705"/>
                  </a:lnTo>
                  <a:lnTo>
                    <a:pt x="904" y="705"/>
                  </a:lnTo>
                  <a:lnTo>
                    <a:pt x="900" y="705"/>
                  </a:lnTo>
                  <a:lnTo>
                    <a:pt x="900" y="705"/>
                  </a:lnTo>
                  <a:lnTo>
                    <a:pt x="895" y="705"/>
                  </a:lnTo>
                  <a:lnTo>
                    <a:pt x="895" y="705"/>
                  </a:lnTo>
                  <a:lnTo>
                    <a:pt x="890" y="705"/>
                  </a:lnTo>
                  <a:lnTo>
                    <a:pt x="890" y="705"/>
                  </a:lnTo>
                  <a:lnTo>
                    <a:pt x="886" y="705"/>
                  </a:lnTo>
                  <a:lnTo>
                    <a:pt x="886" y="705"/>
                  </a:lnTo>
                  <a:lnTo>
                    <a:pt x="881" y="705"/>
                  </a:lnTo>
                  <a:lnTo>
                    <a:pt x="881" y="705"/>
                  </a:lnTo>
                  <a:lnTo>
                    <a:pt x="877" y="705"/>
                  </a:lnTo>
                  <a:lnTo>
                    <a:pt x="877" y="705"/>
                  </a:lnTo>
                  <a:lnTo>
                    <a:pt x="872" y="705"/>
                  </a:lnTo>
                  <a:lnTo>
                    <a:pt x="872" y="705"/>
                  </a:lnTo>
                  <a:lnTo>
                    <a:pt x="867" y="705"/>
                  </a:lnTo>
                  <a:lnTo>
                    <a:pt x="867" y="705"/>
                  </a:lnTo>
                  <a:lnTo>
                    <a:pt x="863" y="705"/>
                  </a:lnTo>
                  <a:lnTo>
                    <a:pt x="863" y="705"/>
                  </a:lnTo>
                  <a:lnTo>
                    <a:pt x="863" y="705"/>
                  </a:lnTo>
                  <a:lnTo>
                    <a:pt x="858" y="705"/>
                  </a:lnTo>
                  <a:lnTo>
                    <a:pt x="858" y="705"/>
                  </a:lnTo>
                  <a:lnTo>
                    <a:pt x="853" y="705"/>
                  </a:lnTo>
                  <a:lnTo>
                    <a:pt x="853" y="705"/>
                  </a:lnTo>
                  <a:lnTo>
                    <a:pt x="849" y="705"/>
                  </a:lnTo>
                  <a:lnTo>
                    <a:pt x="849" y="705"/>
                  </a:lnTo>
                  <a:lnTo>
                    <a:pt x="844" y="705"/>
                  </a:lnTo>
                  <a:lnTo>
                    <a:pt x="844" y="705"/>
                  </a:lnTo>
                  <a:lnTo>
                    <a:pt x="839" y="705"/>
                  </a:lnTo>
                  <a:lnTo>
                    <a:pt x="839" y="705"/>
                  </a:lnTo>
                  <a:lnTo>
                    <a:pt x="835" y="705"/>
                  </a:lnTo>
                  <a:lnTo>
                    <a:pt x="835" y="705"/>
                  </a:lnTo>
                  <a:lnTo>
                    <a:pt x="830" y="705"/>
                  </a:lnTo>
                  <a:lnTo>
                    <a:pt x="830" y="705"/>
                  </a:lnTo>
                  <a:lnTo>
                    <a:pt x="826" y="705"/>
                  </a:lnTo>
                  <a:lnTo>
                    <a:pt x="826" y="705"/>
                  </a:lnTo>
                  <a:lnTo>
                    <a:pt x="821" y="705"/>
                  </a:lnTo>
                  <a:lnTo>
                    <a:pt x="821" y="705"/>
                  </a:lnTo>
                  <a:lnTo>
                    <a:pt x="816" y="705"/>
                  </a:lnTo>
                  <a:lnTo>
                    <a:pt x="816" y="705"/>
                  </a:lnTo>
                  <a:lnTo>
                    <a:pt x="812" y="705"/>
                  </a:lnTo>
                  <a:lnTo>
                    <a:pt x="812" y="705"/>
                  </a:lnTo>
                  <a:lnTo>
                    <a:pt x="807" y="705"/>
                  </a:lnTo>
                  <a:lnTo>
                    <a:pt x="807" y="705"/>
                  </a:lnTo>
                  <a:lnTo>
                    <a:pt x="802" y="705"/>
                  </a:lnTo>
                  <a:lnTo>
                    <a:pt x="802" y="705"/>
                  </a:lnTo>
                  <a:lnTo>
                    <a:pt x="798" y="705"/>
                  </a:lnTo>
                  <a:lnTo>
                    <a:pt x="798" y="705"/>
                  </a:lnTo>
                  <a:lnTo>
                    <a:pt x="793" y="705"/>
                  </a:lnTo>
                  <a:lnTo>
                    <a:pt x="793" y="705"/>
                  </a:lnTo>
                  <a:lnTo>
                    <a:pt x="793" y="705"/>
                  </a:lnTo>
                  <a:lnTo>
                    <a:pt x="788" y="705"/>
                  </a:lnTo>
                  <a:lnTo>
                    <a:pt x="788" y="705"/>
                  </a:lnTo>
                  <a:lnTo>
                    <a:pt x="784" y="705"/>
                  </a:lnTo>
                  <a:lnTo>
                    <a:pt x="784" y="705"/>
                  </a:lnTo>
                  <a:lnTo>
                    <a:pt x="779" y="705"/>
                  </a:lnTo>
                  <a:lnTo>
                    <a:pt x="779" y="705"/>
                  </a:lnTo>
                  <a:lnTo>
                    <a:pt x="775" y="705"/>
                  </a:lnTo>
                  <a:lnTo>
                    <a:pt x="775" y="705"/>
                  </a:lnTo>
                  <a:lnTo>
                    <a:pt x="770" y="705"/>
                  </a:lnTo>
                  <a:lnTo>
                    <a:pt x="770" y="705"/>
                  </a:lnTo>
                  <a:lnTo>
                    <a:pt x="765" y="705"/>
                  </a:lnTo>
                  <a:lnTo>
                    <a:pt x="765" y="705"/>
                  </a:lnTo>
                  <a:lnTo>
                    <a:pt x="761" y="705"/>
                  </a:lnTo>
                  <a:lnTo>
                    <a:pt x="761" y="705"/>
                  </a:lnTo>
                  <a:lnTo>
                    <a:pt x="756" y="705"/>
                  </a:lnTo>
                  <a:lnTo>
                    <a:pt x="756" y="705"/>
                  </a:lnTo>
                  <a:lnTo>
                    <a:pt x="751" y="705"/>
                  </a:lnTo>
                  <a:lnTo>
                    <a:pt x="751" y="705"/>
                  </a:lnTo>
                  <a:lnTo>
                    <a:pt x="747" y="705"/>
                  </a:lnTo>
                  <a:lnTo>
                    <a:pt x="747" y="705"/>
                  </a:lnTo>
                  <a:lnTo>
                    <a:pt x="742" y="705"/>
                  </a:lnTo>
                  <a:lnTo>
                    <a:pt x="742" y="705"/>
                  </a:lnTo>
                  <a:lnTo>
                    <a:pt x="737" y="705"/>
                  </a:lnTo>
                  <a:lnTo>
                    <a:pt x="737" y="705"/>
                  </a:lnTo>
                  <a:lnTo>
                    <a:pt x="733" y="705"/>
                  </a:lnTo>
                  <a:lnTo>
                    <a:pt x="733" y="705"/>
                  </a:lnTo>
                  <a:lnTo>
                    <a:pt x="728" y="705"/>
                  </a:lnTo>
                  <a:lnTo>
                    <a:pt x="728" y="705"/>
                  </a:lnTo>
                  <a:lnTo>
                    <a:pt x="728" y="705"/>
                  </a:lnTo>
                  <a:lnTo>
                    <a:pt x="724" y="705"/>
                  </a:lnTo>
                  <a:lnTo>
                    <a:pt x="724" y="705"/>
                  </a:lnTo>
                  <a:lnTo>
                    <a:pt x="719" y="705"/>
                  </a:lnTo>
                  <a:lnTo>
                    <a:pt x="719" y="705"/>
                  </a:lnTo>
                  <a:lnTo>
                    <a:pt x="714" y="705"/>
                  </a:lnTo>
                  <a:lnTo>
                    <a:pt x="714" y="705"/>
                  </a:lnTo>
                  <a:lnTo>
                    <a:pt x="710" y="705"/>
                  </a:lnTo>
                  <a:lnTo>
                    <a:pt x="710" y="705"/>
                  </a:lnTo>
                  <a:lnTo>
                    <a:pt x="705" y="705"/>
                  </a:lnTo>
                  <a:lnTo>
                    <a:pt x="705" y="705"/>
                  </a:lnTo>
                  <a:lnTo>
                    <a:pt x="700" y="705"/>
                  </a:lnTo>
                  <a:lnTo>
                    <a:pt x="700" y="705"/>
                  </a:lnTo>
                  <a:lnTo>
                    <a:pt x="696" y="705"/>
                  </a:lnTo>
                  <a:lnTo>
                    <a:pt x="696" y="705"/>
                  </a:lnTo>
                  <a:lnTo>
                    <a:pt x="691" y="705"/>
                  </a:lnTo>
                  <a:lnTo>
                    <a:pt x="691" y="705"/>
                  </a:lnTo>
                  <a:lnTo>
                    <a:pt x="686" y="705"/>
                  </a:lnTo>
                  <a:lnTo>
                    <a:pt x="686" y="705"/>
                  </a:lnTo>
                  <a:lnTo>
                    <a:pt x="682" y="705"/>
                  </a:lnTo>
                  <a:lnTo>
                    <a:pt x="682" y="705"/>
                  </a:lnTo>
                  <a:lnTo>
                    <a:pt x="677" y="705"/>
                  </a:lnTo>
                  <a:lnTo>
                    <a:pt x="677" y="705"/>
                  </a:lnTo>
                  <a:lnTo>
                    <a:pt x="673" y="705"/>
                  </a:lnTo>
                  <a:lnTo>
                    <a:pt x="673" y="705"/>
                  </a:lnTo>
                  <a:lnTo>
                    <a:pt x="668" y="705"/>
                  </a:lnTo>
                  <a:lnTo>
                    <a:pt x="668" y="705"/>
                  </a:lnTo>
                  <a:lnTo>
                    <a:pt x="663" y="705"/>
                  </a:lnTo>
                  <a:lnTo>
                    <a:pt x="663" y="705"/>
                  </a:lnTo>
                  <a:lnTo>
                    <a:pt x="663" y="705"/>
                  </a:lnTo>
                  <a:lnTo>
                    <a:pt x="659" y="705"/>
                  </a:lnTo>
                  <a:lnTo>
                    <a:pt x="659" y="705"/>
                  </a:lnTo>
                  <a:lnTo>
                    <a:pt x="654" y="705"/>
                  </a:lnTo>
                  <a:lnTo>
                    <a:pt x="654" y="705"/>
                  </a:lnTo>
                  <a:lnTo>
                    <a:pt x="649" y="705"/>
                  </a:lnTo>
                  <a:lnTo>
                    <a:pt x="649" y="705"/>
                  </a:lnTo>
                  <a:lnTo>
                    <a:pt x="645" y="705"/>
                  </a:lnTo>
                  <a:lnTo>
                    <a:pt x="645" y="705"/>
                  </a:lnTo>
                  <a:lnTo>
                    <a:pt x="640" y="705"/>
                  </a:lnTo>
                  <a:lnTo>
                    <a:pt x="640" y="705"/>
                  </a:lnTo>
                  <a:lnTo>
                    <a:pt x="635" y="705"/>
                  </a:lnTo>
                  <a:lnTo>
                    <a:pt x="635" y="705"/>
                  </a:lnTo>
                  <a:lnTo>
                    <a:pt x="631" y="705"/>
                  </a:lnTo>
                  <a:lnTo>
                    <a:pt x="631" y="705"/>
                  </a:lnTo>
                  <a:lnTo>
                    <a:pt x="626" y="705"/>
                  </a:lnTo>
                  <a:lnTo>
                    <a:pt x="626" y="705"/>
                  </a:lnTo>
                  <a:lnTo>
                    <a:pt x="621" y="705"/>
                  </a:lnTo>
                  <a:lnTo>
                    <a:pt x="621" y="705"/>
                  </a:lnTo>
                  <a:lnTo>
                    <a:pt x="617" y="705"/>
                  </a:lnTo>
                  <a:lnTo>
                    <a:pt x="617" y="705"/>
                  </a:lnTo>
                  <a:lnTo>
                    <a:pt x="612" y="705"/>
                  </a:lnTo>
                  <a:lnTo>
                    <a:pt x="612" y="705"/>
                  </a:lnTo>
                  <a:lnTo>
                    <a:pt x="608" y="705"/>
                  </a:lnTo>
                  <a:lnTo>
                    <a:pt x="608" y="705"/>
                  </a:lnTo>
                  <a:lnTo>
                    <a:pt x="603" y="705"/>
                  </a:lnTo>
                  <a:lnTo>
                    <a:pt x="603" y="705"/>
                  </a:lnTo>
                  <a:lnTo>
                    <a:pt x="598" y="705"/>
                  </a:lnTo>
                  <a:lnTo>
                    <a:pt x="598" y="705"/>
                  </a:lnTo>
                  <a:lnTo>
                    <a:pt x="598" y="705"/>
                  </a:lnTo>
                  <a:lnTo>
                    <a:pt x="594" y="705"/>
                  </a:lnTo>
                  <a:lnTo>
                    <a:pt x="594" y="705"/>
                  </a:lnTo>
                  <a:lnTo>
                    <a:pt x="589" y="705"/>
                  </a:lnTo>
                  <a:lnTo>
                    <a:pt x="589" y="705"/>
                  </a:lnTo>
                  <a:lnTo>
                    <a:pt x="584" y="705"/>
                  </a:lnTo>
                  <a:lnTo>
                    <a:pt x="584" y="705"/>
                  </a:lnTo>
                  <a:lnTo>
                    <a:pt x="580" y="705"/>
                  </a:lnTo>
                  <a:lnTo>
                    <a:pt x="580" y="705"/>
                  </a:lnTo>
                  <a:lnTo>
                    <a:pt x="575" y="705"/>
                  </a:lnTo>
                  <a:lnTo>
                    <a:pt x="575" y="705"/>
                  </a:lnTo>
                  <a:lnTo>
                    <a:pt x="570" y="705"/>
                  </a:lnTo>
                  <a:lnTo>
                    <a:pt x="570" y="705"/>
                  </a:lnTo>
                  <a:lnTo>
                    <a:pt x="566" y="705"/>
                  </a:lnTo>
                  <a:lnTo>
                    <a:pt x="566" y="705"/>
                  </a:lnTo>
                  <a:lnTo>
                    <a:pt x="561" y="705"/>
                  </a:lnTo>
                  <a:lnTo>
                    <a:pt x="561" y="705"/>
                  </a:lnTo>
                  <a:lnTo>
                    <a:pt x="557" y="705"/>
                  </a:lnTo>
                  <a:lnTo>
                    <a:pt x="557" y="705"/>
                  </a:lnTo>
                  <a:lnTo>
                    <a:pt x="552" y="705"/>
                  </a:lnTo>
                  <a:lnTo>
                    <a:pt x="552" y="705"/>
                  </a:lnTo>
                  <a:lnTo>
                    <a:pt x="547" y="705"/>
                  </a:lnTo>
                  <a:lnTo>
                    <a:pt x="547" y="705"/>
                  </a:lnTo>
                  <a:lnTo>
                    <a:pt x="543" y="705"/>
                  </a:lnTo>
                  <a:lnTo>
                    <a:pt x="543" y="705"/>
                  </a:lnTo>
                  <a:lnTo>
                    <a:pt x="538" y="705"/>
                  </a:lnTo>
                  <a:lnTo>
                    <a:pt x="538" y="705"/>
                  </a:lnTo>
                  <a:lnTo>
                    <a:pt x="533" y="705"/>
                  </a:lnTo>
                  <a:lnTo>
                    <a:pt x="533" y="705"/>
                  </a:lnTo>
                  <a:lnTo>
                    <a:pt x="529" y="705"/>
                  </a:lnTo>
                  <a:lnTo>
                    <a:pt x="529" y="705"/>
                  </a:lnTo>
                  <a:lnTo>
                    <a:pt x="529" y="705"/>
                  </a:lnTo>
                  <a:lnTo>
                    <a:pt x="524" y="705"/>
                  </a:lnTo>
                  <a:lnTo>
                    <a:pt x="524" y="705"/>
                  </a:lnTo>
                  <a:lnTo>
                    <a:pt x="519" y="705"/>
                  </a:lnTo>
                  <a:lnTo>
                    <a:pt x="519" y="705"/>
                  </a:lnTo>
                  <a:lnTo>
                    <a:pt x="515" y="705"/>
                  </a:lnTo>
                  <a:lnTo>
                    <a:pt x="515" y="705"/>
                  </a:lnTo>
                  <a:lnTo>
                    <a:pt x="510" y="705"/>
                  </a:lnTo>
                  <a:lnTo>
                    <a:pt x="510" y="705"/>
                  </a:lnTo>
                  <a:lnTo>
                    <a:pt x="506" y="705"/>
                  </a:lnTo>
                  <a:lnTo>
                    <a:pt x="506" y="705"/>
                  </a:lnTo>
                  <a:lnTo>
                    <a:pt x="501" y="705"/>
                  </a:lnTo>
                  <a:lnTo>
                    <a:pt x="501" y="705"/>
                  </a:lnTo>
                  <a:lnTo>
                    <a:pt x="496" y="705"/>
                  </a:lnTo>
                  <a:lnTo>
                    <a:pt x="496" y="705"/>
                  </a:lnTo>
                  <a:lnTo>
                    <a:pt x="492" y="705"/>
                  </a:lnTo>
                  <a:lnTo>
                    <a:pt x="492" y="705"/>
                  </a:lnTo>
                  <a:lnTo>
                    <a:pt x="487" y="705"/>
                  </a:lnTo>
                  <a:lnTo>
                    <a:pt x="487" y="705"/>
                  </a:lnTo>
                  <a:lnTo>
                    <a:pt x="482" y="705"/>
                  </a:lnTo>
                  <a:lnTo>
                    <a:pt x="482" y="705"/>
                  </a:lnTo>
                  <a:lnTo>
                    <a:pt x="478" y="705"/>
                  </a:lnTo>
                  <a:lnTo>
                    <a:pt x="478" y="705"/>
                  </a:lnTo>
                  <a:lnTo>
                    <a:pt x="473" y="705"/>
                  </a:lnTo>
                  <a:lnTo>
                    <a:pt x="473" y="705"/>
                  </a:lnTo>
                  <a:lnTo>
                    <a:pt x="468" y="705"/>
                  </a:lnTo>
                  <a:lnTo>
                    <a:pt x="468" y="705"/>
                  </a:lnTo>
                  <a:lnTo>
                    <a:pt x="464" y="705"/>
                  </a:lnTo>
                  <a:lnTo>
                    <a:pt x="464" y="705"/>
                  </a:lnTo>
                  <a:lnTo>
                    <a:pt x="464" y="705"/>
                  </a:lnTo>
                  <a:lnTo>
                    <a:pt x="459" y="705"/>
                  </a:lnTo>
                  <a:lnTo>
                    <a:pt x="459" y="705"/>
                  </a:lnTo>
                  <a:lnTo>
                    <a:pt x="455" y="705"/>
                  </a:lnTo>
                  <a:lnTo>
                    <a:pt x="455" y="705"/>
                  </a:lnTo>
                  <a:lnTo>
                    <a:pt x="450" y="705"/>
                  </a:lnTo>
                  <a:lnTo>
                    <a:pt x="450" y="705"/>
                  </a:lnTo>
                  <a:lnTo>
                    <a:pt x="445" y="705"/>
                  </a:lnTo>
                  <a:lnTo>
                    <a:pt x="445" y="705"/>
                  </a:lnTo>
                  <a:lnTo>
                    <a:pt x="441" y="705"/>
                  </a:lnTo>
                  <a:lnTo>
                    <a:pt x="441" y="705"/>
                  </a:lnTo>
                  <a:lnTo>
                    <a:pt x="436" y="705"/>
                  </a:lnTo>
                  <a:lnTo>
                    <a:pt x="436" y="705"/>
                  </a:lnTo>
                  <a:lnTo>
                    <a:pt x="431" y="705"/>
                  </a:lnTo>
                  <a:lnTo>
                    <a:pt x="431" y="705"/>
                  </a:lnTo>
                  <a:lnTo>
                    <a:pt x="427" y="705"/>
                  </a:lnTo>
                  <a:lnTo>
                    <a:pt x="427" y="705"/>
                  </a:lnTo>
                  <a:lnTo>
                    <a:pt x="422" y="705"/>
                  </a:lnTo>
                  <a:lnTo>
                    <a:pt x="422" y="705"/>
                  </a:lnTo>
                  <a:lnTo>
                    <a:pt x="417" y="705"/>
                  </a:lnTo>
                  <a:lnTo>
                    <a:pt x="417" y="705"/>
                  </a:lnTo>
                  <a:lnTo>
                    <a:pt x="413" y="705"/>
                  </a:lnTo>
                  <a:lnTo>
                    <a:pt x="413" y="705"/>
                  </a:lnTo>
                  <a:lnTo>
                    <a:pt x="408" y="705"/>
                  </a:lnTo>
                  <a:lnTo>
                    <a:pt x="408" y="705"/>
                  </a:lnTo>
                  <a:lnTo>
                    <a:pt x="404" y="705"/>
                  </a:lnTo>
                  <a:lnTo>
                    <a:pt x="404" y="705"/>
                  </a:lnTo>
                  <a:lnTo>
                    <a:pt x="399" y="705"/>
                  </a:lnTo>
                  <a:lnTo>
                    <a:pt x="399" y="705"/>
                  </a:lnTo>
                  <a:lnTo>
                    <a:pt x="399" y="705"/>
                  </a:lnTo>
                  <a:lnTo>
                    <a:pt x="394" y="705"/>
                  </a:lnTo>
                  <a:lnTo>
                    <a:pt x="394" y="705"/>
                  </a:lnTo>
                  <a:lnTo>
                    <a:pt x="390" y="705"/>
                  </a:lnTo>
                  <a:lnTo>
                    <a:pt x="390" y="705"/>
                  </a:lnTo>
                  <a:lnTo>
                    <a:pt x="385" y="705"/>
                  </a:lnTo>
                  <a:lnTo>
                    <a:pt x="385" y="705"/>
                  </a:lnTo>
                  <a:lnTo>
                    <a:pt x="380" y="705"/>
                  </a:lnTo>
                  <a:lnTo>
                    <a:pt x="380" y="705"/>
                  </a:lnTo>
                  <a:lnTo>
                    <a:pt x="376" y="705"/>
                  </a:lnTo>
                  <a:lnTo>
                    <a:pt x="376" y="705"/>
                  </a:lnTo>
                  <a:lnTo>
                    <a:pt x="371" y="705"/>
                  </a:lnTo>
                  <a:lnTo>
                    <a:pt x="371" y="705"/>
                  </a:lnTo>
                  <a:lnTo>
                    <a:pt x="366" y="705"/>
                  </a:lnTo>
                  <a:lnTo>
                    <a:pt x="366" y="705"/>
                  </a:lnTo>
                  <a:lnTo>
                    <a:pt x="362" y="705"/>
                  </a:lnTo>
                  <a:lnTo>
                    <a:pt x="362" y="705"/>
                  </a:lnTo>
                  <a:lnTo>
                    <a:pt x="357" y="705"/>
                  </a:lnTo>
                  <a:lnTo>
                    <a:pt x="357" y="705"/>
                  </a:lnTo>
                  <a:lnTo>
                    <a:pt x="352" y="705"/>
                  </a:lnTo>
                  <a:lnTo>
                    <a:pt x="352" y="705"/>
                  </a:lnTo>
                  <a:lnTo>
                    <a:pt x="348" y="705"/>
                  </a:lnTo>
                  <a:lnTo>
                    <a:pt x="348" y="705"/>
                  </a:lnTo>
                  <a:lnTo>
                    <a:pt x="343" y="705"/>
                  </a:lnTo>
                  <a:lnTo>
                    <a:pt x="343" y="705"/>
                  </a:lnTo>
                  <a:lnTo>
                    <a:pt x="339" y="705"/>
                  </a:lnTo>
                  <a:lnTo>
                    <a:pt x="339" y="705"/>
                  </a:lnTo>
                  <a:lnTo>
                    <a:pt x="334" y="705"/>
                  </a:lnTo>
                  <a:lnTo>
                    <a:pt x="334" y="705"/>
                  </a:lnTo>
                  <a:lnTo>
                    <a:pt x="329" y="705"/>
                  </a:lnTo>
                  <a:lnTo>
                    <a:pt x="329" y="705"/>
                  </a:lnTo>
                  <a:lnTo>
                    <a:pt x="329" y="705"/>
                  </a:lnTo>
                  <a:lnTo>
                    <a:pt x="325" y="705"/>
                  </a:lnTo>
                  <a:lnTo>
                    <a:pt x="325" y="705"/>
                  </a:lnTo>
                  <a:lnTo>
                    <a:pt x="320" y="705"/>
                  </a:lnTo>
                  <a:lnTo>
                    <a:pt x="320" y="705"/>
                  </a:lnTo>
                  <a:lnTo>
                    <a:pt x="315" y="705"/>
                  </a:lnTo>
                  <a:lnTo>
                    <a:pt x="315" y="705"/>
                  </a:lnTo>
                  <a:lnTo>
                    <a:pt x="311" y="705"/>
                  </a:lnTo>
                  <a:lnTo>
                    <a:pt x="311" y="705"/>
                  </a:lnTo>
                  <a:lnTo>
                    <a:pt x="306" y="705"/>
                  </a:lnTo>
                  <a:lnTo>
                    <a:pt x="306" y="705"/>
                  </a:lnTo>
                  <a:lnTo>
                    <a:pt x="301" y="705"/>
                  </a:lnTo>
                  <a:lnTo>
                    <a:pt x="301" y="705"/>
                  </a:lnTo>
                  <a:lnTo>
                    <a:pt x="297" y="705"/>
                  </a:lnTo>
                  <a:lnTo>
                    <a:pt x="297" y="705"/>
                  </a:lnTo>
                  <a:lnTo>
                    <a:pt x="292" y="705"/>
                  </a:lnTo>
                  <a:lnTo>
                    <a:pt x="292" y="705"/>
                  </a:lnTo>
                  <a:lnTo>
                    <a:pt x="288" y="705"/>
                  </a:lnTo>
                  <a:lnTo>
                    <a:pt x="288" y="705"/>
                  </a:lnTo>
                  <a:lnTo>
                    <a:pt x="283" y="705"/>
                  </a:lnTo>
                  <a:lnTo>
                    <a:pt x="283" y="705"/>
                  </a:lnTo>
                  <a:lnTo>
                    <a:pt x="278" y="705"/>
                  </a:lnTo>
                  <a:lnTo>
                    <a:pt x="278" y="705"/>
                  </a:lnTo>
                  <a:lnTo>
                    <a:pt x="274" y="705"/>
                  </a:lnTo>
                  <a:lnTo>
                    <a:pt x="274" y="705"/>
                  </a:lnTo>
                  <a:lnTo>
                    <a:pt x="269" y="705"/>
                  </a:lnTo>
                  <a:lnTo>
                    <a:pt x="269" y="705"/>
                  </a:lnTo>
                  <a:lnTo>
                    <a:pt x="264" y="705"/>
                  </a:lnTo>
                  <a:lnTo>
                    <a:pt x="264" y="705"/>
                  </a:lnTo>
                  <a:lnTo>
                    <a:pt x="264" y="705"/>
                  </a:lnTo>
                  <a:lnTo>
                    <a:pt x="260" y="705"/>
                  </a:lnTo>
                  <a:lnTo>
                    <a:pt x="260" y="705"/>
                  </a:lnTo>
                  <a:lnTo>
                    <a:pt x="255" y="705"/>
                  </a:lnTo>
                  <a:lnTo>
                    <a:pt x="255" y="705"/>
                  </a:lnTo>
                  <a:lnTo>
                    <a:pt x="250" y="705"/>
                  </a:lnTo>
                  <a:lnTo>
                    <a:pt x="250" y="705"/>
                  </a:lnTo>
                  <a:lnTo>
                    <a:pt x="246" y="705"/>
                  </a:lnTo>
                  <a:lnTo>
                    <a:pt x="246" y="705"/>
                  </a:lnTo>
                  <a:lnTo>
                    <a:pt x="241" y="705"/>
                  </a:lnTo>
                  <a:lnTo>
                    <a:pt x="241" y="705"/>
                  </a:lnTo>
                  <a:lnTo>
                    <a:pt x="237" y="705"/>
                  </a:lnTo>
                  <a:lnTo>
                    <a:pt x="237" y="705"/>
                  </a:lnTo>
                  <a:lnTo>
                    <a:pt x="232" y="705"/>
                  </a:lnTo>
                  <a:lnTo>
                    <a:pt x="232" y="705"/>
                  </a:lnTo>
                  <a:lnTo>
                    <a:pt x="227" y="705"/>
                  </a:lnTo>
                  <a:lnTo>
                    <a:pt x="227" y="705"/>
                  </a:lnTo>
                  <a:lnTo>
                    <a:pt x="223" y="705"/>
                  </a:lnTo>
                  <a:lnTo>
                    <a:pt x="223" y="705"/>
                  </a:lnTo>
                  <a:lnTo>
                    <a:pt x="218" y="705"/>
                  </a:lnTo>
                  <a:lnTo>
                    <a:pt x="218" y="705"/>
                  </a:lnTo>
                  <a:lnTo>
                    <a:pt x="213" y="705"/>
                  </a:lnTo>
                  <a:lnTo>
                    <a:pt x="213" y="705"/>
                  </a:lnTo>
                  <a:lnTo>
                    <a:pt x="209" y="705"/>
                  </a:lnTo>
                  <a:lnTo>
                    <a:pt x="209" y="705"/>
                  </a:lnTo>
                  <a:lnTo>
                    <a:pt x="204" y="705"/>
                  </a:lnTo>
                  <a:lnTo>
                    <a:pt x="204" y="705"/>
                  </a:lnTo>
                  <a:lnTo>
                    <a:pt x="199" y="705"/>
                  </a:lnTo>
                  <a:lnTo>
                    <a:pt x="199" y="705"/>
                  </a:lnTo>
                  <a:lnTo>
                    <a:pt x="199" y="705"/>
                  </a:lnTo>
                  <a:lnTo>
                    <a:pt x="195" y="705"/>
                  </a:lnTo>
                  <a:lnTo>
                    <a:pt x="195" y="705"/>
                  </a:lnTo>
                  <a:lnTo>
                    <a:pt x="190" y="705"/>
                  </a:lnTo>
                  <a:lnTo>
                    <a:pt x="190" y="705"/>
                  </a:lnTo>
                  <a:lnTo>
                    <a:pt x="186" y="705"/>
                  </a:lnTo>
                  <a:lnTo>
                    <a:pt x="186" y="705"/>
                  </a:lnTo>
                  <a:lnTo>
                    <a:pt x="181" y="705"/>
                  </a:lnTo>
                  <a:lnTo>
                    <a:pt x="181" y="705"/>
                  </a:lnTo>
                  <a:lnTo>
                    <a:pt x="176" y="705"/>
                  </a:lnTo>
                  <a:lnTo>
                    <a:pt x="176" y="705"/>
                  </a:lnTo>
                  <a:lnTo>
                    <a:pt x="172" y="705"/>
                  </a:lnTo>
                  <a:lnTo>
                    <a:pt x="172" y="705"/>
                  </a:lnTo>
                  <a:lnTo>
                    <a:pt x="167" y="705"/>
                  </a:lnTo>
                  <a:lnTo>
                    <a:pt x="167" y="705"/>
                  </a:lnTo>
                  <a:lnTo>
                    <a:pt x="162" y="705"/>
                  </a:lnTo>
                  <a:lnTo>
                    <a:pt x="162" y="705"/>
                  </a:lnTo>
                  <a:lnTo>
                    <a:pt x="158" y="705"/>
                  </a:lnTo>
                  <a:lnTo>
                    <a:pt x="158" y="705"/>
                  </a:lnTo>
                  <a:lnTo>
                    <a:pt x="153" y="705"/>
                  </a:lnTo>
                  <a:lnTo>
                    <a:pt x="153" y="705"/>
                  </a:lnTo>
                  <a:lnTo>
                    <a:pt x="148" y="705"/>
                  </a:lnTo>
                  <a:lnTo>
                    <a:pt x="148" y="705"/>
                  </a:lnTo>
                  <a:lnTo>
                    <a:pt x="144" y="705"/>
                  </a:lnTo>
                  <a:lnTo>
                    <a:pt x="144" y="705"/>
                  </a:lnTo>
                  <a:lnTo>
                    <a:pt x="139" y="705"/>
                  </a:lnTo>
                  <a:lnTo>
                    <a:pt x="139" y="705"/>
                  </a:lnTo>
                  <a:lnTo>
                    <a:pt x="135" y="705"/>
                  </a:lnTo>
                  <a:lnTo>
                    <a:pt x="135" y="705"/>
                  </a:lnTo>
                  <a:lnTo>
                    <a:pt x="135" y="705"/>
                  </a:lnTo>
                  <a:lnTo>
                    <a:pt x="130" y="705"/>
                  </a:lnTo>
                  <a:lnTo>
                    <a:pt x="130" y="705"/>
                  </a:lnTo>
                  <a:lnTo>
                    <a:pt x="125" y="705"/>
                  </a:lnTo>
                  <a:lnTo>
                    <a:pt x="125" y="705"/>
                  </a:lnTo>
                  <a:lnTo>
                    <a:pt x="121" y="705"/>
                  </a:lnTo>
                  <a:lnTo>
                    <a:pt x="121" y="705"/>
                  </a:lnTo>
                  <a:lnTo>
                    <a:pt x="116" y="705"/>
                  </a:lnTo>
                  <a:lnTo>
                    <a:pt x="116" y="705"/>
                  </a:lnTo>
                  <a:lnTo>
                    <a:pt x="111" y="705"/>
                  </a:lnTo>
                  <a:lnTo>
                    <a:pt x="111" y="705"/>
                  </a:lnTo>
                  <a:lnTo>
                    <a:pt x="107" y="705"/>
                  </a:lnTo>
                  <a:lnTo>
                    <a:pt x="107" y="705"/>
                  </a:lnTo>
                  <a:lnTo>
                    <a:pt x="102" y="705"/>
                  </a:lnTo>
                  <a:lnTo>
                    <a:pt x="102" y="705"/>
                  </a:lnTo>
                  <a:lnTo>
                    <a:pt x="97" y="705"/>
                  </a:lnTo>
                  <a:lnTo>
                    <a:pt x="97" y="705"/>
                  </a:lnTo>
                  <a:lnTo>
                    <a:pt x="93" y="705"/>
                  </a:lnTo>
                  <a:lnTo>
                    <a:pt x="93" y="705"/>
                  </a:lnTo>
                  <a:lnTo>
                    <a:pt x="88" y="705"/>
                  </a:lnTo>
                  <a:lnTo>
                    <a:pt x="88" y="705"/>
                  </a:lnTo>
                  <a:lnTo>
                    <a:pt x="83" y="705"/>
                  </a:lnTo>
                  <a:lnTo>
                    <a:pt x="83" y="705"/>
                  </a:lnTo>
                  <a:lnTo>
                    <a:pt x="79" y="705"/>
                  </a:lnTo>
                  <a:lnTo>
                    <a:pt x="79" y="705"/>
                  </a:lnTo>
                  <a:lnTo>
                    <a:pt x="74" y="705"/>
                  </a:lnTo>
                  <a:lnTo>
                    <a:pt x="74" y="705"/>
                  </a:lnTo>
                  <a:lnTo>
                    <a:pt x="70" y="705"/>
                  </a:lnTo>
                  <a:lnTo>
                    <a:pt x="70" y="705"/>
                  </a:lnTo>
                  <a:lnTo>
                    <a:pt x="65" y="705"/>
                  </a:lnTo>
                  <a:lnTo>
                    <a:pt x="65" y="705"/>
                  </a:lnTo>
                  <a:lnTo>
                    <a:pt x="65" y="705"/>
                  </a:lnTo>
                  <a:lnTo>
                    <a:pt x="60" y="705"/>
                  </a:lnTo>
                  <a:lnTo>
                    <a:pt x="60" y="705"/>
                  </a:lnTo>
                  <a:lnTo>
                    <a:pt x="56" y="705"/>
                  </a:lnTo>
                  <a:lnTo>
                    <a:pt x="56" y="705"/>
                  </a:lnTo>
                  <a:lnTo>
                    <a:pt x="51" y="705"/>
                  </a:lnTo>
                  <a:lnTo>
                    <a:pt x="51" y="705"/>
                  </a:lnTo>
                  <a:lnTo>
                    <a:pt x="46" y="705"/>
                  </a:lnTo>
                  <a:lnTo>
                    <a:pt x="46" y="705"/>
                  </a:lnTo>
                  <a:lnTo>
                    <a:pt x="42" y="705"/>
                  </a:lnTo>
                  <a:lnTo>
                    <a:pt x="42" y="705"/>
                  </a:lnTo>
                  <a:lnTo>
                    <a:pt x="37" y="705"/>
                  </a:lnTo>
                  <a:lnTo>
                    <a:pt x="37" y="705"/>
                  </a:lnTo>
                  <a:lnTo>
                    <a:pt x="32" y="705"/>
                  </a:lnTo>
                  <a:lnTo>
                    <a:pt x="32" y="705"/>
                  </a:lnTo>
                  <a:lnTo>
                    <a:pt x="28" y="705"/>
                  </a:lnTo>
                  <a:lnTo>
                    <a:pt x="28" y="705"/>
                  </a:lnTo>
                  <a:lnTo>
                    <a:pt x="23" y="705"/>
                  </a:lnTo>
                  <a:lnTo>
                    <a:pt x="23" y="705"/>
                  </a:lnTo>
                  <a:lnTo>
                    <a:pt x="19" y="705"/>
                  </a:lnTo>
                  <a:lnTo>
                    <a:pt x="19" y="705"/>
                  </a:lnTo>
                  <a:lnTo>
                    <a:pt x="14" y="705"/>
                  </a:lnTo>
                  <a:lnTo>
                    <a:pt x="14" y="705"/>
                  </a:lnTo>
                  <a:lnTo>
                    <a:pt x="9" y="705"/>
                  </a:lnTo>
                  <a:lnTo>
                    <a:pt x="9" y="705"/>
                  </a:lnTo>
                  <a:lnTo>
                    <a:pt x="5" y="705"/>
                  </a:lnTo>
                  <a:lnTo>
                    <a:pt x="0" y="705"/>
                  </a:lnTo>
                  <a:lnTo>
                    <a:pt x="0" y="705"/>
                  </a:lnTo>
                  <a:close/>
                </a:path>
              </a:pathLst>
            </a:custGeom>
            <a:solidFill>
              <a:srgbClr val="eaeaea"/>
            </a:solidFill>
            <a:ln w="9360">
              <a:solidFill>
                <a:srgbClr val="c6c6c6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0" name=""/>
            <p:cNvSpPr/>
            <p:nvPr/>
          </p:nvSpPr>
          <p:spPr>
            <a:xfrm>
              <a:off x="1017720" y="1812960"/>
              <a:ext cx="4000320" cy="799920"/>
            </a:xfrm>
            <a:custGeom>
              <a:avLst/>
              <a:gdLst/>
              <a:ahLst/>
              <a:rect l="l" t="t" r="r" b="b"/>
              <a:pathLst>
                <a:path w="2419" h="504">
                  <a:moveTo>
                    <a:pt x="0" y="504"/>
                  </a:moveTo>
                  <a:lnTo>
                    <a:pt x="5" y="504"/>
                  </a:lnTo>
                  <a:lnTo>
                    <a:pt x="5" y="504"/>
                  </a:lnTo>
                  <a:lnTo>
                    <a:pt x="9" y="504"/>
                  </a:lnTo>
                  <a:lnTo>
                    <a:pt x="9" y="504"/>
                  </a:lnTo>
                  <a:lnTo>
                    <a:pt x="15" y="504"/>
                  </a:lnTo>
                  <a:lnTo>
                    <a:pt x="15" y="504"/>
                  </a:lnTo>
                  <a:lnTo>
                    <a:pt x="20" y="504"/>
                  </a:lnTo>
                  <a:lnTo>
                    <a:pt x="20" y="504"/>
                  </a:lnTo>
                  <a:lnTo>
                    <a:pt x="24" y="504"/>
                  </a:lnTo>
                  <a:lnTo>
                    <a:pt x="24" y="504"/>
                  </a:lnTo>
                  <a:lnTo>
                    <a:pt x="29" y="504"/>
                  </a:lnTo>
                  <a:lnTo>
                    <a:pt x="29" y="504"/>
                  </a:lnTo>
                  <a:lnTo>
                    <a:pt x="33" y="504"/>
                  </a:lnTo>
                  <a:lnTo>
                    <a:pt x="33" y="504"/>
                  </a:lnTo>
                  <a:lnTo>
                    <a:pt x="38" y="504"/>
                  </a:lnTo>
                  <a:lnTo>
                    <a:pt x="38" y="504"/>
                  </a:lnTo>
                  <a:lnTo>
                    <a:pt x="44" y="504"/>
                  </a:lnTo>
                  <a:lnTo>
                    <a:pt x="44" y="504"/>
                  </a:lnTo>
                  <a:lnTo>
                    <a:pt x="48" y="504"/>
                  </a:lnTo>
                  <a:lnTo>
                    <a:pt x="48" y="504"/>
                  </a:lnTo>
                  <a:lnTo>
                    <a:pt x="53" y="504"/>
                  </a:lnTo>
                  <a:lnTo>
                    <a:pt x="53" y="504"/>
                  </a:lnTo>
                  <a:lnTo>
                    <a:pt x="58" y="504"/>
                  </a:lnTo>
                  <a:lnTo>
                    <a:pt x="58" y="504"/>
                  </a:lnTo>
                  <a:lnTo>
                    <a:pt x="62" y="504"/>
                  </a:lnTo>
                  <a:lnTo>
                    <a:pt x="62" y="504"/>
                  </a:lnTo>
                  <a:lnTo>
                    <a:pt x="68" y="504"/>
                  </a:lnTo>
                  <a:lnTo>
                    <a:pt x="68" y="504"/>
                  </a:lnTo>
                  <a:lnTo>
                    <a:pt x="68" y="504"/>
                  </a:lnTo>
                  <a:lnTo>
                    <a:pt x="73" y="504"/>
                  </a:lnTo>
                  <a:lnTo>
                    <a:pt x="73" y="504"/>
                  </a:lnTo>
                  <a:lnTo>
                    <a:pt x="77" y="504"/>
                  </a:lnTo>
                  <a:lnTo>
                    <a:pt x="77" y="504"/>
                  </a:lnTo>
                  <a:lnTo>
                    <a:pt x="82" y="504"/>
                  </a:lnTo>
                  <a:lnTo>
                    <a:pt x="82" y="504"/>
                  </a:lnTo>
                  <a:lnTo>
                    <a:pt x="86" y="504"/>
                  </a:lnTo>
                  <a:lnTo>
                    <a:pt x="86" y="504"/>
                  </a:lnTo>
                  <a:lnTo>
                    <a:pt x="92" y="504"/>
                  </a:lnTo>
                  <a:lnTo>
                    <a:pt x="92" y="504"/>
                  </a:lnTo>
                  <a:lnTo>
                    <a:pt x="97" y="504"/>
                  </a:lnTo>
                  <a:lnTo>
                    <a:pt x="97" y="504"/>
                  </a:lnTo>
                  <a:lnTo>
                    <a:pt x="101" y="504"/>
                  </a:lnTo>
                  <a:lnTo>
                    <a:pt x="101" y="504"/>
                  </a:lnTo>
                  <a:lnTo>
                    <a:pt x="106" y="504"/>
                  </a:lnTo>
                  <a:lnTo>
                    <a:pt x="106" y="504"/>
                  </a:lnTo>
                  <a:lnTo>
                    <a:pt x="111" y="504"/>
                  </a:lnTo>
                  <a:lnTo>
                    <a:pt x="111" y="504"/>
                  </a:lnTo>
                  <a:lnTo>
                    <a:pt x="115" y="504"/>
                  </a:lnTo>
                  <a:lnTo>
                    <a:pt x="115" y="504"/>
                  </a:lnTo>
                  <a:lnTo>
                    <a:pt x="121" y="504"/>
                  </a:lnTo>
                  <a:lnTo>
                    <a:pt x="121" y="504"/>
                  </a:lnTo>
                  <a:lnTo>
                    <a:pt x="126" y="504"/>
                  </a:lnTo>
                  <a:lnTo>
                    <a:pt x="126" y="504"/>
                  </a:lnTo>
                  <a:lnTo>
                    <a:pt x="130" y="504"/>
                  </a:lnTo>
                  <a:lnTo>
                    <a:pt x="130" y="504"/>
                  </a:lnTo>
                  <a:lnTo>
                    <a:pt x="135" y="504"/>
                  </a:lnTo>
                  <a:lnTo>
                    <a:pt x="135" y="504"/>
                  </a:lnTo>
                  <a:lnTo>
                    <a:pt x="140" y="504"/>
                  </a:lnTo>
                  <a:lnTo>
                    <a:pt x="140" y="504"/>
                  </a:lnTo>
                  <a:lnTo>
                    <a:pt x="140" y="504"/>
                  </a:lnTo>
                  <a:lnTo>
                    <a:pt x="145" y="504"/>
                  </a:lnTo>
                  <a:lnTo>
                    <a:pt x="145" y="504"/>
                  </a:lnTo>
                  <a:lnTo>
                    <a:pt x="150" y="504"/>
                  </a:lnTo>
                  <a:lnTo>
                    <a:pt x="150" y="504"/>
                  </a:lnTo>
                  <a:lnTo>
                    <a:pt x="154" y="504"/>
                  </a:lnTo>
                  <a:lnTo>
                    <a:pt x="154" y="504"/>
                  </a:lnTo>
                  <a:lnTo>
                    <a:pt x="159" y="504"/>
                  </a:lnTo>
                  <a:lnTo>
                    <a:pt x="159" y="504"/>
                  </a:lnTo>
                  <a:lnTo>
                    <a:pt x="164" y="504"/>
                  </a:lnTo>
                  <a:lnTo>
                    <a:pt x="164" y="504"/>
                  </a:lnTo>
                  <a:lnTo>
                    <a:pt x="169" y="403"/>
                  </a:lnTo>
                  <a:lnTo>
                    <a:pt x="169" y="403"/>
                  </a:lnTo>
                  <a:lnTo>
                    <a:pt x="174" y="403"/>
                  </a:lnTo>
                  <a:lnTo>
                    <a:pt x="174" y="403"/>
                  </a:lnTo>
                  <a:lnTo>
                    <a:pt x="179" y="403"/>
                  </a:lnTo>
                  <a:lnTo>
                    <a:pt x="179" y="403"/>
                  </a:lnTo>
                  <a:lnTo>
                    <a:pt x="183" y="403"/>
                  </a:lnTo>
                  <a:lnTo>
                    <a:pt x="183" y="403"/>
                  </a:lnTo>
                  <a:lnTo>
                    <a:pt x="188" y="403"/>
                  </a:lnTo>
                  <a:lnTo>
                    <a:pt x="188" y="403"/>
                  </a:lnTo>
                  <a:lnTo>
                    <a:pt x="194" y="403"/>
                  </a:lnTo>
                  <a:lnTo>
                    <a:pt x="194" y="403"/>
                  </a:lnTo>
                  <a:lnTo>
                    <a:pt x="198" y="403"/>
                  </a:lnTo>
                  <a:lnTo>
                    <a:pt x="198" y="403"/>
                  </a:lnTo>
                  <a:lnTo>
                    <a:pt x="203" y="403"/>
                  </a:lnTo>
                  <a:lnTo>
                    <a:pt x="203" y="403"/>
                  </a:lnTo>
                  <a:lnTo>
                    <a:pt x="207" y="403"/>
                  </a:lnTo>
                  <a:lnTo>
                    <a:pt x="207" y="403"/>
                  </a:lnTo>
                  <a:lnTo>
                    <a:pt x="207" y="403"/>
                  </a:lnTo>
                  <a:lnTo>
                    <a:pt x="212" y="403"/>
                  </a:lnTo>
                  <a:lnTo>
                    <a:pt x="212" y="403"/>
                  </a:lnTo>
                  <a:lnTo>
                    <a:pt x="217" y="403"/>
                  </a:lnTo>
                  <a:lnTo>
                    <a:pt x="217" y="403"/>
                  </a:lnTo>
                  <a:lnTo>
                    <a:pt x="222" y="403"/>
                  </a:lnTo>
                  <a:lnTo>
                    <a:pt x="222" y="403"/>
                  </a:lnTo>
                  <a:lnTo>
                    <a:pt x="227" y="403"/>
                  </a:lnTo>
                  <a:lnTo>
                    <a:pt x="227" y="403"/>
                  </a:lnTo>
                  <a:lnTo>
                    <a:pt x="232" y="403"/>
                  </a:lnTo>
                  <a:lnTo>
                    <a:pt x="232" y="403"/>
                  </a:lnTo>
                  <a:lnTo>
                    <a:pt x="236" y="403"/>
                  </a:lnTo>
                  <a:lnTo>
                    <a:pt x="236" y="403"/>
                  </a:lnTo>
                  <a:lnTo>
                    <a:pt x="241" y="403"/>
                  </a:lnTo>
                  <a:lnTo>
                    <a:pt x="241" y="403"/>
                  </a:lnTo>
                  <a:lnTo>
                    <a:pt x="247" y="403"/>
                  </a:lnTo>
                  <a:lnTo>
                    <a:pt x="247" y="403"/>
                  </a:lnTo>
                  <a:lnTo>
                    <a:pt x="251" y="403"/>
                  </a:lnTo>
                  <a:lnTo>
                    <a:pt x="251" y="403"/>
                  </a:lnTo>
                  <a:lnTo>
                    <a:pt x="256" y="403"/>
                  </a:lnTo>
                  <a:lnTo>
                    <a:pt x="256" y="403"/>
                  </a:lnTo>
                  <a:lnTo>
                    <a:pt x="260" y="403"/>
                  </a:lnTo>
                  <a:lnTo>
                    <a:pt x="260" y="403"/>
                  </a:lnTo>
                  <a:lnTo>
                    <a:pt x="265" y="403"/>
                  </a:lnTo>
                  <a:lnTo>
                    <a:pt x="265" y="403"/>
                  </a:lnTo>
                  <a:lnTo>
                    <a:pt x="271" y="403"/>
                  </a:lnTo>
                  <a:lnTo>
                    <a:pt x="271" y="403"/>
                  </a:lnTo>
                  <a:lnTo>
                    <a:pt x="275" y="403"/>
                  </a:lnTo>
                  <a:lnTo>
                    <a:pt x="275" y="403"/>
                  </a:lnTo>
                  <a:lnTo>
                    <a:pt x="275" y="403"/>
                  </a:lnTo>
                  <a:lnTo>
                    <a:pt x="280" y="403"/>
                  </a:lnTo>
                  <a:lnTo>
                    <a:pt x="280" y="403"/>
                  </a:lnTo>
                  <a:lnTo>
                    <a:pt x="285" y="403"/>
                  </a:lnTo>
                  <a:lnTo>
                    <a:pt x="285" y="403"/>
                  </a:lnTo>
                  <a:lnTo>
                    <a:pt x="289" y="403"/>
                  </a:lnTo>
                  <a:lnTo>
                    <a:pt x="289" y="403"/>
                  </a:lnTo>
                  <a:lnTo>
                    <a:pt x="294" y="403"/>
                  </a:lnTo>
                  <a:lnTo>
                    <a:pt x="294" y="403"/>
                  </a:lnTo>
                  <a:lnTo>
                    <a:pt x="300" y="403"/>
                  </a:lnTo>
                  <a:lnTo>
                    <a:pt x="300" y="403"/>
                  </a:lnTo>
                  <a:lnTo>
                    <a:pt x="304" y="403"/>
                  </a:lnTo>
                  <a:lnTo>
                    <a:pt x="304" y="403"/>
                  </a:lnTo>
                  <a:lnTo>
                    <a:pt x="309" y="403"/>
                  </a:lnTo>
                  <a:lnTo>
                    <a:pt x="309" y="403"/>
                  </a:lnTo>
                  <a:lnTo>
                    <a:pt x="313" y="403"/>
                  </a:lnTo>
                  <a:lnTo>
                    <a:pt x="313" y="403"/>
                  </a:lnTo>
                  <a:lnTo>
                    <a:pt x="318" y="403"/>
                  </a:lnTo>
                  <a:lnTo>
                    <a:pt x="318" y="403"/>
                  </a:lnTo>
                  <a:lnTo>
                    <a:pt x="324" y="403"/>
                  </a:lnTo>
                  <a:lnTo>
                    <a:pt x="324" y="403"/>
                  </a:lnTo>
                  <a:lnTo>
                    <a:pt x="328" y="403"/>
                  </a:lnTo>
                  <a:lnTo>
                    <a:pt x="328" y="302"/>
                  </a:lnTo>
                  <a:lnTo>
                    <a:pt x="333" y="302"/>
                  </a:lnTo>
                  <a:lnTo>
                    <a:pt x="333" y="302"/>
                  </a:lnTo>
                  <a:lnTo>
                    <a:pt x="338" y="302"/>
                  </a:lnTo>
                  <a:lnTo>
                    <a:pt x="338" y="302"/>
                  </a:lnTo>
                  <a:lnTo>
                    <a:pt x="342" y="302"/>
                  </a:lnTo>
                  <a:lnTo>
                    <a:pt x="342" y="302"/>
                  </a:lnTo>
                  <a:lnTo>
                    <a:pt x="342" y="302"/>
                  </a:lnTo>
                  <a:lnTo>
                    <a:pt x="348" y="302"/>
                  </a:lnTo>
                  <a:lnTo>
                    <a:pt x="348" y="302"/>
                  </a:lnTo>
                  <a:lnTo>
                    <a:pt x="353" y="302"/>
                  </a:lnTo>
                  <a:lnTo>
                    <a:pt x="353" y="302"/>
                  </a:lnTo>
                  <a:lnTo>
                    <a:pt x="357" y="302"/>
                  </a:lnTo>
                  <a:lnTo>
                    <a:pt x="357" y="302"/>
                  </a:lnTo>
                  <a:lnTo>
                    <a:pt x="362" y="302"/>
                  </a:lnTo>
                  <a:lnTo>
                    <a:pt x="362" y="302"/>
                  </a:lnTo>
                  <a:lnTo>
                    <a:pt x="366" y="302"/>
                  </a:lnTo>
                  <a:lnTo>
                    <a:pt x="366" y="302"/>
                  </a:lnTo>
                  <a:lnTo>
                    <a:pt x="371" y="302"/>
                  </a:lnTo>
                  <a:lnTo>
                    <a:pt x="371" y="302"/>
                  </a:lnTo>
                  <a:lnTo>
                    <a:pt x="377" y="302"/>
                  </a:lnTo>
                  <a:lnTo>
                    <a:pt x="377" y="302"/>
                  </a:lnTo>
                  <a:lnTo>
                    <a:pt x="381" y="302"/>
                  </a:lnTo>
                  <a:lnTo>
                    <a:pt x="381" y="302"/>
                  </a:lnTo>
                  <a:lnTo>
                    <a:pt x="386" y="302"/>
                  </a:lnTo>
                  <a:lnTo>
                    <a:pt x="386" y="302"/>
                  </a:lnTo>
                  <a:lnTo>
                    <a:pt x="391" y="302"/>
                  </a:lnTo>
                  <a:lnTo>
                    <a:pt x="391" y="302"/>
                  </a:lnTo>
                  <a:lnTo>
                    <a:pt x="395" y="302"/>
                  </a:lnTo>
                  <a:lnTo>
                    <a:pt x="395" y="302"/>
                  </a:lnTo>
                  <a:lnTo>
                    <a:pt x="401" y="302"/>
                  </a:lnTo>
                  <a:lnTo>
                    <a:pt x="401" y="302"/>
                  </a:lnTo>
                  <a:lnTo>
                    <a:pt x="406" y="403"/>
                  </a:lnTo>
                  <a:lnTo>
                    <a:pt x="406" y="403"/>
                  </a:lnTo>
                  <a:lnTo>
                    <a:pt x="410" y="403"/>
                  </a:lnTo>
                  <a:lnTo>
                    <a:pt x="410" y="403"/>
                  </a:lnTo>
                  <a:lnTo>
                    <a:pt x="415" y="403"/>
                  </a:lnTo>
                  <a:lnTo>
                    <a:pt x="415" y="403"/>
                  </a:lnTo>
                  <a:lnTo>
                    <a:pt x="415" y="403"/>
                  </a:lnTo>
                  <a:lnTo>
                    <a:pt x="420" y="302"/>
                  </a:lnTo>
                  <a:lnTo>
                    <a:pt x="420" y="302"/>
                  </a:lnTo>
                  <a:lnTo>
                    <a:pt x="425" y="302"/>
                  </a:lnTo>
                  <a:lnTo>
                    <a:pt x="425" y="302"/>
                  </a:lnTo>
                  <a:lnTo>
                    <a:pt x="430" y="302"/>
                  </a:lnTo>
                  <a:lnTo>
                    <a:pt x="430" y="403"/>
                  </a:lnTo>
                  <a:lnTo>
                    <a:pt x="434" y="403"/>
                  </a:lnTo>
                  <a:lnTo>
                    <a:pt x="434" y="403"/>
                  </a:lnTo>
                  <a:lnTo>
                    <a:pt x="439" y="403"/>
                  </a:lnTo>
                  <a:lnTo>
                    <a:pt x="439" y="403"/>
                  </a:lnTo>
                  <a:lnTo>
                    <a:pt x="444" y="403"/>
                  </a:lnTo>
                  <a:lnTo>
                    <a:pt x="444" y="302"/>
                  </a:lnTo>
                  <a:lnTo>
                    <a:pt x="448" y="302"/>
                  </a:lnTo>
                  <a:lnTo>
                    <a:pt x="448" y="302"/>
                  </a:lnTo>
                  <a:lnTo>
                    <a:pt x="454" y="302"/>
                  </a:lnTo>
                  <a:lnTo>
                    <a:pt x="454" y="302"/>
                  </a:lnTo>
                  <a:lnTo>
                    <a:pt x="459" y="302"/>
                  </a:lnTo>
                  <a:lnTo>
                    <a:pt x="459" y="302"/>
                  </a:lnTo>
                  <a:lnTo>
                    <a:pt x="463" y="302"/>
                  </a:lnTo>
                  <a:lnTo>
                    <a:pt x="463" y="302"/>
                  </a:lnTo>
                  <a:lnTo>
                    <a:pt x="468" y="403"/>
                  </a:lnTo>
                  <a:lnTo>
                    <a:pt x="468" y="403"/>
                  </a:lnTo>
                  <a:lnTo>
                    <a:pt x="473" y="403"/>
                  </a:lnTo>
                  <a:lnTo>
                    <a:pt x="473" y="403"/>
                  </a:lnTo>
                  <a:lnTo>
                    <a:pt x="478" y="403"/>
                  </a:lnTo>
                  <a:lnTo>
                    <a:pt x="478" y="302"/>
                  </a:lnTo>
                  <a:lnTo>
                    <a:pt x="483" y="302"/>
                  </a:lnTo>
                  <a:lnTo>
                    <a:pt x="483" y="302"/>
                  </a:lnTo>
                  <a:lnTo>
                    <a:pt x="483" y="302"/>
                  </a:lnTo>
                  <a:lnTo>
                    <a:pt x="487" y="302"/>
                  </a:lnTo>
                  <a:lnTo>
                    <a:pt x="487" y="302"/>
                  </a:lnTo>
                  <a:lnTo>
                    <a:pt x="492" y="302"/>
                  </a:lnTo>
                  <a:lnTo>
                    <a:pt x="492" y="302"/>
                  </a:lnTo>
                  <a:lnTo>
                    <a:pt x="497" y="302"/>
                  </a:lnTo>
                  <a:lnTo>
                    <a:pt x="497" y="302"/>
                  </a:lnTo>
                  <a:lnTo>
                    <a:pt x="502" y="302"/>
                  </a:lnTo>
                  <a:lnTo>
                    <a:pt x="502" y="302"/>
                  </a:lnTo>
                  <a:lnTo>
                    <a:pt x="507" y="302"/>
                  </a:lnTo>
                  <a:lnTo>
                    <a:pt x="507" y="302"/>
                  </a:lnTo>
                  <a:lnTo>
                    <a:pt x="512" y="302"/>
                  </a:lnTo>
                  <a:lnTo>
                    <a:pt x="512" y="302"/>
                  </a:lnTo>
                  <a:lnTo>
                    <a:pt x="516" y="302"/>
                  </a:lnTo>
                  <a:lnTo>
                    <a:pt x="516" y="302"/>
                  </a:lnTo>
                  <a:lnTo>
                    <a:pt x="521" y="302"/>
                  </a:lnTo>
                  <a:lnTo>
                    <a:pt x="521" y="302"/>
                  </a:lnTo>
                  <a:lnTo>
                    <a:pt x="526" y="302"/>
                  </a:lnTo>
                  <a:lnTo>
                    <a:pt x="526" y="302"/>
                  </a:lnTo>
                  <a:lnTo>
                    <a:pt x="531" y="302"/>
                  </a:lnTo>
                  <a:lnTo>
                    <a:pt x="531" y="302"/>
                  </a:lnTo>
                  <a:lnTo>
                    <a:pt x="536" y="302"/>
                  </a:lnTo>
                  <a:lnTo>
                    <a:pt x="536" y="302"/>
                  </a:lnTo>
                  <a:lnTo>
                    <a:pt x="540" y="302"/>
                  </a:lnTo>
                  <a:lnTo>
                    <a:pt x="540" y="302"/>
                  </a:lnTo>
                  <a:lnTo>
                    <a:pt x="545" y="302"/>
                  </a:lnTo>
                  <a:lnTo>
                    <a:pt x="545" y="302"/>
                  </a:lnTo>
                  <a:lnTo>
                    <a:pt x="550" y="302"/>
                  </a:lnTo>
                  <a:lnTo>
                    <a:pt x="550" y="302"/>
                  </a:lnTo>
                  <a:lnTo>
                    <a:pt x="550" y="302"/>
                  </a:lnTo>
                  <a:lnTo>
                    <a:pt x="555" y="302"/>
                  </a:lnTo>
                  <a:lnTo>
                    <a:pt x="555" y="302"/>
                  </a:lnTo>
                  <a:lnTo>
                    <a:pt x="560" y="302"/>
                  </a:lnTo>
                  <a:lnTo>
                    <a:pt x="560" y="302"/>
                  </a:lnTo>
                  <a:lnTo>
                    <a:pt x="565" y="302"/>
                  </a:lnTo>
                  <a:lnTo>
                    <a:pt x="565" y="302"/>
                  </a:lnTo>
                  <a:lnTo>
                    <a:pt x="569" y="302"/>
                  </a:lnTo>
                  <a:lnTo>
                    <a:pt x="569" y="302"/>
                  </a:lnTo>
                  <a:lnTo>
                    <a:pt x="574" y="302"/>
                  </a:lnTo>
                  <a:lnTo>
                    <a:pt x="574" y="302"/>
                  </a:lnTo>
                  <a:lnTo>
                    <a:pt x="580" y="302"/>
                  </a:lnTo>
                  <a:lnTo>
                    <a:pt x="580" y="302"/>
                  </a:lnTo>
                  <a:lnTo>
                    <a:pt x="584" y="302"/>
                  </a:lnTo>
                  <a:lnTo>
                    <a:pt x="584" y="302"/>
                  </a:lnTo>
                  <a:lnTo>
                    <a:pt x="589" y="302"/>
                  </a:lnTo>
                  <a:lnTo>
                    <a:pt x="589" y="302"/>
                  </a:lnTo>
                  <a:lnTo>
                    <a:pt x="593" y="302"/>
                  </a:lnTo>
                  <a:lnTo>
                    <a:pt x="593" y="302"/>
                  </a:lnTo>
                  <a:lnTo>
                    <a:pt x="598" y="302"/>
                  </a:lnTo>
                  <a:lnTo>
                    <a:pt x="598" y="302"/>
                  </a:lnTo>
                  <a:lnTo>
                    <a:pt x="603" y="302"/>
                  </a:lnTo>
                  <a:lnTo>
                    <a:pt x="603" y="302"/>
                  </a:lnTo>
                  <a:lnTo>
                    <a:pt x="608" y="302"/>
                  </a:lnTo>
                  <a:lnTo>
                    <a:pt x="608" y="302"/>
                  </a:lnTo>
                  <a:lnTo>
                    <a:pt x="613" y="302"/>
                  </a:lnTo>
                  <a:lnTo>
                    <a:pt x="613" y="302"/>
                  </a:lnTo>
                  <a:lnTo>
                    <a:pt x="618" y="302"/>
                  </a:lnTo>
                  <a:lnTo>
                    <a:pt x="618" y="302"/>
                  </a:lnTo>
                  <a:lnTo>
                    <a:pt x="622" y="302"/>
                  </a:lnTo>
                  <a:lnTo>
                    <a:pt x="622" y="302"/>
                  </a:lnTo>
                  <a:lnTo>
                    <a:pt x="622" y="302"/>
                  </a:lnTo>
                  <a:lnTo>
                    <a:pt x="627" y="302"/>
                  </a:lnTo>
                  <a:lnTo>
                    <a:pt x="627" y="302"/>
                  </a:lnTo>
                  <a:lnTo>
                    <a:pt x="633" y="302"/>
                  </a:lnTo>
                  <a:lnTo>
                    <a:pt x="633" y="302"/>
                  </a:lnTo>
                  <a:lnTo>
                    <a:pt x="637" y="302"/>
                  </a:lnTo>
                  <a:lnTo>
                    <a:pt x="637" y="302"/>
                  </a:lnTo>
                  <a:lnTo>
                    <a:pt x="642" y="302"/>
                  </a:lnTo>
                  <a:lnTo>
                    <a:pt x="642" y="302"/>
                  </a:lnTo>
                  <a:lnTo>
                    <a:pt x="646" y="302"/>
                  </a:lnTo>
                  <a:lnTo>
                    <a:pt x="646" y="302"/>
                  </a:lnTo>
                  <a:lnTo>
                    <a:pt x="651" y="302"/>
                  </a:lnTo>
                  <a:lnTo>
                    <a:pt x="651" y="302"/>
                  </a:lnTo>
                  <a:lnTo>
                    <a:pt x="657" y="302"/>
                  </a:lnTo>
                  <a:lnTo>
                    <a:pt x="657" y="302"/>
                  </a:lnTo>
                  <a:lnTo>
                    <a:pt x="661" y="302"/>
                  </a:lnTo>
                  <a:lnTo>
                    <a:pt x="661" y="302"/>
                  </a:lnTo>
                  <a:lnTo>
                    <a:pt x="666" y="302"/>
                  </a:lnTo>
                  <a:lnTo>
                    <a:pt x="666" y="302"/>
                  </a:lnTo>
                  <a:lnTo>
                    <a:pt x="671" y="302"/>
                  </a:lnTo>
                  <a:lnTo>
                    <a:pt x="671" y="302"/>
                  </a:lnTo>
                  <a:lnTo>
                    <a:pt x="675" y="302"/>
                  </a:lnTo>
                  <a:lnTo>
                    <a:pt x="675" y="302"/>
                  </a:lnTo>
                  <a:lnTo>
                    <a:pt x="680" y="302"/>
                  </a:lnTo>
                  <a:lnTo>
                    <a:pt x="680" y="302"/>
                  </a:lnTo>
                  <a:lnTo>
                    <a:pt x="686" y="302"/>
                  </a:lnTo>
                  <a:lnTo>
                    <a:pt x="686" y="302"/>
                  </a:lnTo>
                  <a:lnTo>
                    <a:pt x="690" y="302"/>
                  </a:lnTo>
                  <a:lnTo>
                    <a:pt x="690" y="302"/>
                  </a:lnTo>
                  <a:lnTo>
                    <a:pt x="690" y="302"/>
                  </a:lnTo>
                  <a:lnTo>
                    <a:pt x="695" y="302"/>
                  </a:lnTo>
                  <a:lnTo>
                    <a:pt x="695" y="302"/>
                  </a:lnTo>
                  <a:lnTo>
                    <a:pt x="700" y="302"/>
                  </a:lnTo>
                  <a:lnTo>
                    <a:pt x="700" y="202"/>
                  </a:lnTo>
                  <a:lnTo>
                    <a:pt x="704" y="202"/>
                  </a:lnTo>
                  <a:lnTo>
                    <a:pt x="704" y="202"/>
                  </a:lnTo>
                  <a:lnTo>
                    <a:pt x="710" y="202"/>
                  </a:lnTo>
                  <a:lnTo>
                    <a:pt x="710" y="202"/>
                  </a:lnTo>
                  <a:lnTo>
                    <a:pt x="714" y="202"/>
                  </a:lnTo>
                  <a:lnTo>
                    <a:pt x="714" y="202"/>
                  </a:lnTo>
                  <a:lnTo>
                    <a:pt x="719" y="202"/>
                  </a:lnTo>
                  <a:lnTo>
                    <a:pt x="719" y="202"/>
                  </a:lnTo>
                  <a:lnTo>
                    <a:pt x="724" y="202"/>
                  </a:lnTo>
                  <a:lnTo>
                    <a:pt x="724" y="202"/>
                  </a:lnTo>
                  <a:lnTo>
                    <a:pt x="728" y="202"/>
                  </a:lnTo>
                  <a:lnTo>
                    <a:pt x="728" y="202"/>
                  </a:lnTo>
                  <a:lnTo>
                    <a:pt x="734" y="202"/>
                  </a:lnTo>
                  <a:lnTo>
                    <a:pt x="734" y="202"/>
                  </a:lnTo>
                  <a:lnTo>
                    <a:pt x="739" y="202"/>
                  </a:lnTo>
                  <a:lnTo>
                    <a:pt x="739" y="202"/>
                  </a:lnTo>
                  <a:lnTo>
                    <a:pt x="743" y="202"/>
                  </a:lnTo>
                  <a:lnTo>
                    <a:pt x="743" y="202"/>
                  </a:lnTo>
                  <a:lnTo>
                    <a:pt x="748" y="202"/>
                  </a:lnTo>
                  <a:lnTo>
                    <a:pt x="748" y="202"/>
                  </a:lnTo>
                  <a:lnTo>
                    <a:pt x="753" y="202"/>
                  </a:lnTo>
                  <a:lnTo>
                    <a:pt x="753" y="202"/>
                  </a:lnTo>
                  <a:lnTo>
                    <a:pt x="757" y="202"/>
                  </a:lnTo>
                  <a:lnTo>
                    <a:pt x="757" y="202"/>
                  </a:lnTo>
                  <a:lnTo>
                    <a:pt x="757" y="202"/>
                  </a:lnTo>
                  <a:lnTo>
                    <a:pt x="763" y="101"/>
                  </a:lnTo>
                  <a:lnTo>
                    <a:pt x="763" y="202"/>
                  </a:lnTo>
                  <a:lnTo>
                    <a:pt x="767" y="202"/>
                  </a:lnTo>
                  <a:lnTo>
                    <a:pt x="767" y="202"/>
                  </a:lnTo>
                  <a:lnTo>
                    <a:pt x="772" y="202"/>
                  </a:lnTo>
                  <a:lnTo>
                    <a:pt x="772" y="202"/>
                  </a:lnTo>
                  <a:lnTo>
                    <a:pt x="777" y="202"/>
                  </a:lnTo>
                  <a:lnTo>
                    <a:pt x="777" y="202"/>
                  </a:lnTo>
                  <a:lnTo>
                    <a:pt x="781" y="202"/>
                  </a:lnTo>
                  <a:lnTo>
                    <a:pt x="781" y="202"/>
                  </a:lnTo>
                  <a:lnTo>
                    <a:pt x="787" y="202"/>
                  </a:lnTo>
                  <a:lnTo>
                    <a:pt x="787" y="101"/>
                  </a:lnTo>
                  <a:lnTo>
                    <a:pt x="792" y="101"/>
                  </a:lnTo>
                  <a:lnTo>
                    <a:pt x="792" y="101"/>
                  </a:lnTo>
                  <a:lnTo>
                    <a:pt x="796" y="101"/>
                  </a:lnTo>
                  <a:lnTo>
                    <a:pt x="796" y="101"/>
                  </a:lnTo>
                  <a:lnTo>
                    <a:pt x="801" y="101"/>
                  </a:lnTo>
                  <a:lnTo>
                    <a:pt x="801" y="101"/>
                  </a:lnTo>
                  <a:lnTo>
                    <a:pt x="806" y="202"/>
                  </a:lnTo>
                  <a:lnTo>
                    <a:pt x="806" y="202"/>
                  </a:lnTo>
                  <a:lnTo>
                    <a:pt x="811" y="202"/>
                  </a:lnTo>
                  <a:lnTo>
                    <a:pt x="811" y="202"/>
                  </a:lnTo>
                  <a:lnTo>
                    <a:pt x="816" y="101"/>
                  </a:lnTo>
                  <a:lnTo>
                    <a:pt x="816" y="202"/>
                  </a:lnTo>
                  <a:lnTo>
                    <a:pt x="820" y="202"/>
                  </a:lnTo>
                  <a:lnTo>
                    <a:pt x="820" y="202"/>
                  </a:lnTo>
                  <a:lnTo>
                    <a:pt x="825" y="202"/>
                  </a:lnTo>
                  <a:lnTo>
                    <a:pt x="825" y="202"/>
                  </a:lnTo>
                  <a:lnTo>
                    <a:pt x="825" y="202"/>
                  </a:lnTo>
                  <a:lnTo>
                    <a:pt x="830" y="202"/>
                  </a:lnTo>
                  <a:lnTo>
                    <a:pt x="830" y="202"/>
                  </a:lnTo>
                  <a:lnTo>
                    <a:pt x="834" y="202"/>
                  </a:lnTo>
                  <a:lnTo>
                    <a:pt x="834" y="202"/>
                  </a:lnTo>
                  <a:lnTo>
                    <a:pt x="840" y="202"/>
                  </a:lnTo>
                  <a:lnTo>
                    <a:pt x="840" y="202"/>
                  </a:lnTo>
                  <a:lnTo>
                    <a:pt x="845" y="202"/>
                  </a:lnTo>
                  <a:lnTo>
                    <a:pt x="845" y="202"/>
                  </a:lnTo>
                  <a:lnTo>
                    <a:pt x="849" y="202"/>
                  </a:lnTo>
                  <a:lnTo>
                    <a:pt x="849" y="202"/>
                  </a:lnTo>
                  <a:lnTo>
                    <a:pt x="854" y="202"/>
                  </a:lnTo>
                  <a:lnTo>
                    <a:pt x="854" y="202"/>
                  </a:lnTo>
                  <a:lnTo>
                    <a:pt x="859" y="202"/>
                  </a:lnTo>
                  <a:lnTo>
                    <a:pt x="859" y="202"/>
                  </a:lnTo>
                  <a:lnTo>
                    <a:pt x="864" y="202"/>
                  </a:lnTo>
                  <a:lnTo>
                    <a:pt x="864" y="202"/>
                  </a:lnTo>
                  <a:lnTo>
                    <a:pt x="869" y="202"/>
                  </a:lnTo>
                  <a:lnTo>
                    <a:pt x="869" y="101"/>
                  </a:lnTo>
                  <a:lnTo>
                    <a:pt x="873" y="101"/>
                  </a:lnTo>
                  <a:lnTo>
                    <a:pt x="873" y="101"/>
                  </a:lnTo>
                  <a:lnTo>
                    <a:pt x="878" y="101"/>
                  </a:lnTo>
                  <a:lnTo>
                    <a:pt x="878" y="101"/>
                  </a:lnTo>
                  <a:lnTo>
                    <a:pt x="883" y="101"/>
                  </a:lnTo>
                  <a:lnTo>
                    <a:pt x="883" y="101"/>
                  </a:lnTo>
                  <a:lnTo>
                    <a:pt x="888" y="101"/>
                  </a:lnTo>
                  <a:lnTo>
                    <a:pt x="888" y="101"/>
                  </a:lnTo>
                  <a:lnTo>
                    <a:pt x="893" y="101"/>
                  </a:lnTo>
                  <a:lnTo>
                    <a:pt x="893" y="101"/>
                  </a:lnTo>
                  <a:lnTo>
                    <a:pt x="898" y="101"/>
                  </a:lnTo>
                  <a:lnTo>
                    <a:pt x="898" y="101"/>
                  </a:lnTo>
                  <a:lnTo>
                    <a:pt x="898" y="101"/>
                  </a:lnTo>
                  <a:lnTo>
                    <a:pt x="902" y="101"/>
                  </a:lnTo>
                  <a:lnTo>
                    <a:pt x="902" y="101"/>
                  </a:lnTo>
                  <a:lnTo>
                    <a:pt x="907" y="101"/>
                  </a:lnTo>
                  <a:lnTo>
                    <a:pt x="907" y="101"/>
                  </a:lnTo>
                  <a:lnTo>
                    <a:pt x="912" y="101"/>
                  </a:lnTo>
                  <a:lnTo>
                    <a:pt x="912" y="101"/>
                  </a:lnTo>
                  <a:lnTo>
                    <a:pt x="917" y="101"/>
                  </a:lnTo>
                  <a:lnTo>
                    <a:pt x="917" y="101"/>
                  </a:lnTo>
                  <a:lnTo>
                    <a:pt x="922" y="101"/>
                  </a:lnTo>
                  <a:lnTo>
                    <a:pt x="922" y="101"/>
                  </a:lnTo>
                  <a:lnTo>
                    <a:pt x="926" y="101"/>
                  </a:lnTo>
                  <a:lnTo>
                    <a:pt x="926" y="0"/>
                  </a:lnTo>
                  <a:lnTo>
                    <a:pt x="931" y="101"/>
                  </a:lnTo>
                  <a:lnTo>
                    <a:pt x="931" y="101"/>
                  </a:lnTo>
                  <a:lnTo>
                    <a:pt x="936" y="101"/>
                  </a:lnTo>
                  <a:lnTo>
                    <a:pt x="936" y="101"/>
                  </a:lnTo>
                  <a:lnTo>
                    <a:pt x="941" y="101"/>
                  </a:lnTo>
                  <a:lnTo>
                    <a:pt x="941" y="101"/>
                  </a:lnTo>
                  <a:lnTo>
                    <a:pt x="946" y="101"/>
                  </a:lnTo>
                  <a:lnTo>
                    <a:pt x="946" y="0"/>
                  </a:lnTo>
                  <a:lnTo>
                    <a:pt x="951" y="0"/>
                  </a:lnTo>
                  <a:lnTo>
                    <a:pt x="951" y="0"/>
                  </a:lnTo>
                  <a:lnTo>
                    <a:pt x="955" y="0"/>
                  </a:lnTo>
                  <a:lnTo>
                    <a:pt x="955" y="0"/>
                  </a:lnTo>
                  <a:lnTo>
                    <a:pt x="960" y="0"/>
                  </a:lnTo>
                  <a:lnTo>
                    <a:pt x="960" y="101"/>
                  </a:lnTo>
                  <a:lnTo>
                    <a:pt x="966" y="101"/>
                  </a:lnTo>
                  <a:lnTo>
                    <a:pt x="966" y="101"/>
                  </a:lnTo>
                  <a:lnTo>
                    <a:pt x="966" y="101"/>
                  </a:lnTo>
                  <a:lnTo>
                    <a:pt x="970" y="0"/>
                  </a:lnTo>
                  <a:lnTo>
                    <a:pt x="970" y="0"/>
                  </a:lnTo>
                  <a:lnTo>
                    <a:pt x="975" y="0"/>
                  </a:lnTo>
                  <a:lnTo>
                    <a:pt x="975" y="0"/>
                  </a:lnTo>
                  <a:lnTo>
                    <a:pt x="980" y="0"/>
                  </a:lnTo>
                  <a:lnTo>
                    <a:pt x="980" y="0"/>
                  </a:lnTo>
                  <a:lnTo>
                    <a:pt x="984" y="0"/>
                  </a:lnTo>
                  <a:lnTo>
                    <a:pt x="984" y="0"/>
                  </a:lnTo>
                  <a:lnTo>
                    <a:pt x="989" y="101"/>
                  </a:lnTo>
                  <a:lnTo>
                    <a:pt x="989" y="101"/>
                  </a:lnTo>
                  <a:lnTo>
                    <a:pt x="994" y="101"/>
                  </a:lnTo>
                  <a:lnTo>
                    <a:pt x="994" y="101"/>
                  </a:lnTo>
                  <a:lnTo>
                    <a:pt x="999" y="101"/>
                  </a:lnTo>
                  <a:lnTo>
                    <a:pt x="999" y="101"/>
                  </a:lnTo>
                  <a:lnTo>
                    <a:pt x="1004" y="101"/>
                  </a:lnTo>
                  <a:lnTo>
                    <a:pt x="1004" y="101"/>
                  </a:lnTo>
                  <a:lnTo>
                    <a:pt x="1008" y="101"/>
                  </a:lnTo>
                  <a:lnTo>
                    <a:pt x="1008" y="101"/>
                  </a:lnTo>
                  <a:lnTo>
                    <a:pt x="1013" y="101"/>
                  </a:lnTo>
                  <a:lnTo>
                    <a:pt x="1013" y="101"/>
                  </a:lnTo>
                  <a:lnTo>
                    <a:pt x="1019" y="101"/>
                  </a:lnTo>
                  <a:lnTo>
                    <a:pt x="1019" y="101"/>
                  </a:lnTo>
                  <a:lnTo>
                    <a:pt x="1023" y="101"/>
                  </a:lnTo>
                  <a:lnTo>
                    <a:pt x="1023" y="101"/>
                  </a:lnTo>
                  <a:lnTo>
                    <a:pt x="1028" y="202"/>
                  </a:lnTo>
                  <a:lnTo>
                    <a:pt x="1028" y="101"/>
                  </a:lnTo>
                  <a:lnTo>
                    <a:pt x="1033" y="101"/>
                  </a:lnTo>
                  <a:lnTo>
                    <a:pt x="1033" y="101"/>
                  </a:lnTo>
                  <a:lnTo>
                    <a:pt x="1033" y="101"/>
                  </a:lnTo>
                  <a:lnTo>
                    <a:pt x="1037" y="101"/>
                  </a:lnTo>
                  <a:lnTo>
                    <a:pt x="1037" y="101"/>
                  </a:lnTo>
                  <a:lnTo>
                    <a:pt x="1043" y="101"/>
                  </a:lnTo>
                  <a:lnTo>
                    <a:pt x="1043" y="101"/>
                  </a:lnTo>
                  <a:lnTo>
                    <a:pt x="1047" y="202"/>
                  </a:lnTo>
                  <a:lnTo>
                    <a:pt x="1047" y="202"/>
                  </a:lnTo>
                  <a:lnTo>
                    <a:pt x="1052" y="202"/>
                  </a:lnTo>
                  <a:lnTo>
                    <a:pt x="1052" y="202"/>
                  </a:lnTo>
                  <a:lnTo>
                    <a:pt x="1057" y="202"/>
                  </a:lnTo>
                  <a:lnTo>
                    <a:pt x="1057" y="101"/>
                  </a:lnTo>
                  <a:lnTo>
                    <a:pt x="1061" y="202"/>
                  </a:lnTo>
                  <a:lnTo>
                    <a:pt x="1061" y="202"/>
                  </a:lnTo>
                  <a:lnTo>
                    <a:pt x="1066" y="202"/>
                  </a:lnTo>
                  <a:lnTo>
                    <a:pt x="1066" y="202"/>
                  </a:lnTo>
                  <a:lnTo>
                    <a:pt x="1072" y="202"/>
                  </a:lnTo>
                  <a:lnTo>
                    <a:pt x="1072" y="202"/>
                  </a:lnTo>
                  <a:lnTo>
                    <a:pt x="1076" y="202"/>
                  </a:lnTo>
                  <a:lnTo>
                    <a:pt x="1076" y="202"/>
                  </a:lnTo>
                  <a:lnTo>
                    <a:pt x="1081" y="101"/>
                  </a:lnTo>
                  <a:lnTo>
                    <a:pt x="1081" y="101"/>
                  </a:lnTo>
                  <a:lnTo>
                    <a:pt x="1086" y="202"/>
                  </a:lnTo>
                  <a:lnTo>
                    <a:pt x="1086" y="202"/>
                  </a:lnTo>
                  <a:lnTo>
                    <a:pt x="1090" y="202"/>
                  </a:lnTo>
                  <a:lnTo>
                    <a:pt x="1090" y="202"/>
                  </a:lnTo>
                  <a:lnTo>
                    <a:pt x="1096" y="202"/>
                  </a:lnTo>
                  <a:lnTo>
                    <a:pt x="1096" y="202"/>
                  </a:lnTo>
                  <a:lnTo>
                    <a:pt x="1100" y="202"/>
                  </a:lnTo>
                  <a:lnTo>
                    <a:pt x="1100" y="101"/>
                  </a:lnTo>
                  <a:lnTo>
                    <a:pt x="1105" y="101"/>
                  </a:lnTo>
                  <a:lnTo>
                    <a:pt x="1105" y="101"/>
                  </a:lnTo>
                  <a:lnTo>
                    <a:pt x="1105" y="101"/>
                  </a:lnTo>
                  <a:lnTo>
                    <a:pt x="1110" y="101"/>
                  </a:lnTo>
                  <a:lnTo>
                    <a:pt x="1110" y="101"/>
                  </a:lnTo>
                  <a:lnTo>
                    <a:pt x="1114" y="101"/>
                  </a:lnTo>
                  <a:lnTo>
                    <a:pt x="1114" y="101"/>
                  </a:lnTo>
                  <a:lnTo>
                    <a:pt x="1120" y="101"/>
                  </a:lnTo>
                  <a:lnTo>
                    <a:pt x="1120" y="101"/>
                  </a:lnTo>
                  <a:lnTo>
                    <a:pt x="1125" y="101"/>
                  </a:lnTo>
                  <a:lnTo>
                    <a:pt x="1125" y="101"/>
                  </a:lnTo>
                  <a:lnTo>
                    <a:pt x="1129" y="101"/>
                  </a:lnTo>
                  <a:lnTo>
                    <a:pt x="1129" y="101"/>
                  </a:lnTo>
                  <a:lnTo>
                    <a:pt x="1134" y="101"/>
                  </a:lnTo>
                  <a:lnTo>
                    <a:pt x="1134" y="202"/>
                  </a:lnTo>
                  <a:lnTo>
                    <a:pt x="1139" y="202"/>
                  </a:lnTo>
                  <a:lnTo>
                    <a:pt x="1139" y="202"/>
                  </a:lnTo>
                  <a:lnTo>
                    <a:pt x="1143" y="202"/>
                  </a:lnTo>
                  <a:lnTo>
                    <a:pt x="1143" y="202"/>
                  </a:lnTo>
                  <a:lnTo>
                    <a:pt x="1149" y="101"/>
                  </a:lnTo>
                  <a:lnTo>
                    <a:pt x="1149" y="202"/>
                  </a:lnTo>
                  <a:lnTo>
                    <a:pt x="1153" y="202"/>
                  </a:lnTo>
                  <a:lnTo>
                    <a:pt x="1153" y="202"/>
                  </a:lnTo>
                  <a:lnTo>
                    <a:pt x="1158" y="202"/>
                  </a:lnTo>
                  <a:lnTo>
                    <a:pt x="1158" y="202"/>
                  </a:lnTo>
                  <a:lnTo>
                    <a:pt x="1163" y="202"/>
                  </a:lnTo>
                  <a:lnTo>
                    <a:pt x="1163" y="202"/>
                  </a:lnTo>
                  <a:lnTo>
                    <a:pt x="1167" y="202"/>
                  </a:lnTo>
                  <a:lnTo>
                    <a:pt x="1167" y="202"/>
                  </a:lnTo>
                  <a:lnTo>
                    <a:pt x="1173" y="202"/>
                  </a:lnTo>
                  <a:lnTo>
                    <a:pt x="1173" y="202"/>
                  </a:lnTo>
                  <a:lnTo>
                    <a:pt x="1173" y="101"/>
                  </a:lnTo>
                  <a:lnTo>
                    <a:pt x="1178" y="202"/>
                  </a:lnTo>
                  <a:lnTo>
                    <a:pt x="1178" y="202"/>
                  </a:lnTo>
                  <a:lnTo>
                    <a:pt x="1182" y="202"/>
                  </a:lnTo>
                  <a:lnTo>
                    <a:pt x="1182" y="202"/>
                  </a:lnTo>
                  <a:lnTo>
                    <a:pt x="1187" y="101"/>
                  </a:lnTo>
                  <a:lnTo>
                    <a:pt x="1187" y="101"/>
                  </a:lnTo>
                  <a:lnTo>
                    <a:pt x="1192" y="101"/>
                  </a:lnTo>
                  <a:lnTo>
                    <a:pt x="1192" y="101"/>
                  </a:lnTo>
                  <a:lnTo>
                    <a:pt x="1197" y="202"/>
                  </a:lnTo>
                  <a:lnTo>
                    <a:pt x="1197" y="202"/>
                  </a:lnTo>
                  <a:lnTo>
                    <a:pt x="1202" y="202"/>
                  </a:lnTo>
                  <a:lnTo>
                    <a:pt x="1202" y="202"/>
                  </a:lnTo>
                  <a:lnTo>
                    <a:pt x="1207" y="202"/>
                  </a:lnTo>
                  <a:lnTo>
                    <a:pt x="1207" y="202"/>
                  </a:lnTo>
                  <a:lnTo>
                    <a:pt x="1211" y="202"/>
                  </a:lnTo>
                  <a:lnTo>
                    <a:pt x="1211" y="202"/>
                  </a:lnTo>
                  <a:lnTo>
                    <a:pt x="1216" y="202"/>
                  </a:lnTo>
                  <a:lnTo>
                    <a:pt x="1216" y="202"/>
                  </a:lnTo>
                  <a:lnTo>
                    <a:pt x="1220" y="202"/>
                  </a:lnTo>
                  <a:lnTo>
                    <a:pt x="1220" y="302"/>
                  </a:lnTo>
                  <a:lnTo>
                    <a:pt x="1226" y="302"/>
                  </a:lnTo>
                  <a:lnTo>
                    <a:pt x="1226" y="302"/>
                  </a:lnTo>
                  <a:lnTo>
                    <a:pt x="1231" y="202"/>
                  </a:lnTo>
                  <a:lnTo>
                    <a:pt x="1231" y="202"/>
                  </a:lnTo>
                  <a:lnTo>
                    <a:pt x="1235" y="202"/>
                  </a:lnTo>
                  <a:lnTo>
                    <a:pt x="1235" y="202"/>
                  </a:lnTo>
                  <a:lnTo>
                    <a:pt x="1240" y="202"/>
                  </a:lnTo>
                  <a:lnTo>
                    <a:pt x="1240" y="202"/>
                  </a:lnTo>
                  <a:lnTo>
                    <a:pt x="1240" y="202"/>
                  </a:lnTo>
                  <a:lnTo>
                    <a:pt x="1245" y="202"/>
                  </a:lnTo>
                  <a:lnTo>
                    <a:pt x="1245" y="202"/>
                  </a:lnTo>
                  <a:lnTo>
                    <a:pt x="1250" y="202"/>
                  </a:lnTo>
                  <a:lnTo>
                    <a:pt x="1250" y="202"/>
                  </a:lnTo>
                  <a:lnTo>
                    <a:pt x="1255" y="202"/>
                  </a:lnTo>
                  <a:lnTo>
                    <a:pt x="1255" y="202"/>
                  </a:lnTo>
                  <a:lnTo>
                    <a:pt x="1260" y="202"/>
                  </a:lnTo>
                  <a:lnTo>
                    <a:pt x="1260" y="202"/>
                  </a:lnTo>
                  <a:lnTo>
                    <a:pt x="1264" y="202"/>
                  </a:lnTo>
                  <a:lnTo>
                    <a:pt x="1264" y="202"/>
                  </a:lnTo>
                  <a:lnTo>
                    <a:pt x="1269" y="202"/>
                  </a:lnTo>
                  <a:lnTo>
                    <a:pt x="1269" y="202"/>
                  </a:lnTo>
                  <a:lnTo>
                    <a:pt x="1274" y="202"/>
                  </a:lnTo>
                  <a:lnTo>
                    <a:pt x="1274" y="202"/>
                  </a:lnTo>
                  <a:lnTo>
                    <a:pt x="1279" y="202"/>
                  </a:lnTo>
                  <a:lnTo>
                    <a:pt x="1279" y="202"/>
                  </a:lnTo>
                  <a:lnTo>
                    <a:pt x="1284" y="202"/>
                  </a:lnTo>
                  <a:lnTo>
                    <a:pt x="1284" y="202"/>
                  </a:lnTo>
                  <a:lnTo>
                    <a:pt x="1288" y="202"/>
                  </a:lnTo>
                  <a:lnTo>
                    <a:pt x="1288" y="202"/>
                  </a:lnTo>
                  <a:lnTo>
                    <a:pt x="1293" y="202"/>
                  </a:lnTo>
                  <a:lnTo>
                    <a:pt x="1293" y="202"/>
                  </a:lnTo>
                  <a:lnTo>
                    <a:pt x="1298" y="202"/>
                  </a:lnTo>
                  <a:lnTo>
                    <a:pt x="1298" y="101"/>
                  </a:lnTo>
                  <a:lnTo>
                    <a:pt x="1303" y="101"/>
                  </a:lnTo>
                  <a:lnTo>
                    <a:pt x="1303" y="101"/>
                  </a:lnTo>
                  <a:lnTo>
                    <a:pt x="1308" y="101"/>
                  </a:lnTo>
                  <a:lnTo>
                    <a:pt x="1308" y="101"/>
                  </a:lnTo>
                  <a:lnTo>
                    <a:pt x="1308" y="101"/>
                  </a:lnTo>
                  <a:lnTo>
                    <a:pt x="1313" y="101"/>
                  </a:lnTo>
                  <a:lnTo>
                    <a:pt x="1313" y="101"/>
                  </a:lnTo>
                  <a:lnTo>
                    <a:pt x="1317" y="101"/>
                  </a:lnTo>
                  <a:lnTo>
                    <a:pt x="1317" y="101"/>
                  </a:lnTo>
                  <a:lnTo>
                    <a:pt x="1322" y="101"/>
                  </a:lnTo>
                  <a:lnTo>
                    <a:pt x="1322" y="101"/>
                  </a:lnTo>
                  <a:lnTo>
                    <a:pt x="1327" y="202"/>
                  </a:lnTo>
                  <a:lnTo>
                    <a:pt x="1327" y="202"/>
                  </a:lnTo>
                  <a:lnTo>
                    <a:pt x="1332" y="202"/>
                  </a:lnTo>
                  <a:lnTo>
                    <a:pt x="1332" y="202"/>
                  </a:lnTo>
                  <a:lnTo>
                    <a:pt x="1337" y="202"/>
                  </a:lnTo>
                  <a:lnTo>
                    <a:pt x="1337" y="202"/>
                  </a:lnTo>
                  <a:lnTo>
                    <a:pt x="1341" y="202"/>
                  </a:lnTo>
                  <a:lnTo>
                    <a:pt x="1341" y="202"/>
                  </a:lnTo>
                  <a:lnTo>
                    <a:pt x="1346" y="202"/>
                  </a:lnTo>
                  <a:lnTo>
                    <a:pt x="1346" y="202"/>
                  </a:lnTo>
                  <a:lnTo>
                    <a:pt x="1352" y="202"/>
                  </a:lnTo>
                  <a:lnTo>
                    <a:pt x="1352" y="202"/>
                  </a:lnTo>
                  <a:lnTo>
                    <a:pt x="1356" y="202"/>
                  </a:lnTo>
                  <a:lnTo>
                    <a:pt x="1356" y="202"/>
                  </a:lnTo>
                  <a:lnTo>
                    <a:pt x="1361" y="202"/>
                  </a:lnTo>
                  <a:lnTo>
                    <a:pt x="1361" y="202"/>
                  </a:lnTo>
                  <a:lnTo>
                    <a:pt x="1366" y="202"/>
                  </a:lnTo>
                  <a:lnTo>
                    <a:pt x="1366" y="202"/>
                  </a:lnTo>
                  <a:lnTo>
                    <a:pt x="1370" y="202"/>
                  </a:lnTo>
                  <a:lnTo>
                    <a:pt x="1370" y="202"/>
                  </a:lnTo>
                  <a:lnTo>
                    <a:pt x="1375" y="202"/>
                  </a:lnTo>
                  <a:lnTo>
                    <a:pt x="1375" y="202"/>
                  </a:lnTo>
                  <a:lnTo>
                    <a:pt x="1380" y="202"/>
                  </a:lnTo>
                  <a:lnTo>
                    <a:pt x="1380" y="202"/>
                  </a:lnTo>
                  <a:lnTo>
                    <a:pt x="1380" y="202"/>
                  </a:lnTo>
                  <a:lnTo>
                    <a:pt x="1385" y="202"/>
                  </a:lnTo>
                  <a:lnTo>
                    <a:pt x="1385" y="202"/>
                  </a:lnTo>
                  <a:lnTo>
                    <a:pt x="1390" y="202"/>
                  </a:lnTo>
                  <a:lnTo>
                    <a:pt x="1390" y="202"/>
                  </a:lnTo>
                  <a:lnTo>
                    <a:pt x="1394" y="202"/>
                  </a:lnTo>
                  <a:lnTo>
                    <a:pt x="1394" y="202"/>
                  </a:lnTo>
                  <a:lnTo>
                    <a:pt x="1399" y="202"/>
                  </a:lnTo>
                  <a:lnTo>
                    <a:pt x="1399" y="202"/>
                  </a:lnTo>
                  <a:lnTo>
                    <a:pt x="1405" y="202"/>
                  </a:lnTo>
                  <a:lnTo>
                    <a:pt x="1405" y="202"/>
                  </a:lnTo>
                  <a:lnTo>
                    <a:pt x="1409" y="101"/>
                  </a:lnTo>
                  <a:lnTo>
                    <a:pt x="1409" y="101"/>
                  </a:lnTo>
                  <a:lnTo>
                    <a:pt x="1414" y="101"/>
                  </a:lnTo>
                  <a:lnTo>
                    <a:pt x="1414" y="101"/>
                  </a:lnTo>
                  <a:lnTo>
                    <a:pt x="1419" y="101"/>
                  </a:lnTo>
                  <a:lnTo>
                    <a:pt x="1419" y="101"/>
                  </a:lnTo>
                  <a:lnTo>
                    <a:pt x="1423" y="101"/>
                  </a:lnTo>
                  <a:lnTo>
                    <a:pt x="1423" y="101"/>
                  </a:lnTo>
                  <a:lnTo>
                    <a:pt x="1429" y="101"/>
                  </a:lnTo>
                  <a:lnTo>
                    <a:pt x="1429" y="101"/>
                  </a:lnTo>
                  <a:lnTo>
                    <a:pt x="1433" y="101"/>
                  </a:lnTo>
                  <a:lnTo>
                    <a:pt x="1433" y="101"/>
                  </a:lnTo>
                  <a:lnTo>
                    <a:pt x="1438" y="101"/>
                  </a:lnTo>
                  <a:lnTo>
                    <a:pt x="1438" y="101"/>
                  </a:lnTo>
                  <a:lnTo>
                    <a:pt x="1443" y="101"/>
                  </a:lnTo>
                  <a:lnTo>
                    <a:pt x="1443" y="101"/>
                  </a:lnTo>
                  <a:lnTo>
                    <a:pt x="1447" y="101"/>
                  </a:lnTo>
                  <a:lnTo>
                    <a:pt x="1447" y="101"/>
                  </a:lnTo>
                  <a:lnTo>
                    <a:pt x="1447" y="101"/>
                  </a:lnTo>
                  <a:lnTo>
                    <a:pt x="1452" y="101"/>
                  </a:lnTo>
                  <a:lnTo>
                    <a:pt x="1452" y="101"/>
                  </a:lnTo>
                  <a:lnTo>
                    <a:pt x="1458" y="101"/>
                  </a:lnTo>
                  <a:lnTo>
                    <a:pt x="1458" y="101"/>
                  </a:lnTo>
                  <a:lnTo>
                    <a:pt x="1462" y="101"/>
                  </a:lnTo>
                  <a:lnTo>
                    <a:pt x="1462" y="0"/>
                  </a:lnTo>
                  <a:lnTo>
                    <a:pt x="1467" y="0"/>
                  </a:lnTo>
                  <a:lnTo>
                    <a:pt x="1467" y="0"/>
                  </a:lnTo>
                  <a:lnTo>
                    <a:pt x="1472" y="0"/>
                  </a:lnTo>
                  <a:lnTo>
                    <a:pt x="1472" y="0"/>
                  </a:lnTo>
                  <a:lnTo>
                    <a:pt x="1476" y="0"/>
                  </a:lnTo>
                  <a:lnTo>
                    <a:pt x="1476" y="0"/>
                  </a:lnTo>
                  <a:lnTo>
                    <a:pt x="1482" y="0"/>
                  </a:lnTo>
                  <a:lnTo>
                    <a:pt x="1482" y="0"/>
                  </a:lnTo>
                  <a:lnTo>
                    <a:pt x="1487" y="0"/>
                  </a:lnTo>
                  <a:lnTo>
                    <a:pt x="1487" y="0"/>
                  </a:lnTo>
                  <a:lnTo>
                    <a:pt x="1491" y="0"/>
                  </a:lnTo>
                  <a:lnTo>
                    <a:pt x="1491" y="0"/>
                  </a:lnTo>
                  <a:lnTo>
                    <a:pt x="1496" y="0"/>
                  </a:lnTo>
                  <a:lnTo>
                    <a:pt x="1496" y="0"/>
                  </a:lnTo>
                  <a:lnTo>
                    <a:pt x="1500" y="0"/>
                  </a:lnTo>
                  <a:lnTo>
                    <a:pt x="1500" y="101"/>
                  </a:lnTo>
                  <a:lnTo>
                    <a:pt x="1506" y="101"/>
                  </a:lnTo>
                  <a:lnTo>
                    <a:pt x="1506" y="101"/>
                  </a:lnTo>
                  <a:lnTo>
                    <a:pt x="1511" y="101"/>
                  </a:lnTo>
                  <a:lnTo>
                    <a:pt x="1511" y="101"/>
                  </a:lnTo>
                  <a:lnTo>
                    <a:pt x="1515" y="101"/>
                  </a:lnTo>
                  <a:lnTo>
                    <a:pt x="1515" y="101"/>
                  </a:lnTo>
                  <a:lnTo>
                    <a:pt x="1515" y="101"/>
                  </a:lnTo>
                  <a:lnTo>
                    <a:pt x="1520" y="101"/>
                  </a:lnTo>
                  <a:lnTo>
                    <a:pt x="1520" y="101"/>
                  </a:lnTo>
                  <a:lnTo>
                    <a:pt x="1525" y="101"/>
                  </a:lnTo>
                  <a:lnTo>
                    <a:pt x="1525" y="101"/>
                  </a:lnTo>
                  <a:lnTo>
                    <a:pt x="1529" y="101"/>
                  </a:lnTo>
                  <a:lnTo>
                    <a:pt x="1529" y="101"/>
                  </a:lnTo>
                  <a:lnTo>
                    <a:pt x="1535" y="101"/>
                  </a:lnTo>
                  <a:lnTo>
                    <a:pt x="1535" y="101"/>
                  </a:lnTo>
                  <a:lnTo>
                    <a:pt x="1540" y="101"/>
                  </a:lnTo>
                  <a:lnTo>
                    <a:pt x="1540" y="101"/>
                  </a:lnTo>
                  <a:lnTo>
                    <a:pt x="1544" y="101"/>
                  </a:lnTo>
                  <a:lnTo>
                    <a:pt x="1544" y="101"/>
                  </a:lnTo>
                  <a:lnTo>
                    <a:pt x="1549" y="101"/>
                  </a:lnTo>
                  <a:lnTo>
                    <a:pt x="1549" y="101"/>
                  </a:lnTo>
                  <a:lnTo>
                    <a:pt x="1553" y="101"/>
                  </a:lnTo>
                  <a:lnTo>
                    <a:pt x="1553" y="101"/>
                  </a:lnTo>
                  <a:lnTo>
                    <a:pt x="1559" y="101"/>
                  </a:lnTo>
                  <a:lnTo>
                    <a:pt x="1559" y="101"/>
                  </a:lnTo>
                  <a:lnTo>
                    <a:pt x="1564" y="101"/>
                  </a:lnTo>
                  <a:lnTo>
                    <a:pt x="1564" y="101"/>
                  </a:lnTo>
                  <a:lnTo>
                    <a:pt x="1568" y="101"/>
                  </a:lnTo>
                  <a:lnTo>
                    <a:pt x="1568" y="101"/>
                  </a:lnTo>
                  <a:lnTo>
                    <a:pt x="1573" y="202"/>
                  </a:lnTo>
                  <a:lnTo>
                    <a:pt x="1573" y="202"/>
                  </a:lnTo>
                  <a:lnTo>
                    <a:pt x="1578" y="202"/>
                  </a:lnTo>
                  <a:lnTo>
                    <a:pt x="1578" y="101"/>
                  </a:lnTo>
                  <a:lnTo>
                    <a:pt x="1583" y="101"/>
                  </a:lnTo>
                  <a:lnTo>
                    <a:pt x="1583" y="101"/>
                  </a:lnTo>
                  <a:lnTo>
                    <a:pt x="1588" y="101"/>
                  </a:lnTo>
                  <a:lnTo>
                    <a:pt x="1588" y="101"/>
                  </a:lnTo>
                  <a:lnTo>
                    <a:pt x="1588" y="101"/>
                  </a:lnTo>
                  <a:lnTo>
                    <a:pt x="1593" y="0"/>
                  </a:lnTo>
                  <a:lnTo>
                    <a:pt x="1593" y="0"/>
                  </a:lnTo>
                  <a:lnTo>
                    <a:pt x="1597" y="101"/>
                  </a:lnTo>
                  <a:lnTo>
                    <a:pt x="1597" y="0"/>
                  </a:lnTo>
                  <a:lnTo>
                    <a:pt x="1602" y="101"/>
                  </a:lnTo>
                  <a:lnTo>
                    <a:pt x="1602" y="101"/>
                  </a:lnTo>
                  <a:lnTo>
                    <a:pt x="1606" y="101"/>
                  </a:lnTo>
                  <a:lnTo>
                    <a:pt x="1606" y="101"/>
                  </a:lnTo>
                  <a:lnTo>
                    <a:pt x="1612" y="101"/>
                  </a:lnTo>
                  <a:lnTo>
                    <a:pt x="1612" y="101"/>
                  </a:lnTo>
                  <a:lnTo>
                    <a:pt x="1617" y="101"/>
                  </a:lnTo>
                  <a:lnTo>
                    <a:pt x="1617" y="101"/>
                  </a:lnTo>
                  <a:lnTo>
                    <a:pt x="1621" y="101"/>
                  </a:lnTo>
                  <a:lnTo>
                    <a:pt x="1621" y="101"/>
                  </a:lnTo>
                  <a:lnTo>
                    <a:pt x="1626" y="101"/>
                  </a:lnTo>
                  <a:lnTo>
                    <a:pt x="1626" y="101"/>
                  </a:lnTo>
                  <a:lnTo>
                    <a:pt x="1631" y="101"/>
                  </a:lnTo>
                  <a:lnTo>
                    <a:pt x="1631" y="101"/>
                  </a:lnTo>
                  <a:lnTo>
                    <a:pt x="1636" y="101"/>
                  </a:lnTo>
                  <a:lnTo>
                    <a:pt x="1636" y="0"/>
                  </a:lnTo>
                  <a:lnTo>
                    <a:pt x="1641" y="0"/>
                  </a:lnTo>
                  <a:lnTo>
                    <a:pt x="1641" y="0"/>
                  </a:lnTo>
                  <a:lnTo>
                    <a:pt x="1646" y="0"/>
                  </a:lnTo>
                  <a:lnTo>
                    <a:pt x="1646" y="0"/>
                  </a:lnTo>
                  <a:lnTo>
                    <a:pt x="1650" y="0"/>
                  </a:lnTo>
                  <a:lnTo>
                    <a:pt x="1650" y="0"/>
                  </a:lnTo>
                  <a:lnTo>
                    <a:pt x="1655" y="0"/>
                  </a:lnTo>
                  <a:lnTo>
                    <a:pt x="1655" y="0"/>
                  </a:lnTo>
                  <a:lnTo>
                    <a:pt x="1655" y="0"/>
                  </a:lnTo>
                  <a:lnTo>
                    <a:pt x="1660" y="0"/>
                  </a:lnTo>
                  <a:lnTo>
                    <a:pt x="1660" y="0"/>
                  </a:lnTo>
                  <a:lnTo>
                    <a:pt x="1665" y="0"/>
                  </a:lnTo>
                  <a:lnTo>
                    <a:pt x="1665" y="0"/>
                  </a:lnTo>
                  <a:lnTo>
                    <a:pt x="1670" y="0"/>
                  </a:lnTo>
                  <a:lnTo>
                    <a:pt x="1670" y="0"/>
                  </a:lnTo>
                  <a:lnTo>
                    <a:pt x="1674" y="0"/>
                  </a:lnTo>
                  <a:lnTo>
                    <a:pt x="1674" y="0"/>
                  </a:lnTo>
                  <a:lnTo>
                    <a:pt x="1679" y="0"/>
                  </a:lnTo>
                  <a:lnTo>
                    <a:pt x="1679" y="0"/>
                  </a:lnTo>
                  <a:lnTo>
                    <a:pt x="1685" y="0"/>
                  </a:lnTo>
                  <a:lnTo>
                    <a:pt x="1685" y="0"/>
                  </a:lnTo>
                  <a:lnTo>
                    <a:pt x="1689" y="0"/>
                  </a:lnTo>
                  <a:lnTo>
                    <a:pt x="1689" y="0"/>
                  </a:lnTo>
                  <a:lnTo>
                    <a:pt x="1694" y="0"/>
                  </a:lnTo>
                  <a:lnTo>
                    <a:pt x="1694" y="0"/>
                  </a:lnTo>
                  <a:lnTo>
                    <a:pt x="1699" y="0"/>
                  </a:lnTo>
                  <a:lnTo>
                    <a:pt x="1699" y="0"/>
                  </a:lnTo>
                  <a:lnTo>
                    <a:pt x="1703" y="0"/>
                  </a:lnTo>
                  <a:lnTo>
                    <a:pt x="1703" y="101"/>
                  </a:lnTo>
                  <a:lnTo>
                    <a:pt x="1708" y="101"/>
                  </a:lnTo>
                  <a:lnTo>
                    <a:pt x="1708" y="101"/>
                  </a:lnTo>
                  <a:lnTo>
                    <a:pt x="1713" y="101"/>
                  </a:lnTo>
                  <a:lnTo>
                    <a:pt x="1713" y="101"/>
                  </a:lnTo>
                  <a:lnTo>
                    <a:pt x="1718" y="101"/>
                  </a:lnTo>
                  <a:lnTo>
                    <a:pt x="1718" y="101"/>
                  </a:lnTo>
                  <a:lnTo>
                    <a:pt x="1723" y="101"/>
                  </a:lnTo>
                  <a:lnTo>
                    <a:pt x="1723" y="101"/>
                  </a:lnTo>
                  <a:lnTo>
                    <a:pt x="1723" y="101"/>
                  </a:lnTo>
                  <a:lnTo>
                    <a:pt x="1727" y="101"/>
                  </a:lnTo>
                  <a:lnTo>
                    <a:pt x="1727" y="101"/>
                  </a:lnTo>
                  <a:lnTo>
                    <a:pt x="1732" y="101"/>
                  </a:lnTo>
                  <a:lnTo>
                    <a:pt x="1732" y="101"/>
                  </a:lnTo>
                  <a:lnTo>
                    <a:pt x="1738" y="101"/>
                  </a:lnTo>
                  <a:lnTo>
                    <a:pt x="1738" y="101"/>
                  </a:lnTo>
                  <a:lnTo>
                    <a:pt x="1742" y="101"/>
                  </a:lnTo>
                  <a:lnTo>
                    <a:pt x="1742" y="101"/>
                  </a:lnTo>
                  <a:lnTo>
                    <a:pt x="1747" y="101"/>
                  </a:lnTo>
                  <a:lnTo>
                    <a:pt x="1747" y="101"/>
                  </a:lnTo>
                  <a:lnTo>
                    <a:pt x="1752" y="101"/>
                  </a:lnTo>
                  <a:lnTo>
                    <a:pt x="1752" y="101"/>
                  </a:lnTo>
                  <a:lnTo>
                    <a:pt x="1756" y="101"/>
                  </a:lnTo>
                  <a:lnTo>
                    <a:pt x="1756" y="101"/>
                  </a:lnTo>
                  <a:lnTo>
                    <a:pt x="1761" y="101"/>
                  </a:lnTo>
                  <a:lnTo>
                    <a:pt x="1761" y="202"/>
                  </a:lnTo>
                  <a:lnTo>
                    <a:pt x="1767" y="202"/>
                  </a:lnTo>
                  <a:lnTo>
                    <a:pt x="1767" y="101"/>
                  </a:lnTo>
                  <a:lnTo>
                    <a:pt x="1771" y="202"/>
                  </a:lnTo>
                  <a:lnTo>
                    <a:pt x="1771" y="202"/>
                  </a:lnTo>
                  <a:lnTo>
                    <a:pt x="1776" y="202"/>
                  </a:lnTo>
                  <a:lnTo>
                    <a:pt x="1776" y="202"/>
                  </a:lnTo>
                  <a:lnTo>
                    <a:pt x="1780" y="202"/>
                  </a:lnTo>
                  <a:lnTo>
                    <a:pt x="1780" y="101"/>
                  </a:lnTo>
                  <a:lnTo>
                    <a:pt x="1785" y="101"/>
                  </a:lnTo>
                  <a:lnTo>
                    <a:pt x="1785" y="101"/>
                  </a:lnTo>
                  <a:lnTo>
                    <a:pt x="1791" y="202"/>
                  </a:lnTo>
                  <a:lnTo>
                    <a:pt x="1791" y="202"/>
                  </a:lnTo>
                  <a:lnTo>
                    <a:pt x="1791" y="101"/>
                  </a:lnTo>
                  <a:lnTo>
                    <a:pt x="1795" y="202"/>
                  </a:lnTo>
                  <a:lnTo>
                    <a:pt x="1795" y="202"/>
                  </a:lnTo>
                  <a:lnTo>
                    <a:pt x="1800" y="202"/>
                  </a:lnTo>
                  <a:lnTo>
                    <a:pt x="1800" y="202"/>
                  </a:lnTo>
                  <a:lnTo>
                    <a:pt x="1805" y="202"/>
                  </a:lnTo>
                  <a:lnTo>
                    <a:pt x="1805" y="202"/>
                  </a:lnTo>
                  <a:lnTo>
                    <a:pt x="1809" y="101"/>
                  </a:lnTo>
                  <a:lnTo>
                    <a:pt x="1809" y="101"/>
                  </a:lnTo>
                  <a:lnTo>
                    <a:pt x="1815" y="101"/>
                  </a:lnTo>
                  <a:lnTo>
                    <a:pt x="1815" y="101"/>
                  </a:lnTo>
                  <a:lnTo>
                    <a:pt x="1820" y="101"/>
                  </a:lnTo>
                  <a:lnTo>
                    <a:pt x="1820" y="101"/>
                  </a:lnTo>
                  <a:lnTo>
                    <a:pt x="1824" y="101"/>
                  </a:lnTo>
                  <a:lnTo>
                    <a:pt x="1824" y="101"/>
                  </a:lnTo>
                  <a:lnTo>
                    <a:pt x="1829" y="101"/>
                  </a:lnTo>
                  <a:lnTo>
                    <a:pt x="1829" y="101"/>
                  </a:lnTo>
                  <a:lnTo>
                    <a:pt x="1833" y="101"/>
                  </a:lnTo>
                  <a:lnTo>
                    <a:pt x="1833" y="101"/>
                  </a:lnTo>
                  <a:lnTo>
                    <a:pt x="1838" y="101"/>
                  </a:lnTo>
                  <a:lnTo>
                    <a:pt x="1838" y="101"/>
                  </a:lnTo>
                  <a:lnTo>
                    <a:pt x="1844" y="101"/>
                  </a:lnTo>
                  <a:lnTo>
                    <a:pt x="1844" y="101"/>
                  </a:lnTo>
                  <a:lnTo>
                    <a:pt x="1848" y="101"/>
                  </a:lnTo>
                  <a:lnTo>
                    <a:pt x="1848" y="101"/>
                  </a:lnTo>
                  <a:lnTo>
                    <a:pt x="1853" y="101"/>
                  </a:lnTo>
                  <a:lnTo>
                    <a:pt x="1853" y="101"/>
                  </a:lnTo>
                  <a:lnTo>
                    <a:pt x="1858" y="101"/>
                  </a:lnTo>
                  <a:lnTo>
                    <a:pt x="1858" y="101"/>
                  </a:lnTo>
                  <a:lnTo>
                    <a:pt x="1862" y="101"/>
                  </a:lnTo>
                  <a:lnTo>
                    <a:pt x="1862" y="101"/>
                  </a:lnTo>
                  <a:lnTo>
                    <a:pt x="1862" y="101"/>
                  </a:lnTo>
                  <a:lnTo>
                    <a:pt x="1868" y="101"/>
                  </a:lnTo>
                  <a:lnTo>
                    <a:pt x="1868" y="101"/>
                  </a:lnTo>
                  <a:lnTo>
                    <a:pt x="1873" y="101"/>
                  </a:lnTo>
                  <a:lnTo>
                    <a:pt x="1873" y="101"/>
                  </a:lnTo>
                  <a:lnTo>
                    <a:pt x="1877" y="101"/>
                  </a:lnTo>
                  <a:lnTo>
                    <a:pt x="1877" y="0"/>
                  </a:lnTo>
                  <a:lnTo>
                    <a:pt x="1882" y="0"/>
                  </a:lnTo>
                  <a:lnTo>
                    <a:pt x="1882" y="0"/>
                  </a:lnTo>
                  <a:lnTo>
                    <a:pt x="1886" y="0"/>
                  </a:lnTo>
                  <a:lnTo>
                    <a:pt x="1886" y="0"/>
                  </a:lnTo>
                  <a:lnTo>
                    <a:pt x="1892" y="0"/>
                  </a:lnTo>
                  <a:lnTo>
                    <a:pt x="1892" y="0"/>
                  </a:lnTo>
                  <a:lnTo>
                    <a:pt x="1897" y="0"/>
                  </a:lnTo>
                  <a:lnTo>
                    <a:pt x="1897" y="101"/>
                  </a:lnTo>
                  <a:lnTo>
                    <a:pt x="1901" y="101"/>
                  </a:lnTo>
                  <a:lnTo>
                    <a:pt x="1901" y="101"/>
                  </a:lnTo>
                  <a:lnTo>
                    <a:pt x="1906" y="101"/>
                  </a:lnTo>
                  <a:lnTo>
                    <a:pt x="1906" y="101"/>
                  </a:lnTo>
                  <a:lnTo>
                    <a:pt x="1911" y="101"/>
                  </a:lnTo>
                  <a:lnTo>
                    <a:pt x="1911" y="101"/>
                  </a:lnTo>
                  <a:lnTo>
                    <a:pt x="1915" y="101"/>
                  </a:lnTo>
                  <a:lnTo>
                    <a:pt x="1915" y="101"/>
                  </a:lnTo>
                  <a:lnTo>
                    <a:pt x="1921" y="101"/>
                  </a:lnTo>
                  <a:lnTo>
                    <a:pt x="1921" y="101"/>
                  </a:lnTo>
                  <a:lnTo>
                    <a:pt x="1926" y="101"/>
                  </a:lnTo>
                  <a:lnTo>
                    <a:pt x="1926" y="101"/>
                  </a:lnTo>
                  <a:lnTo>
                    <a:pt x="1930" y="101"/>
                  </a:lnTo>
                  <a:lnTo>
                    <a:pt x="1930" y="101"/>
                  </a:lnTo>
                  <a:lnTo>
                    <a:pt x="1930" y="101"/>
                  </a:lnTo>
                  <a:lnTo>
                    <a:pt x="1935" y="101"/>
                  </a:lnTo>
                  <a:lnTo>
                    <a:pt x="1935" y="101"/>
                  </a:lnTo>
                  <a:lnTo>
                    <a:pt x="1939" y="101"/>
                  </a:lnTo>
                  <a:lnTo>
                    <a:pt x="1939" y="101"/>
                  </a:lnTo>
                  <a:lnTo>
                    <a:pt x="1945" y="101"/>
                  </a:lnTo>
                  <a:lnTo>
                    <a:pt x="1945" y="101"/>
                  </a:lnTo>
                  <a:lnTo>
                    <a:pt x="1950" y="101"/>
                  </a:lnTo>
                  <a:lnTo>
                    <a:pt x="1950" y="101"/>
                  </a:lnTo>
                  <a:lnTo>
                    <a:pt x="1954" y="101"/>
                  </a:lnTo>
                  <a:lnTo>
                    <a:pt x="1954" y="101"/>
                  </a:lnTo>
                  <a:lnTo>
                    <a:pt x="1959" y="101"/>
                  </a:lnTo>
                  <a:lnTo>
                    <a:pt x="1959" y="101"/>
                  </a:lnTo>
                  <a:lnTo>
                    <a:pt x="1964" y="101"/>
                  </a:lnTo>
                  <a:lnTo>
                    <a:pt x="1964" y="101"/>
                  </a:lnTo>
                  <a:lnTo>
                    <a:pt x="1969" y="101"/>
                  </a:lnTo>
                  <a:lnTo>
                    <a:pt x="1969" y="101"/>
                  </a:lnTo>
                  <a:lnTo>
                    <a:pt x="1974" y="101"/>
                  </a:lnTo>
                  <a:lnTo>
                    <a:pt x="1974" y="101"/>
                  </a:lnTo>
                  <a:lnTo>
                    <a:pt x="1979" y="101"/>
                  </a:lnTo>
                  <a:lnTo>
                    <a:pt x="1979" y="101"/>
                  </a:lnTo>
                  <a:lnTo>
                    <a:pt x="1983" y="101"/>
                  </a:lnTo>
                  <a:lnTo>
                    <a:pt x="1983" y="101"/>
                  </a:lnTo>
                  <a:lnTo>
                    <a:pt x="1988" y="101"/>
                  </a:lnTo>
                  <a:lnTo>
                    <a:pt x="1988" y="101"/>
                  </a:lnTo>
                  <a:lnTo>
                    <a:pt x="1992" y="101"/>
                  </a:lnTo>
                  <a:lnTo>
                    <a:pt x="1992" y="0"/>
                  </a:lnTo>
                  <a:lnTo>
                    <a:pt x="1998" y="0"/>
                  </a:lnTo>
                  <a:lnTo>
                    <a:pt x="1998" y="0"/>
                  </a:lnTo>
                  <a:lnTo>
                    <a:pt x="1998" y="0"/>
                  </a:lnTo>
                  <a:lnTo>
                    <a:pt x="2003" y="0"/>
                  </a:lnTo>
                  <a:lnTo>
                    <a:pt x="2003" y="0"/>
                  </a:lnTo>
                  <a:lnTo>
                    <a:pt x="2007" y="0"/>
                  </a:lnTo>
                  <a:lnTo>
                    <a:pt x="2007" y="0"/>
                  </a:lnTo>
                  <a:lnTo>
                    <a:pt x="2012" y="0"/>
                  </a:lnTo>
                  <a:lnTo>
                    <a:pt x="2012" y="0"/>
                  </a:lnTo>
                  <a:lnTo>
                    <a:pt x="2017" y="0"/>
                  </a:lnTo>
                  <a:lnTo>
                    <a:pt x="2017" y="0"/>
                  </a:lnTo>
                  <a:lnTo>
                    <a:pt x="2022" y="0"/>
                  </a:lnTo>
                  <a:lnTo>
                    <a:pt x="2022" y="0"/>
                  </a:lnTo>
                  <a:lnTo>
                    <a:pt x="2027" y="0"/>
                  </a:lnTo>
                  <a:lnTo>
                    <a:pt x="2027" y="0"/>
                  </a:lnTo>
                  <a:lnTo>
                    <a:pt x="2032" y="0"/>
                  </a:lnTo>
                  <a:lnTo>
                    <a:pt x="2032" y="0"/>
                  </a:lnTo>
                  <a:lnTo>
                    <a:pt x="2036" y="101"/>
                  </a:lnTo>
                  <a:lnTo>
                    <a:pt x="2036" y="101"/>
                  </a:lnTo>
                  <a:lnTo>
                    <a:pt x="2041" y="101"/>
                  </a:lnTo>
                  <a:lnTo>
                    <a:pt x="2041" y="101"/>
                  </a:lnTo>
                  <a:lnTo>
                    <a:pt x="2047" y="101"/>
                  </a:lnTo>
                  <a:lnTo>
                    <a:pt x="2047" y="101"/>
                  </a:lnTo>
                  <a:lnTo>
                    <a:pt x="2051" y="101"/>
                  </a:lnTo>
                  <a:lnTo>
                    <a:pt x="2051" y="101"/>
                  </a:lnTo>
                  <a:lnTo>
                    <a:pt x="2056" y="101"/>
                  </a:lnTo>
                  <a:lnTo>
                    <a:pt x="2056" y="101"/>
                  </a:lnTo>
                  <a:lnTo>
                    <a:pt x="2060" y="101"/>
                  </a:lnTo>
                  <a:lnTo>
                    <a:pt x="2060" y="101"/>
                  </a:lnTo>
                  <a:lnTo>
                    <a:pt x="2065" y="101"/>
                  </a:lnTo>
                  <a:lnTo>
                    <a:pt x="2065" y="101"/>
                  </a:lnTo>
                  <a:lnTo>
                    <a:pt x="2071" y="101"/>
                  </a:lnTo>
                  <a:lnTo>
                    <a:pt x="2071" y="101"/>
                  </a:lnTo>
                  <a:lnTo>
                    <a:pt x="2071" y="101"/>
                  </a:lnTo>
                  <a:lnTo>
                    <a:pt x="2075" y="101"/>
                  </a:lnTo>
                  <a:lnTo>
                    <a:pt x="2075" y="202"/>
                  </a:lnTo>
                  <a:lnTo>
                    <a:pt x="2080" y="202"/>
                  </a:lnTo>
                  <a:lnTo>
                    <a:pt x="2080" y="202"/>
                  </a:lnTo>
                  <a:lnTo>
                    <a:pt x="2085" y="202"/>
                  </a:lnTo>
                  <a:lnTo>
                    <a:pt x="2085" y="202"/>
                  </a:lnTo>
                  <a:lnTo>
                    <a:pt x="2089" y="202"/>
                  </a:lnTo>
                  <a:lnTo>
                    <a:pt x="2089" y="202"/>
                  </a:lnTo>
                  <a:lnTo>
                    <a:pt x="2094" y="202"/>
                  </a:lnTo>
                  <a:lnTo>
                    <a:pt x="2094" y="202"/>
                  </a:lnTo>
                  <a:lnTo>
                    <a:pt x="2100" y="101"/>
                  </a:lnTo>
                  <a:lnTo>
                    <a:pt x="2100" y="101"/>
                  </a:lnTo>
                  <a:lnTo>
                    <a:pt x="2104" y="101"/>
                  </a:lnTo>
                  <a:lnTo>
                    <a:pt x="2104" y="202"/>
                  </a:lnTo>
                  <a:lnTo>
                    <a:pt x="2109" y="202"/>
                  </a:lnTo>
                  <a:lnTo>
                    <a:pt x="2109" y="202"/>
                  </a:lnTo>
                  <a:lnTo>
                    <a:pt x="2113" y="202"/>
                  </a:lnTo>
                  <a:lnTo>
                    <a:pt x="2113" y="202"/>
                  </a:lnTo>
                  <a:lnTo>
                    <a:pt x="2118" y="202"/>
                  </a:lnTo>
                  <a:lnTo>
                    <a:pt x="2118" y="202"/>
                  </a:lnTo>
                  <a:lnTo>
                    <a:pt x="2124" y="202"/>
                  </a:lnTo>
                  <a:lnTo>
                    <a:pt x="2124" y="202"/>
                  </a:lnTo>
                  <a:lnTo>
                    <a:pt x="2128" y="202"/>
                  </a:lnTo>
                  <a:lnTo>
                    <a:pt x="2128" y="202"/>
                  </a:lnTo>
                  <a:lnTo>
                    <a:pt x="2133" y="202"/>
                  </a:lnTo>
                  <a:lnTo>
                    <a:pt x="2133" y="202"/>
                  </a:lnTo>
                  <a:lnTo>
                    <a:pt x="2138" y="202"/>
                  </a:lnTo>
                  <a:lnTo>
                    <a:pt x="2138" y="202"/>
                  </a:lnTo>
                  <a:lnTo>
                    <a:pt x="2138" y="202"/>
                  </a:lnTo>
                  <a:lnTo>
                    <a:pt x="2142" y="202"/>
                  </a:lnTo>
                  <a:lnTo>
                    <a:pt x="2142" y="202"/>
                  </a:lnTo>
                  <a:lnTo>
                    <a:pt x="2148" y="202"/>
                  </a:lnTo>
                  <a:lnTo>
                    <a:pt x="2148" y="202"/>
                  </a:lnTo>
                  <a:lnTo>
                    <a:pt x="2153" y="202"/>
                  </a:lnTo>
                  <a:lnTo>
                    <a:pt x="2153" y="202"/>
                  </a:lnTo>
                  <a:lnTo>
                    <a:pt x="2157" y="202"/>
                  </a:lnTo>
                  <a:lnTo>
                    <a:pt x="2157" y="202"/>
                  </a:lnTo>
                  <a:lnTo>
                    <a:pt x="2162" y="101"/>
                  </a:lnTo>
                  <a:lnTo>
                    <a:pt x="2162" y="101"/>
                  </a:lnTo>
                  <a:lnTo>
                    <a:pt x="2166" y="101"/>
                  </a:lnTo>
                  <a:lnTo>
                    <a:pt x="2166" y="101"/>
                  </a:lnTo>
                  <a:lnTo>
                    <a:pt x="2171" y="101"/>
                  </a:lnTo>
                  <a:lnTo>
                    <a:pt x="2171" y="101"/>
                  </a:lnTo>
                  <a:lnTo>
                    <a:pt x="2177" y="202"/>
                  </a:lnTo>
                  <a:lnTo>
                    <a:pt x="2177" y="202"/>
                  </a:lnTo>
                  <a:lnTo>
                    <a:pt x="2181" y="202"/>
                  </a:lnTo>
                  <a:lnTo>
                    <a:pt x="2181" y="202"/>
                  </a:lnTo>
                  <a:lnTo>
                    <a:pt x="2186" y="202"/>
                  </a:lnTo>
                  <a:lnTo>
                    <a:pt x="2186" y="202"/>
                  </a:lnTo>
                  <a:lnTo>
                    <a:pt x="2191" y="202"/>
                  </a:lnTo>
                  <a:lnTo>
                    <a:pt x="2191" y="202"/>
                  </a:lnTo>
                  <a:lnTo>
                    <a:pt x="2195" y="202"/>
                  </a:lnTo>
                  <a:lnTo>
                    <a:pt x="2195" y="202"/>
                  </a:lnTo>
                  <a:lnTo>
                    <a:pt x="2201" y="202"/>
                  </a:lnTo>
                  <a:lnTo>
                    <a:pt x="2201" y="202"/>
                  </a:lnTo>
                  <a:lnTo>
                    <a:pt x="2206" y="202"/>
                  </a:lnTo>
                  <a:lnTo>
                    <a:pt x="2206" y="202"/>
                  </a:lnTo>
                  <a:lnTo>
                    <a:pt x="2206" y="202"/>
                  </a:lnTo>
                  <a:lnTo>
                    <a:pt x="2210" y="202"/>
                  </a:lnTo>
                  <a:lnTo>
                    <a:pt x="2210" y="202"/>
                  </a:lnTo>
                  <a:lnTo>
                    <a:pt x="2215" y="202"/>
                  </a:lnTo>
                  <a:lnTo>
                    <a:pt x="2215" y="202"/>
                  </a:lnTo>
                  <a:lnTo>
                    <a:pt x="2219" y="202"/>
                  </a:lnTo>
                  <a:lnTo>
                    <a:pt x="2219" y="202"/>
                  </a:lnTo>
                  <a:lnTo>
                    <a:pt x="2225" y="202"/>
                  </a:lnTo>
                  <a:lnTo>
                    <a:pt x="2225" y="202"/>
                  </a:lnTo>
                  <a:lnTo>
                    <a:pt x="2230" y="202"/>
                  </a:lnTo>
                  <a:lnTo>
                    <a:pt x="2230" y="202"/>
                  </a:lnTo>
                  <a:lnTo>
                    <a:pt x="2234" y="202"/>
                  </a:lnTo>
                  <a:lnTo>
                    <a:pt x="2234" y="202"/>
                  </a:lnTo>
                  <a:lnTo>
                    <a:pt x="2239" y="202"/>
                  </a:lnTo>
                  <a:lnTo>
                    <a:pt x="2239" y="202"/>
                  </a:lnTo>
                  <a:lnTo>
                    <a:pt x="2244" y="202"/>
                  </a:lnTo>
                  <a:lnTo>
                    <a:pt x="2244" y="202"/>
                  </a:lnTo>
                  <a:lnTo>
                    <a:pt x="2248" y="202"/>
                  </a:lnTo>
                  <a:lnTo>
                    <a:pt x="2248" y="302"/>
                  </a:lnTo>
                  <a:lnTo>
                    <a:pt x="2254" y="302"/>
                  </a:lnTo>
                  <a:lnTo>
                    <a:pt x="2254" y="302"/>
                  </a:lnTo>
                  <a:lnTo>
                    <a:pt x="2259" y="302"/>
                  </a:lnTo>
                  <a:lnTo>
                    <a:pt x="2259" y="302"/>
                  </a:lnTo>
                  <a:lnTo>
                    <a:pt x="2263" y="302"/>
                  </a:lnTo>
                  <a:lnTo>
                    <a:pt x="2263" y="302"/>
                  </a:lnTo>
                  <a:lnTo>
                    <a:pt x="2268" y="302"/>
                  </a:lnTo>
                  <a:lnTo>
                    <a:pt x="2268" y="302"/>
                  </a:lnTo>
                  <a:lnTo>
                    <a:pt x="2272" y="302"/>
                  </a:lnTo>
                  <a:lnTo>
                    <a:pt x="2272" y="302"/>
                  </a:lnTo>
                  <a:lnTo>
                    <a:pt x="2272" y="302"/>
                  </a:lnTo>
                  <a:lnTo>
                    <a:pt x="2278" y="302"/>
                  </a:lnTo>
                  <a:lnTo>
                    <a:pt x="2278" y="302"/>
                  </a:lnTo>
                  <a:lnTo>
                    <a:pt x="2283" y="302"/>
                  </a:lnTo>
                  <a:lnTo>
                    <a:pt x="2283" y="302"/>
                  </a:lnTo>
                  <a:lnTo>
                    <a:pt x="2287" y="302"/>
                  </a:lnTo>
                  <a:lnTo>
                    <a:pt x="2287" y="302"/>
                  </a:lnTo>
                  <a:lnTo>
                    <a:pt x="2292" y="302"/>
                  </a:lnTo>
                  <a:lnTo>
                    <a:pt x="2292" y="302"/>
                  </a:lnTo>
                  <a:lnTo>
                    <a:pt x="2297" y="302"/>
                  </a:lnTo>
                  <a:lnTo>
                    <a:pt x="2297" y="302"/>
                  </a:lnTo>
                  <a:lnTo>
                    <a:pt x="2301" y="302"/>
                  </a:lnTo>
                  <a:lnTo>
                    <a:pt x="2301" y="302"/>
                  </a:lnTo>
                  <a:lnTo>
                    <a:pt x="2307" y="302"/>
                  </a:lnTo>
                  <a:lnTo>
                    <a:pt x="2307" y="302"/>
                  </a:lnTo>
                  <a:lnTo>
                    <a:pt x="2312" y="403"/>
                  </a:lnTo>
                  <a:lnTo>
                    <a:pt x="2312" y="403"/>
                  </a:lnTo>
                  <a:lnTo>
                    <a:pt x="2316" y="403"/>
                  </a:lnTo>
                  <a:lnTo>
                    <a:pt x="2316" y="403"/>
                  </a:lnTo>
                  <a:lnTo>
                    <a:pt x="2321" y="403"/>
                  </a:lnTo>
                  <a:lnTo>
                    <a:pt x="2321" y="403"/>
                  </a:lnTo>
                  <a:lnTo>
                    <a:pt x="2326" y="403"/>
                  </a:lnTo>
                  <a:lnTo>
                    <a:pt x="2326" y="403"/>
                  </a:lnTo>
                  <a:lnTo>
                    <a:pt x="2331" y="403"/>
                  </a:lnTo>
                  <a:lnTo>
                    <a:pt x="2331" y="403"/>
                  </a:lnTo>
                  <a:lnTo>
                    <a:pt x="2336" y="403"/>
                  </a:lnTo>
                  <a:lnTo>
                    <a:pt x="2336" y="504"/>
                  </a:lnTo>
                  <a:lnTo>
                    <a:pt x="2340" y="504"/>
                  </a:lnTo>
                  <a:lnTo>
                    <a:pt x="2340" y="504"/>
                  </a:lnTo>
                  <a:lnTo>
                    <a:pt x="2345" y="504"/>
                  </a:lnTo>
                  <a:lnTo>
                    <a:pt x="2345" y="504"/>
                  </a:lnTo>
                  <a:lnTo>
                    <a:pt x="2345" y="504"/>
                  </a:lnTo>
                  <a:lnTo>
                    <a:pt x="2350" y="504"/>
                  </a:lnTo>
                  <a:lnTo>
                    <a:pt x="2350" y="504"/>
                  </a:lnTo>
                  <a:lnTo>
                    <a:pt x="2355" y="504"/>
                  </a:lnTo>
                  <a:lnTo>
                    <a:pt x="2355" y="504"/>
                  </a:lnTo>
                  <a:lnTo>
                    <a:pt x="2360" y="504"/>
                  </a:lnTo>
                  <a:lnTo>
                    <a:pt x="2360" y="504"/>
                  </a:lnTo>
                  <a:lnTo>
                    <a:pt x="2365" y="504"/>
                  </a:lnTo>
                  <a:lnTo>
                    <a:pt x="2365" y="504"/>
                  </a:lnTo>
                  <a:lnTo>
                    <a:pt x="2369" y="504"/>
                  </a:lnTo>
                  <a:lnTo>
                    <a:pt x="2369" y="504"/>
                  </a:lnTo>
                  <a:lnTo>
                    <a:pt x="2374" y="504"/>
                  </a:lnTo>
                  <a:lnTo>
                    <a:pt x="2374" y="504"/>
                  </a:lnTo>
                  <a:lnTo>
                    <a:pt x="2380" y="504"/>
                  </a:lnTo>
                  <a:lnTo>
                    <a:pt x="2380" y="504"/>
                  </a:lnTo>
                  <a:lnTo>
                    <a:pt x="2384" y="504"/>
                  </a:lnTo>
                  <a:lnTo>
                    <a:pt x="2384" y="504"/>
                  </a:lnTo>
                  <a:lnTo>
                    <a:pt x="2389" y="504"/>
                  </a:lnTo>
                  <a:lnTo>
                    <a:pt x="2389" y="504"/>
                  </a:lnTo>
                  <a:lnTo>
                    <a:pt x="2393" y="504"/>
                  </a:lnTo>
                  <a:lnTo>
                    <a:pt x="2393" y="504"/>
                  </a:lnTo>
                  <a:lnTo>
                    <a:pt x="2398" y="504"/>
                  </a:lnTo>
                  <a:lnTo>
                    <a:pt x="2398" y="504"/>
                  </a:lnTo>
                  <a:lnTo>
                    <a:pt x="2403" y="504"/>
                  </a:lnTo>
                  <a:lnTo>
                    <a:pt x="2403" y="504"/>
                  </a:lnTo>
                  <a:lnTo>
                    <a:pt x="2419" y="504"/>
                  </a:lnTo>
                  <a:lnTo>
                    <a:pt x="2408" y="504"/>
                  </a:lnTo>
                  <a:lnTo>
                    <a:pt x="2413" y="504"/>
                  </a:lnTo>
                  <a:lnTo>
                    <a:pt x="2413" y="504"/>
                  </a:lnTo>
                  <a:lnTo>
                    <a:pt x="2413" y="504"/>
                  </a:lnTo>
                  <a:lnTo>
                    <a:pt x="2413" y="504"/>
                  </a:lnTo>
                  <a:lnTo>
                    <a:pt x="2408" y="504"/>
                  </a:lnTo>
                  <a:lnTo>
                    <a:pt x="2408" y="504"/>
                  </a:lnTo>
                  <a:lnTo>
                    <a:pt x="2403" y="504"/>
                  </a:lnTo>
                  <a:lnTo>
                    <a:pt x="2403" y="504"/>
                  </a:lnTo>
                  <a:lnTo>
                    <a:pt x="2398" y="504"/>
                  </a:lnTo>
                  <a:lnTo>
                    <a:pt x="2398" y="504"/>
                  </a:lnTo>
                  <a:lnTo>
                    <a:pt x="2393" y="504"/>
                  </a:lnTo>
                  <a:lnTo>
                    <a:pt x="2393" y="504"/>
                  </a:lnTo>
                  <a:lnTo>
                    <a:pt x="2389" y="504"/>
                  </a:lnTo>
                  <a:lnTo>
                    <a:pt x="2389" y="504"/>
                  </a:lnTo>
                  <a:lnTo>
                    <a:pt x="2384" y="504"/>
                  </a:lnTo>
                  <a:lnTo>
                    <a:pt x="2384" y="504"/>
                  </a:lnTo>
                  <a:lnTo>
                    <a:pt x="2380" y="504"/>
                  </a:lnTo>
                  <a:lnTo>
                    <a:pt x="2380" y="504"/>
                  </a:lnTo>
                  <a:lnTo>
                    <a:pt x="2374" y="504"/>
                  </a:lnTo>
                  <a:lnTo>
                    <a:pt x="2374" y="504"/>
                  </a:lnTo>
                  <a:lnTo>
                    <a:pt x="2369" y="504"/>
                  </a:lnTo>
                  <a:lnTo>
                    <a:pt x="2369" y="504"/>
                  </a:lnTo>
                  <a:lnTo>
                    <a:pt x="2365" y="504"/>
                  </a:lnTo>
                  <a:lnTo>
                    <a:pt x="2365" y="504"/>
                  </a:lnTo>
                  <a:lnTo>
                    <a:pt x="2360" y="504"/>
                  </a:lnTo>
                  <a:lnTo>
                    <a:pt x="2360" y="504"/>
                  </a:lnTo>
                  <a:lnTo>
                    <a:pt x="2355" y="504"/>
                  </a:lnTo>
                  <a:lnTo>
                    <a:pt x="2355" y="504"/>
                  </a:lnTo>
                  <a:lnTo>
                    <a:pt x="2350" y="504"/>
                  </a:lnTo>
                  <a:lnTo>
                    <a:pt x="2350" y="504"/>
                  </a:lnTo>
                  <a:lnTo>
                    <a:pt x="2345" y="504"/>
                  </a:lnTo>
                  <a:lnTo>
                    <a:pt x="2345" y="504"/>
                  </a:lnTo>
                  <a:lnTo>
                    <a:pt x="2345" y="504"/>
                  </a:lnTo>
                  <a:lnTo>
                    <a:pt x="2340" y="504"/>
                  </a:lnTo>
                  <a:lnTo>
                    <a:pt x="2340" y="504"/>
                  </a:lnTo>
                  <a:lnTo>
                    <a:pt x="2336" y="504"/>
                  </a:lnTo>
                  <a:lnTo>
                    <a:pt x="2336" y="504"/>
                  </a:lnTo>
                  <a:lnTo>
                    <a:pt x="2331" y="504"/>
                  </a:lnTo>
                  <a:lnTo>
                    <a:pt x="2331" y="504"/>
                  </a:lnTo>
                  <a:lnTo>
                    <a:pt x="2326" y="504"/>
                  </a:lnTo>
                  <a:lnTo>
                    <a:pt x="2326" y="504"/>
                  </a:lnTo>
                  <a:lnTo>
                    <a:pt x="2321" y="504"/>
                  </a:lnTo>
                  <a:lnTo>
                    <a:pt x="2321" y="504"/>
                  </a:lnTo>
                  <a:lnTo>
                    <a:pt x="2316" y="504"/>
                  </a:lnTo>
                  <a:lnTo>
                    <a:pt x="2316" y="504"/>
                  </a:lnTo>
                  <a:lnTo>
                    <a:pt x="2312" y="504"/>
                  </a:lnTo>
                  <a:lnTo>
                    <a:pt x="2312" y="504"/>
                  </a:lnTo>
                  <a:lnTo>
                    <a:pt x="2307" y="504"/>
                  </a:lnTo>
                  <a:lnTo>
                    <a:pt x="2307" y="504"/>
                  </a:lnTo>
                  <a:lnTo>
                    <a:pt x="2301" y="504"/>
                  </a:lnTo>
                  <a:lnTo>
                    <a:pt x="2301" y="504"/>
                  </a:lnTo>
                  <a:lnTo>
                    <a:pt x="2297" y="504"/>
                  </a:lnTo>
                  <a:lnTo>
                    <a:pt x="2297" y="504"/>
                  </a:lnTo>
                  <a:lnTo>
                    <a:pt x="2292" y="504"/>
                  </a:lnTo>
                  <a:lnTo>
                    <a:pt x="2292" y="504"/>
                  </a:lnTo>
                  <a:lnTo>
                    <a:pt x="2287" y="504"/>
                  </a:lnTo>
                  <a:lnTo>
                    <a:pt x="2287" y="504"/>
                  </a:lnTo>
                  <a:lnTo>
                    <a:pt x="2283" y="504"/>
                  </a:lnTo>
                  <a:lnTo>
                    <a:pt x="2283" y="504"/>
                  </a:lnTo>
                  <a:lnTo>
                    <a:pt x="2278" y="504"/>
                  </a:lnTo>
                  <a:lnTo>
                    <a:pt x="2278" y="504"/>
                  </a:lnTo>
                  <a:lnTo>
                    <a:pt x="2272" y="504"/>
                  </a:lnTo>
                  <a:lnTo>
                    <a:pt x="2272" y="504"/>
                  </a:lnTo>
                  <a:lnTo>
                    <a:pt x="2272" y="504"/>
                  </a:lnTo>
                  <a:lnTo>
                    <a:pt x="2268" y="504"/>
                  </a:lnTo>
                  <a:lnTo>
                    <a:pt x="2268" y="504"/>
                  </a:lnTo>
                  <a:lnTo>
                    <a:pt x="2263" y="504"/>
                  </a:lnTo>
                  <a:lnTo>
                    <a:pt x="2263" y="504"/>
                  </a:lnTo>
                  <a:lnTo>
                    <a:pt x="2259" y="504"/>
                  </a:lnTo>
                  <a:lnTo>
                    <a:pt x="2259" y="504"/>
                  </a:lnTo>
                  <a:lnTo>
                    <a:pt x="2254" y="504"/>
                  </a:lnTo>
                  <a:lnTo>
                    <a:pt x="2254" y="504"/>
                  </a:lnTo>
                  <a:lnTo>
                    <a:pt x="2248" y="504"/>
                  </a:lnTo>
                  <a:lnTo>
                    <a:pt x="2248" y="504"/>
                  </a:lnTo>
                  <a:lnTo>
                    <a:pt x="2244" y="504"/>
                  </a:lnTo>
                  <a:lnTo>
                    <a:pt x="2244" y="504"/>
                  </a:lnTo>
                  <a:lnTo>
                    <a:pt x="2239" y="504"/>
                  </a:lnTo>
                  <a:lnTo>
                    <a:pt x="2239" y="504"/>
                  </a:lnTo>
                  <a:lnTo>
                    <a:pt x="2234" y="504"/>
                  </a:lnTo>
                  <a:lnTo>
                    <a:pt x="2234" y="504"/>
                  </a:lnTo>
                  <a:lnTo>
                    <a:pt x="2230" y="504"/>
                  </a:lnTo>
                  <a:lnTo>
                    <a:pt x="2230" y="504"/>
                  </a:lnTo>
                  <a:lnTo>
                    <a:pt x="2225" y="504"/>
                  </a:lnTo>
                  <a:lnTo>
                    <a:pt x="2225" y="504"/>
                  </a:lnTo>
                  <a:lnTo>
                    <a:pt x="2219" y="504"/>
                  </a:lnTo>
                  <a:lnTo>
                    <a:pt x="2219" y="504"/>
                  </a:lnTo>
                  <a:lnTo>
                    <a:pt x="2215" y="504"/>
                  </a:lnTo>
                  <a:lnTo>
                    <a:pt x="2215" y="504"/>
                  </a:lnTo>
                  <a:lnTo>
                    <a:pt x="2210" y="504"/>
                  </a:lnTo>
                  <a:lnTo>
                    <a:pt x="2210" y="504"/>
                  </a:lnTo>
                  <a:lnTo>
                    <a:pt x="2206" y="504"/>
                  </a:lnTo>
                  <a:lnTo>
                    <a:pt x="2206" y="504"/>
                  </a:lnTo>
                  <a:lnTo>
                    <a:pt x="2206" y="504"/>
                  </a:lnTo>
                  <a:lnTo>
                    <a:pt x="2201" y="504"/>
                  </a:lnTo>
                  <a:lnTo>
                    <a:pt x="2201" y="504"/>
                  </a:lnTo>
                  <a:lnTo>
                    <a:pt x="2195" y="504"/>
                  </a:lnTo>
                  <a:lnTo>
                    <a:pt x="2195" y="504"/>
                  </a:lnTo>
                  <a:lnTo>
                    <a:pt x="2191" y="504"/>
                  </a:lnTo>
                  <a:lnTo>
                    <a:pt x="2191" y="504"/>
                  </a:lnTo>
                  <a:lnTo>
                    <a:pt x="2186" y="504"/>
                  </a:lnTo>
                  <a:lnTo>
                    <a:pt x="2186" y="504"/>
                  </a:lnTo>
                  <a:lnTo>
                    <a:pt x="2181" y="504"/>
                  </a:lnTo>
                  <a:lnTo>
                    <a:pt x="2181" y="504"/>
                  </a:lnTo>
                  <a:lnTo>
                    <a:pt x="2177" y="504"/>
                  </a:lnTo>
                  <a:lnTo>
                    <a:pt x="2177" y="504"/>
                  </a:lnTo>
                  <a:lnTo>
                    <a:pt x="2171" y="504"/>
                  </a:lnTo>
                  <a:lnTo>
                    <a:pt x="2171" y="504"/>
                  </a:lnTo>
                  <a:lnTo>
                    <a:pt x="2166" y="504"/>
                  </a:lnTo>
                  <a:lnTo>
                    <a:pt x="2166" y="504"/>
                  </a:lnTo>
                  <a:lnTo>
                    <a:pt x="2162" y="504"/>
                  </a:lnTo>
                  <a:lnTo>
                    <a:pt x="2162" y="504"/>
                  </a:lnTo>
                  <a:lnTo>
                    <a:pt x="2157" y="504"/>
                  </a:lnTo>
                  <a:lnTo>
                    <a:pt x="2157" y="504"/>
                  </a:lnTo>
                  <a:lnTo>
                    <a:pt x="2153" y="504"/>
                  </a:lnTo>
                  <a:lnTo>
                    <a:pt x="2153" y="504"/>
                  </a:lnTo>
                  <a:lnTo>
                    <a:pt x="2148" y="504"/>
                  </a:lnTo>
                  <a:lnTo>
                    <a:pt x="2148" y="504"/>
                  </a:lnTo>
                  <a:lnTo>
                    <a:pt x="2142" y="504"/>
                  </a:lnTo>
                  <a:lnTo>
                    <a:pt x="2142" y="504"/>
                  </a:lnTo>
                  <a:lnTo>
                    <a:pt x="2138" y="504"/>
                  </a:lnTo>
                  <a:lnTo>
                    <a:pt x="2138" y="504"/>
                  </a:lnTo>
                  <a:lnTo>
                    <a:pt x="2138" y="504"/>
                  </a:lnTo>
                  <a:lnTo>
                    <a:pt x="2133" y="504"/>
                  </a:lnTo>
                  <a:lnTo>
                    <a:pt x="2133" y="504"/>
                  </a:lnTo>
                  <a:lnTo>
                    <a:pt x="2128" y="504"/>
                  </a:lnTo>
                  <a:lnTo>
                    <a:pt x="2128" y="504"/>
                  </a:lnTo>
                  <a:lnTo>
                    <a:pt x="2124" y="504"/>
                  </a:lnTo>
                  <a:lnTo>
                    <a:pt x="2124" y="504"/>
                  </a:lnTo>
                  <a:lnTo>
                    <a:pt x="2118" y="504"/>
                  </a:lnTo>
                  <a:lnTo>
                    <a:pt x="2118" y="504"/>
                  </a:lnTo>
                  <a:lnTo>
                    <a:pt x="2113" y="504"/>
                  </a:lnTo>
                  <a:lnTo>
                    <a:pt x="2113" y="504"/>
                  </a:lnTo>
                  <a:lnTo>
                    <a:pt x="2109" y="504"/>
                  </a:lnTo>
                  <a:lnTo>
                    <a:pt x="2109" y="504"/>
                  </a:lnTo>
                  <a:lnTo>
                    <a:pt x="2104" y="504"/>
                  </a:lnTo>
                  <a:lnTo>
                    <a:pt x="2104" y="504"/>
                  </a:lnTo>
                  <a:lnTo>
                    <a:pt x="2100" y="504"/>
                  </a:lnTo>
                  <a:lnTo>
                    <a:pt x="2100" y="504"/>
                  </a:lnTo>
                  <a:lnTo>
                    <a:pt x="2094" y="504"/>
                  </a:lnTo>
                  <a:lnTo>
                    <a:pt x="2094" y="504"/>
                  </a:lnTo>
                  <a:lnTo>
                    <a:pt x="2089" y="504"/>
                  </a:lnTo>
                  <a:lnTo>
                    <a:pt x="2089" y="504"/>
                  </a:lnTo>
                  <a:lnTo>
                    <a:pt x="2085" y="504"/>
                  </a:lnTo>
                  <a:lnTo>
                    <a:pt x="2085" y="504"/>
                  </a:lnTo>
                  <a:lnTo>
                    <a:pt x="2080" y="504"/>
                  </a:lnTo>
                  <a:lnTo>
                    <a:pt x="2080" y="504"/>
                  </a:lnTo>
                  <a:lnTo>
                    <a:pt x="2075" y="504"/>
                  </a:lnTo>
                  <a:lnTo>
                    <a:pt x="2075" y="504"/>
                  </a:lnTo>
                  <a:lnTo>
                    <a:pt x="2071" y="504"/>
                  </a:lnTo>
                  <a:lnTo>
                    <a:pt x="2071" y="504"/>
                  </a:lnTo>
                  <a:lnTo>
                    <a:pt x="2071" y="504"/>
                  </a:lnTo>
                  <a:lnTo>
                    <a:pt x="2065" y="504"/>
                  </a:lnTo>
                  <a:lnTo>
                    <a:pt x="2065" y="504"/>
                  </a:lnTo>
                  <a:lnTo>
                    <a:pt x="2060" y="504"/>
                  </a:lnTo>
                  <a:lnTo>
                    <a:pt x="2060" y="504"/>
                  </a:lnTo>
                  <a:lnTo>
                    <a:pt x="2056" y="504"/>
                  </a:lnTo>
                  <a:lnTo>
                    <a:pt x="2056" y="504"/>
                  </a:lnTo>
                  <a:lnTo>
                    <a:pt x="2051" y="504"/>
                  </a:lnTo>
                  <a:lnTo>
                    <a:pt x="2051" y="504"/>
                  </a:lnTo>
                  <a:lnTo>
                    <a:pt x="2047" y="504"/>
                  </a:lnTo>
                  <a:lnTo>
                    <a:pt x="2047" y="504"/>
                  </a:lnTo>
                  <a:lnTo>
                    <a:pt x="2041" y="504"/>
                  </a:lnTo>
                  <a:lnTo>
                    <a:pt x="2041" y="504"/>
                  </a:lnTo>
                  <a:lnTo>
                    <a:pt x="2036" y="504"/>
                  </a:lnTo>
                  <a:lnTo>
                    <a:pt x="2036" y="504"/>
                  </a:lnTo>
                  <a:lnTo>
                    <a:pt x="2032" y="504"/>
                  </a:lnTo>
                  <a:lnTo>
                    <a:pt x="2032" y="504"/>
                  </a:lnTo>
                  <a:lnTo>
                    <a:pt x="2027" y="504"/>
                  </a:lnTo>
                  <a:lnTo>
                    <a:pt x="2027" y="504"/>
                  </a:lnTo>
                  <a:lnTo>
                    <a:pt x="2022" y="504"/>
                  </a:lnTo>
                  <a:lnTo>
                    <a:pt x="2022" y="504"/>
                  </a:lnTo>
                  <a:lnTo>
                    <a:pt x="2017" y="504"/>
                  </a:lnTo>
                  <a:lnTo>
                    <a:pt x="2017" y="504"/>
                  </a:lnTo>
                  <a:lnTo>
                    <a:pt x="2012" y="504"/>
                  </a:lnTo>
                  <a:lnTo>
                    <a:pt x="2012" y="504"/>
                  </a:lnTo>
                  <a:lnTo>
                    <a:pt x="2007" y="504"/>
                  </a:lnTo>
                  <a:lnTo>
                    <a:pt x="2007" y="504"/>
                  </a:lnTo>
                  <a:lnTo>
                    <a:pt x="2003" y="504"/>
                  </a:lnTo>
                  <a:lnTo>
                    <a:pt x="2003" y="504"/>
                  </a:lnTo>
                  <a:lnTo>
                    <a:pt x="1998" y="504"/>
                  </a:lnTo>
                  <a:lnTo>
                    <a:pt x="1998" y="504"/>
                  </a:lnTo>
                  <a:lnTo>
                    <a:pt x="1998" y="504"/>
                  </a:lnTo>
                  <a:lnTo>
                    <a:pt x="1992" y="504"/>
                  </a:lnTo>
                  <a:lnTo>
                    <a:pt x="1992" y="504"/>
                  </a:lnTo>
                  <a:lnTo>
                    <a:pt x="1988" y="504"/>
                  </a:lnTo>
                  <a:lnTo>
                    <a:pt x="1988" y="504"/>
                  </a:lnTo>
                  <a:lnTo>
                    <a:pt x="1983" y="504"/>
                  </a:lnTo>
                  <a:lnTo>
                    <a:pt x="1983" y="504"/>
                  </a:lnTo>
                  <a:lnTo>
                    <a:pt x="1979" y="504"/>
                  </a:lnTo>
                  <a:lnTo>
                    <a:pt x="1979" y="504"/>
                  </a:lnTo>
                  <a:lnTo>
                    <a:pt x="1974" y="504"/>
                  </a:lnTo>
                  <a:lnTo>
                    <a:pt x="1974" y="504"/>
                  </a:lnTo>
                  <a:lnTo>
                    <a:pt x="1969" y="504"/>
                  </a:lnTo>
                  <a:lnTo>
                    <a:pt x="1969" y="504"/>
                  </a:lnTo>
                  <a:lnTo>
                    <a:pt x="1964" y="504"/>
                  </a:lnTo>
                  <a:lnTo>
                    <a:pt x="1964" y="504"/>
                  </a:lnTo>
                  <a:lnTo>
                    <a:pt x="1959" y="504"/>
                  </a:lnTo>
                  <a:lnTo>
                    <a:pt x="1959" y="504"/>
                  </a:lnTo>
                  <a:lnTo>
                    <a:pt x="1954" y="504"/>
                  </a:lnTo>
                  <a:lnTo>
                    <a:pt x="1954" y="504"/>
                  </a:lnTo>
                  <a:lnTo>
                    <a:pt x="1950" y="504"/>
                  </a:lnTo>
                  <a:lnTo>
                    <a:pt x="1950" y="504"/>
                  </a:lnTo>
                  <a:lnTo>
                    <a:pt x="1945" y="504"/>
                  </a:lnTo>
                  <a:lnTo>
                    <a:pt x="1945" y="504"/>
                  </a:lnTo>
                  <a:lnTo>
                    <a:pt x="1939" y="504"/>
                  </a:lnTo>
                  <a:lnTo>
                    <a:pt x="1939" y="504"/>
                  </a:lnTo>
                  <a:lnTo>
                    <a:pt x="1935" y="504"/>
                  </a:lnTo>
                  <a:lnTo>
                    <a:pt x="1935" y="504"/>
                  </a:lnTo>
                  <a:lnTo>
                    <a:pt x="1930" y="504"/>
                  </a:lnTo>
                  <a:lnTo>
                    <a:pt x="1930" y="504"/>
                  </a:lnTo>
                  <a:lnTo>
                    <a:pt x="1930" y="504"/>
                  </a:lnTo>
                  <a:lnTo>
                    <a:pt x="1926" y="504"/>
                  </a:lnTo>
                  <a:lnTo>
                    <a:pt x="1926" y="504"/>
                  </a:lnTo>
                  <a:lnTo>
                    <a:pt x="1921" y="504"/>
                  </a:lnTo>
                  <a:lnTo>
                    <a:pt x="1921" y="504"/>
                  </a:lnTo>
                  <a:lnTo>
                    <a:pt x="1915" y="504"/>
                  </a:lnTo>
                  <a:lnTo>
                    <a:pt x="1915" y="504"/>
                  </a:lnTo>
                  <a:lnTo>
                    <a:pt x="1911" y="504"/>
                  </a:lnTo>
                  <a:lnTo>
                    <a:pt x="1911" y="504"/>
                  </a:lnTo>
                  <a:lnTo>
                    <a:pt x="1906" y="504"/>
                  </a:lnTo>
                  <a:lnTo>
                    <a:pt x="1906" y="504"/>
                  </a:lnTo>
                  <a:lnTo>
                    <a:pt x="1901" y="504"/>
                  </a:lnTo>
                  <a:lnTo>
                    <a:pt x="1901" y="504"/>
                  </a:lnTo>
                  <a:lnTo>
                    <a:pt x="1897" y="504"/>
                  </a:lnTo>
                  <a:lnTo>
                    <a:pt x="1897" y="504"/>
                  </a:lnTo>
                  <a:lnTo>
                    <a:pt x="1892" y="504"/>
                  </a:lnTo>
                  <a:lnTo>
                    <a:pt x="1892" y="504"/>
                  </a:lnTo>
                  <a:lnTo>
                    <a:pt x="1886" y="504"/>
                  </a:lnTo>
                  <a:lnTo>
                    <a:pt x="1886" y="504"/>
                  </a:lnTo>
                  <a:lnTo>
                    <a:pt x="1882" y="504"/>
                  </a:lnTo>
                  <a:lnTo>
                    <a:pt x="1882" y="504"/>
                  </a:lnTo>
                  <a:lnTo>
                    <a:pt x="1877" y="504"/>
                  </a:lnTo>
                  <a:lnTo>
                    <a:pt x="1877" y="504"/>
                  </a:lnTo>
                  <a:lnTo>
                    <a:pt x="1873" y="504"/>
                  </a:lnTo>
                  <a:lnTo>
                    <a:pt x="1873" y="504"/>
                  </a:lnTo>
                  <a:lnTo>
                    <a:pt x="1868" y="504"/>
                  </a:lnTo>
                  <a:lnTo>
                    <a:pt x="1868" y="504"/>
                  </a:lnTo>
                  <a:lnTo>
                    <a:pt x="1862" y="504"/>
                  </a:lnTo>
                  <a:lnTo>
                    <a:pt x="1862" y="504"/>
                  </a:lnTo>
                  <a:lnTo>
                    <a:pt x="1862" y="504"/>
                  </a:lnTo>
                  <a:lnTo>
                    <a:pt x="1858" y="504"/>
                  </a:lnTo>
                  <a:lnTo>
                    <a:pt x="1858" y="504"/>
                  </a:lnTo>
                  <a:lnTo>
                    <a:pt x="1853" y="504"/>
                  </a:lnTo>
                  <a:lnTo>
                    <a:pt x="1853" y="504"/>
                  </a:lnTo>
                  <a:lnTo>
                    <a:pt x="1848" y="504"/>
                  </a:lnTo>
                  <a:lnTo>
                    <a:pt x="1848" y="504"/>
                  </a:lnTo>
                  <a:lnTo>
                    <a:pt x="1844" y="504"/>
                  </a:lnTo>
                  <a:lnTo>
                    <a:pt x="1844" y="504"/>
                  </a:lnTo>
                  <a:lnTo>
                    <a:pt x="1838" y="504"/>
                  </a:lnTo>
                  <a:lnTo>
                    <a:pt x="1838" y="504"/>
                  </a:lnTo>
                  <a:lnTo>
                    <a:pt x="1833" y="504"/>
                  </a:lnTo>
                  <a:lnTo>
                    <a:pt x="1833" y="504"/>
                  </a:lnTo>
                  <a:lnTo>
                    <a:pt x="1829" y="504"/>
                  </a:lnTo>
                  <a:lnTo>
                    <a:pt x="1829" y="504"/>
                  </a:lnTo>
                  <a:lnTo>
                    <a:pt x="1824" y="504"/>
                  </a:lnTo>
                  <a:lnTo>
                    <a:pt x="1824" y="504"/>
                  </a:lnTo>
                  <a:lnTo>
                    <a:pt x="1820" y="504"/>
                  </a:lnTo>
                  <a:lnTo>
                    <a:pt x="1820" y="504"/>
                  </a:lnTo>
                  <a:lnTo>
                    <a:pt x="1815" y="504"/>
                  </a:lnTo>
                  <a:lnTo>
                    <a:pt x="1815" y="504"/>
                  </a:lnTo>
                  <a:lnTo>
                    <a:pt x="1809" y="504"/>
                  </a:lnTo>
                  <a:lnTo>
                    <a:pt x="1809" y="504"/>
                  </a:lnTo>
                  <a:lnTo>
                    <a:pt x="1805" y="504"/>
                  </a:lnTo>
                  <a:lnTo>
                    <a:pt x="1805" y="504"/>
                  </a:lnTo>
                  <a:lnTo>
                    <a:pt x="1800" y="504"/>
                  </a:lnTo>
                  <a:lnTo>
                    <a:pt x="1800" y="504"/>
                  </a:lnTo>
                  <a:lnTo>
                    <a:pt x="1795" y="504"/>
                  </a:lnTo>
                  <a:lnTo>
                    <a:pt x="1795" y="504"/>
                  </a:lnTo>
                  <a:lnTo>
                    <a:pt x="1791" y="504"/>
                  </a:lnTo>
                  <a:lnTo>
                    <a:pt x="1791" y="504"/>
                  </a:lnTo>
                  <a:lnTo>
                    <a:pt x="1791" y="504"/>
                  </a:lnTo>
                  <a:lnTo>
                    <a:pt x="1785" y="504"/>
                  </a:lnTo>
                  <a:lnTo>
                    <a:pt x="1785" y="504"/>
                  </a:lnTo>
                  <a:lnTo>
                    <a:pt x="1780" y="504"/>
                  </a:lnTo>
                  <a:lnTo>
                    <a:pt x="1780" y="504"/>
                  </a:lnTo>
                  <a:lnTo>
                    <a:pt x="1776" y="504"/>
                  </a:lnTo>
                  <a:lnTo>
                    <a:pt x="1776" y="504"/>
                  </a:lnTo>
                  <a:lnTo>
                    <a:pt x="1771" y="504"/>
                  </a:lnTo>
                  <a:lnTo>
                    <a:pt x="1771" y="504"/>
                  </a:lnTo>
                  <a:lnTo>
                    <a:pt x="1767" y="504"/>
                  </a:lnTo>
                  <a:lnTo>
                    <a:pt x="1767" y="504"/>
                  </a:lnTo>
                  <a:lnTo>
                    <a:pt x="1761" y="504"/>
                  </a:lnTo>
                  <a:lnTo>
                    <a:pt x="1761" y="504"/>
                  </a:lnTo>
                  <a:lnTo>
                    <a:pt x="1756" y="504"/>
                  </a:lnTo>
                  <a:lnTo>
                    <a:pt x="1756" y="504"/>
                  </a:lnTo>
                  <a:lnTo>
                    <a:pt x="1752" y="504"/>
                  </a:lnTo>
                  <a:lnTo>
                    <a:pt x="1752" y="504"/>
                  </a:lnTo>
                  <a:lnTo>
                    <a:pt x="1747" y="504"/>
                  </a:lnTo>
                  <a:lnTo>
                    <a:pt x="1747" y="504"/>
                  </a:lnTo>
                  <a:lnTo>
                    <a:pt x="1742" y="504"/>
                  </a:lnTo>
                  <a:lnTo>
                    <a:pt x="1742" y="504"/>
                  </a:lnTo>
                  <a:lnTo>
                    <a:pt x="1738" y="504"/>
                  </a:lnTo>
                  <a:lnTo>
                    <a:pt x="1738" y="504"/>
                  </a:lnTo>
                  <a:lnTo>
                    <a:pt x="1732" y="504"/>
                  </a:lnTo>
                  <a:lnTo>
                    <a:pt x="1732" y="504"/>
                  </a:lnTo>
                  <a:lnTo>
                    <a:pt x="1727" y="504"/>
                  </a:lnTo>
                  <a:lnTo>
                    <a:pt x="1727" y="504"/>
                  </a:lnTo>
                  <a:lnTo>
                    <a:pt x="1723" y="504"/>
                  </a:lnTo>
                  <a:lnTo>
                    <a:pt x="1723" y="504"/>
                  </a:lnTo>
                  <a:lnTo>
                    <a:pt x="1723" y="504"/>
                  </a:lnTo>
                  <a:lnTo>
                    <a:pt x="1718" y="504"/>
                  </a:lnTo>
                  <a:lnTo>
                    <a:pt x="1718" y="504"/>
                  </a:lnTo>
                  <a:lnTo>
                    <a:pt x="1713" y="504"/>
                  </a:lnTo>
                  <a:lnTo>
                    <a:pt x="1713" y="504"/>
                  </a:lnTo>
                  <a:lnTo>
                    <a:pt x="1708" y="504"/>
                  </a:lnTo>
                  <a:lnTo>
                    <a:pt x="1708" y="504"/>
                  </a:lnTo>
                  <a:lnTo>
                    <a:pt x="1703" y="504"/>
                  </a:lnTo>
                  <a:lnTo>
                    <a:pt x="1703" y="504"/>
                  </a:lnTo>
                  <a:lnTo>
                    <a:pt x="1699" y="504"/>
                  </a:lnTo>
                  <a:lnTo>
                    <a:pt x="1699" y="504"/>
                  </a:lnTo>
                  <a:lnTo>
                    <a:pt x="1694" y="504"/>
                  </a:lnTo>
                  <a:lnTo>
                    <a:pt x="1694" y="504"/>
                  </a:lnTo>
                  <a:lnTo>
                    <a:pt x="1689" y="504"/>
                  </a:lnTo>
                  <a:lnTo>
                    <a:pt x="1689" y="504"/>
                  </a:lnTo>
                  <a:lnTo>
                    <a:pt x="1685" y="504"/>
                  </a:lnTo>
                  <a:lnTo>
                    <a:pt x="1685" y="504"/>
                  </a:lnTo>
                  <a:lnTo>
                    <a:pt x="1679" y="504"/>
                  </a:lnTo>
                  <a:lnTo>
                    <a:pt x="1679" y="504"/>
                  </a:lnTo>
                  <a:lnTo>
                    <a:pt x="1674" y="504"/>
                  </a:lnTo>
                  <a:lnTo>
                    <a:pt x="1674" y="504"/>
                  </a:lnTo>
                  <a:lnTo>
                    <a:pt x="1670" y="403"/>
                  </a:lnTo>
                  <a:lnTo>
                    <a:pt x="1670" y="403"/>
                  </a:lnTo>
                  <a:lnTo>
                    <a:pt x="1665" y="504"/>
                  </a:lnTo>
                  <a:lnTo>
                    <a:pt x="1665" y="403"/>
                  </a:lnTo>
                  <a:lnTo>
                    <a:pt x="1660" y="403"/>
                  </a:lnTo>
                  <a:lnTo>
                    <a:pt x="1660" y="403"/>
                  </a:lnTo>
                  <a:lnTo>
                    <a:pt x="1655" y="403"/>
                  </a:lnTo>
                  <a:lnTo>
                    <a:pt x="1655" y="403"/>
                  </a:lnTo>
                  <a:lnTo>
                    <a:pt x="1655" y="403"/>
                  </a:lnTo>
                  <a:lnTo>
                    <a:pt x="1650" y="403"/>
                  </a:lnTo>
                  <a:lnTo>
                    <a:pt x="1650" y="504"/>
                  </a:lnTo>
                  <a:lnTo>
                    <a:pt x="1646" y="504"/>
                  </a:lnTo>
                  <a:lnTo>
                    <a:pt x="1646" y="504"/>
                  </a:lnTo>
                  <a:lnTo>
                    <a:pt x="1641" y="504"/>
                  </a:lnTo>
                  <a:lnTo>
                    <a:pt x="1641" y="504"/>
                  </a:lnTo>
                  <a:lnTo>
                    <a:pt x="1636" y="504"/>
                  </a:lnTo>
                  <a:lnTo>
                    <a:pt x="1636" y="504"/>
                  </a:lnTo>
                  <a:lnTo>
                    <a:pt x="1631" y="504"/>
                  </a:lnTo>
                  <a:lnTo>
                    <a:pt x="1631" y="504"/>
                  </a:lnTo>
                  <a:lnTo>
                    <a:pt x="1626" y="504"/>
                  </a:lnTo>
                  <a:lnTo>
                    <a:pt x="1626" y="504"/>
                  </a:lnTo>
                  <a:lnTo>
                    <a:pt x="1621" y="504"/>
                  </a:lnTo>
                  <a:lnTo>
                    <a:pt x="1621" y="504"/>
                  </a:lnTo>
                  <a:lnTo>
                    <a:pt x="1617" y="504"/>
                  </a:lnTo>
                  <a:lnTo>
                    <a:pt x="1617" y="504"/>
                  </a:lnTo>
                  <a:lnTo>
                    <a:pt x="1612" y="504"/>
                  </a:lnTo>
                  <a:lnTo>
                    <a:pt x="1612" y="504"/>
                  </a:lnTo>
                  <a:lnTo>
                    <a:pt x="1606" y="504"/>
                  </a:lnTo>
                  <a:lnTo>
                    <a:pt x="1606" y="504"/>
                  </a:lnTo>
                  <a:lnTo>
                    <a:pt x="1602" y="504"/>
                  </a:lnTo>
                  <a:lnTo>
                    <a:pt x="1602" y="504"/>
                  </a:lnTo>
                  <a:lnTo>
                    <a:pt x="1597" y="504"/>
                  </a:lnTo>
                  <a:lnTo>
                    <a:pt x="1597" y="504"/>
                  </a:lnTo>
                  <a:lnTo>
                    <a:pt x="1593" y="504"/>
                  </a:lnTo>
                  <a:lnTo>
                    <a:pt x="1593" y="504"/>
                  </a:lnTo>
                  <a:lnTo>
                    <a:pt x="1588" y="504"/>
                  </a:lnTo>
                  <a:lnTo>
                    <a:pt x="1588" y="504"/>
                  </a:lnTo>
                  <a:lnTo>
                    <a:pt x="1588" y="504"/>
                  </a:lnTo>
                  <a:lnTo>
                    <a:pt x="1583" y="504"/>
                  </a:lnTo>
                  <a:lnTo>
                    <a:pt x="1583" y="504"/>
                  </a:lnTo>
                  <a:lnTo>
                    <a:pt x="1578" y="504"/>
                  </a:lnTo>
                  <a:lnTo>
                    <a:pt x="1578" y="504"/>
                  </a:lnTo>
                  <a:lnTo>
                    <a:pt x="1573" y="504"/>
                  </a:lnTo>
                  <a:lnTo>
                    <a:pt x="1573" y="504"/>
                  </a:lnTo>
                  <a:lnTo>
                    <a:pt x="1568" y="504"/>
                  </a:lnTo>
                  <a:lnTo>
                    <a:pt x="1568" y="504"/>
                  </a:lnTo>
                  <a:lnTo>
                    <a:pt x="1564" y="504"/>
                  </a:lnTo>
                  <a:lnTo>
                    <a:pt x="1564" y="504"/>
                  </a:lnTo>
                  <a:lnTo>
                    <a:pt x="1559" y="504"/>
                  </a:lnTo>
                  <a:lnTo>
                    <a:pt x="1559" y="504"/>
                  </a:lnTo>
                  <a:lnTo>
                    <a:pt x="1553" y="504"/>
                  </a:lnTo>
                  <a:lnTo>
                    <a:pt x="1553" y="504"/>
                  </a:lnTo>
                  <a:lnTo>
                    <a:pt x="1549" y="504"/>
                  </a:lnTo>
                  <a:lnTo>
                    <a:pt x="1549" y="504"/>
                  </a:lnTo>
                  <a:lnTo>
                    <a:pt x="1544" y="504"/>
                  </a:lnTo>
                  <a:lnTo>
                    <a:pt x="1544" y="504"/>
                  </a:lnTo>
                  <a:lnTo>
                    <a:pt x="1540" y="504"/>
                  </a:lnTo>
                  <a:lnTo>
                    <a:pt x="1540" y="504"/>
                  </a:lnTo>
                  <a:lnTo>
                    <a:pt x="1535" y="504"/>
                  </a:lnTo>
                  <a:lnTo>
                    <a:pt x="1535" y="504"/>
                  </a:lnTo>
                  <a:lnTo>
                    <a:pt x="1529" y="504"/>
                  </a:lnTo>
                  <a:lnTo>
                    <a:pt x="1529" y="504"/>
                  </a:lnTo>
                  <a:lnTo>
                    <a:pt x="1525" y="504"/>
                  </a:lnTo>
                  <a:lnTo>
                    <a:pt x="1525" y="504"/>
                  </a:lnTo>
                  <a:lnTo>
                    <a:pt x="1520" y="504"/>
                  </a:lnTo>
                  <a:lnTo>
                    <a:pt x="1520" y="504"/>
                  </a:lnTo>
                  <a:lnTo>
                    <a:pt x="1515" y="504"/>
                  </a:lnTo>
                  <a:lnTo>
                    <a:pt x="1515" y="504"/>
                  </a:lnTo>
                  <a:lnTo>
                    <a:pt x="1515" y="504"/>
                  </a:lnTo>
                  <a:lnTo>
                    <a:pt x="1511" y="504"/>
                  </a:lnTo>
                  <a:lnTo>
                    <a:pt x="1511" y="504"/>
                  </a:lnTo>
                  <a:lnTo>
                    <a:pt x="1506" y="504"/>
                  </a:lnTo>
                  <a:lnTo>
                    <a:pt x="1506" y="504"/>
                  </a:lnTo>
                  <a:lnTo>
                    <a:pt x="1500" y="504"/>
                  </a:lnTo>
                  <a:lnTo>
                    <a:pt x="1500" y="504"/>
                  </a:lnTo>
                  <a:lnTo>
                    <a:pt x="1496" y="504"/>
                  </a:lnTo>
                  <a:lnTo>
                    <a:pt x="1496" y="504"/>
                  </a:lnTo>
                  <a:lnTo>
                    <a:pt x="1491" y="504"/>
                  </a:lnTo>
                  <a:lnTo>
                    <a:pt x="1491" y="504"/>
                  </a:lnTo>
                  <a:lnTo>
                    <a:pt x="1487" y="504"/>
                  </a:lnTo>
                  <a:lnTo>
                    <a:pt x="1487" y="504"/>
                  </a:lnTo>
                  <a:lnTo>
                    <a:pt x="1482" y="504"/>
                  </a:lnTo>
                  <a:lnTo>
                    <a:pt x="1482" y="504"/>
                  </a:lnTo>
                  <a:lnTo>
                    <a:pt x="1476" y="504"/>
                  </a:lnTo>
                  <a:lnTo>
                    <a:pt x="1476" y="504"/>
                  </a:lnTo>
                  <a:lnTo>
                    <a:pt x="1472" y="504"/>
                  </a:lnTo>
                  <a:lnTo>
                    <a:pt x="1472" y="504"/>
                  </a:lnTo>
                  <a:lnTo>
                    <a:pt x="1467" y="504"/>
                  </a:lnTo>
                  <a:lnTo>
                    <a:pt x="1467" y="504"/>
                  </a:lnTo>
                  <a:lnTo>
                    <a:pt x="1462" y="504"/>
                  </a:lnTo>
                  <a:lnTo>
                    <a:pt x="1462" y="504"/>
                  </a:lnTo>
                  <a:lnTo>
                    <a:pt x="1458" y="504"/>
                  </a:lnTo>
                  <a:lnTo>
                    <a:pt x="1458" y="504"/>
                  </a:lnTo>
                  <a:lnTo>
                    <a:pt x="1452" y="504"/>
                  </a:lnTo>
                  <a:lnTo>
                    <a:pt x="1452" y="504"/>
                  </a:lnTo>
                  <a:lnTo>
                    <a:pt x="1447" y="504"/>
                  </a:lnTo>
                  <a:lnTo>
                    <a:pt x="1447" y="504"/>
                  </a:lnTo>
                  <a:lnTo>
                    <a:pt x="1447" y="504"/>
                  </a:lnTo>
                  <a:lnTo>
                    <a:pt x="1443" y="504"/>
                  </a:lnTo>
                  <a:lnTo>
                    <a:pt x="1443" y="504"/>
                  </a:lnTo>
                  <a:lnTo>
                    <a:pt x="1438" y="504"/>
                  </a:lnTo>
                  <a:lnTo>
                    <a:pt x="1438" y="504"/>
                  </a:lnTo>
                  <a:lnTo>
                    <a:pt x="1433" y="504"/>
                  </a:lnTo>
                  <a:lnTo>
                    <a:pt x="1433" y="504"/>
                  </a:lnTo>
                  <a:lnTo>
                    <a:pt x="1429" y="504"/>
                  </a:lnTo>
                  <a:lnTo>
                    <a:pt x="1429" y="504"/>
                  </a:lnTo>
                  <a:lnTo>
                    <a:pt x="1423" y="504"/>
                  </a:lnTo>
                  <a:lnTo>
                    <a:pt x="1423" y="504"/>
                  </a:lnTo>
                  <a:lnTo>
                    <a:pt x="1419" y="504"/>
                  </a:lnTo>
                  <a:lnTo>
                    <a:pt x="1419" y="504"/>
                  </a:lnTo>
                  <a:lnTo>
                    <a:pt x="1414" y="504"/>
                  </a:lnTo>
                  <a:lnTo>
                    <a:pt x="1414" y="504"/>
                  </a:lnTo>
                  <a:lnTo>
                    <a:pt x="1409" y="504"/>
                  </a:lnTo>
                  <a:lnTo>
                    <a:pt x="1409" y="504"/>
                  </a:lnTo>
                  <a:lnTo>
                    <a:pt x="1405" y="504"/>
                  </a:lnTo>
                  <a:lnTo>
                    <a:pt x="1405" y="504"/>
                  </a:lnTo>
                  <a:lnTo>
                    <a:pt x="1399" y="504"/>
                  </a:lnTo>
                  <a:lnTo>
                    <a:pt x="1399" y="504"/>
                  </a:lnTo>
                  <a:lnTo>
                    <a:pt x="1394" y="504"/>
                  </a:lnTo>
                  <a:lnTo>
                    <a:pt x="1394" y="504"/>
                  </a:lnTo>
                  <a:lnTo>
                    <a:pt x="1390" y="504"/>
                  </a:lnTo>
                  <a:lnTo>
                    <a:pt x="1390" y="504"/>
                  </a:lnTo>
                  <a:lnTo>
                    <a:pt x="1385" y="504"/>
                  </a:lnTo>
                  <a:lnTo>
                    <a:pt x="1385" y="504"/>
                  </a:lnTo>
                  <a:lnTo>
                    <a:pt x="1380" y="504"/>
                  </a:lnTo>
                  <a:lnTo>
                    <a:pt x="1380" y="504"/>
                  </a:lnTo>
                  <a:lnTo>
                    <a:pt x="1380" y="504"/>
                  </a:lnTo>
                  <a:lnTo>
                    <a:pt x="1375" y="504"/>
                  </a:lnTo>
                  <a:lnTo>
                    <a:pt x="1375" y="504"/>
                  </a:lnTo>
                  <a:lnTo>
                    <a:pt x="1370" y="504"/>
                  </a:lnTo>
                  <a:lnTo>
                    <a:pt x="1370" y="504"/>
                  </a:lnTo>
                  <a:lnTo>
                    <a:pt x="1366" y="504"/>
                  </a:lnTo>
                  <a:lnTo>
                    <a:pt x="1366" y="504"/>
                  </a:lnTo>
                  <a:lnTo>
                    <a:pt x="1361" y="504"/>
                  </a:lnTo>
                  <a:lnTo>
                    <a:pt x="1361" y="504"/>
                  </a:lnTo>
                  <a:lnTo>
                    <a:pt x="1356" y="504"/>
                  </a:lnTo>
                  <a:lnTo>
                    <a:pt x="1356" y="504"/>
                  </a:lnTo>
                  <a:lnTo>
                    <a:pt x="1352" y="504"/>
                  </a:lnTo>
                  <a:lnTo>
                    <a:pt x="1352" y="504"/>
                  </a:lnTo>
                  <a:lnTo>
                    <a:pt x="1346" y="504"/>
                  </a:lnTo>
                  <a:lnTo>
                    <a:pt x="1346" y="504"/>
                  </a:lnTo>
                  <a:lnTo>
                    <a:pt x="1341" y="504"/>
                  </a:lnTo>
                  <a:lnTo>
                    <a:pt x="1341" y="504"/>
                  </a:lnTo>
                  <a:lnTo>
                    <a:pt x="1337" y="504"/>
                  </a:lnTo>
                  <a:lnTo>
                    <a:pt x="1337" y="504"/>
                  </a:lnTo>
                  <a:lnTo>
                    <a:pt x="1332" y="504"/>
                  </a:lnTo>
                  <a:lnTo>
                    <a:pt x="1332" y="504"/>
                  </a:lnTo>
                  <a:lnTo>
                    <a:pt x="1327" y="504"/>
                  </a:lnTo>
                  <a:lnTo>
                    <a:pt x="1327" y="504"/>
                  </a:lnTo>
                  <a:lnTo>
                    <a:pt x="1322" y="504"/>
                  </a:lnTo>
                  <a:lnTo>
                    <a:pt x="1322" y="504"/>
                  </a:lnTo>
                  <a:lnTo>
                    <a:pt x="1317" y="504"/>
                  </a:lnTo>
                  <a:lnTo>
                    <a:pt x="1317" y="504"/>
                  </a:lnTo>
                  <a:lnTo>
                    <a:pt x="1313" y="504"/>
                  </a:lnTo>
                  <a:lnTo>
                    <a:pt x="1313" y="504"/>
                  </a:lnTo>
                  <a:lnTo>
                    <a:pt x="1308" y="504"/>
                  </a:lnTo>
                  <a:lnTo>
                    <a:pt x="1308" y="504"/>
                  </a:lnTo>
                  <a:lnTo>
                    <a:pt x="1308" y="504"/>
                  </a:lnTo>
                  <a:lnTo>
                    <a:pt x="1303" y="504"/>
                  </a:lnTo>
                  <a:lnTo>
                    <a:pt x="1303" y="504"/>
                  </a:lnTo>
                  <a:lnTo>
                    <a:pt x="1298" y="504"/>
                  </a:lnTo>
                  <a:lnTo>
                    <a:pt x="1298" y="504"/>
                  </a:lnTo>
                  <a:lnTo>
                    <a:pt x="1293" y="504"/>
                  </a:lnTo>
                  <a:lnTo>
                    <a:pt x="1293" y="504"/>
                  </a:lnTo>
                  <a:lnTo>
                    <a:pt x="1288" y="504"/>
                  </a:lnTo>
                  <a:lnTo>
                    <a:pt x="1288" y="504"/>
                  </a:lnTo>
                  <a:lnTo>
                    <a:pt x="1284" y="504"/>
                  </a:lnTo>
                  <a:lnTo>
                    <a:pt x="1284" y="504"/>
                  </a:lnTo>
                  <a:lnTo>
                    <a:pt x="1279" y="504"/>
                  </a:lnTo>
                  <a:lnTo>
                    <a:pt x="1279" y="504"/>
                  </a:lnTo>
                  <a:lnTo>
                    <a:pt x="1274" y="504"/>
                  </a:lnTo>
                  <a:lnTo>
                    <a:pt x="1274" y="504"/>
                  </a:lnTo>
                  <a:lnTo>
                    <a:pt x="1269" y="504"/>
                  </a:lnTo>
                  <a:lnTo>
                    <a:pt x="1269" y="504"/>
                  </a:lnTo>
                  <a:lnTo>
                    <a:pt x="1264" y="504"/>
                  </a:lnTo>
                  <a:lnTo>
                    <a:pt x="1264" y="504"/>
                  </a:lnTo>
                  <a:lnTo>
                    <a:pt x="1260" y="504"/>
                  </a:lnTo>
                  <a:lnTo>
                    <a:pt x="1260" y="504"/>
                  </a:lnTo>
                  <a:lnTo>
                    <a:pt x="1255" y="504"/>
                  </a:lnTo>
                  <a:lnTo>
                    <a:pt x="1255" y="504"/>
                  </a:lnTo>
                  <a:lnTo>
                    <a:pt x="1250" y="504"/>
                  </a:lnTo>
                  <a:lnTo>
                    <a:pt x="1250" y="504"/>
                  </a:lnTo>
                  <a:lnTo>
                    <a:pt x="1245" y="504"/>
                  </a:lnTo>
                  <a:lnTo>
                    <a:pt x="1245" y="504"/>
                  </a:lnTo>
                  <a:lnTo>
                    <a:pt x="1240" y="504"/>
                  </a:lnTo>
                  <a:lnTo>
                    <a:pt x="1240" y="504"/>
                  </a:lnTo>
                  <a:lnTo>
                    <a:pt x="1240" y="504"/>
                  </a:lnTo>
                  <a:lnTo>
                    <a:pt x="1235" y="504"/>
                  </a:lnTo>
                  <a:lnTo>
                    <a:pt x="1235" y="504"/>
                  </a:lnTo>
                  <a:lnTo>
                    <a:pt x="1231" y="504"/>
                  </a:lnTo>
                  <a:lnTo>
                    <a:pt x="1231" y="504"/>
                  </a:lnTo>
                  <a:lnTo>
                    <a:pt x="1226" y="504"/>
                  </a:lnTo>
                  <a:lnTo>
                    <a:pt x="1226" y="504"/>
                  </a:lnTo>
                  <a:lnTo>
                    <a:pt x="1220" y="504"/>
                  </a:lnTo>
                  <a:lnTo>
                    <a:pt x="1220" y="504"/>
                  </a:lnTo>
                  <a:lnTo>
                    <a:pt x="1216" y="504"/>
                  </a:lnTo>
                  <a:lnTo>
                    <a:pt x="1216" y="504"/>
                  </a:lnTo>
                  <a:lnTo>
                    <a:pt x="1211" y="504"/>
                  </a:lnTo>
                  <a:lnTo>
                    <a:pt x="1211" y="504"/>
                  </a:lnTo>
                  <a:lnTo>
                    <a:pt x="1207" y="504"/>
                  </a:lnTo>
                  <a:lnTo>
                    <a:pt x="1207" y="504"/>
                  </a:lnTo>
                  <a:lnTo>
                    <a:pt x="1202" y="504"/>
                  </a:lnTo>
                  <a:lnTo>
                    <a:pt x="1202" y="504"/>
                  </a:lnTo>
                  <a:lnTo>
                    <a:pt x="1197" y="504"/>
                  </a:lnTo>
                  <a:lnTo>
                    <a:pt x="1197" y="504"/>
                  </a:lnTo>
                  <a:lnTo>
                    <a:pt x="1192" y="504"/>
                  </a:lnTo>
                  <a:lnTo>
                    <a:pt x="1192" y="504"/>
                  </a:lnTo>
                  <a:lnTo>
                    <a:pt x="1187" y="504"/>
                  </a:lnTo>
                  <a:lnTo>
                    <a:pt x="1187" y="504"/>
                  </a:lnTo>
                  <a:lnTo>
                    <a:pt x="1182" y="504"/>
                  </a:lnTo>
                  <a:lnTo>
                    <a:pt x="1182" y="504"/>
                  </a:lnTo>
                  <a:lnTo>
                    <a:pt x="1178" y="504"/>
                  </a:lnTo>
                  <a:lnTo>
                    <a:pt x="1178" y="504"/>
                  </a:lnTo>
                  <a:lnTo>
                    <a:pt x="1173" y="504"/>
                  </a:lnTo>
                  <a:lnTo>
                    <a:pt x="1173" y="504"/>
                  </a:lnTo>
                  <a:lnTo>
                    <a:pt x="1173" y="504"/>
                  </a:lnTo>
                  <a:lnTo>
                    <a:pt x="1167" y="504"/>
                  </a:lnTo>
                  <a:lnTo>
                    <a:pt x="1167" y="504"/>
                  </a:lnTo>
                  <a:lnTo>
                    <a:pt x="1163" y="504"/>
                  </a:lnTo>
                  <a:lnTo>
                    <a:pt x="1163" y="504"/>
                  </a:lnTo>
                  <a:lnTo>
                    <a:pt x="1158" y="504"/>
                  </a:lnTo>
                  <a:lnTo>
                    <a:pt x="1158" y="504"/>
                  </a:lnTo>
                  <a:lnTo>
                    <a:pt x="1153" y="504"/>
                  </a:lnTo>
                  <a:lnTo>
                    <a:pt x="1153" y="504"/>
                  </a:lnTo>
                  <a:lnTo>
                    <a:pt x="1149" y="504"/>
                  </a:lnTo>
                  <a:lnTo>
                    <a:pt x="1149" y="504"/>
                  </a:lnTo>
                  <a:lnTo>
                    <a:pt x="1143" y="504"/>
                  </a:lnTo>
                  <a:lnTo>
                    <a:pt x="1143" y="504"/>
                  </a:lnTo>
                  <a:lnTo>
                    <a:pt x="1139" y="504"/>
                  </a:lnTo>
                  <a:lnTo>
                    <a:pt x="1139" y="504"/>
                  </a:lnTo>
                  <a:lnTo>
                    <a:pt x="1134" y="504"/>
                  </a:lnTo>
                  <a:lnTo>
                    <a:pt x="1134" y="504"/>
                  </a:lnTo>
                  <a:lnTo>
                    <a:pt x="1129" y="504"/>
                  </a:lnTo>
                  <a:lnTo>
                    <a:pt x="1129" y="504"/>
                  </a:lnTo>
                  <a:lnTo>
                    <a:pt x="1125" y="504"/>
                  </a:lnTo>
                  <a:lnTo>
                    <a:pt x="1125" y="504"/>
                  </a:lnTo>
                  <a:lnTo>
                    <a:pt x="1120" y="504"/>
                  </a:lnTo>
                  <a:lnTo>
                    <a:pt x="1120" y="504"/>
                  </a:lnTo>
                  <a:lnTo>
                    <a:pt x="1114" y="504"/>
                  </a:lnTo>
                  <a:lnTo>
                    <a:pt x="1114" y="504"/>
                  </a:lnTo>
                  <a:lnTo>
                    <a:pt x="1110" y="504"/>
                  </a:lnTo>
                  <a:lnTo>
                    <a:pt x="1110" y="504"/>
                  </a:lnTo>
                  <a:lnTo>
                    <a:pt x="1105" y="504"/>
                  </a:lnTo>
                  <a:lnTo>
                    <a:pt x="1105" y="504"/>
                  </a:lnTo>
                  <a:lnTo>
                    <a:pt x="1105" y="504"/>
                  </a:lnTo>
                  <a:lnTo>
                    <a:pt x="1100" y="504"/>
                  </a:lnTo>
                  <a:lnTo>
                    <a:pt x="1100" y="504"/>
                  </a:lnTo>
                  <a:lnTo>
                    <a:pt x="1096" y="504"/>
                  </a:lnTo>
                  <a:lnTo>
                    <a:pt x="1096" y="504"/>
                  </a:lnTo>
                  <a:lnTo>
                    <a:pt x="1090" y="504"/>
                  </a:lnTo>
                  <a:lnTo>
                    <a:pt x="1090" y="504"/>
                  </a:lnTo>
                  <a:lnTo>
                    <a:pt x="1086" y="504"/>
                  </a:lnTo>
                  <a:lnTo>
                    <a:pt x="1086" y="504"/>
                  </a:lnTo>
                  <a:lnTo>
                    <a:pt x="1081" y="504"/>
                  </a:lnTo>
                  <a:lnTo>
                    <a:pt x="1081" y="504"/>
                  </a:lnTo>
                  <a:lnTo>
                    <a:pt x="1076" y="504"/>
                  </a:lnTo>
                  <a:lnTo>
                    <a:pt x="1076" y="504"/>
                  </a:lnTo>
                  <a:lnTo>
                    <a:pt x="1072" y="504"/>
                  </a:lnTo>
                  <a:lnTo>
                    <a:pt x="1072" y="504"/>
                  </a:lnTo>
                  <a:lnTo>
                    <a:pt x="1066" y="504"/>
                  </a:lnTo>
                  <a:lnTo>
                    <a:pt x="1066" y="504"/>
                  </a:lnTo>
                  <a:lnTo>
                    <a:pt x="1061" y="504"/>
                  </a:lnTo>
                  <a:lnTo>
                    <a:pt x="1061" y="504"/>
                  </a:lnTo>
                  <a:lnTo>
                    <a:pt x="1057" y="504"/>
                  </a:lnTo>
                  <a:lnTo>
                    <a:pt x="1057" y="504"/>
                  </a:lnTo>
                  <a:lnTo>
                    <a:pt x="1052" y="504"/>
                  </a:lnTo>
                  <a:lnTo>
                    <a:pt x="1052" y="504"/>
                  </a:lnTo>
                  <a:lnTo>
                    <a:pt x="1047" y="504"/>
                  </a:lnTo>
                  <a:lnTo>
                    <a:pt x="1047" y="504"/>
                  </a:lnTo>
                  <a:lnTo>
                    <a:pt x="1043" y="504"/>
                  </a:lnTo>
                  <a:lnTo>
                    <a:pt x="1043" y="504"/>
                  </a:lnTo>
                  <a:lnTo>
                    <a:pt x="1037" y="504"/>
                  </a:lnTo>
                  <a:lnTo>
                    <a:pt x="1037" y="504"/>
                  </a:lnTo>
                  <a:lnTo>
                    <a:pt x="1033" y="504"/>
                  </a:lnTo>
                  <a:lnTo>
                    <a:pt x="1033" y="504"/>
                  </a:lnTo>
                  <a:lnTo>
                    <a:pt x="1033" y="504"/>
                  </a:lnTo>
                  <a:lnTo>
                    <a:pt x="1028" y="504"/>
                  </a:lnTo>
                  <a:lnTo>
                    <a:pt x="1028" y="504"/>
                  </a:lnTo>
                  <a:lnTo>
                    <a:pt x="1023" y="504"/>
                  </a:lnTo>
                  <a:lnTo>
                    <a:pt x="1023" y="504"/>
                  </a:lnTo>
                  <a:lnTo>
                    <a:pt x="1019" y="504"/>
                  </a:lnTo>
                  <a:lnTo>
                    <a:pt x="1019" y="504"/>
                  </a:lnTo>
                  <a:lnTo>
                    <a:pt x="1013" y="504"/>
                  </a:lnTo>
                  <a:lnTo>
                    <a:pt x="1013" y="504"/>
                  </a:lnTo>
                  <a:lnTo>
                    <a:pt x="1008" y="504"/>
                  </a:lnTo>
                  <a:lnTo>
                    <a:pt x="1008" y="504"/>
                  </a:lnTo>
                  <a:lnTo>
                    <a:pt x="1004" y="504"/>
                  </a:lnTo>
                  <a:lnTo>
                    <a:pt x="1004" y="504"/>
                  </a:lnTo>
                  <a:lnTo>
                    <a:pt x="999" y="504"/>
                  </a:lnTo>
                  <a:lnTo>
                    <a:pt x="999" y="504"/>
                  </a:lnTo>
                  <a:lnTo>
                    <a:pt x="994" y="504"/>
                  </a:lnTo>
                  <a:lnTo>
                    <a:pt x="994" y="504"/>
                  </a:lnTo>
                  <a:lnTo>
                    <a:pt x="989" y="504"/>
                  </a:lnTo>
                  <a:lnTo>
                    <a:pt x="989" y="504"/>
                  </a:lnTo>
                  <a:lnTo>
                    <a:pt x="984" y="504"/>
                  </a:lnTo>
                  <a:lnTo>
                    <a:pt x="984" y="504"/>
                  </a:lnTo>
                  <a:lnTo>
                    <a:pt x="980" y="504"/>
                  </a:lnTo>
                  <a:lnTo>
                    <a:pt x="980" y="504"/>
                  </a:lnTo>
                  <a:lnTo>
                    <a:pt x="975" y="504"/>
                  </a:lnTo>
                  <a:lnTo>
                    <a:pt x="975" y="504"/>
                  </a:lnTo>
                  <a:lnTo>
                    <a:pt x="970" y="504"/>
                  </a:lnTo>
                  <a:lnTo>
                    <a:pt x="970" y="504"/>
                  </a:lnTo>
                  <a:lnTo>
                    <a:pt x="966" y="504"/>
                  </a:lnTo>
                  <a:lnTo>
                    <a:pt x="966" y="504"/>
                  </a:lnTo>
                  <a:lnTo>
                    <a:pt x="966" y="504"/>
                  </a:lnTo>
                  <a:lnTo>
                    <a:pt x="960" y="504"/>
                  </a:lnTo>
                  <a:lnTo>
                    <a:pt x="960" y="403"/>
                  </a:lnTo>
                  <a:lnTo>
                    <a:pt x="955" y="403"/>
                  </a:lnTo>
                  <a:lnTo>
                    <a:pt x="955" y="403"/>
                  </a:lnTo>
                  <a:lnTo>
                    <a:pt x="951" y="403"/>
                  </a:lnTo>
                  <a:lnTo>
                    <a:pt x="951" y="403"/>
                  </a:lnTo>
                  <a:lnTo>
                    <a:pt x="946" y="403"/>
                  </a:lnTo>
                  <a:lnTo>
                    <a:pt x="946" y="403"/>
                  </a:lnTo>
                  <a:lnTo>
                    <a:pt x="941" y="403"/>
                  </a:lnTo>
                  <a:lnTo>
                    <a:pt x="941" y="403"/>
                  </a:lnTo>
                  <a:lnTo>
                    <a:pt x="936" y="403"/>
                  </a:lnTo>
                  <a:lnTo>
                    <a:pt x="936" y="403"/>
                  </a:lnTo>
                  <a:lnTo>
                    <a:pt x="931" y="403"/>
                  </a:lnTo>
                  <a:lnTo>
                    <a:pt x="931" y="403"/>
                  </a:lnTo>
                  <a:lnTo>
                    <a:pt x="926" y="403"/>
                  </a:lnTo>
                  <a:lnTo>
                    <a:pt x="926" y="403"/>
                  </a:lnTo>
                  <a:lnTo>
                    <a:pt x="922" y="403"/>
                  </a:lnTo>
                  <a:lnTo>
                    <a:pt x="922" y="403"/>
                  </a:lnTo>
                  <a:lnTo>
                    <a:pt x="917" y="403"/>
                  </a:lnTo>
                  <a:lnTo>
                    <a:pt x="917" y="504"/>
                  </a:lnTo>
                  <a:lnTo>
                    <a:pt x="912" y="504"/>
                  </a:lnTo>
                  <a:lnTo>
                    <a:pt x="912" y="504"/>
                  </a:lnTo>
                  <a:lnTo>
                    <a:pt x="907" y="504"/>
                  </a:lnTo>
                  <a:lnTo>
                    <a:pt x="907" y="504"/>
                  </a:lnTo>
                  <a:lnTo>
                    <a:pt x="902" y="504"/>
                  </a:lnTo>
                  <a:lnTo>
                    <a:pt x="902" y="504"/>
                  </a:lnTo>
                  <a:lnTo>
                    <a:pt x="898" y="504"/>
                  </a:lnTo>
                  <a:lnTo>
                    <a:pt x="898" y="504"/>
                  </a:lnTo>
                  <a:lnTo>
                    <a:pt x="898" y="504"/>
                  </a:lnTo>
                  <a:lnTo>
                    <a:pt x="893" y="504"/>
                  </a:lnTo>
                  <a:lnTo>
                    <a:pt x="893" y="504"/>
                  </a:lnTo>
                  <a:lnTo>
                    <a:pt x="888" y="504"/>
                  </a:lnTo>
                  <a:lnTo>
                    <a:pt x="888" y="504"/>
                  </a:lnTo>
                  <a:lnTo>
                    <a:pt x="883" y="504"/>
                  </a:lnTo>
                  <a:lnTo>
                    <a:pt x="883" y="504"/>
                  </a:lnTo>
                  <a:lnTo>
                    <a:pt x="878" y="504"/>
                  </a:lnTo>
                  <a:lnTo>
                    <a:pt x="878" y="504"/>
                  </a:lnTo>
                  <a:lnTo>
                    <a:pt x="873" y="504"/>
                  </a:lnTo>
                  <a:lnTo>
                    <a:pt x="873" y="504"/>
                  </a:lnTo>
                  <a:lnTo>
                    <a:pt x="869" y="504"/>
                  </a:lnTo>
                  <a:lnTo>
                    <a:pt x="869" y="504"/>
                  </a:lnTo>
                  <a:lnTo>
                    <a:pt x="864" y="504"/>
                  </a:lnTo>
                  <a:lnTo>
                    <a:pt x="864" y="504"/>
                  </a:lnTo>
                  <a:lnTo>
                    <a:pt x="859" y="504"/>
                  </a:lnTo>
                  <a:lnTo>
                    <a:pt x="859" y="504"/>
                  </a:lnTo>
                  <a:lnTo>
                    <a:pt x="854" y="504"/>
                  </a:lnTo>
                  <a:lnTo>
                    <a:pt x="854" y="504"/>
                  </a:lnTo>
                  <a:lnTo>
                    <a:pt x="849" y="504"/>
                  </a:lnTo>
                  <a:lnTo>
                    <a:pt x="849" y="504"/>
                  </a:lnTo>
                  <a:lnTo>
                    <a:pt x="845" y="504"/>
                  </a:lnTo>
                  <a:lnTo>
                    <a:pt x="845" y="504"/>
                  </a:lnTo>
                  <a:lnTo>
                    <a:pt x="840" y="504"/>
                  </a:lnTo>
                  <a:lnTo>
                    <a:pt x="840" y="504"/>
                  </a:lnTo>
                  <a:lnTo>
                    <a:pt x="834" y="504"/>
                  </a:lnTo>
                  <a:lnTo>
                    <a:pt x="834" y="504"/>
                  </a:lnTo>
                  <a:lnTo>
                    <a:pt x="830" y="504"/>
                  </a:lnTo>
                  <a:lnTo>
                    <a:pt x="830" y="504"/>
                  </a:lnTo>
                  <a:lnTo>
                    <a:pt x="825" y="504"/>
                  </a:lnTo>
                  <a:lnTo>
                    <a:pt x="825" y="504"/>
                  </a:lnTo>
                  <a:lnTo>
                    <a:pt x="825" y="504"/>
                  </a:lnTo>
                  <a:lnTo>
                    <a:pt x="820" y="504"/>
                  </a:lnTo>
                  <a:lnTo>
                    <a:pt x="820" y="504"/>
                  </a:lnTo>
                  <a:lnTo>
                    <a:pt x="816" y="504"/>
                  </a:lnTo>
                  <a:lnTo>
                    <a:pt x="816" y="504"/>
                  </a:lnTo>
                  <a:lnTo>
                    <a:pt x="811" y="504"/>
                  </a:lnTo>
                  <a:lnTo>
                    <a:pt x="811" y="504"/>
                  </a:lnTo>
                  <a:lnTo>
                    <a:pt x="806" y="504"/>
                  </a:lnTo>
                  <a:lnTo>
                    <a:pt x="806" y="504"/>
                  </a:lnTo>
                  <a:lnTo>
                    <a:pt x="801" y="504"/>
                  </a:lnTo>
                  <a:lnTo>
                    <a:pt x="801" y="504"/>
                  </a:lnTo>
                  <a:lnTo>
                    <a:pt x="796" y="504"/>
                  </a:lnTo>
                  <a:lnTo>
                    <a:pt x="796" y="504"/>
                  </a:lnTo>
                  <a:lnTo>
                    <a:pt x="792" y="504"/>
                  </a:lnTo>
                  <a:lnTo>
                    <a:pt x="792" y="504"/>
                  </a:lnTo>
                  <a:lnTo>
                    <a:pt x="787" y="504"/>
                  </a:lnTo>
                  <a:lnTo>
                    <a:pt x="787" y="504"/>
                  </a:lnTo>
                  <a:lnTo>
                    <a:pt x="781" y="504"/>
                  </a:lnTo>
                  <a:lnTo>
                    <a:pt x="781" y="504"/>
                  </a:lnTo>
                  <a:lnTo>
                    <a:pt x="777" y="504"/>
                  </a:lnTo>
                  <a:lnTo>
                    <a:pt x="777" y="504"/>
                  </a:lnTo>
                  <a:lnTo>
                    <a:pt x="772" y="504"/>
                  </a:lnTo>
                  <a:lnTo>
                    <a:pt x="772" y="504"/>
                  </a:lnTo>
                  <a:lnTo>
                    <a:pt x="767" y="504"/>
                  </a:lnTo>
                  <a:lnTo>
                    <a:pt x="767" y="504"/>
                  </a:lnTo>
                  <a:lnTo>
                    <a:pt x="763" y="504"/>
                  </a:lnTo>
                  <a:lnTo>
                    <a:pt x="763" y="504"/>
                  </a:lnTo>
                  <a:lnTo>
                    <a:pt x="757" y="504"/>
                  </a:lnTo>
                  <a:lnTo>
                    <a:pt x="757" y="504"/>
                  </a:lnTo>
                  <a:lnTo>
                    <a:pt x="757" y="504"/>
                  </a:lnTo>
                  <a:lnTo>
                    <a:pt x="753" y="504"/>
                  </a:lnTo>
                  <a:lnTo>
                    <a:pt x="753" y="504"/>
                  </a:lnTo>
                  <a:lnTo>
                    <a:pt x="748" y="504"/>
                  </a:lnTo>
                  <a:lnTo>
                    <a:pt x="748" y="504"/>
                  </a:lnTo>
                  <a:lnTo>
                    <a:pt x="743" y="504"/>
                  </a:lnTo>
                  <a:lnTo>
                    <a:pt x="743" y="504"/>
                  </a:lnTo>
                  <a:lnTo>
                    <a:pt x="739" y="504"/>
                  </a:lnTo>
                  <a:lnTo>
                    <a:pt x="739" y="504"/>
                  </a:lnTo>
                  <a:lnTo>
                    <a:pt x="734" y="504"/>
                  </a:lnTo>
                  <a:lnTo>
                    <a:pt x="734" y="504"/>
                  </a:lnTo>
                  <a:lnTo>
                    <a:pt x="728" y="504"/>
                  </a:lnTo>
                  <a:lnTo>
                    <a:pt x="728" y="504"/>
                  </a:lnTo>
                  <a:lnTo>
                    <a:pt x="724" y="504"/>
                  </a:lnTo>
                  <a:lnTo>
                    <a:pt x="724" y="504"/>
                  </a:lnTo>
                  <a:lnTo>
                    <a:pt x="719" y="504"/>
                  </a:lnTo>
                  <a:lnTo>
                    <a:pt x="719" y="504"/>
                  </a:lnTo>
                  <a:lnTo>
                    <a:pt x="714" y="504"/>
                  </a:lnTo>
                  <a:lnTo>
                    <a:pt x="714" y="504"/>
                  </a:lnTo>
                  <a:lnTo>
                    <a:pt x="710" y="504"/>
                  </a:lnTo>
                  <a:lnTo>
                    <a:pt x="710" y="504"/>
                  </a:lnTo>
                  <a:lnTo>
                    <a:pt x="704" y="504"/>
                  </a:lnTo>
                  <a:lnTo>
                    <a:pt x="704" y="504"/>
                  </a:lnTo>
                  <a:lnTo>
                    <a:pt x="700" y="504"/>
                  </a:lnTo>
                  <a:lnTo>
                    <a:pt x="700" y="504"/>
                  </a:lnTo>
                  <a:lnTo>
                    <a:pt x="695" y="504"/>
                  </a:lnTo>
                  <a:lnTo>
                    <a:pt x="695" y="504"/>
                  </a:lnTo>
                  <a:lnTo>
                    <a:pt x="690" y="504"/>
                  </a:lnTo>
                  <a:lnTo>
                    <a:pt x="690" y="504"/>
                  </a:lnTo>
                  <a:lnTo>
                    <a:pt x="690" y="504"/>
                  </a:lnTo>
                  <a:lnTo>
                    <a:pt x="686" y="504"/>
                  </a:lnTo>
                  <a:lnTo>
                    <a:pt x="686" y="504"/>
                  </a:lnTo>
                  <a:lnTo>
                    <a:pt x="680" y="504"/>
                  </a:lnTo>
                  <a:lnTo>
                    <a:pt x="680" y="504"/>
                  </a:lnTo>
                  <a:lnTo>
                    <a:pt x="675" y="504"/>
                  </a:lnTo>
                  <a:lnTo>
                    <a:pt x="675" y="504"/>
                  </a:lnTo>
                  <a:lnTo>
                    <a:pt x="671" y="504"/>
                  </a:lnTo>
                  <a:lnTo>
                    <a:pt x="671" y="504"/>
                  </a:lnTo>
                  <a:lnTo>
                    <a:pt x="666" y="504"/>
                  </a:lnTo>
                  <a:lnTo>
                    <a:pt x="666" y="504"/>
                  </a:lnTo>
                  <a:lnTo>
                    <a:pt x="661" y="504"/>
                  </a:lnTo>
                  <a:lnTo>
                    <a:pt x="661" y="504"/>
                  </a:lnTo>
                  <a:lnTo>
                    <a:pt x="657" y="504"/>
                  </a:lnTo>
                  <a:lnTo>
                    <a:pt x="657" y="504"/>
                  </a:lnTo>
                  <a:lnTo>
                    <a:pt x="651" y="504"/>
                  </a:lnTo>
                  <a:lnTo>
                    <a:pt x="651" y="504"/>
                  </a:lnTo>
                  <a:lnTo>
                    <a:pt x="646" y="504"/>
                  </a:lnTo>
                  <a:lnTo>
                    <a:pt x="646" y="504"/>
                  </a:lnTo>
                  <a:lnTo>
                    <a:pt x="642" y="504"/>
                  </a:lnTo>
                  <a:lnTo>
                    <a:pt x="642" y="504"/>
                  </a:lnTo>
                  <a:lnTo>
                    <a:pt x="637" y="504"/>
                  </a:lnTo>
                  <a:lnTo>
                    <a:pt x="637" y="504"/>
                  </a:lnTo>
                  <a:lnTo>
                    <a:pt x="633" y="504"/>
                  </a:lnTo>
                  <a:lnTo>
                    <a:pt x="633" y="504"/>
                  </a:lnTo>
                  <a:lnTo>
                    <a:pt x="627" y="504"/>
                  </a:lnTo>
                  <a:lnTo>
                    <a:pt x="627" y="504"/>
                  </a:lnTo>
                  <a:lnTo>
                    <a:pt x="622" y="504"/>
                  </a:lnTo>
                  <a:lnTo>
                    <a:pt x="622" y="504"/>
                  </a:lnTo>
                  <a:lnTo>
                    <a:pt x="622" y="504"/>
                  </a:lnTo>
                  <a:lnTo>
                    <a:pt x="618" y="504"/>
                  </a:lnTo>
                  <a:lnTo>
                    <a:pt x="618" y="504"/>
                  </a:lnTo>
                  <a:lnTo>
                    <a:pt x="613" y="504"/>
                  </a:lnTo>
                  <a:lnTo>
                    <a:pt x="613" y="504"/>
                  </a:lnTo>
                  <a:lnTo>
                    <a:pt x="608" y="504"/>
                  </a:lnTo>
                  <a:lnTo>
                    <a:pt x="608" y="504"/>
                  </a:lnTo>
                  <a:lnTo>
                    <a:pt x="603" y="504"/>
                  </a:lnTo>
                  <a:lnTo>
                    <a:pt x="603" y="504"/>
                  </a:lnTo>
                  <a:lnTo>
                    <a:pt x="598" y="504"/>
                  </a:lnTo>
                  <a:lnTo>
                    <a:pt x="598" y="504"/>
                  </a:lnTo>
                  <a:lnTo>
                    <a:pt x="593" y="504"/>
                  </a:lnTo>
                  <a:lnTo>
                    <a:pt x="593" y="504"/>
                  </a:lnTo>
                  <a:lnTo>
                    <a:pt x="589" y="504"/>
                  </a:lnTo>
                  <a:lnTo>
                    <a:pt x="589" y="504"/>
                  </a:lnTo>
                  <a:lnTo>
                    <a:pt x="584" y="504"/>
                  </a:lnTo>
                  <a:lnTo>
                    <a:pt x="584" y="504"/>
                  </a:lnTo>
                  <a:lnTo>
                    <a:pt x="580" y="504"/>
                  </a:lnTo>
                  <a:lnTo>
                    <a:pt x="580" y="504"/>
                  </a:lnTo>
                  <a:lnTo>
                    <a:pt x="574" y="504"/>
                  </a:lnTo>
                  <a:lnTo>
                    <a:pt x="574" y="504"/>
                  </a:lnTo>
                  <a:lnTo>
                    <a:pt x="569" y="504"/>
                  </a:lnTo>
                  <a:lnTo>
                    <a:pt x="569" y="504"/>
                  </a:lnTo>
                  <a:lnTo>
                    <a:pt x="565" y="504"/>
                  </a:lnTo>
                  <a:lnTo>
                    <a:pt x="565" y="504"/>
                  </a:lnTo>
                  <a:lnTo>
                    <a:pt x="560" y="504"/>
                  </a:lnTo>
                  <a:lnTo>
                    <a:pt x="560" y="504"/>
                  </a:lnTo>
                  <a:lnTo>
                    <a:pt x="555" y="504"/>
                  </a:lnTo>
                  <a:lnTo>
                    <a:pt x="555" y="504"/>
                  </a:lnTo>
                  <a:lnTo>
                    <a:pt x="550" y="504"/>
                  </a:lnTo>
                  <a:lnTo>
                    <a:pt x="550" y="504"/>
                  </a:lnTo>
                  <a:lnTo>
                    <a:pt x="550" y="504"/>
                  </a:lnTo>
                  <a:lnTo>
                    <a:pt x="545" y="504"/>
                  </a:lnTo>
                  <a:lnTo>
                    <a:pt x="545" y="504"/>
                  </a:lnTo>
                  <a:lnTo>
                    <a:pt x="540" y="504"/>
                  </a:lnTo>
                  <a:lnTo>
                    <a:pt x="540" y="504"/>
                  </a:lnTo>
                  <a:lnTo>
                    <a:pt x="536" y="504"/>
                  </a:lnTo>
                  <a:lnTo>
                    <a:pt x="536" y="504"/>
                  </a:lnTo>
                  <a:lnTo>
                    <a:pt x="531" y="504"/>
                  </a:lnTo>
                  <a:lnTo>
                    <a:pt x="531" y="504"/>
                  </a:lnTo>
                  <a:lnTo>
                    <a:pt x="526" y="504"/>
                  </a:lnTo>
                  <a:lnTo>
                    <a:pt x="526" y="504"/>
                  </a:lnTo>
                  <a:lnTo>
                    <a:pt x="521" y="504"/>
                  </a:lnTo>
                  <a:lnTo>
                    <a:pt x="521" y="504"/>
                  </a:lnTo>
                  <a:lnTo>
                    <a:pt x="516" y="504"/>
                  </a:lnTo>
                  <a:lnTo>
                    <a:pt x="516" y="504"/>
                  </a:lnTo>
                  <a:lnTo>
                    <a:pt x="512" y="504"/>
                  </a:lnTo>
                  <a:lnTo>
                    <a:pt x="512" y="504"/>
                  </a:lnTo>
                  <a:lnTo>
                    <a:pt x="507" y="504"/>
                  </a:lnTo>
                  <a:lnTo>
                    <a:pt x="507" y="504"/>
                  </a:lnTo>
                  <a:lnTo>
                    <a:pt x="502" y="504"/>
                  </a:lnTo>
                  <a:lnTo>
                    <a:pt x="502" y="504"/>
                  </a:lnTo>
                  <a:lnTo>
                    <a:pt x="497" y="504"/>
                  </a:lnTo>
                  <a:lnTo>
                    <a:pt x="497" y="504"/>
                  </a:lnTo>
                  <a:lnTo>
                    <a:pt x="492" y="504"/>
                  </a:lnTo>
                  <a:lnTo>
                    <a:pt x="492" y="504"/>
                  </a:lnTo>
                  <a:lnTo>
                    <a:pt x="487" y="504"/>
                  </a:lnTo>
                  <a:lnTo>
                    <a:pt x="487" y="504"/>
                  </a:lnTo>
                  <a:lnTo>
                    <a:pt x="483" y="504"/>
                  </a:lnTo>
                  <a:lnTo>
                    <a:pt x="483" y="504"/>
                  </a:lnTo>
                  <a:lnTo>
                    <a:pt x="483" y="504"/>
                  </a:lnTo>
                  <a:lnTo>
                    <a:pt x="478" y="504"/>
                  </a:lnTo>
                  <a:lnTo>
                    <a:pt x="478" y="504"/>
                  </a:lnTo>
                  <a:lnTo>
                    <a:pt x="473" y="504"/>
                  </a:lnTo>
                  <a:lnTo>
                    <a:pt x="473" y="504"/>
                  </a:lnTo>
                  <a:lnTo>
                    <a:pt x="468" y="504"/>
                  </a:lnTo>
                  <a:lnTo>
                    <a:pt x="468" y="504"/>
                  </a:lnTo>
                  <a:lnTo>
                    <a:pt x="463" y="504"/>
                  </a:lnTo>
                  <a:lnTo>
                    <a:pt x="463" y="504"/>
                  </a:lnTo>
                  <a:lnTo>
                    <a:pt x="459" y="504"/>
                  </a:lnTo>
                  <a:lnTo>
                    <a:pt x="459" y="504"/>
                  </a:lnTo>
                  <a:lnTo>
                    <a:pt x="454" y="504"/>
                  </a:lnTo>
                  <a:lnTo>
                    <a:pt x="454" y="504"/>
                  </a:lnTo>
                  <a:lnTo>
                    <a:pt x="448" y="504"/>
                  </a:lnTo>
                  <a:lnTo>
                    <a:pt x="448" y="504"/>
                  </a:lnTo>
                  <a:lnTo>
                    <a:pt x="444" y="504"/>
                  </a:lnTo>
                  <a:lnTo>
                    <a:pt x="444" y="504"/>
                  </a:lnTo>
                  <a:lnTo>
                    <a:pt x="439" y="504"/>
                  </a:lnTo>
                  <a:lnTo>
                    <a:pt x="439" y="504"/>
                  </a:lnTo>
                  <a:lnTo>
                    <a:pt x="434" y="504"/>
                  </a:lnTo>
                  <a:lnTo>
                    <a:pt x="434" y="504"/>
                  </a:lnTo>
                  <a:lnTo>
                    <a:pt x="430" y="504"/>
                  </a:lnTo>
                  <a:lnTo>
                    <a:pt x="430" y="504"/>
                  </a:lnTo>
                  <a:lnTo>
                    <a:pt x="425" y="504"/>
                  </a:lnTo>
                  <a:lnTo>
                    <a:pt x="425" y="504"/>
                  </a:lnTo>
                  <a:lnTo>
                    <a:pt x="420" y="504"/>
                  </a:lnTo>
                  <a:lnTo>
                    <a:pt x="420" y="504"/>
                  </a:lnTo>
                  <a:lnTo>
                    <a:pt x="415" y="504"/>
                  </a:lnTo>
                  <a:lnTo>
                    <a:pt x="415" y="504"/>
                  </a:lnTo>
                  <a:lnTo>
                    <a:pt x="415" y="504"/>
                  </a:lnTo>
                  <a:lnTo>
                    <a:pt x="410" y="504"/>
                  </a:lnTo>
                  <a:lnTo>
                    <a:pt x="410" y="504"/>
                  </a:lnTo>
                  <a:lnTo>
                    <a:pt x="406" y="504"/>
                  </a:lnTo>
                  <a:lnTo>
                    <a:pt x="406" y="504"/>
                  </a:lnTo>
                  <a:lnTo>
                    <a:pt x="401" y="504"/>
                  </a:lnTo>
                  <a:lnTo>
                    <a:pt x="401" y="504"/>
                  </a:lnTo>
                  <a:lnTo>
                    <a:pt x="395" y="504"/>
                  </a:lnTo>
                  <a:lnTo>
                    <a:pt x="395" y="504"/>
                  </a:lnTo>
                  <a:lnTo>
                    <a:pt x="391" y="504"/>
                  </a:lnTo>
                  <a:lnTo>
                    <a:pt x="391" y="504"/>
                  </a:lnTo>
                  <a:lnTo>
                    <a:pt x="386" y="504"/>
                  </a:lnTo>
                  <a:lnTo>
                    <a:pt x="386" y="504"/>
                  </a:lnTo>
                  <a:lnTo>
                    <a:pt x="381" y="504"/>
                  </a:lnTo>
                  <a:lnTo>
                    <a:pt x="381" y="504"/>
                  </a:lnTo>
                  <a:lnTo>
                    <a:pt x="377" y="504"/>
                  </a:lnTo>
                  <a:lnTo>
                    <a:pt x="377" y="504"/>
                  </a:lnTo>
                  <a:lnTo>
                    <a:pt x="371" y="504"/>
                  </a:lnTo>
                  <a:lnTo>
                    <a:pt x="371" y="504"/>
                  </a:lnTo>
                  <a:lnTo>
                    <a:pt x="366" y="504"/>
                  </a:lnTo>
                  <a:lnTo>
                    <a:pt x="366" y="504"/>
                  </a:lnTo>
                  <a:lnTo>
                    <a:pt x="362" y="504"/>
                  </a:lnTo>
                  <a:lnTo>
                    <a:pt x="362" y="504"/>
                  </a:lnTo>
                  <a:lnTo>
                    <a:pt x="357" y="504"/>
                  </a:lnTo>
                  <a:lnTo>
                    <a:pt x="357" y="504"/>
                  </a:lnTo>
                  <a:lnTo>
                    <a:pt x="353" y="504"/>
                  </a:lnTo>
                  <a:lnTo>
                    <a:pt x="353" y="504"/>
                  </a:lnTo>
                  <a:lnTo>
                    <a:pt x="348" y="504"/>
                  </a:lnTo>
                  <a:lnTo>
                    <a:pt x="348" y="504"/>
                  </a:lnTo>
                  <a:lnTo>
                    <a:pt x="342" y="504"/>
                  </a:lnTo>
                  <a:lnTo>
                    <a:pt x="342" y="504"/>
                  </a:lnTo>
                  <a:lnTo>
                    <a:pt x="342" y="504"/>
                  </a:lnTo>
                  <a:lnTo>
                    <a:pt x="338" y="504"/>
                  </a:lnTo>
                  <a:lnTo>
                    <a:pt x="338" y="504"/>
                  </a:lnTo>
                  <a:lnTo>
                    <a:pt x="333" y="504"/>
                  </a:lnTo>
                  <a:lnTo>
                    <a:pt x="333" y="504"/>
                  </a:lnTo>
                  <a:lnTo>
                    <a:pt x="328" y="504"/>
                  </a:lnTo>
                  <a:lnTo>
                    <a:pt x="328" y="504"/>
                  </a:lnTo>
                  <a:lnTo>
                    <a:pt x="324" y="504"/>
                  </a:lnTo>
                  <a:lnTo>
                    <a:pt x="324" y="504"/>
                  </a:lnTo>
                  <a:lnTo>
                    <a:pt x="318" y="504"/>
                  </a:lnTo>
                  <a:lnTo>
                    <a:pt x="318" y="504"/>
                  </a:lnTo>
                  <a:lnTo>
                    <a:pt x="313" y="504"/>
                  </a:lnTo>
                  <a:lnTo>
                    <a:pt x="313" y="504"/>
                  </a:lnTo>
                  <a:lnTo>
                    <a:pt x="309" y="504"/>
                  </a:lnTo>
                  <a:lnTo>
                    <a:pt x="309" y="504"/>
                  </a:lnTo>
                  <a:lnTo>
                    <a:pt x="304" y="504"/>
                  </a:lnTo>
                  <a:lnTo>
                    <a:pt x="304" y="504"/>
                  </a:lnTo>
                  <a:lnTo>
                    <a:pt x="300" y="504"/>
                  </a:lnTo>
                  <a:lnTo>
                    <a:pt x="300" y="504"/>
                  </a:lnTo>
                  <a:lnTo>
                    <a:pt x="294" y="504"/>
                  </a:lnTo>
                  <a:lnTo>
                    <a:pt x="294" y="504"/>
                  </a:lnTo>
                  <a:lnTo>
                    <a:pt x="289" y="504"/>
                  </a:lnTo>
                  <a:lnTo>
                    <a:pt x="289" y="504"/>
                  </a:lnTo>
                  <a:lnTo>
                    <a:pt x="285" y="504"/>
                  </a:lnTo>
                  <a:lnTo>
                    <a:pt x="285" y="504"/>
                  </a:lnTo>
                  <a:lnTo>
                    <a:pt x="280" y="504"/>
                  </a:lnTo>
                  <a:lnTo>
                    <a:pt x="280" y="504"/>
                  </a:lnTo>
                  <a:lnTo>
                    <a:pt x="275" y="504"/>
                  </a:lnTo>
                  <a:lnTo>
                    <a:pt x="275" y="504"/>
                  </a:lnTo>
                  <a:lnTo>
                    <a:pt x="275" y="504"/>
                  </a:lnTo>
                  <a:lnTo>
                    <a:pt x="271" y="504"/>
                  </a:lnTo>
                  <a:lnTo>
                    <a:pt x="271" y="504"/>
                  </a:lnTo>
                  <a:lnTo>
                    <a:pt x="265" y="504"/>
                  </a:lnTo>
                  <a:lnTo>
                    <a:pt x="265" y="504"/>
                  </a:lnTo>
                  <a:lnTo>
                    <a:pt x="260" y="504"/>
                  </a:lnTo>
                  <a:lnTo>
                    <a:pt x="260" y="504"/>
                  </a:lnTo>
                  <a:lnTo>
                    <a:pt x="256" y="504"/>
                  </a:lnTo>
                  <a:lnTo>
                    <a:pt x="256" y="504"/>
                  </a:lnTo>
                  <a:lnTo>
                    <a:pt x="251" y="504"/>
                  </a:lnTo>
                  <a:lnTo>
                    <a:pt x="251" y="504"/>
                  </a:lnTo>
                  <a:lnTo>
                    <a:pt x="247" y="504"/>
                  </a:lnTo>
                  <a:lnTo>
                    <a:pt x="247" y="504"/>
                  </a:lnTo>
                  <a:lnTo>
                    <a:pt x="241" y="504"/>
                  </a:lnTo>
                  <a:lnTo>
                    <a:pt x="241" y="504"/>
                  </a:lnTo>
                  <a:lnTo>
                    <a:pt x="236" y="504"/>
                  </a:lnTo>
                  <a:lnTo>
                    <a:pt x="236" y="504"/>
                  </a:lnTo>
                  <a:lnTo>
                    <a:pt x="232" y="504"/>
                  </a:lnTo>
                  <a:lnTo>
                    <a:pt x="232" y="504"/>
                  </a:lnTo>
                  <a:lnTo>
                    <a:pt x="227" y="504"/>
                  </a:lnTo>
                  <a:lnTo>
                    <a:pt x="227" y="504"/>
                  </a:lnTo>
                  <a:lnTo>
                    <a:pt x="222" y="504"/>
                  </a:lnTo>
                  <a:lnTo>
                    <a:pt x="222" y="504"/>
                  </a:lnTo>
                  <a:lnTo>
                    <a:pt x="217" y="504"/>
                  </a:lnTo>
                  <a:lnTo>
                    <a:pt x="217" y="504"/>
                  </a:lnTo>
                  <a:lnTo>
                    <a:pt x="212" y="504"/>
                  </a:lnTo>
                  <a:lnTo>
                    <a:pt x="212" y="504"/>
                  </a:lnTo>
                  <a:lnTo>
                    <a:pt x="207" y="504"/>
                  </a:lnTo>
                  <a:lnTo>
                    <a:pt x="207" y="504"/>
                  </a:lnTo>
                  <a:lnTo>
                    <a:pt x="207" y="504"/>
                  </a:lnTo>
                  <a:lnTo>
                    <a:pt x="203" y="504"/>
                  </a:lnTo>
                  <a:lnTo>
                    <a:pt x="203" y="504"/>
                  </a:lnTo>
                  <a:lnTo>
                    <a:pt x="198" y="504"/>
                  </a:lnTo>
                  <a:lnTo>
                    <a:pt x="198" y="504"/>
                  </a:lnTo>
                  <a:lnTo>
                    <a:pt x="194" y="504"/>
                  </a:lnTo>
                  <a:lnTo>
                    <a:pt x="194" y="504"/>
                  </a:lnTo>
                  <a:lnTo>
                    <a:pt x="188" y="504"/>
                  </a:lnTo>
                  <a:lnTo>
                    <a:pt x="188" y="504"/>
                  </a:lnTo>
                  <a:lnTo>
                    <a:pt x="183" y="504"/>
                  </a:lnTo>
                  <a:lnTo>
                    <a:pt x="183" y="504"/>
                  </a:lnTo>
                  <a:lnTo>
                    <a:pt x="179" y="504"/>
                  </a:lnTo>
                  <a:lnTo>
                    <a:pt x="179" y="504"/>
                  </a:lnTo>
                  <a:lnTo>
                    <a:pt x="174" y="504"/>
                  </a:lnTo>
                  <a:lnTo>
                    <a:pt x="174" y="504"/>
                  </a:lnTo>
                  <a:lnTo>
                    <a:pt x="169" y="504"/>
                  </a:lnTo>
                  <a:lnTo>
                    <a:pt x="169" y="504"/>
                  </a:lnTo>
                  <a:lnTo>
                    <a:pt x="164" y="504"/>
                  </a:lnTo>
                  <a:lnTo>
                    <a:pt x="164" y="504"/>
                  </a:lnTo>
                  <a:lnTo>
                    <a:pt x="159" y="504"/>
                  </a:lnTo>
                  <a:lnTo>
                    <a:pt x="159" y="504"/>
                  </a:lnTo>
                  <a:lnTo>
                    <a:pt x="154" y="504"/>
                  </a:lnTo>
                  <a:lnTo>
                    <a:pt x="154" y="504"/>
                  </a:lnTo>
                  <a:lnTo>
                    <a:pt x="150" y="504"/>
                  </a:lnTo>
                  <a:lnTo>
                    <a:pt x="150" y="504"/>
                  </a:lnTo>
                  <a:lnTo>
                    <a:pt x="145" y="504"/>
                  </a:lnTo>
                  <a:lnTo>
                    <a:pt x="145" y="504"/>
                  </a:lnTo>
                  <a:lnTo>
                    <a:pt x="140" y="504"/>
                  </a:lnTo>
                  <a:lnTo>
                    <a:pt x="140" y="504"/>
                  </a:lnTo>
                  <a:lnTo>
                    <a:pt x="140" y="504"/>
                  </a:lnTo>
                  <a:lnTo>
                    <a:pt x="135" y="504"/>
                  </a:lnTo>
                  <a:lnTo>
                    <a:pt x="135" y="504"/>
                  </a:lnTo>
                  <a:lnTo>
                    <a:pt x="130" y="504"/>
                  </a:lnTo>
                  <a:lnTo>
                    <a:pt x="130" y="504"/>
                  </a:lnTo>
                  <a:lnTo>
                    <a:pt x="126" y="504"/>
                  </a:lnTo>
                  <a:lnTo>
                    <a:pt x="126" y="504"/>
                  </a:lnTo>
                  <a:lnTo>
                    <a:pt x="121" y="504"/>
                  </a:lnTo>
                  <a:lnTo>
                    <a:pt x="121" y="504"/>
                  </a:lnTo>
                  <a:lnTo>
                    <a:pt x="115" y="504"/>
                  </a:lnTo>
                  <a:lnTo>
                    <a:pt x="115" y="504"/>
                  </a:lnTo>
                  <a:lnTo>
                    <a:pt x="111" y="504"/>
                  </a:lnTo>
                  <a:lnTo>
                    <a:pt x="111" y="504"/>
                  </a:lnTo>
                  <a:lnTo>
                    <a:pt x="106" y="504"/>
                  </a:lnTo>
                  <a:lnTo>
                    <a:pt x="106" y="504"/>
                  </a:lnTo>
                  <a:lnTo>
                    <a:pt x="101" y="504"/>
                  </a:lnTo>
                  <a:lnTo>
                    <a:pt x="101" y="504"/>
                  </a:lnTo>
                  <a:lnTo>
                    <a:pt x="97" y="504"/>
                  </a:lnTo>
                  <a:lnTo>
                    <a:pt x="97" y="504"/>
                  </a:lnTo>
                  <a:lnTo>
                    <a:pt x="92" y="504"/>
                  </a:lnTo>
                  <a:lnTo>
                    <a:pt x="92" y="504"/>
                  </a:lnTo>
                  <a:lnTo>
                    <a:pt x="86" y="504"/>
                  </a:lnTo>
                  <a:lnTo>
                    <a:pt x="86" y="504"/>
                  </a:lnTo>
                  <a:lnTo>
                    <a:pt x="82" y="504"/>
                  </a:lnTo>
                  <a:lnTo>
                    <a:pt x="82" y="504"/>
                  </a:lnTo>
                  <a:lnTo>
                    <a:pt x="77" y="504"/>
                  </a:lnTo>
                  <a:lnTo>
                    <a:pt x="77" y="504"/>
                  </a:lnTo>
                  <a:lnTo>
                    <a:pt x="73" y="504"/>
                  </a:lnTo>
                  <a:lnTo>
                    <a:pt x="73" y="504"/>
                  </a:lnTo>
                  <a:lnTo>
                    <a:pt x="68" y="504"/>
                  </a:lnTo>
                  <a:lnTo>
                    <a:pt x="68" y="504"/>
                  </a:lnTo>
                  <a:lnTo>
                    <a:pt x="68" y="504"/>
                  </a:lnTo>
                  <a:lnTo>
                    <a:pt x="62" y="504"/>
                  </a:lnTo>
                  <a:lnTo>
                    <a:pt x="62" y="504"/>
                  </a:lnTo>
                  <a:lnTo>
                    <a:pt x="58" y="504"/>
                  </a:lnTo>
                  <a:lnTo>
                    <a:pt x="58" y="504"/>
                  </a:lnTo>
                  <a:lnTo>
                    <a:pt x="53" y="504"/>
                  </a:lnTo>
                  <a:lnTo>
                    <a:pt x="53" y="504"/>
                  </a:lnTo>
                  <a:lnTo>
                    <a:pt x="48" y="504"/>
                  </a:lnTo>
                  <a:lnTo>
                    <a:pt x="48" y="504"/>
                  </a:lnTo>
                  <a:lnTo>
                    <a:pt x="44" y="504"/>
                  </a:lnTo>
                  <a:lnTo>
                    <a:pt x="44" y="504"/>
                  </a:lnTo>
                  <a:lnTo>
                    <a:pt x="38" y="504"/>
                  </a:lnTo>
                  <a:lnTo>
                    <a:pt x="38" y="504"/>
                  </a:lnTo>
                  <a:lnTo>
                    <a:pt x="33" y="504"/>
                  </a:lnTo>
                  <a:lnTo>
                    <a:pt x="33" y="504"/>
                  </a:lnTo>
                  <a:lnTo>
                    <a:pt x="29" y="504"/>
                  </a:lnTo>
                  <a:lnTo>
                    <a:pt x="29" y="504"/>
                  </a:lnTo>
                  <a:lnTo>
                    <a:pt x="24" y="504"/>
                  </a:lnTo>
                  <a:lnTo>
                    <a:pt x="24" y="504"/>
                  </a:lnTo>
                  <a:lnTo>
                    <a:pt x="20" y="504"/>
                  </a:lnTo>
                  <a:lnTo>
                    <a:pt x="20" y="504"/>
                  </a:lnTo>
                  <a:lnTo>
                    <a:pt x="15" y="504"/>
                  </a:lnTo>
                  <a:lnTo>
                    <a:pt x="15" y="504"/>
                  </a:lnTo>
                  <a:lnTo>
                    <a:pt x="9" y="504"/>
                  </a:lnTo>
                  <a:lnTo>
                    <a:pt x="9" y="504"/>
                  </a:lnTo>
                  <a:lnTo>
                    <a:pt x="5" y="504"/>
                  </a:lnTo>
                  <a:lnTo>
                    <a:pt x="0" y="504"/>
                  </a:lnTo>
                  <a:lnTo>
                    <a:pt x="0" y="504"/>
                  </a:lnTo>
                  <a:close/>
                </a:path>
              </a:pathLst>
            </a:custGeom>
            <a:solidFill>
              <a:srgbClr val="969696"/>
            </a:solidFill>
            <a:ln w="936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1" name=""/>
            <p:cNvSpPr/>
            <p:nvPr/>
          </p:nvSpPr>
          <p:spPr>
            <a:xfrm>
              <a:off x="1017720" y="1012680"/>
              <a:ext cx="4002120" cy="1600200"/>
            </a:xfrm>
            <a:custGeom>
              <a:avLst/>
              <a:gdLst/>
              <a:ahLst/>
              <a:rect l="l" t="t" r="r" b="b"/>
              <a:pathLst>
                <a:path w="2521" h="1008">
                  <a:moveTo>
                    <a:pt x="0" y="1008"/>
                  </a:moveTo>
                  <a:lnTo>
                    <a:pt x="5" y="1008"/>
                  </a:lnTo>
                  <a:lnTo>
                    <a:pt x="5" y="1008"/>
                  </a:lnTo>
                  <a:lnTo>
                    <a:pt x="9" y="1008"/>
                  </a:lnTo>
                  <a:lnTo>
                    <a:pt x="9" y="1008"/>
                  </a:lnTo>
                  <a:lnTo>
                    <a:pt x="14" y="1008"/>
                  </a:lnTo>
                  <a:lnTo>
                    <a:pt x="14" y="1008"/>
                  </a:lnTo>
                  <a:lnTo>
                    <a:pt x="19" y="1008"/>
                  </a:lnTo>
                  <a:lnTo>
                    <a:pt x="19" y="1008"/>
                  </a:lnTo>
                  <a:lnTo>
                    <a:pt x="23" y="1008"/>
                  </a:lnTo>
                  <a:lnTo>
                    <a:pt x="23" y="1008"/>
                  </a:lnTo>
                  <a:lnTo>
                    <a:pt x="28" y="1008"/>
                  </a:lnTo>
                  <a:lnTo>
                    <a:pt x="28" y="1008"/>
                  </a:lnTo>
                  <a:lnTo>
                    <a:pt x="32" y="1008"/>
                  </a:lnTo>
                  <a:lnTo>
                    <a:pt x="32" y="1008"/>
                  </a:lnTo>
                  <a:lnTo>
                    <a:pt x="37" y="1008"/>
                  </a:lnTo>
                  <a:lnTo>
                    <a:pt x="37" y="1008"/>
                  </a:lnTo>
                  <a:lnTo>
                    <a:pt x="42" y="1008"/>
                  </a:lnTo>
                  <a:lnTo>
                    <a:pt x="42" y="1008"/>
                  </a:lnTo>
                  <a:lnTo>
                    <a:pt x="46" y="1008"/>
                  </a:lnTo>
                  <a:lnTo>
                    <a:pt x="46" y="1008"/>
                  </a:lnTo>
                  <a:lnTo>
                    <a:pt x="51" y="1008"/>
                  </a:lnTo>
                  <a:lnTo>
                    <a:pt x="51" y="1008"/>
                  </a:lnTo>
                  <a:lnTo>
                    <a:pt x="56" y="1008"/>
                  </a:lnTo>
                  <a:lnTo>
                    <a:pt x="56" y="1008"/>
                  </a:lnTo>
                  <a:lnTo>
                    <a:pt x="60" y="1008"/>
                  </a:lnTo>
                  <a:lnTo>
                    <a:pt x="60" y="1008"/>
                  </a:lnTo>
                  <a:lnTo>
                    <a:pt x="65" y="1008"/>
                  </a:lnTo>
                  <a:lnTo>
                    <a:pt x="65" y="1008"/>
                  </a:lnTo>
                  <a:lnTo>
                    <a:pt x="65" y="1008"/>
                  </a:lnTo>
                  <a:lnTo>
                    <a:pt x="70" y="1008"/>
                  </a:lnTo>
                  <a:lnTo>
                    <a:pt x="70" y="1008"/>
                  </a:lnTo>
                  <a:lnTo>
                    <a:pt x="74" y="1008"/>
                  </a:lnTo>
                  <a:lnTo>
                    <a:pt x="74" y="1008"/>
                  </a:lnTo>
                  <a:lnTo>
                    <a:pt x="79" y="1008"/>
                  </a:lnTo>
                  <a:lnTo>
                    <a:pt x="79" y="1008"/>
                  </a:lnTo>
                  <a:lnTo>
                    <a:pt x="83" y="1008"/>
                  </a:lnTo>
                  <a:lnTo>
                    <a:pt x="83" y="1008"/>
                  </a:lnTo>
                  <a:lnTo>
                    <a:pt x="88" y="1008"/>
                  </a:lnTo>
                  <a:lnTo>
                    <a:pt x="88" y="1008"/>
                  </a:lnTo>
                  <a:lnTo>
                    <a:pt x="93" y="1008"/>
                  </a:lnTo>
                  <a:lnTo>
                    <a:pt x="93" y="1008"/>
                  </a:lnTo>
                  <a:lnTo>
                    <a:pt x="97" y="1008"/>
                  </a:lnTo>
                  <a:lnTo>
                    <a:pt x="97" y="1008"/>
                  </a:lnTo>
                  <a:lnTo>
                    <a:pt x="102" y="1008"/>
                  </a:lnTo>
                  <a:lnTo>
                    <a:pt x="102" y="1008"/>
                  </a:lnTo>
                  <a:lnTo>
                    <a:pt x="107" y="1008"/>
                  </a:lnTo>
                  <a:lnTo>
                    <a:pt x="107" y="1008"/>
                  </a:lnTo>
                  <a:lnTo>
                    <a:pt x="111" y="1008"/>
                  </a:lnTo>
                  <a:lnTo>
                    <a:pt x="111" y="1008"/>
                  </a:lnTo>
                  <a:lnTo>
                    <a:pt x="116" y="1008"/>
                  </a:lnTo>
                  <a:lnTo>
                    <a:pt x="116" y="1008"/>
                  </a:lnTo>
                  <a:lnTo>
                    <a:pt x="121" y="1008"/>
                  </a:lnTo>
                  <a:lnTo>
                    <a:pt x="121" y="1008"/>
                  </a:lnTo>
                  <a:lnTo>
                    <a:pt x="125" y="1008"/>
                  </a:lnTo>
                  <a:lnTo>
                    <a:pt x="125" y="1008"/>
                  </a:lnTo>
                  <a:lnTo>
                    <a:pt x="130" y="1008"/>
                  </a:lnTo>
                  <a:lnTo>
                    <a:pt x="130" y="1008"/>
                  </a:lnTo>
                  <a:lnTo>
                    <a:pt x="135" y="1008"/>
                  </a:lnTo>
                  <a:lnTo>
                    <a:pt x="135" y="1008"/>
                  </a:lnTo>
                  <a:lnTo>
                    <a:pt x="135" y="1008"/>
                  </a:lnTo>
                  <a:lnTo>
                    <a:pt x="139" y="1008"/>
                  </a:lnTo>
                  <a:lnTo>
                    <a:pt x="139" y="1008"/>
                  </a:lnTo>
                  <a:lnTo>
                    <a:pt x="144" y="907"/>
                  </a:lnTo>
                  <a:lnTo>
                    <a:pt x="144" y="907"/>
                  </a:lnTo>
                  <a:lnTo>
                    <a:pt x="148" y="907"/>
                  </a:lnTo>
                  <a:lnTo>
                    <a:pt x="148" y="907"/>
                  </a:lnTo>
                  <a:lnTo>
                    <a:pt x="153" y="907"/>
                  </a:lnTo>
                  <a:lnTo>
                    <a:pt x="153" y="907"/>
                  </a:lnTo>
                  <a:lnTo>
                    <a:pt x="158" y="907"/>
                  </a:lnTo>
                  <a:lnTo>
                    <a:pt x="158" y="907"/>
                  </a:lnTo>
                  <a:lnTo>
                    <a:pt x="162" y="907"/>
                  </a:lnTo>
                  <a:lnTo>
                    <a:pt x="162" y="907"/>
                  </a:lnTo>
                  <a:lnTo>
                    <a:pt x="167" y="907"/>
                  </a:lnTo>
                  <a:lnTo>
                    <a:pt x="167" y="907"/>
                  </a:lnTo>
                  <a:lnTo>
                    <a:pt x="172" y="907"/>
                  </a:lnTo>
                  <a:lnTo>
                    <a:pt x="172" y="907"/>
                  </a:lnTo>
                  <a:lnTo>
                    <a:pt x="176" y="907"/>
                  </a:lnTo>
                  <a:lnTo>
                    <a:pt x="176" y="907"/>
                  </a:lnTo>
                  <a:lnTo>
                    <a:pt x="181" y="907"/>
                  </a:lnTo>
                  <a:lnTo>
                    <a:pt x="181" y="907"/>
                  </a:lnTo>
                  <a:lnTo>
                    <a:pt x="186" y="907"/>
                  </a:lnTo>
                  <a:lnTo>
                    <a:pt x="186" y="907"/>
                  </a:lnTo>
                  <a:lnTo>
                    <a:pt x="190" y="907"/>
                  </a:lnTo>
                  <a:lnTo>
                    <a:pt x="190" y="907"/>
                  </a:lnTo>
                  <a:lnTo>
                    <a:pt x="195" y="907"/>
                  </a:lnTo>
                  <a:lnTo>
                    <a:pt x="195" y="907"/>
                  </a:lnTo>
                  <a:lnTo>
                    <a:pt x="199" y="907"/>
                  </a:lnTo>
                  <a:lnTo>
                    <a:pt x="199" y="907"/>
                  </a:lnTo>
                  <a:lnTo>
                    <a:pt x="199" y="907"/>
                  </a:lnTo>
                  <a:lnTo>
                    <a:pt x="204" y="907"/>
                  </a:lnTo>
                  <a:lnTo>
                    <a:pt x="204" y="907"/>
                  </a:lnTo>
                  <a:lnTo>
                    <a:pt x="209" y="907"/>
                  </a:lnTo>
                  <a:lnTo>
                    <a:pt x="209" y="907"/>
                  </a:lnTo>
                  <a:lnTo>
                    <a:pt x="213" y="907"/>
                  </a:lnTo>
                  <a:lnTo>
                    <a:pt x="213" y="907"/>
                  </a:lnTo>
                  <a:lnTo>
                    <a:pt x="218" y="907"/>
                  </a:lnTo>
                  <a:lnTo>
                    <a:pt x="218" y="907"/>
                  </a:lnTo>
                  <a:lnTo>
                    <a:pt x="223" y="907"/>
                  </a:lnTo>
                  <a:lnTo>
                    <a:pt x="223" y="907"/>
                  </a:lnTo>
                  <a:lnTo>
                    <a:pt x="227" y="907"/>
                  </a:lnTo>
                  <a:lnTo>
                    <a:pt x="227" y="907"/>
                  </a:lnTo>
                  <a:lnTo>
                    <a:pt x="232" y="907"/>
                  </a:lnTo>
                  <a:lnTo>
                    <a:pt x="232" y="907"/>
                  </a:lnTo>
                  <a:lnTo>
                    <a:pt x="237" y="907"/>
                  </a:lnTo>
                  <a:lnTo>
                    <a:pt x="237" y="907"/>
                  </a:lnTo>
                  <a:lnTo>
                    <a:pt x="241" y="907"/>
                  </a:lnTo>
                  <a:lnTo>
                    <a:pt x="241" y="907"/>
                  </a:lnTo>
                  <a:lnTo>
                    <a:pt x="246" y="907"/>
                  </a:lnTo>
                  <a:lnTo>
                    <a:pt x="246" y="907"/>
                  </a:lnTo>
                  <a:lnTo>
                    <a:pt x="250" y="907"/>
                  </a:lnTo>
                  <a:lnTo>
                    <a:pt x="250" y="907"/>
                  </a:lnTo>
                  <a:lnTo>
                    <a:pt x="255" y="907"/>
                  </a:lnTo>
                  <a:lnTo>
                    <a:pt x="255" y="1008"/>
                  </a:lnTo>
                  <a:lnTo>
                    <a:pt x="260" y="1008"/>
                  </a:lnTo>
                  <a:lnTo>
                    <a:pt x="260" y="1008"/>
                  </a:lnTo>
                  <a:lnTo>
                    <a:pt x="264" y="1008"/>
                  </a:lnTo>
                  <a:lnTo>
                    <a:pt x="264" y="1008"/>
                  </a:lnTo>
                  <a:lnTo>
                    <a:pt x="264" y="1008"/>
                  </a:lnTo>
                  <a:lnTo>
                    <a:pt x="269" y="1008"/>
                  </a:lnTo>
                  <a:lnTo>
                    <a:pt x="269" y="1008"/>
                  </a:lnTo>
                  <a:lnTo>
                    <a:pt x="274" y="1008"/>
                  </a:lnTo>
                  <a:lnTo>
                    <a:pt x="274" y="1008"/>
                  </a:lnTo>
                  <a:lnTo>
                    <a:pt x="278" y="1008"/>
                  </a:lnTo>
                  <a:lnTo>
                    <a:pt x="278" y="1008"/>
                  </a:lnTo>
                  <a:lnTo>
                    <a:pt x="283" y="1008"/>
                  </a:lnTo>
                  <a:lnTo>
                    <a:pt x="283" y="1008"/>
                  </a:lnTo>
                  <a:lnTo>
                    <a:pt x="288" y="1008"/>
                  </a:lnTo>
                  <a:lnTo>
                    <a:pt x="288" y="1008"/>
                  </a:lnTo>
                  <a:lnTo>
                    <a:pt x="292" y="1008"/>
                  </a:lnTo>
                  <a:lnTo>
                    <a:pt x="292" y="1008"/>
                  </a:lnTo>
                  <a:lnTo>
                    <a:pt x="297" y="1008"/>
                  </a:lnTo>
                  <a:lnTo>
                    <a:pt x="297" y="1008"/>
                  </a:lnTo>
                  <a:lnTo>
                    <a:pt x="301" y="1008"/>
                  </a:lnTo>
                  <a:lnTo>
                    <a:pt x="301" y="1008"/>
                  </a:lnTo>
                  <a:lnTo>
                    <a:pt x="306" y="1008"/>
                  </a:lnTo>
                  <a:lnTo>
                    <a:pt x="306" y="1008"/>
                  </a:lnTo>
                  <a:lnTo>
                    <a:pt x="311" y="1008"/>
                  </a:lnTo>
                  <a:lnTo>
                    <a:pt x="311" y="1008"/>
                  </a:lnTo>
                  <a:lnTo>
                    <a:pt x="315" y="1008"/>
                  </a:lnTo>
                  <a:lnTo>
                    <a:pt x="315" y="1008"/>
                  </a:lnTo>
                  <a:lnTo>
                    <a:pt x="320" y="1008"/>
                  </a:lnTo>
                  <a:lnTo>
                    <a:pt x="320" y="1008"/>
                  </a:lnTo>
                  <a:lnTo>
                    <a:pt x="325" y="1008"/>
                  </a:lnTo>
                  <a:lnTo>
                    <a:pt x="325" y="1008"/>
                  </a:lnTo>
                  <a:lnTo>
                    <a:pt x="329" y="1008"/>
                  </a:lnTo>
                  <a:lnTo>
                    <a:pt x="329" y="1008"/>
                  </a:lnTo>
                  <a:lnTo>
                    <a:pt x="329" y="1008"/>
                  </a:lnTo>
                  <a:lnTo>
                    <a:pt x="334" y="1008"/>
                  </a:lnTo>
                  <a:lnTo>
                    <a:pt x="334" y="1008"/>
                  </a:lnTo>
                  <a:lnTo>
                    <a:pt x="339" y="1008"/>
                  </a:lnTo>
                  <a:lnTo>
                    <a:pt x="339" y="1008"/>
                  </a:lnTo>
                  <a:lnTo>
                    <a:pt x="343" y="1008"/>
                  </a:lnTo>
                  <a:lnTo>
                    <a:pt x="343" y="1008"/>
                  </a:lnTo>
                  <a:lnTo>
                    <a:pt x="348" y="1008"/>
                  </a:lnTo>
                  <a:lnTo>
                    <a:pt x="348" y="1008"/>
                  </a:lnTo>
                  <a:lnTo>
                    <a:pt x="352" y="1008"/>
                  </a:lnTo>
                  <a:lnTo>
                    <a:pt x="352" y="1008"/>
                  </a:lnTo>
                  <a:lnTo>
                    <a:pt x="357" y="1008"/>
                  </a:lnTo>
                  <a:lnTo>
                    <a:pt x="357" y="1008"/>
                  </a:lnTo>
                  <a:lnTo>
                    <a:pt x="362" y="1008"/>
                  </a:lnTo>
                  <a:lnTo>
                    <a:pt x="362" y="1008"/>
                  </a:lnTo>
                  <a:lnTo>
                    <a:pt x="366" y="1008"/>
                  </a:lnTo>
                  <a:lnTo>
                    <a:pt x="366" y="1008"/>
                  </a:lnTo>
                  <a:lnTo>
                    <a:pt x="371" y="1008"/>
                  </a:lnTo>
                  <a:lnTo>
                    <a:pt x="371" y="1008"/>
                  </a:lnTo>
                  <a:lnTo>
                    <a:pt x="376" y="1008"/>
                  </a:lnTo>
                  <a:lnTo>
                    <a:pt x="376" y="1008"/>
                  </a:lnTo>
                  <a:lnTo>
                    <a:pt x="380" y="1008"/>
                  </a:lnTo>
                  <a:lnTo>
                    <a:pt x="380" y="1008"/>
                  </a:lnTo>
                  <a:lnTo>
                    <a:pt x="385" y="1008"/>
                  </a:lnTo>
                  <a:lnTo>
                    <a:pt x="385" y="1008"/>
                  </a:lnTo>
                  <a:lnTo>
                    <a:pt x="390" y="1008"/>
                  </a:lnTo>
                  <a:lnTo>
                    <a:pt x="390" y="1008"/>
                  </a:lnTo>
                  <a:lnTo>
                    <a:pt x="394" y="1008"/>
                  </a:lnTo>
                  <a:lnTo>
                    <a:pt x="394" y="1008"/>
                  </a:lnTo>
                  <a:lnTo>
                    <a:pt x="399" y="1008"/>
                  </a:lnTo>
                  <a:lnTo>
                    <a:pt x="399" y="1008"/>
                  </a:lnTo>
                  <a:lnTo>
                    <a:pt x="399" y="1008"/>
                  </a:lnTo>
                  <a:lnTo>
                    <a:pt x="404" y="1008"/>
                  </a:lnTo>
                  <a:lnTo>
                    <a:pt x="404" y="1008"/>
                  </a:lnTo>
                  <a:lnTo>
                    <a:pt x="408" y="1008"/>
                  </a:lnTo>
                  <a:lnTo>
                    <a:pt x="408" y="1008"/>
                  </a:lnTo>
                  <a:lnTo>
                    <a:pt x="413" y="1008"/>
                  </a:lnTo>
                  <a:lnTo>
                    <a:pt x="413" y="1008"/>
                  </a:lnTo>
                  <a:lnTo>
                    <a:pt x="417" y="1008"/>
                  </a:lnTo>
                  <a:lnTo>
                    <a:pt x="417" y="1008"/>
                  </a:lnTo>
                  <a:lnTo>
                    <a:pt x="422" y="1008"/>
                  </a:lnTo>
                  <a:lnTo>
                    <a:pt x="422" y="1008"/>
                  </a:lnTo>
                  <a:lnTo>
                    <a:pt x="427" y="1008"/>
                  </a:lnTo>
                  <a:lnTo>
                    <a:pt x="427" y="1008"/>
                  </a:lnTo>
                  <a:lnTo>
                    <a:pt x="431" y="1008"/>
                  </a:lnTo>
                  <a:lnTo>
                    <a:pt x="431" y="1008"/>
                  </a:lnTo>
                  <a:lnTo>
                    <a:pt x="436" y="1008"/>
                  </a:lnTo>
                  <a:lnTo>
                    <a:pt x="436" y="1008"/>
                  </a:lnTo>
                  <a:lnTo>
                    <a:pt x="441" y="1008"/>
                  </a:lnTo>
                  <a:lnTo>
                    <a:pt x="441" y="1008"/>
                  </a:lnTo>
                  <a:lnTo>
                    <a:pt x="445" y="1008"/>
                  </a:lnTo>
                  <a:lnTo>
                    <a:pt x="445" y="1008"/>
                  </a:lnTo>
                  <a:lnTo>
                    <a:pt x="450" y="1008"/>
                  </a:lnTo>
                  <a:lnTo>
                    <a:pt x="450" y="1008"/>
                  </a:lnTo>
                  <a:lnTo>
                    <a:pt x="455" y="1008"/>
                  </a:lnTo>
                  <a:lnTo>
                    <a:pt x="455" y="1008"/>
                  </a:lnTo>
                  <a:lnTo>
                    <a:pt x="459" y="1008"/>
                  </a:lnTo>
                  <a:lnTo>
                    <a:pt x="459" y="1008"/>
                  </a:lnTo>
                  <a:lnTo>
                    <a:pt x="464" y="1008"/>
                  </a:lnTo>
                  <a:lnTo>
                    <a:pt x="464" y="1008"/>
                  </a:lnTo>
                  <a:lnTo>
                    <a:pt x="464" y="1008"/>
                  </a:lnTo>
                  <a:lnTo>
                    <a:pt x="468" y="1008"/>
                  </a:lnTo>
                  <a:lnTo>
                    <a:pt x="468" y="1008"/>
                  </a:lnTo>
                  <a:lnTo>
                    <a:pt x="473" y="1008"/>
                  </a:lnTo>
                  <a:lnTo>
                    <a:pt x="473" y="1008"/>
                  </a:lnTo>
                  <a:lnTo>
                    <a:pt x="478" y="1008"/>
                  </a:lnTo>
                  <a:lnTo>
                    <a:pt x="478" y="1008"/>
                  </a:lnTo>
                  <a:lnTo>
                    <a:pt x="482" y="1008"/>
                  </a:lnTo>
                  <a:lnTo>
                    <a:pt x="482" y="1008"/>
                  </a:lnTo>
                  <a:lnTo>
                    <a:pt x="487" y="1008"/>
                  </a:lnTo>
                  <a:lnTo>
                    <a:pt x="487" y="1008"/>
                  </a:lnTo>
                  <a:lnTo>
                    <a:pt x="492" y="1008"/>
                  </a:lnTo>
                  <a:lnTo>
                    <a:pt x="492" y="1008"/>
                  </a:lnTo>
                  <a:lnTo>
                    <a:pt x="496" y="1008"/>
                  </a:lnTo>
                  <a:lnTo>
                    <a:pt x="496" y="1008"/>
                  </a:lnTo>
                  <a:lnTo>
                    <a:pt x="501" y="1008"/>
                  </a:lnTo>
                  <a:lnTo>
                    <a:pt x="501" y="1008"/>
                  </a:lnTo>
                  <a:lnTo>
                    <a:pt x="506" y="1008"/>
                  </a:lnTo>
                  <a:lnTo>
                    <a:pt x="506" y="1008"/>
                  </a:lnTo>
                  <a:lnTo>
                    <a:pt x="510" y="1008"/>
                  </a:lnTo>
                  <a:lnTo>
                    <a:pt x="510" y="1008"/>
                  </a:lnTo>
                  <a:lnTo>
                    <a:pt x="515" y="1008"/>
                  </a:lnTo>
                  <a:lnTo>
                    <a:pt x="515" y="1008"/>
                  </a:lnTo>
                  <a:lnTo>
                    <a:pt x="519" y="1008"/>
                  </a:lnTo>
                  <a:lnTo>
                    <a:pt x="519" y="1008"/>
                  </a:lnTo>
                  <a:lnTo>
                    <a:pt x="524" y="1008"/>
                  </a:lnTo>
                  <a:lnTo>
                    <a:pt x="524" y="1008"/>
                  </a:lnTo>
                  <a:lnTo>
                    <a:pt x="529" y="1008"/>
                  </a:lnTo>
                  <a:lnTo>
                    <a:pt x="529" y="1008"/>
                  </a:lnTo>
                  <a:lnTo>
                    <a:pt x="529" y="1008"/>
                  </a:lnTo>
                  <a:lnTo>
                    <a:pt x="533" y="1008"/>
                  </a:lnTo>
                  <a:lnTo>
                    <a:pt x="533" y="1008"/>
                  </a:lnTo>
                  <a:lnTo>
                    <a:pt x="538" y="1008"/>
                  </a:lnTo>
                  <a:lnTo>
                    <a:pt x="538" y="1008"/>
                  </a:lnTo>
                  <a:lnTo>
                    <a:pt x="543" y="1008"/>
                  </a:lnTo>
                  <a:lnTo>
                    <a:pt x="543" y="1008"/>
                  </a:lnTo>
                  <a:lnTo>
                    <a:pt x="547" y="1008"/>
                  </a:lnTo>
                  <a:lnTo>
                    <a:pt x="547" y="1008"/>
                  </a:lnTo>
                  <a:lnTo>
                    <a:pt x="552" y="1008"/>
                  </a:lnTo>
                  <a:lnTo>
                    <a:pt x="552" y="1008"/>
                  </a:lnTo>
                  <a:lnTo>
                    <a:pt x="557" y="1008"/>
                  </a:lnTo>
                  <a:lnTo>
                    <a:pt x="557" y="1008"/>
                  </a:lnTo>
                  <a:lnTo>
                    <a:pt x="561" y="1008"/>
                  </a:lnTo>
                  <a:lnTo>
                    <a:pt x="561" y="1008"/>
                  </a:lnTo>
                  <a:lnTo>
                    <a:pt x="566" y="1008"/>
                  </a:lnTo>
                  <a:lnTo>
                    <a:pt x="566" y="1008"/>
                  </a:lnTo>
                  <a:lnTo>
                    <a:pt x="570" y="1008"/>
                  </a:lnTo>
                  <a:lnTo>
                    <a:pt x="570" y="1008"/>
                  </a:lnTo>
                  <a:lnTo>
                    <a:pt x="575" y="1008"/>
                  </a:lnTo>
                  <a:lnTo>
                    <a:pt x="575" y="1008"/>
                  </a:lnTo>
                  <a:lnTo>
                    <a:pt x="580" y="1008"/>
                  </a:lnTo>
                  <a:lnTo>
                    <a:pt x="580" y="1008"/>
                  </a:lnTo>
                  <a:lnTo>
                    <a:pt x="584" y="1008"/>
                  </a:lnTo>
                  <a:lnTo>
                    <a:pt x="584" y="1008"/>
                  </a:lnTo>
                  <a:lnTo>
                    <a:pt x="589" y="1008"/>
                  </a:lnTo>
                  <a:lnTo>
                    <a:pt x="589" y="1008"/>
                  </a:lnTo>
                  <a:lnTo>
                    <a:pt x="594" y="1008"/>
                  </a:lnTo>
                  <a:lnTo>
                    <a:pt x="594" y="1008"/>
                  </a:lnTo>
                  <a:lnTo>
                    <a:pt x="598" y="1008"/>
                  </a:lnTo>
                  <a:lnTo>
                    <a:pt x="598" y="1008"/>
                  </a:lnTo>
                  <a:lnTo>
                    <a:pt x="598" y="1008"/>
                  </a:lnTo>
                  <a:lnTo>
                    <a:pt x="603" y="1008"/>
                  </a:lnTo>
                  <a:lnTo>
                    <a:pt x="603" y="1008"/>
                  </a:lnTo>
                  <a:lnTo>
                    <a:pt x="608" y="1008"/>
                  </a:lnTo>
                  <a:lnTo>
                    <a:pt x="608" y="1008"/>
                  </a:lnTo>
                  <a:lnTo>
                    <a:pt x="612" y="1008"/>
                  </a:lnTo>
                  <a:lnTo>
                    <a:pt x="612" y="1008"/>
                  </a:lnTo>
                  <a:lnTo>
                    <a:pt x="617" y="1008"/>
                  </a:lnTo>
                  <a:lnTo>
                    <a:pt x="617" y="1008"/>
                  </a:lnTo>
                  <a:lnTo>
                    <a:pt x="621" y="1008"/>
                  </a:lnTo>
                  <a:lnTo>
                    <a:pt x="621" y="1008"/>
                  </a:lnTo>
                  <a:lnTo>
                    <a:pt x="626" y="1008"/>
                  </a:lnTo>
                  <a:lnTo>
                    <a:pt x="626" y="1008"/>
                  </a:lnTo>
                  <a:lnTo>
                    <a:pt x="631" y="1008"/>
                  </a:lnTo>
                  <a:lnTo>
                    <a:pt x="631" y="1008"/>
                  </a:lnTo>
                  <a:lnTo>
                    <a:pt x="635" y="1008"/>
                  </a:lnTo>
                  <a:lnTo>
                    <a:pt x="635" y="1008"/>
                  </a:lnTo>
                  <a:lnTo>
                    <a:pt x="640" y="1008"/>
                  </a:lnTo>
                  <a:lnTo>
                    <a:pt x="640" y="1008"/>
                  </a:lnTo>
                  <a:lnTo>
                    <a:pt x="645" y="1008"/>
                  </a:lnTo>
                  <a:lnTo>
                    <a:pt x="645" y="1008"/>
                  </a:lnTo>
                  <a:lnTo>
                    <a:pt x="649" y="1008"/>
                  </a:lnTo>
                  <a:lnTo>
                    <a:pt x="649" y="1008"/>
                  </a:lnTo>
                  <a:lnTo>
                    <a:pt x="654" y="1008"/>
                  </a:lnTo>
                  <a:lnTo>
                    <a:pt x="654" y="1008"/>
                  </a:lnTo>
                  <a:lnTo>
                    <a:pt x="659" y="1008"/>
                  </a:lnTo>
                  <a:lnTo>
                    <a:pt x="659" y="1008"/>
                  </a:lnTo>
                  <a:lnTo>
                    <a:pt x="663" y="1008"/>
                  </a:lnTo>
                  <a:lnTo>
                    <a:pt x="663" y="1008"/>
                  </a:lnTo>
                  <a:lnTo>
                    <a:pt x="663" y="1008"/>
                  </a:lnTo>
                  <a:lnTo>
                    <a:pt x="668" y="1008"/>
                  </a:lnTo>
                  <a:lnTo>
                    <a:pt x="668" y="1008"/>
                  </a:lnTo>
                  <a:lnTo>
                    <a:pt x="673" y="1008"/>
                  </a:lnTo>
                  <a:lnTo>
                    <a:pt x="673" y="1008"/>
                  </a:lnTo>
                  <a:lnTo>
                    <a:pt x="677" y="1008"/>
                  </a:lnTo>
                  <a:lnTo>
                    <a:pt x="677" y="1008"/>
                  </a:lnTo>
                  <a:lnTo>
                    <a:pt x="682" y="1008"/>
                  </a:lnTo>
                  <a:lnTo>
                    <a:pt x="682" y="1008"/>
                  </a:lnTo>
                  <a:lnTo>
                    <a:pt x="686" y="1008"/>
                  </a:lnTo>
                  <a:lnTo>
                    <a:pt x="686" y="1008"/>
                  </a:lnTo>
                  <a:lnTo>
                    <a:pt x="691" y="1008"/>
                  </a:lnTo>
                  <a:lnTo>
                    <a:pt x="691" y="1008"/>
                  </a:lnTo>
                  <a:lnTo>
                    <a:pt x="696" y="1008"/>
                  </a:lnTo>
                  <a:lnTo>
                    <a:pt x="696" y="1008"/>
                  </a:lnTo>
                  <a:lnTo>
                    <a:pt x="700" y="1008"/>
                  </a:lnTo>
                  <a:lnTo>
                    <a:pt x="700" y="1008"/>
                  </a:lnTo>
                  <a:lnTo>
                    <a:pt x="705" y="1008"/>
                  </a:lnTo>
                  <a:lnTo>
                    <a:pt x="705" y="1008"/>
                  </a:lnTo>
                  <a:lnTo>
                    <a:pt x="710" y="1008"/>
                  </a:lnTo>
                  <a:lnTo>
                    <a:pt x="710" y="1008"/>
                  </a:lnTo>
                  <a:lnTo>
                    <a:pt x="714" y="1008"/>
                  </a:lnTo>
                  <a:lnTo>
                    <a:pt x="714" y="1008"/>
                  </a:lnTo>
                  <a:lnTo>
                    <a:pt x="719" y="1008"/>
                  </a:lnTo>
                  <a:lnTo>
                    <a:pt x="719" y="1008"/>
                  </a:lnTo>
                  <a:lnTo>
                    <a:pt x="724" y="1008"/>
                  </a:lnTo>
                  <a:lnTo>
                    <a:pt x="724" y="1008"/>
                  </a:lnTo>
                  <a:lnTo>
                    <a:pt x="728" y="1008"/>
                  </a:lnTo>
                  <a:lnTo>
                    <a:pt x="728" y="1008"/>
                  </a:lnTo>
                  <a:lnTo>
                    <a:pt x="728" y="1008"/>
                  </a:lnTo>
                  <a:lnTo>
                    <a:pt x="733" y="1008"/>
                  </a:lnTo>
                  <a:lnTo>
                    <a:pt x="733" y="1008"/>
                  </a:lnTo>
                  <a:lnTo>
                    <a:pt x="737" y="1008"/>
                  </a:lnTo>
                  <a:lnTo>
                    <a:pt x="737" y="1008"/>
                  </a:lnTo>
                  <a:lnTo>
                    <a:pt x="742" y="1008"/>
                  </a:lnTo>
                  <a:lnTo>
                    <a:pt x="742" y="1008"/>
                  </a:lnTo>
                  <a:lnTo>
                    <a:pt x="747" y="1008"/>
                  </a:lnTo>
                  <a:lnTo>
                    <a:pt x="747" y="1008"/>
                  </a:lnTo>
                  <a:lnTo>
                    <a:pt x="751" y="1008"/>
                  </a:lnTo>
                  <a:lnTo>
                    <a:pt x="751" y="1008"/>
                  </a:lnTo>
                  <a:lnTo>
                    <a:pt x="756" y="1008"/>
                  </a:lnTo>
                  <a:lnTo>
                    <a:pt x="756" y="1008"/>
                  </a:lnTo>
                  <a:lnTo>
                    <a:pt x="761" y="1008"/>
                  </a:lnTo>
                  <a:lnTo>
                    <a:pt x="761" y="1008"/>
                  </a:lnTo>
                  <a:lnTo>
                    <a:pt x="765" y="1008"/>
                  </a:lnTo>
                  <a:lnTo>
                    <a:pt x="765" y="1008"/>
                  </a:lnTo>
                  <a:lnTo>
                    <a:pt x="770" y="1008"/>
                  </a:lnTo>
                  <a:lnTo>
                    <a:pt x="770" y="1008"/>
                  </a:lnTo>
                  <a:lnTo>
                    <a:pt x="775" y="1008"/>
                  </a:lnTo>
                  <a:lnTo>
                    <a:pt x="775" y="1008"/>
                  </a:lnTo>
                  <a:lnTo>
                    <a:pt x="779" y="1008"/>
                  </a:lnTo>
                  <a:lnTo>
                    <a:pt x="779" y="1008"/>
                  </a:lnTo>
                  <a:lnTo>
                    <a:pt x="784" y="1008"/>
                  </a:lnTo>
                  <a:lnTo>
                    <a:pt x="784" y="1008"/>
                  </a:lnTo>
                  <a:lnTo>
                    <a:pt x="788" y="1008"/>
                  </a:lnTo>
                  <a:lnTo>
                    <a:pt x="788" y="1008"/>
                  </a:lnTo>
                  <a:lnTo>
                    <a:pt x="793" y="1008"/>
                  </a:lnTo>
                  <a:lnTo>
                    <a:pt x="793" y="1008"/>
                  </a:lnTo>
                  <a:lnTo>
                    <a:pt x="793" y="1008"/>
                  </a:lnTo>
                  <a:lnTo>
                    <a:pt x="798" y="1008"/>
                  </a:lnTo>
                  <a:lnTo>
                    <a:pt x="798" y="1008"/>
                  </a:lnTo>
                  <a:lnTo>
                    <a:pt x="802" y="1008"/>
                  </a:lnTo>
                  <a:lnTo>
                    <a:pt x="802" y="1008"/>
                  </a:lnTo>
                  <a:lnTo>
                    <a:pt x="807" y="1008"/>
                  </a:lnTo>
                  <a:lnTo>
                    <a:pt x="807" y="1008"/>
                  </a:lnTo>
                  <a:lnTo>
                    <a:pt x="812" y="907"/>
                  </a:lnTo>
                  <a:lnTo>
                    <a:pt x="812" y="907"/>
                  </a:lnTo>
                  <a:lnTo>
                    <a:pt x="816" y="907"/>
                  </a:lnTo>
                  <a:lnTo>
                    <a:pt x="816" y="907"/>
                  </a:lnTo>
                  <a:lnTo>
                    <a:pt x="821" y="907"/>
                  </a:lnTo>
                  <a:lnTo>
                    <a:pt x="821" y="806"/>
                  </a:lnTo>
                  <a:lnTo>
                    <a:pt x="826" y="806"/>
                  </a:lnTo>
                  <a:lnTo>
                    <a:pt x="826" y="806"/>
                  </a:lnTo>
                  <a:lnTo>
                    <a:pt x="830" y="806"/>
                  </a:lnTo>
                  <a:lnTo>
                    <a:pt x="830" y="806"/>
                  </a:lnTo>
                  <a:lnTo>
                    <a:pt x="835" y="806"/>
                  </a:lnTo>
                  <a:lnTo>
                    <a:pt x="835" y="806"/>
                  </a:lnTo>
                  <a:lnTo>
                    <a:pt x="839" y="806"/>
                  </a:lnTo>
                  <a:lnTo>
                    <a:pt x="839" y="806"/>
                  </a:lnTo>
                  <a:lnTo>
                    <a:pt x="844" y="706"/>
                  </a:lnTo>
                  <a:lnTo>
                    <a:pt x="844" y="706"/>
                  </a:lnTo>
                  <a:lnTo>
                    <a:pt x="849" y="706"/>
                  </a:lnTo>
                  <a:lnTo>
                    <a:pt x="849" y="706"/>
                  </a:lnTo>
                  <a:lnTo>
                    <a:pt x="853" y="706"/>
                  </a:lnTo>
                  <a:lnTo>
                    <a:pt x="853" y="706"/>
                  </a:lnTo>
                  <a:lnTo>
                    <a:pt x="858" y="706"/>
                  </a:lnTo>
                  <a:lnTo>
                    <a:pt x="858" y="706"/>
                  </a:lnTo>
                  <a:lnTo>
                    <a:pt x="863" y="706"/>
                  </a:lnTo>
                  <a:lnTo>
                    <a:pt x="863" y="706"/>
                  </a:lnTo>
                  <a:lnTo>
                    <a:pt x="863" y="706"/>
                  </a:lnTo>
                  <a:lnTo>
                    <a:pt x="867" y="706"/>
                  </a:lnTo>
                  <a:lnTo>
                    <a:pt x="867" y="706"/>
                  </a:lnTo>
                  <a:lnTo>
                    <a:pt x="872" y="706"/>
                  </a:lnTo>
                  <a:lnTo>
                    <a:pt x="872" y="706"/>
                  </a:lnTo>
                  <a:lnTo>
                    <a:pt x="877" y="706"/>
                  </a:lnTo>
                  <a:lnTo>
                    <a:pt x="877" y="706"/>
                  </a:lnTo>
                  <a:lnTo>
                    <a:pt x="881" y="706"/>
                  </a:lnTo>
                  <a:lnTo>
                    <a:pt x="881" y="706"/>
                  </a:lnTo>
                  <a:lnTo>
                    <a:pt x="886" y="706"/>
                  </a:lnTo>
                  <a:lnTo>
                    <a:pt x="886" y="706"/>
                  </a:lnTo>
                  <a:lnTo>
                    <a:pt x="890" y="706"/>
                  </a:lnTo>
                  <a:lnTo>
                    <a:pt x="890" y="706"/>
                  </a:lnTo>
                  <a:lnTo>
                    <a:pt x="895" y="706"/>
                  </a:lnTo>
                  <a:lnTo>
                    <a:pt x="895" y="706"/>
                  </a:lnTo>
                  <a:lnTo>
                    <a:pt x="900" y="706"/>
                  </a:lnTo>
                  <a:lnTo>
                    <a:pt x="900" y="706"/>
                  </a:lnTo>
                  <a:lnTo>
                    <a:pt x="904" y="706"/>
                  </a:lnTo>
                  <a:lnTo>
                    <a:pt x="904" y="706"/>
                  </a:lnTo>
                  <a:lnTo>
                    <a:pt x="909" y="706"/>
                  </a:lnTo>
                  <a:lnTo>
                    <a:pt x="909" y="706"/>
                  </a:lnTo>
                  <a:lnTo>
                    <a:pt x="914" y="706"/>
                  </a:lnTo>
                  <a:lnTo>
                    <a:pt x="914" y="706"/>
                  </a:lnTo>
                  <a:lnTo>
                    <a:pt x="918" y="706"/>
                  </a:lnTo>
                  <a:lnTo>
                    <a:pt x="918" y="706"/>
                  </a:lnTo>
                  <a:lnTo>
                    <a:pt x="923" y="706"/>
                  </a:lnTo>
                  <a:lnTo>
                    <a:pt x="923" y="806"/>
                  </a:lnTo>
                  <a:lnTo>
                    <a:pt x="928" y="806"/>
                  </a:lnTo>
                  <a:lnTo>
                    <a:pt x="928" y="806"/>
                  </a:lnTo>
                  <a:lnTo>
                    <a:pt x="928" y="806"/>
                  </a:lnTo>
                  <a:lnTo>
                    <a:pt x="932" y="806"/>
                  </a:lnTo>
                  <a:lnTo>
                    <a:pt x="932" y="907"/>
                  </a:lnTo>
                  <a:lnTo>
                    <a:pt x="937" y="907"/>
                  </a:lnTo>
                  <a:lnTo>
                    <a:pt x="937" y="907"/>
                  </a:lnTo>
                  <a:lnTo>
                    <a:pt x="942" y="907"/>
                  </a:lnTo>
                  <a:lnTo>
                    <a:pt x="942" y="907"/>
                  </a:lnTo>
                  <a:lnTo>
                    <a:pt x="946" y="907"/>
                  </a:lnTo>
                  <a:lnTo>
                    <a:pt x="946" y="907"/>
                  </a:lnTo>
                  <a:lnTo>
                    <a:pt x="951" y="907"/>
                  </a:lnTo>
                  <a:lnTo>
                    <a:pt x="951" y="907"/>
                  </a:lnTo>
                  <a:lnTo>
                    <a:pt x="955" y="1008"/>
                  </a:lnTo>
                  <a:lnTo>
                    <a:pt x="955" y="1008"/>
                  </a:lnTo>
                  <a:lnTo>
                    <a:pt x="960" y="1008"/>
                  </a:lnTo>
                  <a:lnTo>
                    <a:pt x="960" y="1008"/>
                  </a:lnTo>
                  <a:lnTo>
                    <a:pt x="965" y="1008"/>
                  </a:lnTo>
                  <a:lnTo>
                    <a:pt x="965" y="1008"/>
                  </a:lnTo>
                  <a:lnTo>
                    <a:pt x="969" y="1008"/>
                  </a:lnTo>
                  <a:lnTo>
                    <a:pt x="969" y="1008"/>
                  </a:lnTo>
                  <a:lnTo>
                    <a:pt x="974" y="1008"/>
                  </a:lnTo>
                  <a:lnTo>
                    <a:pt x="974" y="1008"/>
                  </a:lnTo>
                  <a:lnTo>
                    <a:pt x="979" y="1008"/>
                  </a:lnTo>
                  <a:lnTo>
                    <a:pt x="979" y="1008"/>
                  </a:lnTo>
                  <a:lnTo>
                    <a:pt x="983" y="1008"/>
                  </a:lnTo>
                  <a:lnTo>
                    <a:pt x="983" y="1008"/>
                  </a:lnTo>
                  <a:lnTo>
                    <a:pt x="988" y="1008"/>
                  </a:lnTo>
                  <a:lnTo>
                    <a:pt x="988" y="1008"/>
                  </a:lnTo>
                  <a:lnTo>
                    <a:pt x="993" y="1008"/>
                  </a:lnTo>
                  <a:lnTo>
                    <a:pt x="993" y="1008"/>
                  </a:lnTo>
                  <a:lnTo>
                    <a:pt x="993" y="1008"/>
                  </a:lnTo>
                  <a:lnTo>
                    <a:pt x="997" y="1008"/>
                  </a:lnTo>
                  <a:lnTo>
                    <a:pt x="997" y="1008"/>
                  </a:lnTo>
                  <a:lnTo>
                    <a:pt x="1002" y="1008"/>
                  </a:lnTo>
                  <a:lnTo>
                    <a:pt x="1002" y="1008"/>
                  </a:lnTo>
                  <a:lnTo>
                    <a:pt x="1006" y="1008"/>
                  </a:lnTo>
                  <a:lnTo>
                    <a:pt x="1006" y="1008"/>
                  </a:lnTo>
                  <a:lnTo>
                    <a:pt x="1011" y="1008"/>
                  </a:lnTo>
                  <a:lnTo>
                    <a:pt x="1011" y="1008"/>
                  </a:lnTo>
                  <a:lnTo>
                    <a:pt x="1016" y="1008"/>
                  </a:lnTo>
                  <a:lnTo>
                    <a:pt x="1016" y="1008"/>
                  </a:lnTo>
                  <a:lnTo>
                    <a:pt x="1020" y="1008"/>
                  </a:lnTo>
                  <a:lnTo>
                    <a:pt x="1020" y="1008"/>
                  </a:lnTo>
                  <a:lnTo>
                    <a:pt x="1025" y="1008"/>
                  </a:lnTo>
                  <a:lnTo>
                    <a:pt x="1025" y="1008"/>
                  </a:lnTo>
                  <a:lnTo>
                    <a:pt x="1030" y="1008"/>
                  </a:lnTo>
                  <a:lnTo>
                    <a:pt x="1030" y="1008"/>
                  </a:lnTo>
                  <a:lnTo>
                    <a:pt x="1034" y="1008"/>
                  </a:lnTo>
                  <a:lnTo>
                    <a:pt x="1034" y="1008"/>
                  </a:lnTo>
                  <a:lnTo>
                    <a:pt x="1039" y="1008"/>
                  </a:lnTo>
                  <a:lnTo>
                    <a:pt x="1039" y="1008"/>
                  </a:lnTo>
                  <a:lnTo>
                    <a:pt x="1044" y="1008"/>
                  </a:lnTo>
                  <a:lnTo>
                    <a:pt x="1044" y="1008"/>
                  </a:lnTo>
                  <a:lnTo>
                    <a:pt x="1048" y="1008"/>
                  </a:lnTo>
                  <a:lnTo>
                    <a:pt x="1048" y="1008"/>
                  </a:lnTo>
                  <a:lnTo>
                    <a:pt x="1053" y="1008"/>
                  </a:lnTo>
                  <a:lnTo>
                    <a:pt x="1053" y="1008"/>
                  </a:lnTo>
                  <a:lnTo>
                    <a:pt x="1057" y="1008"/>
                  </a:lnTo>
                  <a:lnTo>
                    <a:pt x="1057" y="1008"/>
                  </a:lnTo>
                  <a:lnTo>
                    <a:pt x="1062" y="1008"/>
                  </a:lnTo>
                  <a:lnTo>
                    <a:pt x="1062" y="1008"/>
                  </a:lnTo>
                  <a:lnTo>
                    <a:pt x="1062" y="1008"/>
                  </a:lnTo>
                  <a:lnTo>
                    <a:pt x="1067" y="1008"/>
                  </a:lnTo>
                  <a:lnTo>
                    <a:pt x="1067" y="1008"/>
                  </a:lnTo>
                  <a:lnTo>
                    <a:pt x="1071" y="1008"/>
                  </a:lnTo>
                  <a:lnTo>
                    <a:pt x="1071" y="1008"/>
                  </a:lnTo>
                  <a:lnTo>
                    <a:pt x="1076" y="1008"/>
                  </a:lnTo>
                  <a:lnTo>
                    <a:pt x="1076" y="1008"/>
                  </a:lnTo>
                  <a:lnTo>
                    <a:pt x="1081" y="1008"/>
                  </a:lnTo>
                  <a:lnTo>
                    <a:pt x="1081" y="1008"/>
                  </a:lnTo>
                  <a:lnTo>
                    <a:pt x="1085" y="1008"/>
                  </a:lnTo>
                  <a:lnTo>
                    <a:pt x="1085" y="1008"/>
                  </a:lnTo>
                  <a:lnTo>
                    <a:pt x="1090" y="1008"/>
                  </a:lnTo>
                  <a:lnTo>
                    <a:pt x="1090" y="1008"/>
                  </a:lnTo>
                  <a:lnTo>
                    <a:pt x="1095" y="1008"/>
                  </a:lnTo>
                  <a:lnTo>
                    <a:pt x="1095" y="1008"/>
                  </a:lnTo>
                  <a:lnTo>
                    <a:pt x="1099" y="1008"/>
                  </a:lnTo>
                  <a:lnTo>
                    <a:pt x="1099" y="1008"/>
                  </a:lnTo>
                  <a:lnTo>
                    <a:pt x="1104" y="1008"/>
                  </a:lnTo>
                  <a:lnTo>
                    <a:pt x="1104" y="1008"/>
                  </a:lnTo>
                  <a:lnTo>
                    <a:pt x="1108" y="1008"/>
                  </a:lnTo>
                  <a:lnTo>
                    <a:pt x="1108" y="1008"/>
                  </a:lnTo>
                  <a:lnTo>
                    <a:pt x="1113" y="1008"/>
                  </a:lnTo>
                  <a:lnTo>
                    <a:pt x="1113" y="1008"/>
                  </a:lnTo>
                  <a:lnTo>
                    <a:pt x="1118" y="1008"/>
                  </a:lnTo>
                  <a:lnTo>
                    <a:pt x="1118" y="1008"/>
                  </a:lnTo>
                  <a:lnTo>
                    <a:pt x="1122" y="1008"/>
                  </a:lnTo>
                  <a:lnTo>
                    <a:pt x="1122" y="1008"/>
                  </a:lnTo>
                  <a:lnTo>
                    <a:pt x="1127" y="1008"/>
                  </a:lnTo>
                  <a:lnTo>
                    <a:pt x="1127" y="1008"/>
                  </a:lnTo>
                  <a:lnTo>
                    <a:pt x="1127" y="1008"/>
                  </a:lnTo>
                  <a:lnTo>
                    <a:pt x="1132" y="1008"/>
                  </a:lnTo>
                  <a:lnTo>
                    <a:pt x="1132" y="1008"/>
                  </a:lnTo>
                  <a:lnTo>
                    <a:pt x="1136" y="1008"/>
                  </a:lnTo>
                  <a:lnTo>
                    <a:pt x="1136" y="1008"/>
                  </a:lnTo>
                  <a:lnTo>
                    <a:pt x="1141" y="1008"/>
                  </a:lnTo>
                  <a:lnTo>
                    <a:pt x="1141" y="1008"/>
                  </a:lnTo>
                  <a:lnTo>
                    <a:pt x="1146" y="1008"/>
                  </a:lnTo>
                  <a:lnTo>
                    <a:pt x="1146" y="1008"/>
                  </a:lnTo>
                  <a:lnTo>
                    <a:pt x="1150" y="1008"/>
                  </a:lnTo>
                  <a:lnTo>
                    <a:pt x="1150" y="1008"/>
                  </a:lnTo>
                  <a:lnTo>
                    <a:pt x="1155" y="1008"/>
                  </a:lnTo>
                  <a:lnTo>
                    <a:pt x="1155" y="1008"/>
                  </a:lnTo>
                  <a:lnTo>
                    <a:pt x="1160" y="1008"/>
                  </a:lnTo>
                  <a:lnTo>
                    <a:pt x="1160" y="1008"/>
                  </a:lnTo>
                  <a:lnTo>
                    <a:pt x="1164" y="1008"/>
                  </a:lnTo>
                  <a:lnTo>
                    <a:pt x="1164" y="1008"/>
                  </a:lnTo>
                  <a:lnTo>
                    <a:pt x="1169" y="1008"/>
                  </a:lnTo>
                  <a:lnTo>
                    <a:pt x="1169" y="1008"/>
                  </a:lnTo>
                  <a:lnTo>
                    <a:pt x="1173" y="1008"/>
                  </a:lnTo>
                  <a:lnTo>
                    <a:pt x="1173" y="1008"/>
                  </a:lnTo>
                  <a:lnTo>
                    <a:pt x="1178" y="1008"/>
                  </a:lnTo>
                  <a:lnTo>
                    <a:pt x="1178" y="1008"/>
                  </a:lnTo>
                  <a:lnTo>
                    <a:pt x="1183" y="1008"/>
                  </a:lnTo>
                  <a:lnTo>
                    <a:pt x="1183" y="1008"/>
                  </a:lnTo>
                  <a:lnTo>
                    <a:pt x="1187" y="1008"/>
                  </a:lnTo>
                  <a:lnTo>
                    <a:pt x="1187" y="1008"/>
                  </a:lnTo>
                  <a:lnTo>
                    <a:pt x="1192" y="1008"/>
                  </a:lnTo>
                  <a:lnTo>
                    <a:pt x="1192" y="1008"/>
                  </a:lnTo>
                  <a:lnTo>
                    <a:pt x="1192" y="1008"/>
                  </a:lnTo>
                  <a:lnTo>
                    <a:pt x="1197" y="1008"/>
                  </a:lnTo>
                  <a:lnTo>
                    <a:pt x="1197" y="1008"/>
                  </a:lnTo>
                  <a:lnTo>
                    <a:pt x="1201" y="1008"/>
                  </a:lnTo>
                  <a:lnTo>
                    <a:pt x="1201" y="1008"/>
                  </a:lnTo>
                  <a:lnTo>
                    <a:pt x="1206" y="907"/>
                  </a:lnTo>
                  <a:lnTo>
                    <a:pt x="1206" y="907"/>
                  </a:lnTo>
                  <a:lnTo>
                    <a:pt x="1211" y="907"/>
                  </a:lnTo>
                  <a:lnTo>
                    <a:pt x="1211" y="907"/>
                  </a:lnTo>
                  <a:lnTo>
                    <a:pt x="1215" y="907"/>
                  </a:lnTo>
                  <a:lnTo>
                    <a:pt x="1215" y="907"/>
                  </a:lnTo>
                  <a:lnTo>
                    <a:pt x="1220" y="907"/>
                  </a:lnTo>
                  <a:lnTo>
                    <a:pt x="1220" y="907"/>
                  </a:lnTo>
                  <a:lnTo>
                    <a:pt x="1224" y="907"/>
                  </a:lnTo>
                  <a:lnTo>
                    <a:pt x="1224" y="907"/>
                  </a:lnTo>
                  <a:lnTo>
                    <a:pt x="1229" y="907"/>
                  </a:lnTo>
                  <a:lnTo>
                    <a:pt x="1229" y="907"/>
                  </a:lnTo>
                  <a:lnTo>
                    <a:pt x="1234" y="907"/>
                  </a:lnTo>
                  <a:lnTo>
                    <a:pt x="1234" y="907"/>
                  </a:lnTo>
                  <a:lnTo>
                    <a:pt x="1238" y="907"/>
                  </a:lnTo>
                  <a:lnTo>
                    <a:pt x="1238" y="907"/>
                  </a:lnTo>
                  <a:lnTo>
                    <a:pt x="1243" y="907"/>
                  </a:lnTo>
                  <a:lnTo>
                    <a:pt x="1243" y="907"/>
                  </a:lnTo>
                  <a:lnTo>
                    <a:pt x="1248" y="907"/>
                  </a:lnTo>
                  <a:lnTo>
                    <a:pt x="1248" y="907"/>
                  </a:lnTo>
                  <a:lnTo>
                    <a:pt x="1252" y="907"/>
                  </a:lnTo>
                  <a:lnTo>
                    <a:pt x="1252" y="907"/>
                  </a:lnTo>
                  <a:lnTo>
                    <a:pt x="1257" y="907"/>
                  </a:lnTo>
                  <a:lnTo>
                    <a:pt x="1257" y="907"/>
                  </a:lnTo>
                  <a:lnTo>
                    <a:pt x="1257" y="907"/>
                  </a:lnTo>
                  <a:lnTo>
                    <a:pt x="1262" y="907"/>
                  </a:lnTo>
                  <a:lnTo>
                    <a:pt x="1262" y="907"/>
                  </a:lnTo>
                  <a:lnTo>
                    <a:pt x="1266" y="907"/>
                  </a:lnTo>
                  <a:lnTo>
                    <a:pt x="1266" y="907"/>
                  </a:lnTo>
                  <a:lnTo>
                    <a:pt x="1271" y="806"/>
                  </a:lnTo>
                  <a:lnTo>
                    <a:pt x="1271" y="706"/>
                  </a:lnTo>
                  <a:lnTo>
                    <a:pt x="1275" y="706"/>
                  </a:lnTo>
                  <a:lnTo>
                    <a:pt x="1275" y="706"/>
                  </a:lnTo>
                  <a:lnTo>
                    <a:pt x="1280" y="706"/>
                  </a:lnTo>
                  <a:lnTo>
                    <a:pt x="1280" y="706"/>
                  </a:lnTo>
                  <a:lnTo>
                    <a:pt x="1285" y="706"/>
                  </a:lnTo>
                  <a:lnTo>
                    <a:pt x="1285" y="706"/>
                  </a:lnTo>
                  <a:lnTo>
                    <a:pt x="1289" y="706"/>
                  </a:lnTo>
                  <a:lnTo>
                    <a:pt x="1289" y="706"/>
                  </a:lnTo>
                  <a:lnTo>
                    <a:pt x="1294" y="706"/>
                  </a:lnTo>
                  <a:lnTo>
                    <a:pt x="1294" y="706"/>
                  </a:lnTo>
                  <a:lnTo>
                    <a:pt x="1299" y="706"/>
                  </a:lnTo>
                  <a:lnTo>
                    <a:pt x="1299" y="605"/>
                  </a:lnTo>
                  <a:lnTo>
                    <a:pt x="1303" y="605"/>
                  </a:lnTo>
                  <a:lnTo>
                    <a:pt x="1303" y="605"/>
                  </a:lnTo>
                  <a:lnTo>
                    <a:pt x="1308" y="605"/>
                  </a:lnTo>
                  <a:lnTo>
                    <a:pt x="1308" y="605"/>
                  </a:lnTo>
                  <a:lnTo>
                    <a:pt x="1313" y="605"/>
                  </a:lnTo>
                  <a:lnTo>
                    <a:pt x="1313" y="605"/>
                  </a:lnTo>
                  <a:lnTo>
                    <a:pt x="1317" y="605"/>
                  </a:lnTo>
                  <a:lnTo>
                    <a:pt x="1317" y="706"/>
                  </a:lnTo>
                  <a:lnTo>
                    <a:pt x="1322" y="706"/>
                  </a:lnTo>
                  <a:lnTo>
                    <a:pt x="1322" y="706"/>
                  </a:lnTo>
                  <a:lnTo>
                    <a:pt x="1326" y="706"/>
                  </a:lnTo>
                  <a:lnTo>
                    <a:pt x="1326" y="706"/>
                  </a:lnTo>
                  <a:lnTo>
                    <a:pt x="1326" y="706"/>
                  </a:lnTo>
                  <a:lnTo>
                    <a:pt x="1331" y="706"/>
                  </a:lnTo>
                  <a:lnTo>
                    <a:pt x="1331" y="706"/>
                  </a:lnTo>
                  <a:lnTo>
                    <a:pt x="1336" y="706"/>
                  </a:lnTo>
                  <a:lnTo>
                    <a:pt x="1336" y="706"/>
                  </a:lnTo>
                  <a:lnTo>
                    <a:pt x="1340" y="706"/>
                  </a:lnTo>
                  <a:lnTo>
                    <a:pt x="1340" y="504"/>
                  </a:lnTo>
                  <a:lnTo>
                    <a:pt x="1345" y="504"/>
                  </a:lnTo>
                  <a:lnTo>
                    <a:pt x="1345" y="403"/>
                  </a:lnTo>
                  <a:lnTo>
                    <a:pt x="1350" y="302"/>
                  </a:lnTo>
                  <a:lnTo>
                    <a:pt x="1350" y="302"/>
                  </a:lnTo>
                  <a:lnTo>
                    <a:pt x="1354" y="302"/>
                  </a:lnTo>
                  <a:lnTo>
                    <a:pt x="1354" y="202"/>
                  </a:lnTo>
                  <a:lnTo>
                    <a:pt x="1359" y="202"/>
                  </a:lnTo>
                  <a:lnTo>
                    <a:pt x="1359" y="101"/>
                  </a:lnTo>
                  <a:lnTo>
                    <a:pt x="1364" y="101"/>
                  </a:lnTo>
                  <a:lnTo>
                    <a:pt x="1364" y="0"/>
                  </a:lnTo>
                  <a:lnTo>
                    <a:pt x="1368" y="0"/>
                  </a:lnTo>
                  <a:lnTo>
                    <a:pt x="1368" y="0"/>
                  </a:lnTo>
                  <a:lnTo>
                    <a:pt x="1373" y="0"/>
                  </a:lnTo>
                  <a:lnTo>
                    <a:pt x="1373" y="0"/>
                  </a:lnTo>
                  <a:lnTo>
                    <a:pt x="1377" y="0"/>
                  </a:lnTo>
                  <a:lnTo>
                    <a:pt x="1377" y="0"/>
                  </a:lnTo>
                  <a:lnTo>
                    <a:pt x="1382" y="0"/>
                  </a:lnTo>
                  <a:lnTo>
                    <a:pt x="1382" y="101"/>
                  </a:lnTo>
                  <a:lnTo>
                    <a:pt x="1387" y="202"/>
                  </a:lnTo>
                  <a:lnTo>
                    <a:pt x="1387" y="202"/>
                  </a:lnTo>
                  <a:lnTo>
                    <a:pt x="1391" y="202"/>
                  </a:lnTo>
                  <a:lnTo>
                    <a:pt x="1391" y="202"/>
                  </a:lnTo>
                  <a:lnTo>
                    <a:pt x="1391" y="202"/>
                  </a:lnTo>
                  <a:lnTo>
                    <a:pt x="1396" y="202"/>
                  </a:lnTo>
                  <a:lnTo>
                    <a:pt x="1396" y="202"/>
                  </a:lnTo>
                  <a:lnTo>
                    <a:pt x="1401" y="202"/>
                  </a:lnTo>
                  <a:lnTo>
                    <a:pt x="1401" y="202"/>
                  </a:lnTo>
                  <a:lnTo>
                    <a:pt x="1405" y="202"/>
                  </a:lnTo>
                  <a:lnTo>
                    <a:pt x="1405" y="202"/>
                  </a:lnTo>
                  <a:lnTo>
                    <a:pt x="1410" y="202"/>
                  </a:lnTo>
                  <a:lnTo>
                    <a:pt x="1410" y="302"/>
                  </a:lnTo>
                  <a:lnTo>
                    <a:pt x="1415" y="302"/>
                  </a:lnTo>
                  <a:lnTo>
                    <a:pt x="1415" y="302"/>
                  </a:lnTo>
                  <a:lnTo>
                    <a:pt x="1419" y="302"/>
                  </a:lnTo>
                  <a:lnTo>
                    <a:pt x="1419" y="302"/>
                  </a:lnTo>
                  <a:lnTo>
                    <a:pt x="1424" y="302"/>
                  </a:lnTo>
                  <a:lnTo>
                    <a:pt x="1424" y="302"/>
                  </a:lnTo>
                  <a:lnTo>
                    <a:pt x="1429" y="302"/>
                  </a:lnTo>
                  <a:lnTo>
                    <a:pt x="1429" y="302"/>
                  </a:lnTo>
                  <a:lnTo>
                    <a:pt x="1433" y="302"/>
                  </a:lnTo>
                  <a:lnTo>
                    <a:pt x="1433" y="302"/>
                  </a:lnTo>
                  <a:lnTo>
                    <a:pt x="1438" y="302"/>
                  </a:lnTo>
                  <a:lnTo>
                    <a:pt x="1438" y="302"/>
                  </a:lnTo>
                  <a:lnTo>
                    <a:pt x="1442" y="302"/>
                  </a:lnTo>
                  <a:lnTo>
                    <a:pt x="1442" y="302"/>
                  </a:lnTo>
                  <a:lnTo>
                    <a:pt x="1447" y="302"/>
                  </a:lnTo>
                  <a:lnTo>
                    <a:pt x="1447" y="302"/>
                  </a:lnTo>
                  <a:lnTo>
                    <a:pt x="1452" y="302"/>
                  </a:lnTo>
                  <a:lnTo>
                    <a:pt x="1452" y="302"/>
                  </a:lnTo>
                  <a:lnTo>
                    <a:pt x="1456" y="504"/>
                  </a:lnTo>
                  <a:lnTo>
                    <a:pt x="1456" y="504"/>
                  </a:lnTo>
                  <a:lnTo>
                    <a:pt x="1456" y="605"/>
                  </a:lnTo>
                  <a:lnTo>
                    <a:pt x="1461" y="605"/>
                  </a:lnTo>
                  <a:lnTo>
                    <a:pt x="1461" y="605"/>
                  </a:lnTo>
                  <a:lnTo>
                    <a:pt x="1466" y="605"/>
                  </a:lnTo>
                  <a:lnTo>
                    <a:pt x="1466" y="706"/>
                  </a:lnTo>
                  <a:lnTo>
                    <a:pt x="1470" y="706"/>
                  </a:lnTo>
                  <a:lnTo>
                    <a:pt x="1470" y="806"/>
                  </a:lnTo>
                  <a:lnTo>
                    <a:pt x="1475" y="806"/>
                  </a:lnTo>
                  <a:lnTo>
                    <a:pt x="1475" y="907"/>
                  </a:lnTo>
                  <a:lnTo>
                    <a:pt x="1480" y="907"/>
                  </a:lnTo>
                  <a:lnTo>
                    <a:pt x="1480" y="907"/>
                  </a:lnTo>
                  <a:lnTo>
                    <a:pt x="1484" y="907"/>
                  </a:lnTo>
                  <a:lnTo>
                    <a:pt x="1484" y="907"/>
                  </a:lnTo>
                  <a:lnTo>
                    <a:pt x="1489" y="806"/>
                  </a:lnTo>
                  <a:lnTo>
                    <a:pt x="1489" y="806"/>
                  </a:lnTo>
                  <a:lnTo>
                    <a:pt x="1493" y="806"/>
                  </a:lnTo>
                  <a:lnTo>
                    <a:pt x="1493" y="706"/>
                  </a:lnTo>
                  <a:lnTo>
                    <a:pt x="1498" y="706"/>
                  </a:lnTo>
                  <a:lnTo>
                    <a:pt x="1498" y="706"/>
                  </a:lnTo>
                  <a:lnTo>
                    <a:pt x="1503" y="706"/>
                  </a:lnTo>
                  <a:lnTo>
                    <a:pt x="1503" y="706"/>
                  </a:lnTo>
                  <a:lnTo>
                    <a:pt x="1507" y="706"/>
                  </a:lnTo>
                  <a:lnTo>
                    <a:pt x="1507" y="706"/>
                  </a:lnTo>
                  <a:lnTo>
                    <a:pt x="1512" y="706"/>
                  </a:lnTo>
                  <a:lnTo>
                    <a:pt x="1512" y="706"/>
                  </a:lnTo>
                  <a:lnTo>
                    <a:pt x="1517" y="706"/>
                  </a:lnTo>
                  <a:lnTo>
                    <a:pt x="1517" y="706"/>
                  </a:lnTo>
                  <a:lnTo>
                    <a:pt x="1521" y="706"/>
                  </a:lnTo>
                  <a:lnTo>
                    <a:pt x="1521" y="706"/>
                  </a:lnTo>
                  <a:lnTo>
                    <a:pt x="1526" y="706"/>
                  </a:lnTo>
                  <a:lnTo>
                    <a:pt x="1526" y="706"/>
                  </a:lnTo>
                  <a:lnTo>
                    <a:pt x="1526" y="706"/>
                  </a:lnTo>
                  <a:lnTo>
                    <a:pt x="1531" y="605"/>
                  </a:lnTo>
                  <a:lnTo>
                    <a:pt x="1531" y="605"/>
                  </a:lnTo>
                  <a:lnTo>
                    <a:pt x="1535" y="605"/>
                  </a:lnTo>
                  <a:lnTo>
                    <a:pt x="1535" y="605"/>
                  </a:lnTo>
                  <a:lnTo>
                    <a:pt x="1540" y="605"/>
                  </a:lnTo>
                  <a:lnTo>
                    <a:pt x="1540" y="605"/>
                  </a:lnTo>
                  <a:lnTo>
                    <a:pt x="1544" y="605"/>
                  </a:lnTo>
                  <a:lnTo>
                    <a:pt x="1544" y="605"/>
                  </a:lnTo>
                  <a:lnTo>
                    <a:pt x="1549" y="605"/>
                  </a:lnTo>
                  <a:lnTo>
                    <a:pt x="1549" y="605"/>
                  </a:lnTo>
                  <a:lnTo>
                    <a:pt x="1554" y="605"/>
                  </a:lnTo>
                  <a:lnTo>
                    <a:pt x="1554" y="605"/>
                  </a:lnTo>
                  <a:lnTo>
                    <a:pt x="1558" y="605"/>
                  </a:lnTo>
                  <a:lnTo>
                    <a:pt x="1558" y="605"/>
                  </a:lnTo>
                  <a:lnTo>
                    <a:pt x="1563" y="605"/>
                  </a:lnTo>
                  <a:lnTo>
                    <a:pt x="1563" y="605"/>
                  </a:lnTo>
                  <a:lnTo>
                    <a:pt x="1568" y="605"/>
                  </a:lnTo>
                  <a:lnTo>
                    <a:pt x="1568" y="605"/>
                  </a:lnTo>
                  <a:lnTo>
                    <a:pt x="1572" y="605"/>
                  </a:lnTo>
                  <a:lnTo>
                    <a:pt x="1572" y="706"/>
                  </a:lnTo>
                  <a:lnTo>
                    <a:pt x="1577" y="706"/>
                  </a:lnTo>
                  <a:lnTo>
                    <a:pt x="1577" y="706"/>
                  </a:lnTo>
                  <a:lnTo>
                    <a:pt x="1582" y="706"/>
                  </a:lnTo>
                  <a:lnTo>
                    <a:pt x="1582" y="706"/>
                  </a:lnTo>
                  <a:lnTo>
                    <a:pt x="1586" y="706"/>
                  </a:lnTo>
                  <a:lnTo>
                    <a:pt x="1586" y="706"/>
                  </a:lnTo>
                  <a:lnTo>
                    <a:pt x="1591" y="706"/>
                  </a:lnTo>
                  <a:lnTo>
                    <a:pt x="1591" y="706"/>
                  </a:lnTo>
                  <a:lnTo>
                    <a:pt x="1591" y="706"/>
                  </a:lnTo>
                  <a:lnTo>
                    <a:pt x="1595" y="706"/>
                  </a:lnTo>
                  <a:lnTo>
                    <a:pt x="1595" y="706"/>
                  </a:lnTo>
                  <a:lnTo>
                    <a:pt x="1600" y="706"/>
                  </a:lnTo>
                  <a:lnTo>
                    <a:pt x="1600" y="706"/>
                  </a:lnTo>
                  <a:lnTo>
                    <a:pt x="1605" y="706"/>
                  </a:lnTo>
                  <a:lnTo>
                    <a:pt x="1605" y="806"/>
                  </a:lnTo>
                  <a:lnTo>
                    <a:pt x="1609" y="806"/>
                  </a:lnTo>
                  <a:lnTo>
                    <a:pt x="1609" y="806"/>
                  </a:lnTo>
                  <a:lnTo>
                    <a:pt x="1614" y="806"/>
                  </a:lnTo>
                  <a:lnTo>
                    <a:pt x="1614" y="806"/>
                  </a:lnTo>
                  <a:lnTo>
                    <a:pt x="1619" y="806"/>
                  </a:lnTo>
                  <a:lnTo>
                    <a:pt x="1619" y="806"/>
                  </a:lnTo>
                  <a:lnTo>
                    <a:pt x="1623" y="806"/>
                  </a:lnTo>
                  <a:lnTo>
                    <a:pt x="1623" y="806"/>
                  </a:lnTo>
                  <a:lnTo>
                    <a:pt x="1628" y="806"/>
                  </a:lnTo>
                  <a:lnTo>
                    <a:pt x="1628" y="806"/>
                  </a:lnTo>
                  <a:lnTo>
                    <a:pt x="1633" y="806"/>
                  </a:lnTo>
                  <a:lnTo>
                    <a:pt x="1633" y="806"/>
                  </a:lnTo>
                  <a:lnTo>
                    <a:pt x="1637" y="806"/>
                  </a:lnTo>
                  <a:lnTo>
                    <a:pt x="1637" y="806"/>
                  </a:lnTo>
                  <a:lnTo>
                    <a:pt x="1642" y="806"/>
                  </a:lnTo>
                  <a:lnTo>
                    <a:pt x="1642" y="907"/>
                  </a:lnTo>
                  <a:lnTo>
                    <a:pt x="1646" y="907"/>
                  </a:lnTo>
                  <a:lnTo>
                    <a:pt x="1646" y="907"/>
                  </a:lnTo>
                  <a:lnTo>
                    <a:pt x="1651" y="907"/>
                  </a:lnTo>
                  <a:lnTo>
                    <a:pt x="1651" y="907"/>
                  </a:lnTo>
                  <a:lnTo>
                    <a:pt x="1656" y="907"/>
                  </a:lnTo>
                  <a:lnTo>
                    <a:pt x="1656" y="907"/>
                  </a:lnTo>
                  <a:lnTo>
                    <a:pt x="1656" y="907"/>
                  </a:lnTo>
                  <a:lnTo>
                    <a:pt x="1660" y="907"/>
                  </a:lnTo>
                  <a:lnTo>
                    <a:pt x="1660" y="907"/>
                  </a:lnTo>
                  <a:lnTo>
                    <a:pt x="1665" y="907"/>
                  </a:lnTo>
                  <a:lnTo>
                    <a:pt x="1665" y="907"/>
                  </a:lnTo>
                  <a:lnTo>
                    <a:pt x="1670" y="907"/>
                  </a:lnTo>
                  <a:lnTo>
                    <a:pt x="1670" y="907"/>
                  </a:lnTo>
                  <a:lnTo>
                    <a:pt x="1674" y="907"/>
                  </a:lnTo>
                  <a:lnTo>
                    <a:pt x="1674" y="907"/>
                  </a:lnTo>
                  <a:lnTo>
                    <a:pt x="1679" y="907"/>
                  </a:lnTo>
                  <a:lnTo>
                    <a:pt x="1679" y="907"/>
                  </a:lnTo>
                  <a:lnTo>
                    <a:pt x="1684" y="907"/>
                  </a:lnTo>
                  <a:lnTo>
                    <a:pt x="1684" y="806"/>
                  </a:lnTo>
                  <a:lnTo>
                    <a:pt x="1688" y="806"/>
                  </a:lnTo>
                  <a:lnTo>
                    <a:pt x="1688" y="806"/>
                  </a:lnTo>
                  <a:lnTo>
                    <a:pt x="1693" y="806"/>
                  </a:lnTo>
                  <a:lnTo>
                    <a:pt x="1693" y="806"/>
                  </a:lnTo>
                  <a:lnTo>
                    <a:pt x="1698" y="706"/>
                  </a:lnTo>
                  <a:lnTo>
                    <a:pt x="1698" y="706"/>
                  </a:lnTo>
                  <a:lnTo>
                    <a:pt x="1702" y="706"/>
                  </a:lnTo>
                  <a:lnTo>
                    <a:pt x="1702" y="706"/>
                  </a:lnTo>
                  <a:lnTo>
                    <a:pt x="1707" y="706"/>
                  </a:lnTo>
                  <a:lnTo>
                    <a:pt x="1707" y="706"/>
                  </a:lnTo>
                  <a:lnTo>
                    <a:pt x="1711" y="706"/>
                  </a:lnTo>
                  <a:lnTo>
                    <a:pt x="1711" y="806"/>
                  </a:lnTo>
                  <a:lnTo>
                    <a:pt x="1716" y="806"/>
                  </a:lnTo>
                  <a:lnTo>
                    <a:pt x="1716" y="806"/>
                  </a:lnTo>
                  <a:lnTo>
                    <a:pt x="1721" y="806"/>
                  </a:lnTo>
                  <a:lnTo>
                    <a:pt x="1721" y="806"/>
                  </a:lnTo>
                  <a:lnTo>
                    <a:pt x="1721" y="806"/>
                  </a:lnTo>
                  <a:lnTo>
                    <a:pt x="1725" y="806"/>
                  </a:lnTo>
                  <a:lnTo>
                    <a:pt x="1725" y="806"/>
                  </a:lnTo>
                  <a:lnTo>
                    <a:pt x="1730" y="806"/>
                  </a:lnTo>
                  <a:lnTo>
                    <a:pt x="1730" y="806"/>
                  </a:lnTo>
                  <a:lnTo>
                    <a:pt x="1735" y="806"/>
                  </a:lnTo>
                  <a:lnTo>
                    <a:pt x="1735" y="806"/>
                  </a:lnTo>
                  <a:lnTo>
                    <a:pt x="1739" y="806"/>
                  </a:lnTo>
                  <a:lnTo>
                    <a:pt x="1739" y="806"/>
                  </a:lnTo>
                  <a:lnTo>
                    <a:pt x="1744" y="806"/>
                  </a:lnTo>
                  <a:lnTo>
                    <a:pt x="1744" y="706"/>
                  </a:lnTo>
                  <a:lnTo>
                    <a:pt x="1749" y="706"/>
                  </a:lnTo>
                  <a:lnTo>
                    <a:pt x="1749" y="706"/>
                  </a:lnTo>
                  <a:lnTo>
                    <a:pt x="1753" y="706"/>
                  </a:lnTo>
                  <a:lnTo>
                    <a:pt x="1753" y="706"/>
                  </a:lnTo>
                  <a:lnTo>
                    <a:pt x="1758" y="706"/>
                  </a:lnTo>
                  <a:lnTo>
                    <a:pt x="1758" y="706"/>
                  </a:lnTo>
                  <a:lnTo>
                    <a:pt x="1762" y="706"/>
                  </a:lnTo>
                  <a:lnTo>
                    <a:pt x="1762" y="706"/>
                  </a:lnTo>
                  <a:lnTo>
                    <a:pt x="1767" y="706"/>
                  </a:lnTo>
                  <a:lnTo>
                    <a:pt x="1767" y="706"/>
                  </a:lnTo>
                  <a:lnTo>
                    <a:pt x="1772" y="706"/>
                  </a:lnTo>
                  <a:lnTo>
                    <a:pt x="1772" y="706"/>
                  </a:lnTo>
                  <a:lnTo>
                    <a:pt x="1776" y="706"/>
                  </a:lnTo>
                  <a:lnTo>
                    <a:pt x="1776" y="706"/>
                  </a:lnTo>
                  <a:lnTo>
                    <a:pt x="1781" y="706"/>
                  </a:lnTo>
                  <a:lnTo>
                    <a:pt x="1781" y="706"/>
                  </a:lnTo>
                  <a:lnTo>
                    <a:pt x="1786" y="706"/>
                  </a:lnTo>
                  <a:lnTo>
                    <a:pt x="1786" y="706"/>
                  </a:lnTo>
                  <a:lnTo>
                    <a:pt x="1790" y="706"/>
                  </a:lnTo>
                  <a:lnTo>
                    <a:pt x="1790" y="706"/>
                  </a:lnTo>
                  <a:lnTo>
                    <a:pt x="1790" y="706"/>
                  </a:lnTo>
                  <a:lnTo>
                    <a:pt x="1795" y="706"/>
                  </a:lnTo>
                  <a:lnTo>
                    <a:pt x="1795" y="806"/>
                  </a:lnTo>
                  <a:lnTo>
                    <a:pt x="1800" y="806"/>
                  </a:lnTo>
                  <a:lnTo>
                    <a:pt x="1800" y="806"/>
                  </a:lnTo>
                  <a:lnTo>
                    <a:pt x="1804" y="806"/>
                  </a:lnTo>
                  <a:lnTo>
                    <a:pt x="1804" y="806"/>
                  </a:lnTo>
                  <a:lnTo>
                    <a:pt x="1809" y="907"/>
                  </a:lnTo>
                  <a:lnTo>
                    <a:pt x="1809" y="907"/>
                  </a:lnTo>
                  <a:lnTo>
                    <a:pt x="1813" y="907"/>
                  </a:lnTo>
                  <a:lnTo>
                    <a:pt x="1813" y="907"/>
                  </a:lnTo>
                  <a:lnTo>
                    <a:pt x="1818" y="907"/>
                  </a:lnTo>
                  <a:lnTo>
                    <a:pt x="1818" y="907"/>
                  </a:lnTo>
                  <a:lnTo>
                    <a:pt x="1823" y="907"/>
                  </a:lnTo>
                  <a:lnTo>
                    <a:pt x="1823" y="907"/>
                  </a:lnTo>
                  <a:lnTo>
                    <a:pt x="1827" y="907"/>
                  </a:lnTo>
                  <a:lnTo>
                    <a:pt x="1827" y="907"/>
                  </a:lnTo>
                  <a:lnTo>
                    <a:pt x="1832" y="907"/>
                  </a:lnTo>
                  <a:lnTo>
                    <a:pt x="1832" y="907"/>
                  </a:lnTo>
                  <a:lnTo>
                    <a:pt x="1837" y="907"/>
                  </a:lnTo>
                  <a:lnTo>
                    <a:pt x="1837" y="907"/>
                  </a:lnTo>
                  <a:lnTo>
                    <a:pt x="1841" y="907"/>
                  </a:lnTo>
                  <a:lnTo>
                    <a:pt x="1841" y="907"/>
                  </a:lnTo>
                  <a:lnTo>
                    <a:pt x="1846" y="907"/>
                  </a:lnTo>
                  <a:lnTo>
                    <a:pt x="1846" y="907"/>
                  </a:lnTo>
                  <a:lnTo>
                    <a:pt x="1851" y="907"/>
                  </a:lnTo>
                  <a:lnTo>
                    <a:pt x="1851" y="907"/>
                  </a:lnTo>
                  <a:lnTo>
                    <a:pt x="1855" y="907"/>
                  </a:lnTo>
                  <a:lnTo>
                    <a:pt x="1855" y="907"/>
                  </a:lnTo>
                  <a:lnTo>
                    <a:pt x="1855" y="1008"/>
                  </a:lnTo>
                  <a:lnTo>
                    <a:pt x="1860" y="1008"/>
                  </a:lnTo>
                  <a:lnTo>
                    <a:pt x="1860" y="1008"/>
                  </a:lnTo>
                  <a:lnTo>
                    <a:pt x="1864" y="1008"/>
                  </a:lnTo>
                  <a:lnTo>
                    <a:pt x="1864" y="1008"/>
                  </a:lnTo>
                  <a:lnTo>
                    <a:pt x="1869" y="1008"/>
                  </a:lnTo>
                  <a:lnTo>
                    <a:pt x="1869" y="1008"/>
                  </a:lnTo>
                  <a:lnTo>
                    <a:pt x="1874" y="1008"/>
                  </a:lnTo>
                  <a:lnTo>
                    <a:pt x="1874" y="1008"/>
                  </a:lnTo>
                  <a:lnTo>
                    <a:pt x="1878" y="1008"/>
                  </a:lnTo>
                  <a:lnTo>
                    <a:pt x="1878" y="1008"/>
                  </a:lnTo>
                  <a:lnTo>
                    <a:pt x="1883" y="1008"/>
                  </a:lnTo>
                  <a:lnTo>
                    <a:pt x="1883" y="1008"/>
                  </a:lnTo>
                  <a:lnTo>
                    <a:pt x="1888" y="1008"/>
                  </a:lnTo>
                  <a:lnTo>
                    <a:pt x="1888" y="907"/>
                  </a:lnTo>
                  <a:lnTo>
                    <a:pt x="1892" y="907"/>
                  </a:lnTo>
                  <a:lnTo>
                    <a:pt x="1892" y="907"/>
                  </a:lnTo>
                  <a:lnTo>
                    <a:pt x="1897" y="907"/>
                  </a:lnTo>
                  <a:lnTo>
                    <a:pt x="1897" y="907"/>
                  </a:lnTo>
                  <a:lnTo>
                    <a:pt x="1902" y="907"/>
                  </a:lnTo>
                  <a:lnTo>
                    <a:pt x="1902" y="907"/>
                  </a:lnTo>
                  <a:lnTo>
                    <a:pt x="1906" y="907"/>
                  </a:lnTo>
                  <a:lnTo>
                    <a:pt x="1906" y="907"/>
                  </a:lnTo>
                  <a:lnTo>
                    <a:pt x="1911" y="907"/>
                  </a:lnTo>
                  <a:lnTo>
                    <a:pt x="1911" y="907"/>
                  </a:lnTo>
                  <a:lnTo>
                    <a:pt x="1915" y="907"/>
                  </a:lnTo>
                  <a:lnTo>
                    <a:pt x="1915" y="907"/>
                  </a:lnTo>
                  <a:lnTo>
                    <a:pt x="1920" y="907"/>
                  </a:lnTo>
                  <a:lnTo>
                    <a:pt x="1920" y="907"/>
                  </a:lnTo>
                  <a:lnTo>
                    <a:pt x="1920" y="907"/>
                  </a:lnTo>
                  <a:lnTo>
                    <a:pt x="1925" y="907"/>
                  </a:lnTo>
                  <a:lnTo>
                    <a:pt x="1925" y="907"/>
                  </a:lnTo>
                  <a:lnTo>
                    <a:pt x="1929" y="907"/>
                  </a:lnTo>
                  <a:lnTo>
                    <a:pt x="1929" y="907"/>
                  </a:lnTo>
                  <a:lnTo>
                    <a:pt x="1934" y="907"/>
                  </a:lnTo>
                  <a:lnTo>
                    <a:pt x="1934" y="907"/>
                  </a:lnTo>
                  <a:lnTo>
                    <a:pt x="1939" y="907"/>
                  </a:lnTo>
                  <a:lnTo>
                    <a:pt x="1939" y="907"/>
                  </a:lnTo>
                  <a:lnTo>
                    <a:pt x="1943" y="907"/>
                  </a:lnTo>
                  <a:lnTo>
                    <a:pt x="1943" y="907"/>
                  </a:lnTo>
                  <a:lnTo>
                    <a:pt x="1948" y="907"/>
                  </a:lnTo>
                  <a:lnTo>
                    <a:pt x="1948" y="907"/>
                  </a:lnTo>
                  <a:lnTo>
                    <a:pt x="1953" y="907"/>
                  </a:lnTo>
                  <a:lnTo>
                    <a:pt x="1953" y="907"/>
                  </a:lnTo>
                  <a:lnTo>
                    <a:pt x="1957" y="907"/>
                  </a:lnTo>
                  <a:lnTo>
                    <a:pt x="1957" y="907"/>
                  </a:lnTo>
                  <a:lnTo>
                    <a:pt x="1962" y="907"/>
                  </a:lnTo>
                  <a:lnTo>
                    <a:pt x="1962" y="907"/>
                  </a:lnTo>
                  <a:lnTo>
                    <a:pt x="1967" y="907"/>
                  </a:lnTo>
                  <a:lnTo>
                    <a:pt x="1967" y="907"/>
                  </a:lnTo>
                  <a:lnTo>
                    <a:pt x="1971" y="907"/>
                  </a:lnTo>
                  <a:lnTo>
                    <a:pt x="1971" y="907"/>
                  </a:lnTo>
                  <a:lnTo>
                    <a:pt x="1976" y="907"/>
                  </a:lnTo>
                  <a:lnTo>
                    <a:pt x="1976" y="907"/>
                  </a:lnTo>
                  <a:lnTo>
                    <a:pt x="1980" y="907"/>
                  </a:lnTo>
                  <a:lnTo>
                    <a:pt x="1980" y="907"/>
                  </a:lnTo>
                  <a:lnTo>
                    <a:pt x="1985" y="907"/>
                  </a:lnTo>
                  <a:lnTo>
                    <a:pt x="1985" y="907"/>
                  </a:lnTo>
                  <a:lnTo>
                    <a:pt x="1990" y="907"/>
                  </a:lnTo>
                  <a:lnTo>
                    <a:pt x="1990" y="907"/>
                  </a:lnTo>
                  <a:lnTo>
                    <a:pt x="1990" y="907"/>
                  </a:lnTo>
                  <a:lnTo>
                    <a:pt x="1994" y="907"/>
                  </a:lnTo>
                  <a:lnTo>
                    <a:pt x="1994" y="907"/>
                  </a:lnTo>
                  <a:lnTo>
                    <a:pt x="1999" y="907"/>
                  </a:lnTo>
                  <a:lnTo>
                    <a:pt x="1999" y="1008"/>
                  </a:lnTo>
                  <a:lnTo>
                    <a:pt x="2004" y="1008"/>
                  </a:lnTo>
                  <a:lnTo>
                    <a:pt x="2004" y="1008"/>
                  </a:lnTo>
                  <a:lnTo>
                    <a:pt x="2008" y="1008"/>
                  </a:lnTo>
                  <a:lnTo>
                    <a:pt x="2008" y="1008"/>
                  </a:lnTo>
                  <a:lnTo>
                    <a:pt x="2013" y="1008"/>
                  </a:lnTo>
                  <a:lnTo>
                    <a:pt x="2013" y="1008"/>
                  </a:lnTo>
                  <a:lnTo>
                    <a:pt x="2018" y="1008"/>
                  </a:lnTo>
                  <a:lnTo>
                    <a:pt x="2018" y="1008"/>
                  </a:lnTo>
                  <a:lnTo>
                    <a:pt x="2022" y="1008"/>
                  </a:lnTo>
                  <a:lnTo>
                    <a:pt x="2022" y="1008"/>
                  </a:lnTo>
                  <a:lnTo>
                    <a:pt x="2027" y="1008"/>
                  </a:lnTo>
                  <a:lnTo>
                    <a:pt x="2027" y="1008"/>
                  </a:lnTo>
                  <a:lnTo>
                    <a:pt x="2031" y="1008"/>
                  </a:lnTo>
                  <a:lnTo>
                    <a:pt x="2031" y="1008"/>
                  </a:lnTo>
                  <a:lnTo>
                    <a:pt x="2036" y="1008"/>
                  </a:lnTo>
                  <a:lnTo>
                    <a:pt x="2036" y="1008"/>
                  </a:lnTo>
                  <a:lnTo>
                    <a:pt x="2041" y="1008"/>
                  </a:lnTo>
                  <a:lnTo>
                    <a:pt x="2041" y="1008"/>
                  </a:lnTo>
                  <a:lnTo>
                    <a:pt x="2045" y="1008"/>
                  </a:lnTo>
                  <a:lnTo>
                    <a:pt x="2045" y="1008"/>
                  </a:lnTo>
                  <a:lnTo>
                    <a:pt x="2050" y="1008"/>
                  </a:lnTo>
                  <a:lnTo>
                    <a:pt x="2050" y="1008"/>
                  </a:lnTo>
                  <a:lnTo>
                    <a:pt x="2055" y="1008"/>
                  </a:lnTo>
                  <a:lnTo>
                    <a:pt x="2055" y="1008"/>
                  </a:lnTo>
                  <a:lnTo>
                    <a:pt x="2055" y="1008"/>
                  </a:lnTo>
                  <a:lnTo>
                    <a:pt x="2059" y="1008"/>
                  </a:lnTo>
                  <a:lnTo>
                    <a:pt x="2059" y="1008"/>
                  </a:lnTo>
                  <a:lnTo>
                    <a:pt x="2064" y="1008"/>
                  </a:lnTo>
                  <a:lnTo>
                    <a:pt x="2064" y="1008"/>
                  </a:lnTo>
                  <a:lnTo>
                    <a:pt x="2069" y="1008"/>
                  </a:lnTo>
                  <a:lnTo>
                    <a:pt x="2069" y="1008"/>
                  </a:lnTo>
                  <a:lnTo>
                    <a:pt x="2073" y="1008"/>
                  </a:lnTo>
                  <a:lnTo>
                    <a:pt x="2073" y="1008"/>
                  </a:lnTo>
                  <a:lnTo>
                    <a:pt x="2078" y="1008"/>
                  </a:lnTo>
                  <a:lnTo>
                    <a:pt x="2078" y="1008"/>
                  </a:lnTo>
                  <a:lnTo>
                    <a:pt x="2082" y="1008"/>
                  </a:lnTo>
                  <a:lnTo>
                    <a:pt x="2082" y="1008"/>
                  </a:lnTo>
                  <a:lnTo>
                    <a:pt x="2087" y="1008"/>
                  </a:lnTo>
                  <a:lnTo>
                    <a:pt x="2087" y="1008"/>
                  </a:lnTo>
                  <a:lnTo>
                    <a:pt x="2092" y="1008"/>
                  </a:lnTo>
                  <a:lnTo>
                    <a:pt x="2092" y="1008"/>
                  </a:lnTo>
                  <a:lnTo>
                    <a:pt x="2096" y="1008"/>
                  </a:lnTo>
                  <a:lnTo>
                    <a:pt x="2096" y="1008"/>
                  </a:lnTo>
                  <a:lnTo>
                    <a:pt x="2101" y="1008"/>
                  </a:lnTo>
                  <a:lnTo>
                    <a:pt x="2101" y="1008"/>
                  </a:lnTo>
                  <a:lnTo>
                    <a:pt x="2106" y="1008"/>
                  </a:lnTo>
                  <a:lnTo>
                    <a:pt x="2106" y="1008"/>
                  </a:lnTo>
                  <a:lnTo>
                    <a:pt x="2110" y="1008"/>
                  </a:lnTo>
                  <a:lnTo>
                    <a:pt x="2110" y="1008"/>
                  </a:lnTo>
                  <a:lnTo>
                    <a:pt x="2115" y="1008"/>
                  </a:lnTo>
                  <a:lnTo>
                    <a:pt x="2115" y="1008"/>
                  </a:lnTo>
                  <a:lnTo>
                    <a:pt x="2120" y="1008"/>
                  </a:lnTo>
                  <a:lnTo>
                    <a:pt x="2120" y="1008"/>
                  </a:lnTo>
                  <a:lnTo>
                    <a:pt x="2120" y="1008"/>
                  </a:lnTo>
                  <a:lnTo>
                    <a:pt x="2124" y="1008"/>
                  </a:lnTo>
                  <a:lnTo>
                    <a:pt x="2124" y="1008"/>
                  </a:lnTo>
                  <a:lnTo>
                    <a:pt x="2129" y="1008"/>
                  </a:lnTo>
                  <a:lnTo>
                    <a:pt x="2129" y="1008"/>
                  </a:lnTo>
                  <a:lnTo>
                    <a:pt x="2133" y="1008"/>
                  </a:lnTo>
                  <a:lnTo>
                    <a:pt x="2133" y="1008"/>
                  </a:lnTo>
                  <a:lnTo>
                    <a:pt x="2138" y="1008"/>
                  </a:lnTo>
                  <a:lnTo>
                    <a:pt x="2138" y="1008"/>
                  </a:lnTo>
                  <a:lnTo>
                    <a:pt x="2143" y="1008"/>
                  </a:lnTo>
                  <a:lnTo>
                    <a:pt x="2143" y="1008"/>
                  </a:lnTo>
                  <a:lnTo>
                    <a:pt x="2147" y="1008"/>
                  </a:lnTo>
                  <a:lnTo>
                    <a:pt x="2147" y="1008"/>
                  </a:lnTo>
                  <a:lnTo>
                    <a:pt x="2152" y="1008"/>
                  </a:lnTo>
                  <a:lnTo>
                    <a:pt x="2152" y="1008"/>
                  </a:lnTo>
                  <a:lnTo>
                    <a:pt x="2157" y="1008"/>
                  </a:lnTo>
                  <a:lnTo>
                    <a:pt x="2157" y="1008"/>
                  </a:lnTo>
                  <a:lnTo>
                    <a:pt x="2161" y="1008"/>
                  </a:lnTo>
                  <a:lnTo>
                    <a:pt x="2161" y="1008"/>
                  </a:lnTo>
                  <a:lnTo>
                    <a:pt x="2166" y="1008"/>
                  </a:lnTo>
                  <a:lnTo>
                    <a:pt x="2166" y="1008"/>
                  </a:lnTo>
                  <a:lnTo>
                    <a:pt x="2171" y="1008"/>
                  </a:lnTo>
                  <a:lnTo>
                    <a:pt x="2171" y="1008"/>
                  </a:lnTo>
                  <a:lnTo>
                    <a:pt x="2175" y="1008"/>
                  </a:lnTo>
                  <a:lnTo>
                    <a:pt x="2175" y="1008"/>
                  </a:lnTo>
                  <a:lnTo>
                    <a:pt x="2180" y="1008"/>
                  </a:lnTo>
                  <a:lnTo>
                    <a:pt x="2180" y="1008"/>
                  </a:lnTo>
                  <a:lnTo>
                    <a:pt x="2184" y="1008"/>
                  </a:lnTo>
                  <a:lnTo>
                    <a:pt x="2184" y="1008"/>
                  </a:lnTo>
                  <a:lnTo>
                    <a:pt x="2184" y="1008"/>
                  </a:lnTo>
                  <a:lnTo>
                    <a:pt x="2189" y="1008"/>
                  </a:lnTo>
                  <a:lnTo>
                    <a:pt x="2189" y="1008"/>
                  </a:lnTo>
                  <a:lnTo>
                    <a:pt x="2194" y="1008"/>
                  </a:lnTo>
                  <a:lnTo>
                    <a:pt x="2194" y="1008"/>
                  </a:lnTo>
                  <a:lnTo>
                    <a:pt x="2198" y="1008"/>
                  </a:lnTo>
                  <a:lnTo>
                    <a:pt x="2198" y="1008"/>
                  </a:lnTo>
                  <a:lnTo>
                    <a:pt x="2203" y="1008"/>
                  </a:lnTo>
                  <a:lnTo>
                    <a:pt x="2203" y="1008"/>
                  </a:lnTo>
                  <a:lnTo>
                    <a:pt x="2208" y="1008"/>
                  </a:lnTo>
                  <a:lnTo>
                    <a:pt x="2208" y="1008"/>
                  </a:lnTo>
                  <a:lnTo>
                    <a:pt x="2212" y="1008"/>
                  </a:lnTo>
                  <a:lnTo>
                    <a:pt x="2212" y="1008"/>
                  </a:lnTo>
                  <a:lnTo>
                    <a:pt x="2217" y="1008"/>
                  </a:lnTo>
                  <a:lnTo>
                    <a:pt x="2217" y="1008"/>
                  </a:lnTo>
                  <a:lnTo>
                    <a:pt x="2222" y="1008"/>
                  </a:lnTo>
                  <a:lnTo>
                    <a:pt x="2222" y="1008"/>
                  </a:lnTo>
                  <a:lnTo>
                    <a:pt x="2226" y="1008"/>
                  </a:lnTo>
                  <a:lnTo>
                    <a:pt x="2226" y="1008"/>
                  </a:lnTo>
                  <a:lnTo>
                    <a:pt x="2231" y="1008"/>
                  </a:lnTo>
                  <a:lnTo>
                    <a:pt x="2231" y="1008"/>
                  </a:lnTo>
                  <a:lnTo>
                    <a:pt x="2236" y="1008"/>
                  </a:lnTo>
                  <a:lnTo>
                    <a:pt x="2236" y="1008"/>
                  </a:lnTo>
                  <a:lnTo>
                    <a:pt x="2240" y="1008"/>
                  </a:lnTo>
                  <a:lnTo>
                    <a:pt x="2240" y="1008"/>
                  </a:lnTo>
                  <a:lnTo>
                    <a:pt x="2245" y="1008"/>
                  </a:lnTo>
                  <a:lnTo>
                    <a:pt x="2245" y="1008"/>
                  </a:lnTo>
                  <a:lnTo>
                    <a:pt x="2249" y="1008"/>
                  </a:lnTo>
                  <a:lnTo>
                    <a:pt x="2249" y="1008"/>
                  </a:lnTo>
                  <a:lnTo>
                    <a:pt x="2254" y="1008"/>
                  </a:lnTo>
                  <a:lnTo>
                    <a:pt x="2254" y="1008"/>
                  </a:lnTo>
                  <a:lnTo>
                    <a:pt x="2254" y="1008"/>
                  </a:lnTo>
                  <a:lnTo>
                    <a:pt x="2259" y="1008"/>
                  </a:lnTo>
                  <a:lnTo>
                    <a:pt x="2259" y="1008"/>
                  </a:lnTo>
                  <a:lnTo>
                    <a:pt x="2263" y="1008"/>
                  </a:lnTo>
                  <a:lnTo>
                    <a:pt x="2263" y="1008"/>
                  </a:lnTo>
                  <a:lnTo>
                    <a:pt x="2268" y="1008"/>
                  </a:lnTo>
                  <a:lnTo>
                    <a:pt x="2268" y="1008"/>
                  </a:lnTo>
                  <a:lnTo>
                    <a:pt x="2273" y="1008"/>
                  </a:lnTo>
                  <a:lnTo>
                    <a:pt x="2273" y="1008"/>
                  </a:lnTo>
                  <a:lnTo>
                    <a:pt x="2277" y="1008"/>
                  </a:lnTo>
                  <a:lnTo>
                    <a:pt x="2277" y="1008"/>
                  </a:lnTo>
                  <a:lnTo>
                    <a:pt x="2282" y="1008"/>
                  </a:lnTo>
                  <a:lnTo>
                    <a:pt x="2282" y="1008"/>
                  </a:lnTo>
                  <a:lnTo>
                    <a:pt x="2287" y="1008"/>
                  </a:lnTo>
                  <a:lnTo>
                    <a:pt x="2287" y="1008"/>
                  </a:lnTo>
                  <a:lnTo>
                    <a:pt x="2291" y="1008"/>
                  </a:lnTo>
                  <a:lnTo>
                    <a:pt x="2291" y="1008"/>
                  </a:lnTo>
                  <a:lnTo>
                    <a:pt x="2296" y="1008"/>
                  </a:lnTo>
                  <a:lnTo>
                    <a:pt x="2296" y="1008"/>
                  </a:lnTo>
                  <a:lnTo>
                    <a:pt x="2300" y="1008"/>
                  </a:lnTo>
                  <a:lnTo>
                    <a:pt x="2300" y="1008"/>
                  </a:lnTo>
                  <a:lnTo>
                    <a:pt x="2305" y="1008"/>
                  </a:lnTo>
                  <a:lnTo>
                    <a:pt x="2305" y="1008"/>
                  </a:lnTo>
                  <a:lnTo>
                    <a:pt x="2310" y="1008"/>
                  </a:lnTo>
                  <a:lnTo>
                    <a:pt x="2310" y="1008"/>
                  </a:lnTo>
                  <a:lnTo>
                    <a:pt x="2521" y="1008"/>
                  </a:lnTo>
                  <a:lnTo>
                    <a:pt x="2314" y="1008"/>
                  </a:lnTo>
                  <a:lnTo>
                    <a:pt x="2319" y="1008"/>
                  </a:lnTo>
                  <a:lnTo>
                    <a:pt x="2319" y="1008"/>
                  </a:lnTo>
                  <a:lnTo>
                    <a:pt x="2319" y="1008"/>
                  </a:lnTo>
                  <a:lnTo>
                    <a:pt x="2319" y="1008"/>
                  </a:lnTo>
                  <a:lnTo>
                    <a:pt x="2314" y="1008"/>
                  </a:lnTo>
                  <a:lnTo>
                    <a:pt x="2314" y="1008"/>
                  </a:lnTo>
                  <a:lnTo>
                    <a:pt x="2310" y="1008"/>
                  </a:lnTo>
                  <a:lnTo>
                    <a:pt x="2310" y="1008"/>
                  </a:lnTo>
                  <a:lnTo>
                    <a:pt x="2305" y="1008"/>
                  </a:lnTo>
                  <a:lnTo>
                    <a:pt x="2305" y="1008"/>
                  </a:lnTo>
                  <a:lnTo>
                    <a:pt x="2300" y="1008"/>
                  </a:lnTo>
                  <a:lnTo>
                    <a:pt x="2300" y="1008"/>
                  </a:lnTo>
                  <a:lnTo>
                    <a:pt x="2296" y="1008"/>
                  </a:lnTo>
                  <a:lnTo>
                    <a:pt x="2296" y="1008"/>
                  </a:lnTo>
                  <a:lnTo>
                    <a:pt x="2291" y="1008"/>
                  </a:lnTo>
                  <a:lnTo>
                    <a:pt x="2291" y="1008"/>
                  </a:lnTo>
                  <a:lnTo>
                    <a:pt x="2287" y="1008"/>
                  </a:lnTo>
                  <a:lnTo>
                    <a:pt x="2287" y="1008"/>
                  </a:lnTo>
                  <a:lnTo>
                    <a:pt x="2282" y="1008"/>
                  </a:lnTo>
                  <a:lnTo>
                    <a:pt x="2282" y="1008"/>
                  </a:lnTo>
                  <a:lnTo>
                    <a:pt x="2277" y="1008"/>
                  </a:lnTo>
                  <a:lnTo>
                    <a:pt x="2277" y="1008"/>
                  </a:lnTo>
                  <a:lnTo>
                    <a:pt x="2273" y="1008"/>
                  </a:lnTo>
                  <a:lnTo>
                    <a:pt x="2273" y="1008"/>
                  </a:lnTo>
                  <a:lnTo>
                    <a:pt x="2268" y="1008"/>
                  </a:lnTo>
                  <a:lnTo>
                    <a:pt x="2268" y="1008"/>
                  </a:lnTo>
                  <a:lnTo>
                    <a:pt x="2263" y="1008"/>
                  </a:lnTo>
                  <a:lnTo>
                    <a:pt x="2263" y="1008"/>
                  </a:lnTo>
                  <a:lnTo>
                    <a:pt x="2259" y="1008"/>
                  </a:lnTo>
                  <a:lnTo>
                    <a:pt x="2259" y="1008"/>
                  </a:lnTo>
                  <a:lnTo>
                    <a:pt x="2254" y="1008"/>
                  </a:lnTo>
                  <a:lnTo>
                    <a:pt x="2254" y="1008"/>
                  </a:lnTo>
                  <a:lnTo>
                    <a:pt x="2254" y="1008"/>
                  </a:lnTo>
                  <a:lnTo>
                    <a:pt x="2249" y="1008"/>
                  </a:lnTo>
                  <a:lnTo>
                    <a:pt x="2249" y="1008"/>
                  </a:lnTo>
                  <a:lnTo>
                    <a:pt x="2245" y="1008"/>
                  </a:lnTo>
                  <a:lnTo>
                    <a:pt x="2245" y="1008"/>
                  </a:lnTo>
                  <a:lnTo>
                    <a:pt x="2240" y="1008"/>
                  </a:lnTo>
                  <a:lnTo>
                    <a:pt x="2240" y="1008"/>
                  </a:lnTo>
                  <a:lnTo>
                    <a:pt x="2236" y="1008"/>
                  </a:lnTo>
                  <a:lnTo>
                    <a:pt x="2236" y="1008"/>
                  </a:lnTo>
                  <a:lnTo>
                    <a:pt x="2231" y="1008"/>
                  </a:lnTo>
                  <a:lnTo>
                    <a:pt x="2231" y="1008"/>
                  </a:lnTo>
                  <a:lnTo>
                    <a:pt x="2226" y="1008"/>
                  </a:lnTo>
                  <a:lnTo>
                    <a:pt x="2226" y="1008"/>
                  </a:lnTo>
                  <a:lnTo>
                    <a:pt x="2222" y="1008"/>
                  </a:lnTo>
                  <a:lnTo>
                    <a:pt x="2222" y="1008"/>
                  </a:lnTo>
                  <a:lnTo>
                    <a:pt x="2217" y="1008"/>
                  </a:lnTo>
                  <a:lnTo>
                    <a:pt x="2217" y="1008"/>
                  </a:lnTo>
                  <a:lnTo>
                    <a:pt x="2212" y="1008"/>
                  </a:lnTo>
                  <a:lnTo>
                    <a:pt x="2212" y="1008"/>
                  </a:lnTo>
                  <a:lnTo>
                    <a:pt x="2208" y="1008"/>
                  </a:lnTo>
                  <a:lnTo>
                    <a:pt x="2208" y="1008"/>
                  </a:lnTo>
                  <a:lnTo>
                    <a:pt x="2203" y="1008"/>
                  </a:lnTo>
                  <a:lnTo>
                    <a:pt x="2203" y="1008"/>
                  </a:lnTo>
                  <a:lnTo>
                    <a:pt x="2198" y="1008"/>
                  </a:lnTo>
                  <a:lnTo>
                    <a:pt x="2198" y="1008"/>
                  </a:lnTo>
                  <a:lnTo>
                    <a:pt x="2194" y="1008"/>
                  </a:lnTo>
                  <a:lnTo>
                    <a:pt x="2194" y="1008"/>
                  </a:lnTo>
                  <a:lnTo>
                    <a:pt x="2189" y="1008"/>
                  </a:lnTo>
                  <a:lnTo>
                    <a:pt x="2189" y="1008"/>
                  </a:lnTo>
                  <a:lnTo>
                    <a:pt x="2184" y="1008"/>
                  </a:lnTo>
                  <a:lnTo>
                    <a:pt x="2184" y="1008"/>
                  </a:lnTo>
                  <a:lnTo>
                    <a:pt x="2184" y="1008"/>
                  </a:lnTo>
                  <a:lnTo>
                    <a:pt x="2180" y="1008"/>
                  </a:lnTo>
                  <a:lnTo>
                    <a:pt x="2180" y="1008"/>
                  </a:lnTo>
                  <a:lnTo>
                    <a:pt x="2175" y="1008"/>
                  </a:lnTo>
                  <a:lnTo>
                    <a:pt x="2175" y="1008"/>
                  </a:lnTo>
                  <a:lnTo>
                    <a:pt x="2171" y="1008"/>
                  </a:lnTo>
                  <a:lnTo>
                    <a:pt x="2171" y="1008"/>
                  </a:lnTo>
                  <a:lnTo>
                    <a:pt x="2166" y="1008"/>
                  </a:lnTo>
                  <a:lnTo>
                    <a:pt x="2166" y="1008"/>
                  </a:lnTo>
                  <a:lnTo>
                    <a:pt x="2161" y="1008"/>
                  </a:lnTo>
                  <a:lnTo>
                    <a:pt x="2161" y="1008"/>
                  </a:lnTo>
                  <a:lnTo>
                    <a:pt x="2157" y="1008"/>
                  </a:lnTo>
                  <a:lnTo>
                    <a:pt x="2157" y="1008"/>
                  </a:lnTo>
                  <a:lnTo>
                    <a:pt x="2152" y="1008"/>
                  </a:lnTo>
                  <a:lnTo>
                    <a:pt x="2152" y="1008"/>
                  </a:lnTo>
                  <a:lnTo>
                    <a:pt x="2147" y="1008"/>
                  </a:lnTo>
                  <a:lnTo>
                    <a:pt x="2147" y="1008"/>
                  </a:lnTo>
                  <a:lnTo>
                    <a:pt x="2143" y="1008"/>
                  </a:lnTo>
                  <a:lnTo>
                    <a:pt x="2143" y="1008"/>
                  </a:lnTo>
                  <a:lnTo>
                    <a:pt x="2138" y="1008"/>
                  </a:lnTo>
                  <a:lnTo>
                    <a:pt x="2138" y="1008"/>
                  </a:lnTo>
                  <a:lnTo>
                    <a:pt x="2133" y="1008"/>
                  </a:lnTo>
                  <a:lnTo>
                    <a:pt x="2133" y="1008"/>
                  </a:lnTo>
                  <a:lnTo>
                    <a:pt x="2129" y="1008"/>
                  </a:lnTo>
                  <a:lnTo>
                    <a:pt x="2129" y="1008"/>
                  </a:lnTo>
                  <a:lnTo>
                    <a:pt x="2124" y="1008"/>
                  </a:lnTo>
                  <a:lnTo>
                    <a:pt x="2124" y="1008"/>
                  </a:lnTo>
                  <a:lnTo>
                    <a:pt x="2120" y="1008"/>
                  </a:lnTo>
                  <a:lnTo>
                    <a:pt x="2120" y="1008"/>
                  </a:lnTo>
                  <a:lnTo>
                    <a:pt x="2120" y="1008"/>
                  </a:lnTo>
                  <a:lnTo>
                    <a:pt x="2115" y="1008"/>
                  </a:lnTo>
                  <a:lnTo>
                    <a:pt x="2115" y="1008"/>
                  </a:lnTo>
                  <a:lnTo>
                    <a:pt x="2110" y="1008"/>
                  </a:lnTo>
                  <a:lnTo>
                    <a:pt x="2110" y="1008"/>
                  </a:lnTo>
                  <a:lnTo>
                    <a:pt x="2106" y="1008"/>
                  </a:lnTo>
                  <a:lnTo>
                    <a:pt x="2106" y="1008"/>
                  </a:lnTo>
                  <a:lnTo>
                    <a:pt x="2101" y="1008"/>
                  </a:lnTo>
                  <a:lnTo>
                    <a:pt x="2101" y="1008"/>
                  </a:lnTo>
                  <a:lnTo>
                    <a:pt x="2096" y="1008"/>
                  </a:lnTo>
                  <a:lnTo>
                    <a:pt x="2096" y="1008"/>
                  </a:lnTo>
                  <a:lnTo>
                    <a:pt x="2092" y="1008"/>
                  </a:lnTo>
                  <a:lnTo>
                    <a:pt x="2092" y="1008"/>
                  </a:lnTo>
                  <a:lnTo>
                    <a:pt x="2087" y="1008"/>
                  </a:lnTo>
                  <a:lnTo>
                    <a:pt x="2087" y="1008"/>
                  </a:lnTo>
                  <a:lnTo>
                    <a:pt x="2082" y="1008"/>
                  </a:lnTo>
                  <a:lnTo>
                    <a:pt x="2082" y="1008"/>
                  </a:lnTo>
                  <a:lnTo>
                    <a:pt x="2078" y="1008"/>
                  </a:lnTo>
                  <a:lnTo>
                    <a:pt x="2078" y="1008"/>
                  </a:lnTo>
                  <a:lnTo>
                    <a:pt x="2073" y="1008"/>
                  </a:lnTo>
                  <a:lnTo>
                    <a:pt x="2073" y="1008"/>
                  </a:lnTo>
                  <a:lnTo>
                    <a:pt x="2069" y="1008"/>
                  </a:lnTo>
                  <a:lnTo>
                    <a:pt x="2069" y="1008"/>
                  </a:lnTo>
                  <a:lnTo>
                    <a:pt x="2064" y="1008"/>
                  </a:lnTo>
                  <a:lnTo>
                    <a:pt x="2064" y="1008"/>
                  </a:lnTo>
                  <a:lnTo>
                    <a:pt x="2059" y="1008"/>
                  </a:lnTo>
                  <a:lnTo>
                    <a:pt x="2059" y="1008"/>
                  </a:lnTo>
                  <a:lnTo>
                    <a:pt x="2055" y="1008"/>
                  </a:lnTo>
                  <a:lnTo>
                    <a:pt x="2055" y="1008"/>
                  </a:lnTo>
                  <a:lnTo>
                    <a:pt x="2055" y="1008"/>
                  </a:lnTo>
                  <a:lnTo>
                    <a:pt x="2050" y="1008"/>
                  </a:lnTo>
                  <a:lnTo>
                    <a:pt x="2050" y="1008"/>
                  </a:lnTo>
                  <a:lnTo>
                    <a:pt x="2045" y="1008"/>
                  </a:lnTo>
                  <a:lnTo>
                    <a:pt x="2045" y="1008"/>
                  </a:lnTo>
                  <a:lnTo>
                    <a:pt x="2041" y="1008"/>
                  </a:lnTo>
                  <a:lnTo>
                    <a:pt x="2041" y="1008"/>
                  </a:lnTo>
                  <a:lnTo>
                    <a:pt x="2036" y="1008"/>
                  </a:lnTo>
                  <a:lnTo>
                    <a:pt x="2036" y="1008"/>
                  </a:lnTo>
                  <a:lnTo>
                    <a:pt x="2031" y="1008"/>
                  </a:lnTo>
                  <a:lnTo>
                    <a:pt x="2031" y="1008"/>
                  </a:lnTo>
                  <a:lnTo>
                    <a:pt x="2027" y="1008"/>
                  </a:lnTo>
                  <a:lnTo>
                    <a:pt x="2027" y="1008"/>
                  </a:lnTo>
                  <a:lnTo>
                    <a:pt x="2022" y="1008"/>
                  </a:lnTo>
                  <a:lnTo>
                    <a:pt x="2022" y="1008"/>
                  </a:lnTo>
                  <a:lnTo>
                    <a:pt x="2018" y="1008"/>
                  </a:lnTo>
                  <a:lnTo>
                    <a:pt x="2018" y="1008"/>
                  </a:lnTo>
                  <a:lnTo>
                    <a:pt x="2013" y="1008"/>
                  </a:lnTo>
                  <a:lnTo>
                    <a:pt x="2013" y="1008"/>
                  </a:lnTo>
                  <a:lnTo>
                    <a:pt x="2008" y="1008"/>
                  </a:lnTo>
                  <a:lnTo>
                    <a:pt x="2008" y="1008"/>
                  </a:lnTo>
                  <a:lnTo>
                    <a:pt x="2004" y="1008"/>
                  </a:lnTo>
                  <a:lnTo>
                    <a:pt x="2004" y="1008"/>
                  </a:lnTo>
                  <a:lnTo>
                    <a:pt x="1999" y="1008"/>
                  </a:lnTo>
                  <a:lnTo>
                    <a:pt x="1999" y="907"/>
                  </a:lnTo>
                  <a:lnTo>
                    <a:pt x="1994" y="907"/>
                  </a:lnTo>
                  <a:lnTo>
                    <a:pt x="1994" y="907"/>
                  </a:lnTo>
                  <a:lnTo>
                    <a:pt x="1990" y="907"/>
                  </a:lnTo>
                  <a:lnTo>
                    <a:pt x="1990" y="907"/>
                  </a:lnTo>
                  <a:lnTo>
                    <a:pt x="1990" y="907"/>
                  </a:lnTo>
                  <a:lnTo>
                    <a:pt x="1985" y="907"/>
                  </a:lnTo>
                  <a:lnTo>
                    <a:pt x="1985" y="907"/>
                  </a:lnTo>
                  <a:lnTo>
                    <a:pt x="1980" y="907"/>
                  </a:lnTo>
                  <a:lnTo>
                    <a:pt x="1980" y="907"/>
                  </a:lnTo>
                  <a:lnTo>
                    <a:pt x="1976" y="907"/>
                  </a:lnTo>
                  <a:lnTo>
                    <a:pt x="1976" y="907"/>
                  </a:lnTo>
                  <a:lnTo>
                    <a:pt x="1971" y="907"/>
                  </a:lnTo>
                  <a:lnTo>
                    <a:pt x="1971" y="907"/>
                  </a:lnTo>
                  <a:lnTo>
                    <a:pt x="1967" y="907"/>
                  </a:lnTo>
                  <a:lnTo>
                    <a:pt x="1967" y="907"/>
                  </a:lnTo>
                  <a:lnTo>
                    <a:pt x="1962" y="907"/>
                  </a:lnTo>
                  <a:lnTo>
                    <a:pt x="1962" y="907"/>
                  </a:lnTo>
                  <a:lnTo>
                    <a:pt x="1957" y="907"/>
                  </a:lnTo>
                  <a:lnTo>
                    <a:pt x="1957" y="907"/>
                  </a:lnTo>
                  <a:lnTo>
                    <a:pt x="1953" y="907"/>
                  </a:lnTo>
                  <a:lnTo>
                    <a:pt x="1953" y="907"/>
                  </a:lnTo>
                  <a:lnTo>
                    <a:pt x="1948" y="907"/>
                  </a:lnTo>
                  <a:lnTo>
                    <a:pt x="1948" y="907"/>
                  </a:lnTo>
                  <a:lnTo>
                    <a:pt x="1943" y="907"/>
                  </a:lnTo>
                  <a:lnTo>
                    <a:pt x="1943" y="907"/>
                  </a:lnTo>
                  <a:lnTo>
                    <a:pt x="1939" y="907"/>
                  </a:lnTo>
                  <a:lnTo>
                    <a:pt x="1939" y="907"/>
                  </a:lnTo>
                  <a:lnTo>
                    <a:pt x="1934" y="907"/>
                  </a:lnTo>
                  <a:lnTo>
                    <a:pt x="1934" y="907"/>
                  </a:lnTo>
                  <a:lnTo>
                    <a:pt x="1929" y="907"/>
                  </a:lnTo>
                  <a:lnTo>
                    <a:pt x="1929" y="907"/>
                  </a:lnTo>
                  <a:lnTo>
                    <a:pt x="1925" y="907"/>
                  </a:lnTo>
                  <a:lnTo>
                    <a:pt x="1925" y="907"/>
                  </a:lnTo>
                  <a:lnTo>
                    <a:pt x="1920" y="907"/>
                  </a:lnTo>
                  <a:lnTo>
                    <a:pt x="1920" y="907"/>
                  </a:lnTo>
                  <a:lnTo>
                    <a:pt x="1920" y="907"/>
                  </a:lnTo>
                  <a:lnTo>
                    <a:pt x="1915" y="907"/>
                  </a:lnTo>
                  <a:lnTo>
                    <a:pt x="1915" y="907"/>
                  </a:lnTo>
                  <a:lnTo>
                    <a:pt x="1911" y="907"/>
                  </a:lnTo>
                  <a:lnTo>
                    <a:pt x="1911" y="907"/>
                  </a:lnTo>
                  <a:lnTo>
                    <a:pt x="1906" y="907"/>
                  </a:lnTo>
                  <a:lnTo>
                    <a:pt x="1906" y="907"/>
                  </a:lnTo>
                  <a:lnTo>
                    <a:pt x="1902" y="907"/>
                  </a:lnTo>
                  <a:lnTo>
                    <a:pt x="1902" y="907"/>
                  </a:lnTo>
                  <a:lnTo>
                    <a:pt x="1897" y="907"/>
                  </a:lnTo>
                  <a:lnTo>
                    <a:pt x="1897" y="907"/>
                  </a:lnTo>
                  <a:lnTo>
                    <a:pt x="1892" y="907"/>
                  </a:lnTo>
                  <a:lnTo>
                    <a:pt x="1892" y="907"/>
                  </a:lnTo>
                  <a:lnTo>
                    <a:pt x="1888" y="907"/>
                  </a:lnTo>
                  <a:lnTo>
                    <a:pt x="1888" y="1008"/>
                  </a:lnTo>
                  <a:lnTo>
                    <a:pt x="1883" y="1008"/>
                  </a:lnTo>
                  <a:lnTo>
                    <a:pt x="1883" y="1008"/>
                  </a:lnTo>
                  <a:lnTo>
                    <a:pt x="1878" y="1008"/>
                  </a:lnTo>
                  <a:lnTo>
                    <a:pt x="1878" y="1008"/>
                  </a:lnTo>
                  <a:lnTo>
                    <a:pt x="1874" y="1008"/>
                  </a:lnTo>
                  <a:lnTo>
                    <a:pt x="1874" y="1008"/>
                  </a:lnTo>
                  <a:lnTo>
                    <a:pt x="1869" y="1008"/>
                  </a:lnTo>
                  <a:lnTo>
                    <a:pt x="1869" y="1008"/>
                  </a:lnTo>
                  <a:lnTo>
                    <a:pt x="1864" y="1008"/>
                  </a:lnTo>
                  <a:lnTo>
                    <a:pt x="1864" y="1008"/>
                  </a:lnTo>
                  <a:lnTo>
                    <a:pt x="1860" y="1008"/>
                  </a:lnTo>
                  <a:lnTo>
                    <a:pt x="1860" y="1008"/>
                  </a:lnTo>
                  <a:lnTo>
                    <a:pt x="1855" y="1008"/>
                  </a:lnTo>
                  <a:lnTo>
                    <a:pt x="1855" y="907"/>
                  </a:lnTo>
                  <a:lnTo>
                    <a:pt x="1855" y="907"/>
                  </a:lnTo>
                  <a:lnTo>
                    <a:pt x="1851" y="907"/>
                  </a:lnTo>
                  <a:lnTo>
                    <a:pt x="1851" y="907"/>
                  </a:lnTo>
                  <a:lnTo>
                    <a:pt x="1846" y="907"/>
                  </a:lnTo>
                  <a:lnTo>
                    <a:pt x="1846" y="907"/>
                  </a:lnTo>
                  <a:lnTo>
                    <a:pt x="1841" y="907"/>
                  </a:lnTo>
                  <a:lnTo>
                    <a:pt x="1841" y="907"/>
                  </a:lnTo>
                  <a:lnTo>
                    <a:pt x="1837" y="907"/>
                  </a:lnTo>
                  <a:lnTo>
                    <a:pt x="1837" y="907"/>
                  </a:lnTo>
                  <a:lnTo>
                    <a:pt x="1832" y="907"/>
                  </a:lnTo>
                  <a:lnTo>
                    <a:pt x="1832" y="907"/>
                  </a:lnTo>
                  <a:lnTo>
                    <a:pt x="1827" y="907"/>
                  </a:lnTo>
                  <a:lnTo>
                    <a:pt x="1827" y="907"/>
                  </a:lnTo>
                  <a:lnTo>
                    <a:pt x="1823" y="907"/>
                  </a:lnTo>
                  <a:lnTo>
                    <a:pt x="1823" y="907"/>
                  </a:lnTo>
                  <a:lnTo>
                    <a:pt x="1818" y="907"/>
                  </a:lnTo>
                  <a:lnTo>
                    <a:pt x="1818" y="907"/>
                  </a:lnTo>
                  <a:lnTo>
                    <a:pt x="1813" y="907"/>
                  </a:lnTo>
                  <a:lnTo>
                    <a:pt x="1813" y="907"/>
                  </a:lnTo>
                  <a:lnTo>
                    <a:pt x="1809" y="907"/>
                  </a:lnTo>
                  <a:lnTo>
                    <a:pt x="1809" y="907"/>
                  </a:lnTo>
                  <a:lnTo>
                    <a:pt x="1804" y="806"/>
                  </a:lnTo>
                  <a:lnTo>
                    <a:pt x="1804" y="806"/>
                  </a:lnTo>
                  <a:lnTo>
                    <a:pt x="1800" y="806"/>
                  </a:lnTo>
                  <a:lnTo>
                    <a:pt x="1800" y="806"/>
                  </a:lnTo>
                  <a:lnTo>
                    <a:pt x="1795" y="806"/>
                  </a:lnTo>
                  <a:lnTo>
                    <a:pt x="1795" y="706"/>
                  </a:lnTo>
                  <a:lnTo>
                    <a:pt x="1790" y="706"/>
                  </a:lnTo>
                  <a:lnTo>
                    <a:pt x="1790" y="706"/>
                  </a:lnTo>
                  <a:lnTo>
                    <a:pt x="1790" y="706"/>
                  </a:lnTo>
                  <a:lnTo>
                    <a:pt x="1786" y="706"/>
                  </a:lnTo>
                  <a:lnTo>
                    <a:pt x="1786" y="706"/>
                  </a:lnTo>
                  <a:lnTo>
                    <a:pt x="1781" y="706"/>
                  </a:lnTo>
                  <a:lnTo>
                    <a:pt x="1781" y="706"/>
                  </a:lnTo>
                  <a:lnTo>
                    <a:pt x="1776" y="706"/>
                  </a:lnTo>
                  <a:lnTo>
                    <a:pt x="1776" y="706"/>
                  </a:lnTo>
                  <a:lnTo>
                    <a:pt x="1772" y="706"/>
                  </a:lnTo>
                  <a:lnTo>
                    <a:pt x="1772" y="706"/>
                  </a:lnTo>
                  <a:lnTo>
                    <a:pt x="1767" y="706"/>
                  </a:lnTo>
                  <a:lnTo>
                    <a:pt x="1767" y="706"/>
                  </a:lnTo>
                  <a:lnTo>
                    <a:pt x="1762" y="706"/>
                  </a:lnTo>
                  <a:lnTo>
                    <a:pt x="1762" y="706"/>
                  </a:lnTo>
                  <a:lnTo>
                    <a:pt x="1758" y="706"/>
                  </a:lnTo>
                  <a:lnTo>
                    <a:pt x="1758" y="706"/>
                  </a:lnTo>
                  <a:lnTo>
                    <a:pt x="1753" y="706"/>
                  </a:lnTo>
                  <a:lnTo>
                    <a:pt x="1753" y="706"/>
                  </a:lnTo>
                  <a:lnTo>
                    <a:pt x="1749" y="706"/>
                  </a:lnTo>
                  <a:lnTo>
                    <a:pt x="1749" y="706"/>
                  </a:lnTo>
                  <a:lnTo>
                    <a:pt x="1744" y="706"/>
                  </a:lnTo>
                  <a:lnTo>
                    <a:pt x="1744" y="806"/>
                  </a:lnTo>
                  <a:lnTo>
                    <a:pt x="1739" y="806"/>
                  </a:lnTo>
                  <a:lnTo>
                    <a:pt x="1739" y="806"/>
                  </a:lnTo>
                  <a:lnTo>
                    <a:pt x="1735" y="806"/>
                  </a:lnTo>
                  <a:lnTo>
                    <a:pt x="1735" y="806"/>
                  </a:lnTo>
                  <a:lnTo>
                    <a:pt x="1730" y="806"/>
                  </a:lnTo>
                  <a:lnTo>
                    <a:pt x="1730" y="806"/>
                  </a:lnTo>
                  <a:lnTo>
                    <a:pt x="1725" y="806"/>
                  </a:lnTo>
                  <a:lnTo>
                    <a:pt x="1725" y="806"/>
                  </a:lnTo>
                  <a:lnTo>
                    <a:pt x="1721" y="806"/>
                  </a:lnTo>
                  <a:lnTo>
                    <a:pt x="1721" y="806"/>
                  </a:lnTo>
                  <a:lnTo>
                    <a:pt x="1721" y="806"/>
                  </a:lnTo>
                  <a:lnTo>
                    <a:pt x="1716" y="806"/>
                  </a:lnTo>
                  <a:lnTo>
                    <a:pt x="1716" y="806"/>
                  </a:lnTo>
                  <a:lnTo>
                    <a:pt x="1711" y="806"/>
                  </a:lnTo>
                  <a:lnTo>
                    <a:pt x="1711" y="706"/>
                  </a:lnTo>
                  <a:lnTo>
                    <a:pt x="1707" y="706"/>
                  </a:lnTo>
                  <a:lnTo>
                    <a:pt x="1707" y="706"/>
                  </a:lnTo>
                  <a:lnTo>
                    <a:pt x="1702" y="706"/>
                  </a:lnTo>
                  <a:lnTo>
                    <a:pt x="1702" y="706"/>
                  </a:lnTo>
                  <a:lnTo>
                    <a:pt x="1698" y="706"/>
                  </a:lnTo>
                  <a:lnTo>
                    <a:pt x="1698" y="706"/>
                  </a:lnTo>
                  <a:lnTo>
                    <a:pt x="1693" y="806"/>
                  </a:lnTo>
                  <a:lnTo>
                    <a:pt x="1693" y="806"/>
                  </a:lnTo>
                  <a:lnTo>
                    <a:pt x="1688" y="806"/>
                  </a:lnTo>
                  <a:lnTo>
                    <a:pt x="1688" y="806"/>
                  </a:lnTo>
                  <a:lnTo>
                    <a:pt x="1684" y="806"/>
                  </a:lnTo>
                  <a:lnTo>
                    <a:pt x="1684" y="907"/>
                  </a:lnTo>
                  <a:lnTo>
                    <a:pt x="1679" y="907"/>
                  </a:lnTo>
                  <a:lnTo>
                    <a:pt x="1679" y="907"/>
                  </a:lnTo>
                  <a:lnTo>
                    <a:pt x="1674" y="907"/>
                  </a:lnTo>
                  <a:lnTo>
                    <a:pt x="1674" y="907"/>
                  </a:lnTo>
                  <a:lnTo>
                    <a:pt x="1670" y="907"/>
                  </a:lnTo>
                  <a:lnTo>
                    <a:pt x="1670" y="907"/>
                  </a:lnTo>
                  <a:lnTo>
                    <a:pt x="1665" y="907"/>
                  </a:lnTo>
                  <a:lnTo>
                    <a:pt x="1665" y="907"/>
                  </a:lnTo>
                  <a:lnTo>
                    <a:pt x="1660" y="907"/>
                  </a:lnTo>
                  <a:lnTo>
                    <a:pt x="1660" y="907"/>
                  </a:lnTo>
                  <a:lnTo>
                    <a:pt x="1656" y="907"/>
                  </a:lnTo>
                  <a:lnTo>
                    <a:pt x="1656" y="907"/>
                  </a:lnTo>
                  <a:lnTo>
                    <a:pt x="1656" y="907"/>
                  </a:lnTo>
                  <a:lnTo>
                    <a:pt x="1651" y="907"/>
                  </a:lnTo>
                  <a:lnTo>
                    <a:pt x="1651" y="907"/>
                  </a:lnTo>
                  <a:lnTo>
                    <a:pt x="1646" y="907"/>
                  </a:lnTo>
                  <a:lnTo>
                    <a:pt x="1646" y="907"/>
                  </a:lnTo>
                  <a:lnTo>
                    <a:pt x="1642" y="907"/>
                  </a:lnTo>
                  <a:lnTo>
                    <a:pt x="1642" y="806"/>
                  </a:lnTo>
                  <a:lnTo>
                    <a:pt x="1637" y="806"/>
                  </a:lnTo>
                  <a:lnTo>
                    <a:pt x="1637" y="806"/>
                  </a:lnTo>
                  <a:lnTo>
                    <a:pt x="1633" y="806"/>
                  </a:lnTo>
                  <a:lnTo>
                    <a:pt x="1633" y="806"/>
                  </a:lnTo>
                  <a:lnTo>
                    <a:pt x="1628" y="806"/>
                  </a:lnTo>
                  <a:lnTo>
                    <a:pt x="1628" y="806"/>
                  </a:lnTo>
                  <a:lnTo>
                    <a:pt x="1623" y="806"/>
                  </a:lnTo>
                  <a:lnTo>
                    <a:pt x="1623" y="806"/>
                  </a:lnTo>
                  <a:lnTo>
                    <a:pt x="1619" y="806"/>
                  </a:lnTo>
                  <a:lnTo>
                    <a:pt x="1619" y="806"/>
                  </a:lnTo>
                  <a:lnTo>
                    <a:pt x="1614" y="806"/>
                  </a:lnTo>
                  <a:lnTo>
                    <a:pt x="1614" y="806"/>
                  </a:lnTo>
                  <a:lnTo>
                    <a:pt x="1609" y="806"/>
                  </a:lnTo>
                  <a:lnTo>
                    <a:pt x="1609" y="806"/>
                  </a:lnTo>
                  <a:lnTo>
                    <a:pt x="1605" y="806"/>
                  </a:lnTo>
                  <a:lnTo>
                    <a:pt x="1605" y="706"/>
                  </a:lnTo>
                  <a:lnTo>
                    <a:pt x="1600" y="706"/>
                  </a:lnTo>
                  <a:lnTo>
                    <a:pt x="1600" y="706"/>
                  </a:lnTo>
                  <a:lnTo>
                    <a:pt x="1595" y="706"/>
                  </a:lnTo>
                  <a:lnTo>
                    <a:pt x="1595" y="706"/>
                  </a:lnTo>
                  <a:lnTo>
                    <a:pt x="1591" y="706"/>
                  </a:lnTo>
                  <a:lnTo>
                    <a:pt x="1591" y="706"/>
                  </a:lnTo>
                  <a:lnTo>
                    <a:pt x="1591" y="706"/>
                  </a:lnTo>
                  <a:lnTo>
                    <a:pt x="1586" y="706"/>
                  </a:lnTo>
                  <a:lnTo>
                    <a:pt x="1586" y="706"/>
                  </a:lnTo>
                  <a:lnTo>
                    <a:pt x="1582" y="706"/>
                  </a:lnTo>
                  <a:lnTo>
                    <a:pt x="1582" y="706"/>
                  </a:lnTo>
                  <a:lnTo>
                    <a:pt x="1577" y="706"/>
                  </a:lnTo>
                  <a:lnTo>
                    <a:pt x="1577" y="706"/>
                  </a:lnTo>
                  <a:lnTo>
                    <a:pt x="1572" y="706"/>
                  </a:lnTo>
                  <a:lnTo>
                    <a:pt x="1572" y="605"/>
                  </a:lnTo>
                  <a:lnTo>
                    <a:pt x="1568" y="605"/>
                  </a:lnTo>
                  <a:lnTo>
                    <a:pt x="1568" y="605"/>
                  </a:lnTo>
                  <a:lnTo>
                    <a:pt x="1563" y="605"/>
                  </a:lnTo>
                  <a:lnTo>
                    <a:pt x="1563" y="605"/>
                  </a:lnTo>
                  <a:lnTo>
                    <a:pt x="1558" y="605"/>
                  </a:lnTo>
                  <a:lnTo>
                    <a:pt x="1558" y="605"/>
                  </a:lnTo>
                  <a:lnTo>
                    <a:pt x="1554" y="605"/>
                  </a:lnTo>
                  <a:lnTo>
                    <a:pt x="1554" y="605"/>
                  </a:lnTo>
                  <a:lnTo>
                    <a:pt x="1549" y="605"/>
                  </a:lnTo>
                  <a:lnTo>
                    <a:pt x="1549" y="605"/>
                  </a:lnTo>
                  <a:lnTo>
                    <a:pt x="1544" y="605"/>
                  </a:lnTo>
                  <a:lnTo>
                    <a:pt x="1544" y="605"/>
                  </a:lnTo>
                  <a:lnTo>
                    <a:pt x="1540" y="605"/>
                  </a:lnTo>
                  <a:lnTo>
                    <a:pt x="1540" y="605"/>
                  </a:lnTo>
                  <a:lnTo>
                    <a:pt x="1535" y="605"/>
                  </a:lnTo>
                  <a:lnTo>
                    <a:pt x="1535" y="605"/>
                  </a:lnTo>
                  <a:lnTo>
                    <a:pt x="1531" y="605"/>
                  </a:lnTo>
                  <a:lnTo>
                    <a:pt x="1531" y="605"/>
                  </a:lnTo>
                  <a:lnTo>
                    <a:pt x="1526" y="706"/>
                  </a:lnTo>
                  <a:lnTo>
                    <a:pt x="1526" y="706"/>
                  </a:lnTo>
                  <a:lnTo>
                    <a:pt x="1526" y="706"/>
                  </a:lnTo>
                  <a:lnTo>
                    <a:pt x="1521" y="706"/>
                  </a:lnTo>
                  <a:lnTo>
                    <a:pt x="1521" y="706"/>
                  </a:lnTo>
                  <a:lnTo>
                    <a:pt x="1517" y="706"/>
                  </a:lnTo>
                  <a:lnTo>
                    <a:pt x="1517" y="706"/>
                  </a:lnTo>
                  <a:lnTo>
                    <a:pt x="1512" y="706"/>
                  </a:lnTo>
                  <a:lnTo>
                    <a:pt x="1512" y="706"/>
                  </a:lnTo>
                  <a:lnTo>
                    <a:pt x="1507" y="706"/>
                  </a:lnTo>
                  <a:lnTo>
                    <a:pt x="1507" y="706"/>
                  </a:lnTo>
                  <a:lnTo>
                    <a:pt x="1503" y="706"/>
                  </a:lnTo>
                  <a:lnTo>
                    <a:pt x="1503" y="706"/>
                  </a:lnTo>
                  <a:lnTo>
                    <a:pt x="1498" y="706"/>
                  </a:lnTo>
                  <a:lnTo>
                    <a:pt x="1498" y="706"/>
                  </a:lnTo>
                  <a:lnTo>
                    <a:pt x="1493" y="706"/>
                  </a:lnTo>
                  <a:lnTo>
                    <a:pt x="1493" y="806"/>
                  </a:lnTo>
                  <a:lnTo>
                    <a:pt x="1489" y="806"/>
                  </a:lnTo>
                  <a:lnTo>
                    <a:pt x="1489" y="806"/>
                  </a:lnTo>
                  <a:lnTo>
                    <a:pt x="1484" y="907"/>
                  </a:lnTo>
                  <a:lnTo>
                    <a:pt x="1484" y="907"/>
                  </a:lnTo>
                  <a:lnTo>
                    <a:pt x="1480" y="907"/>
                  </a:lnTo>
                  <a:lnTo>
                    <a:pt x="1480" y="907"/>
                  </a:lnTo>
                  <a:lnTo>
                    <a:pt x="1475" y="907"/>
                  </a:lnTo>
                  <a:lnTo>
                    <a:pt x="1475" y="806"/>
                  </a:lnTo>
                  <a:lnTo>
                    <a:pt x="1470" y="806"/>
                  </a:lnTo>
                  <a:lnTo>
                    <a:pt x="1470" y="706"/>
                  </a:lnTo>
                  <a:lnTo>
                    <a:pt x="1466" y="706"/>
                  </a:lnTo>
                  <a:lnTo>
                    <a:pt x="1466" y="605"/>
                  </a:lnTo>
                  <a:lnTo>
                    <a:pt x="1461" y="605"/>
                  </a:lnTo>
                  <a:lnTo>
                    <a:pt x="1461" y="605"/>
                  </a:lnTo>
                  <a:lnTo>
                    <a:pt x="1456" y="605"/>
                  </a:lnTo>
                  <a:lnTo>
                    <a:pt x="1456" y="504"/>
                  </a:lnTo>
                  <a:lnTo>
                    <a:pt x="1456" y="504"/>
                  </a:lnTo>
                  <a:lnTo>
                    <a:pt x="1452" y="302"/>
                  </a:lnTo>
                  <a:lnTo>
                    <a:pt x="1452" y="302"/>
                  </a:lnTo>
                  <a:lnTo>
                    <a:pt x="1447" y="302"/>
                  </a:lnTo>
                  <a:lnTo>
                    <a:pt x="1447" y="302"/>
                  </a:lnTo>
                  <a:lnTo>
                    <a:pt x="1442" y="302"/>
                  </a:lnTo>
                  <a:lnTo>
                    <a:pt x="1442" y="302"/>
                  </a:lnTo>
                  <a:lnTo>
                    <a:pt x="1438" y="302"/>
                  </a:lnTo>
                  <a:lnTo>
                    <a:pt x="1438" y="302"/>
                  </a:lnTo>
                  <a:lnTo>
                    <a:pt x="1433" y="302"/>
                  </a:lnTo>
                  <a:lnTo>
                    <a:pt x="1433" y="302"/>
                  </a:lnTo>
                  <a:lnTo>
                    <a:pt x="1429" y="302"/>
                  </a:lnTo>
                  <a:lnTo>
                    <a:pt x="1429" y="302"/>
                  </a:lnTo>
                  <a:lnTo>
                    <a:pt x="1424" y="302"/>
                  </a:lnTo>
                  <a:lnTo>
                    <a:pt x="1424" y="302"/>
                  </a:lnTo>
                  <a:lnTo>
                    <a:pt x="1419" y="302"/>
                  </a:lnTo>
                  <a:lnTo>
                    <a:pt x="1419" y="302"/>
                  </a:lnTo>
                  <a:lnTo>
                    <a:pt x="1415" y="302"/>
                  </a:lnTo>
                  <a:lnTo>
                    <a:pt x="1415" y="302"/>
                  </a:lnTo>
                  <a:lnTo>
                    <a:pt x="1410" y="302"/>
                  </a:lnTo>
                  <a:lnTo>
                    <a:pt x="1410" y="202"/>
                  </a:lnTo>
                  <a:lnTo>
                    <a:pt x="1405" y="202"/>
                  </a:lnTo>
                  <a:lnTo>
                    <a:pt x="1405" y="202"/>
                  </a:lnTo>
                  <a:lnTo>
                    <a:pt x="1401" y="202"/>
                  </a:lnTo>
                  <a:lnTo>
                    <a:pt x="1401" y="202"/>
                  </a:lnTo>
                  <a:lnTo>
                    <a:pt x="1396" y="202"/>
                  </a:lnTo>
                  <a:lnTo>
                    <a:pt x="1396" y="202"/>
                  </a:lnTo>
                  <a:lnTo>
                    <a:pt x="1391" y="202"/>
                  </a:lnTo>
                  <a:lnTo>
                    <a:pt x="1391" y="202"/>
                  </a:lnTo>
                  <a:lnTo>
                    <a:pt x="1391" y="202"/>
                  </a:lnTo>
                  <a:lnTo>
                    <a:pt x="1387" y="202"/>
                  </a:lnTo>
                  <a:lnTo>
                    <a:pt x="1387" y="202"/>
                  </a:lnTo>
                  <a:lnTo>
                    <a:pt x="1382" y="101"/>
                  </a:lnTo>
                  <a:lnTo>
                    <a:pt x="1382" y="0"/>
                  </a:lnTo>
                  <a:lnTo>
                    <a:pt x="1377" y="0"/>
                  </a:lnTo>
                  <a:lnTo>
                    <a:pt x="1377" y="0"/>
                  </a:lnTo>
                  <a:lnTo>
                    <a:pt x="1373" y="0"/>
                  </a:lnTo>
                  <a:lnTo>
                    <a:pt x="1373" y="0"/>
                  </a:lnTo>
                  <a:lnTo>
                    <a:pt x="1368" y="0"/>
                  </a:lnTo>
                  <a:lnTo>
                    <a:pt x="1368" y="0"/>
                  </a:lnTo>
                  <a:lnTo>
                    <a:pt x="1364" y="0"/>
                  </a:lnTo>
                  <a:lnTo>
                    <a:pt x="1364" y="101"/>
                  </a:lnTo>
                  <a:lnTo>
                    <a:pt x="1359" y="101"/>
                  </a:lnTo>
                  <a:lnTo>
                    <a:pt x="1359" y="202"/>
                  </a:lnTo>
                  <a:lnTo>
                    <a:pt x="1354" y="202"/>
                  </a:lnTo>
                  <a:lnTo>
                    <a:pt x="1354" y="302"/>
                  </a:lnTo>
                  <a:lnTo>
                    <a:pt x="1350" y="302"/>
                  </a:lnTo>
                  <a:lnTo>
                    <a:pt x="1350" y="302"/>
                  </a:lnTo>
                  <a:lnTo>
                    <a:pt x="1345" y="403"/>
                  </a:lnTo>
                  <a:lnTo>
                    <a:pt x="1345" y="504"/>
                  </a:lnTo>
                  <a:lnTo>
                    <a:pt x="1340" y="504"/>
                  </a:lnTo>
                  <a:lnTo>
                    <a:pt x="1340" y="706"/>
                  </a:lnTo>
                  <a:lnTo>
                    <a:pt x="1336" y="706"/>
                  </a:lnTo>
                  <a:lnTo>
                    <a:pt x="1336" y="706"/>
                  </a:lnTo>
                  <a:lnTo>
                    <a:pt x="1331" y="706"/>
                  </a:lnTo>
                  <a:lnTo>
                    <a:pt x="1331" y="706"/>
                  </a:lnTo>
                  <a:lnTo>
                    <a:pt x="1326" y="706"/>
                  </a:lnTo>
                  <a:lnTo>
                    <a:pt x="1326" y="706"/>
                  </a:lnTo>
                  <a:lnTo>
                    <a:pt x="1326" y="706"/>
                  </a:lnTo>
                  <a:lnTo>
                    <a:pt x="1322" y="706"/>
                  </a:lnTo>
                  <a:lnTo>
                    <a:pt x="1322" y="706"/>
                  </a:lnTo>
                  <a:lnTo>
                    <a:pt x="1317" y="706"/>
                  </a:lnTo>
                  <a:lnTo>
                    <a:pt x="1317" y="605"/>
                  </a:lnTo>
                  <a:lnTo>
                    <a:pt x="1313" y="605"/>
                  </a:lnTo>
                  <a:lnTo>
                    <a:pt x="1313" y="605"/>
                  </a:lnTo>
                  <a:lnTo>
                    <a:pt x="1308" y="605"/>
                  </a:lnTo>
                  <a:lnTo>
                    <a:pt x="1308" y="605"/>
                  </a:lnTo>
                  <a:lnTo>
                    <a:pt x="1303" y="605"/>
                  </a:lnTo>
                  <a:lnTo>
                    <a:pt x="1303" y="605"/>
                  </a:lnTo>
                  <a:lnTo>
                    <a:pt x="1299" y="605"/>
                  </a:lnTo>
                  <a:lnTo>
                    <a:pt x="1299" y="706"/>
                  </a:lnTo>
                  <a:lnTo>
                    <a:pt x="1294" y="706"/>
                  </a:lnTo>
                  <a:lnTo>
                    <a:pt x="1294" y="706"/>
                  </a:lnTo>
                  <a:lnTo>
                    <a:pt x="1289" y="706"/>
                  </a:lnTo>
                  <a:lnTo>
                    <a:pt x="1289" y="706"/>
                  </a:lnTo>
                  <a:lnTo>
                    <a:pt x="1285" y="706"/>
                  </a:lnTo>
                  <a:lnTo>
                    <a:pt x="1285" y="706"/>
                  </a:lnTo>
                  <a:lnTo>
                    <a:pt x="1280" y="706"/>
                  </a:lnTo>
                  <a:lnTo>
                    <a:pt x="1280" y="706"/>
                  </a:lnTo>
                  <a:lnTo>
                    <a:pt x="1275" y="706"/>
                  </a:lnTo>
                  <a:lnTo>
                    <a:pt x="1275" y="706"/>
                  </a:lnTo>
                  <a:lnTo>
                    <a:pt x="1271" y="706"/>
                  </a:lnTo>
                  <a:lnTo>
                    <a:pt x="1271" y="806"/>
                  </a:lnTo>
                  <a:lnTo>
                    <a:pt x="1266" y="907"/>
                  </a:lnTo>
                  <a:lnTo>
                    <a:pt x="1266" y="907"/>
                  </a:lnTo>
                  <a:lnTo>
                    <a:pt x="1262" y="907"/>
                  </a:lnTo>
                  <a:lnTo>
                    <a:pt x="1262" y="907"/>
                  </a:lnTo>
                  <a:lnTo>
                    <a:pt x="1257" y="907"/>
                  </a:lnTo>
                  <a:lnTo>
                    <a:pt x="1257" y="907"/>
                  </a:lnTo>
                  <a:lnTo>
                    <a:pt x="1257" y="907"/>
                  </a:lnTo>
                  <a:lnTo>
                    <a:pt x="1252" y="907"/>
                  </a:lnTo>
                  <a:lnTo>
                    <a:pt x="1252" y="907"/>
                  </a:lnTo>
                  <a:lnTo>
                    <a:pt x="1248" y="907"/>
                  </a:lnTo>
                  <a:lnTo>
                    <a:pt x="1248" y="907"/>
                  </a:lnTo>
                  <a:lnTo>
                    <a:pt x="1243" y="907"/>
                  </a:lnTo>
                  <a:lnTo>
                    <a:pt x="1243" y="907"/>
                  </a:lnTo>
                  <a:lnTo>
                    <a:pt x="1238" y="907"/>
                  </a:lnTo>
                  <a:lnTo>
                    <a:pt x="1238" y="907"/>
                  </a:lnTo>
                  <a:lnTo>
                    <a:pt x="1234" y="907"/>
                  </a:lnTo>
                  <a:lnTo>
                    <a:pt x="1234" y="907"/>
                  </a:lnTo>
                  <a:lnTo>
                    <a:pt x="1229" y="907"/>
                  </a:lnTo>
                  <a:lnTo>
                    <a:pt x="1229" y="907"/>
                  </a:lnTo>
                  <a:lnTo>
                    <a:pt x="1224" y="907"/>
                  </a:lnTo>
                  <a:lnTo>
                    <a:pt x="1224" y="907"/>
                  </a:lnTo>
                  <a:lnTo>
                    <a:pt x="1220" y="907"/>
                  </a:lnTo>
                  <a:lnTo>
                    <a:pt x="1220" y="907"/>
                  </a:lnTo>
                  <a:lnTo>
                    <a:pt x="1215" y="907"/>
                  </a:lnTo>
                  <a:lnTo>
                    <a:pt x="1215" y="907"/>
                  </a:lnTo>
                  <a:lnTo>
                    <a:pt x="1211" y="907"/>
                  </a:lnTo>
                  <a:lnTo>
                    <a:pt x="1211" y="907"/>
                  </a:lnTo>
                  <a:lnTo>
                    <a:pt x="1206" y="907"/>
                  </a:lnTo>
                  <a:lnTo>
                    <a:pt x="1206" y="907"/>
                  </a:lnTo>
                  <a:lnTo>
                    <a:pt x="1201" y="1008"/>
                  </a:lnTo>
                  <a:lnTo>
                    <a:pt x="1201" y="1008"/>
                  </a:lnTo>
                  <a:lnTo>
                    <a:pt x="1197" y="1008"/>
                  </a:lnTo>
                  <a:lnTo>
                    <a:pt x="1197" y="1008"/>
                  </a:lnTo>
                  <a:lnTo>
                    <a:pt x="1192" y="1008"/>
                  </a:lnTo>
                  <a:lnTo>
                    <a:pt x="1192" y="1008"/>
                  </a:lnTo>
                  <a:lnTo>
                    <a:pt x="1192" y="1008"/>
                  </a:lnTo>
                  <a:lnTo>
                    <a:pt x="1187" y="1008"/>
                  </a:lnTo>
                  <a:lnTo>
                    <a:pt x="1187" y="1008"/>
                  </a:lnTo>
                  <a:lnTo>
                    <a:pt x="1183" y="1008"/>
                  </a:lnTo>
                  <a:lnTo>
                    <a:pt x="1183" y="1008"/>
                  </a:lnTo>
                  <a:lnTo>
                    <a:pt x="1178" y="1008"/>
                  </a:lnTo>
                  <a:lnTo>
                    <a:pt x="1178" y="1008"/>
                  </a:lnTo>
                  <a:lnTo>
                    <a:pt x="1173" y="1008"/>
                  </a:lnTo>
                  <a:lnTo>
                    <a:pt x="1173" y="1008"/>
                  </a:lnTo>
                  <a:lnTo>
                    <a:pt x="1169" y="1008"/>
                  </a:lnTo>
                  <a:lnTo>
                    <a:pt x="1169" y="1008"/>
                  </a:lnTo>
                  <a:lnTo>
                    <a:pt x="1164" y="1008"/>
                  </a:lnTo>
                  <a:lnTo>
                    <a:pt x="1164" y="1008"/>
                  </a:lnTo>
                  <a:lnTo>
                    <a:pt x="1160" y="1008"/>
                  </a:lnTo>
                  <a:lnTo>
                    <a:pt x="1160" y="1008"/>
                  </a:lnTo>
                  <a:lnTo>
                    <a:pt x="1155" y="1008"/>
                  </a:lnTo>
                  <a:lnTo>
                    <a:pt x="1155" y="1008"/>
                  </a:lnTo>
                  <a:lnTo>
                    <a:pt x="1150" y="1008"/>
                  </a:lnTo>
                  <a:lnTo>
                    <a:pt x="1150" y="1008"/>
                  </a:lnTo>
                  <a:lnTo>
                    <a:pt x="1146" y="1008"/>
                  </a:lnTo>
                  <a:lnTo>
                    <a:pt x="1146" y="1008"/>
                  </a:lnTo>
                  <a:lnTo>
                    <a:pt x="1141" y="1008"/>
                  </a:lnTo>
                  <a:lnTo>
                    <a:pt x="1141" y="1008"/>
                  </a:lnTo>
                  <a:lnTo>
                    <a:pt x="1136" y="1008"/>
                  </a:lnTo>
                  <a:lnTo>
                    <a:pt x="1136" y="1008"/>
                  </a:lnTo>
                  <a:lnTo>
                    <a:pt x="1132" y="1008"/>
                  </a:lnTo>
                  <a:lnTo>
                    <a:pt x="1132" y="1008"/>
                  </a:lnTo>
                  <a:lnTo>
                    <a:pt x="1127" y="1008"/>
                  </a:lnTo>
                  <a:lnTo>
                    <a:pt x="1127" y="1008"/>
                  </a:lnTo>
                  <a:lnTo>
                    <a:pt x="1127" y="1008"/>
                  </a:lnTo>
                  <a:lnTo>
                    <a:pt x="1122" y="1008"/>
                  </a:lnTo>
                  <a:lnTo>
                    <a:pt x="1122" y="1008"/>
                  </a:lnTo>
                  <a:lnTo>
                    <a:pt x="1118" y="1008"/>
                  </a:lnTo>
                  <a:lnTo>
                    <a:pt x="1118" y="1008"/>
                  </a:lnTo>
                  <a:lnTo>
                    <a:pt x="1113" y="1008"/>
                  </a:lnTo>
                  <a:lnTo>
                    <a:pt x="1113" y="1008"/>
                  </a:lnTo>
                  <a:lnTo>
                    <a:pt x="1108" y="1008"/>
                  </a:lnTo>
                  <a:lnTo>
                    <a:pt x="1108" y="1008"/>
                  </a:lnTo>
                  <a:lnTo>
                    <a:pt x="1104" y="1008"/>
                  </a:lnTo>
                  <a:lnTo>
                    <a:pt x="1104" y="1008"/>
                  </a:lnTo>
                  <a:lnTo>
                    <a:pt x="1099" y="1008"/>
                  </a:lnTo>
                  <a:lnTo>
                    <a:pt x="1099" y="1008"/>
                  </a:lnTo>
                  <a:lnTo>
                    <a:pt x="1095" y="1008"/>
                  </a:lnTo>
                  <a:lnTo>
                    <a:pt x="1095" y="1008"/>
                  </a:lnTo>
                  <a:lnTo>
                    <a:pt x="1090" y="1008"/>
                  </a:lnTo>
                  <a:lnTo>
                    <a:pt x="1090" y="1008"/>
                  </a:lnTo>
                  <a:lnTo>
                    <a:pt x="1085" y="1008"/>
                  </a:lnTo>
                  <a:lnTo>
                    <a:pt x="1085" y="1008"/>
                  </a:lnTo>
                  <a:lnTo>
                    <a:pt x="1081" y="1008"/>
                  </a:lnTo>
                  <a:lnTo>
                    <a:pt x="1081" y="1008"/>
                  </a:lnTo>
                  <a:lnTo>
                    <a:pt x="1076" y="1008"/>
                  </a:lnTo>
                  <a:lnTo>
                    <a:pt x="1076" y="1008"/>
                  </a:lnTo>
                  <a:lnTo>
                    <a:pt x="1071" y="1008"/>
                  </a:lnTo>
                  <a:lnTo>
                    <a:pt x="1071" y="1008"/>
                  </a:lnTo>
                  <a:lnTo>
                    <a:pt x="1067" y="1008"/>
                  </a:lnTo>
                  <a:lnTo>
                    <a:pt x="1067" y="1008"/>
                  </a:lnTo>
                  <a:lnTo>
                    <a:pt x="1062" y="1008"/>
                  </a:lnTo>
                  <a:lnTo>
                    <a:pt x="1062" y="1008"/>
                  </a:lnTo>
                  <a:lnTo>
                    <a:pt x="1062" y="1008"/>
                  </a:lnTo>
                  <a:lnTo>
                    <a:pt x="1057" y="1008"/>
                  </a:lnTo>
                  <a:lnTo>
                    <a:pt x="1057" y="1008"/>
                  </a:lnTo>
                  <a:lnTo>
                    <a:pt x="1053" y="1008"/>
                  </a:lnTo>
                  <a:lnTo>
                    <a:pt x="1053" y="1008"/>
                  </a:lnTo>
                  <a:lnTo>
                    <a:pt x="1048" y="1008"/>
                  </a:lnTo>
                  <a:lnTo>
                    <a:pt x="1048" y="1008"/>
                  </a:lnTo>
                  <a:lnTo>
                    <a:pt x="1044" y="1008"/>
                  </a:lnTo>
                  <a:lnTo>
                    <a:pt x="1044" y="1008"/>
                  </a:lnTo>
                  <a:lnTo>
                    <a:pt x="1039" y="1008"/>
                  </a:lnTo>
                  <a:lnTo>
                    <a:pt x="1039" y="1008"/>
                  </a:lnTo>
                  <a:lnTo>
                    <a:pt x="1034" y="1008"/>
                  </a:lnTo>
                  <a:lnTo>
                    <a:pt x="1034" y="1008"/>
                  </a:lnTo>
                  <a:lnTo>
                    <a:pt x="1030" y="1008"/>
                  </a:lnTo>
                  <a:lnTo>
                    <a:pt x="1030" y="1008"/>
                  </a:lnTo>
                  <a:lnTo>
                    <a:pt x="1025" y="1008"/>
                  </a:lnTo>
                  <a:lnTo>
                    <a:pt x="1025" y="1008"/>
                  </a:lnTo>
                  <a:lnTo>
                    <a:pt x="1020" y="1008"/>
                  </a:lnTo>
                  <a:lnTo>
                    <a:pt x="1020" y="1008"/>
                  </a:lnTo>
                  <a:lnTo>
                    <a:pt x="1016" y="1008"/>
                  </a:lnTo>
                  <a:lnTo>
                    <a:pt x="1016" y="1008"/>
                  </a:lnTo>
                  <a:lnTo>
                    <a:pt x="1011" y="1008"/>
                  </a:lnTo>
                  <a:lnTo>
                    <a:pt x="1011" y="1008"/>
                  </a:lnTo>
                  <a:lnTo>
                    <a:pt x="1006" y="1008"/>
                  </a:lnTo>
                  <a:lnTo>
                    <a:pt x="1006" y="1008"/>
                  </a:lnTo>
                  <a:lnTo>
                    <a:pt x="1002" y="1008"/>
                  </a:lnTo>
                  <a:lnTo>
                    <a:pt x="1002" y="1008"/>
                  </a:lnTo>
                  <a:lnTo>
                    <a:pt x="997" y="1008"/>
                  </a:lnTo>
                  <a:lnTo>
                    <a:pt x="997" y="1008"/>
                  </a:lnTo>
                  <a:lnTo>
                    <a:pt x="993" y="1008"/>
                  </a:lnTo>
                  <a:lnTo>
                    <a:pt x="993" y="1008"/>
                  </a:lnTo>
                  <a:lnTo>
                    <a:pt x="993" y="1008"/>
                  </a:lnTo>
                  <a:lnTo>
                    <a:pt x="988" y="1008"/>
                  </a:lnTo>
                  <a:lnTo>
                    <a:pt x="988" y="1008"/>
                  </a:lnTo>
                  <a:lnTo>
                    <a:pt x="983" y="1008"/>
                  </a:lnTo>
                  <a:lnTo>
                    <a:pt x="983" y="1008"/>
                  </a:lnTo>
                  <a:lnTo>
                    <a:pt x="979" y="1008"/>
                  </a:lnTo>
                  <a:lnTo>
                    <a:pt x="979" y="1008"/>
                  </a:lnTo>
                  <a:lnTo>
                    <a:pt x="974" y="1008"/>
                  </a:lnTo>
                  <a:lnTo>
                    <a:pt x="974" y="1008"/>
                  </a:lnTo>
                  <a:lnTo>
                    <a:pt x="969" y="1008"/>
                  </a:lnTo>
                  <a:lnTo>
                    <a:pt x="969" y="1008"/>
                  </a:lnTo>
                  <a:lnTo>
                    <a:pt x="965" y="1008"/>
                  </a:lnTo>
                  <a:lnTo>
                    <a:pt x="965" y="1008"/>
                  </a:lnTo>
                  <a:lnTo>
                    <a:pt x="960" y="1008"/>
                  </a:lnTo>
                  <a:lnTo>
                    <a:pt x="960" y="1008"/>
                  </a:lnTo>
                  <a:lnTo>
                    <a:pt x="955" y="1008"/>
                  </a:lnTo>
                  <a:lnTo>
                    <a:pt x="955" y="1008"/>
                  </a:lnTo>
                  <a:lnTo>
                    <a:pt x="951" y="907"/>
                  </a:lnTo>
                  <a:lnTo>
                    <a:pt x="951" y="907"/>
                  </a:lnTo>
                  <a:lnTo>
                    <a:pt x="946" y="907"/>
                  </a:lnTo>
                  <a:lnTo>
                    <a:pt x="946" y="907"/>
                  </a:lnTo>
                  <a:lnTo>
                    <a:pt x="942" y="907"/>
                  </a:lnTo>
                  <a:lnTo>
                    <a:pt x="942" y="907"/>
                  </a:lnTo>
                  <a:lnTo>
                    <a:pt x="937" y="907"/>
                  </a:lnTo>
                  <a:lnTo>
                    <a:pt x="937" y="907"/>
                  </a:lnTo>
                  <a:lnTo>
                    <a:pt x="932" y="907"/>
                  </a:lnTo>
                  <a:lnTo>
                    <a:pt x="932" y="806"/>
                  </a:lnTo>
                  <a:lnTo>
                    <a:pt x="928" y="806"/>
                  </a:lnTo>
                  <a:lnTo>
                    <a:pt x="928" y="806"/>
                  </a:lnTo>
                  <a:lnTo>
                    <a:pt x="928" y="806"/>
                  </a:lnTo>
                  <a:lnTo>
                    <a:pt x="923" y="806"/>
                  </a:lnTo>
                  <a:lnTo>
                    <a:pt x="923" y="706"/>
                  </a:lnTo>
                  <a:lnTo>
                    <a:pt x="918" y="706"/>
                  </a:lnTo>
                  <a:lnTo>
                    <a:pt x="918" y="706"/>
                  </a:lnTo>
                  <a:lnTo>
                    <a:pt x="914" y="706"/>
                  </a:lnTo>
                  <a:lnTo>
                    <a:pt x="914" y="706"/>
                  </a:lnTo>
                  <a:lnTo>
                    <a:pt x="909" y="706"/>
                  </a:lnTo>
                  <a:lnTo>
                    <a:pt x="909" y="706"/>
                  </a:lnTo>
                  <a:lnTo>
                    <a:pt x="904" y="706"/>
                  </a:lnTo>
                  <a:lnTo>
                    <a:pt x="904" y="706"/>
                  </a:lnTo>
                  <a:lnTo>
                    <a:pt x="900" y="706"/>
                  </a:lnTo>
                  <a:lnTo>
                    <a:pt x="900" y="706"/>
                  </a:lnTo>
                  <a:lnTo>
                    <a:pt x="895" y="706"/>
                  </a:lnTo>
                  <a:lnTo>
                    <a:pt x="895" y="706"/>
                  </a:lnTo>
                  <a:lnTo>
                    <a:pt x="890" y="706"/>
                  </a:lnTo>
                  <a:lnTo>
                    <a:pt x="890" y="706"/>
                  </a:lnTo>
                  <a:lnTo>
                    <a:pt x="886" y="706"/>
                  </a:lnTo>
                  <a:lnTo>
                    <a:pt x="886" y="706"/>
                  </a:lnTo>
                  <a:lnTo>
                    <a:pt x="881" y="706"/>
                  </a:lnTo>
                  <a:lnTo>
                    <a:pt x="881" y="706"/>
                  </a:lnTo>
                  <a:lnTo>
                    <a:pt x="877" y="706"/>
                  </a:lnTo>
                  <a:lnTo>
                    <a:pt x="877" y="706"/>
                  </a:lnTo>
                  <a:lnTo>
                    <a:pt x="872" y="706"/>
                  </a:lnTo>
                  <a:lnTo>
                    <a:pt x="872" y="706"/>
                  </a:lnTo>
                  <a:lnTo>
                    <a:pt x="867" y="706"/>
                  </a:lnTo>
                  <a:lnTo>
                    <a:pt x="867" y="706"/>
                  </a:lnTo>
                  <a:lnTo>
                    <a:pt x="863" y="706"/>
                  </a:lnTo>
                  <a:lnTo>
                    <a:pt x="863" y="706"/>
                  </a:lnTo>
                  <a:lnTo>
                    <a:pt x="863" y="706"/>
                  </a:lnTo>
                  <a:lnTo>
                    <a:pt x="858" y="706"/>
                  </a:lnTo>
                  <a:lnTo>
                    <a:pt x="858" y="706"/>
                  </a:lnTo>
                  <a:lnTo>
                    <a:pt x="853" y="706"/>
                  </a:lnTo>
                  <a:lnTo>
                    <a:pt x="853" y="706"/>
                  </a:lnTo>
                  <a:lnTo>
                    <a:pt x="849" y="706"/>
                  </a:lnTo>
                  <a:lnTo>
                    <a:pt x="849" y="706"/>
                  </a:lnTo>
                  <a:lnTo>
                    <a:pt x="844" y="706"/>
                  </a:lnTo>
                  <a:lnTo>
                    <a:pt x="844" y="706"/>
                  </a:lnTo>
                  <a:lnTo>
                    <a:pt x="839" y="806"/>
                  </a:lnTo>
                  <a:lnTo>
                    <a:pt x="839" y="806"/>
                  </a:lnTo>
                  <a:lnTo>
                    <a:pt x="835" y="806"/>
                  </a:lnTo>
                  <a:lnTo>
                    <a:pt x="835" y="806"/>
                  </a:lnTo>
                  <a:lnTo>
                    <a:pt x="830" y="806"/>
                  </a:lnTo>
                  <a:lnTo>
                    <a:pt x="830" y="806"/>
                  </a:lnTo>
                  <a:lnTo>
                    <a:pt x="826" y="806"/>
                  </a:lnTo>
                  <a:lnTo>
                    <a:pt x="826" y="806"/>
                  </a:lnTo>
                  <a:lnTo>
                    <a:pt x="821" y="806"/>
                  </a:lnTo>
                  <a:lnTo>
                    <a:pt x="821" y="907"/>
                  </a:lnTo>
                  <a:lnTo>
                    <a:pt x="816" y="907"/>
                  </a:lnTo>
                  <a:lnTo>
                    <a:pt x="816" y="907"/>
                  </a:lnTo>
                  <a:lnTo>
                    <a:pt x="812" y="907"/>
                  </a:lnTo>
                  <a:lnTo>
                    <a:pt x="812" y="907"/>
                  </a:lnTo>
                  <a:lnTo>
                    <a:pt x="807" y="1008"/>
                  </a:lnTo>
                  <a:lnTo>
                    <a:pt x="807" y="1008"/>
                  </a:lnTo>
                  <a:lnTo>
                    <a:pt x="802" y="1008"/>
                  </a:lnTo>
                  <a:lnTo>
                    <a:pt x="802" y="1008"/>
                  </a:lnTo>
                  <a:lnTo>
                    <a:pt x="798" y="1008"/>
                  </a:lnTo>
                  <a:lnTo>
                    <a:pt x="798" y="1008"/>
                  </a:lnTo>
                  <a:lnTo>
                    <a:pt x="793" y="1008"/>
                  </a:lnTo>
                  <a:lnTo>
                    <a:pt x="793" y="1008"/>
                  </a:lnTo>
                  <a:lnTo>
                    <a:pt x="793" y="1008"/>
                  </a:lnTo>
                  <a:lnTo>
                    <a:pt x="788" y="1008"/>
                  </a:lnTo>
                  <a:lnTo>
                    <a:pt x="788" y="1008"/>
                  </a:lnTo>
                  <a:lnTo>
                    <a:pt x="784" y="1008"/>
                  </a:lnTo>
                  <a:lnTo>
                    <a:pt x="784" y="1008"/>
                  </a:lnTo>
                  <a:lnTo>
                    <a:pt x="779" y="1008"/>
                  </a:lnTo>
                  <a:lnTo>
                    <a:pt x="779" y="1008"/>
                  </a:lnTo>
                  <a:lnTo>
                    <a:pt x="775" y="1008"/>
                  </a:lnTo>
                  <a:lnTo>
                    <a:pt x="775" y="1008"/>
                  </a:lnTo>
                  <a:lnTo>
                    <a:pt x="770" y="1008"/>
                  </a:lnTo>
                  <a:lnTo>
                    <a:pt x="770" y="1008"/>
                  </a:lnTo>
                  <a:lnTo>
                    <a:pt x="765" y="1008"/>
                  </a:lnTo>
                  <a:lnTo>
                    <a:pt x="765" y="1008"/>
                  </a:lnTo>
                  <a:lnTo>
                    <a:pt x="761" y="1008"/>
                  </a:lnTo>
                  <a:lnTo>
                    <a:pt x="761" y="1008"/>
                  </a:lnTo>
                  <a:lnTo>
                    <a:pt x="756" y="1008"/>
                  </a:lnTo>
                  <a:lnTo>
                    <a:pt x="756" y="1008"/>
                  </a:lnTo>
                  <a:lnTo>
                    <a:pt x="751" y="1008"/>
                  </a:lnTo>
                  <a:lnTo>
                    <a:pt x="751" y="1008"/>
                  </a:lnTo>
                  <a:lnTo>
                    <a:pt x="747" y="1008"/>
                  </a:lnTo>
                  <a:lnTo>
                    <a:pt x="747" y="1008"/>
                  </a:lnTo>
                  <a:lnTo>
                    <a:pt x="742" y="1008"/>
                  </a:lnTo>
                  <a:lnTo>
                    <a:pt x="742" y="1008"/>
                  </a:lnTo>
                  <a:lnTo>
                    <a:pt x="737" y="1008"/>
                  </a:lnTo>
                  <a:lnTo>
                    <a:pt x="737" y="1008"/>
                  </a:lnTo>
                  <a:lnTo>
                    <a:pt x="733" y="1008"/>
                  </a:lnTo>
                  <a:lnTo>
                    <a:pt x="733" y="1008"/>
                  </a:lnTo>
                  <a:lnTo>
                    <a:pt x="728" y="1008"/>
                  </a:lnTo>
                  <a:lnTo>
                    <a:pt x="728" y="1008"/>
                  </a:lnTo>
                  <a:lnTo>
                    <a:pt x="728" y="1008"/>
                  </a:lnTo>
                  <a:lnTo>
                    <a:pt x="724" y="1008"/>
                  </a:lnTo>
                  <a:lnTo>
                    <a:pt x="724" y="1008"/>
                  </a:lnTo>
                  <a:lnTo>
                    <a:pt x="719" y="1008"/>
                  </a:lnTo>
                  <a:lnTo>
                    <a:pt x="719" y="1008"/>
                  </a:lnTo>
                  <a:lnTo>
                    <a:pt x="714" y="1008"/>
                  </a:lnTo>
                  <a:lnTo>
                    <a:pt x="714" y="1008"/>
                  </a:lnTo>
                  <a:lnTo>
                    <a:pt x="710" y="1008"/>
                  </a:lnTo>
                  <a:lnTo>
                    <a:pt x="710" y="1008"/>
                  </a:lnTo>
                  <a:lnTo>
                    <a:pt x="705" y="1008"/>
                  </a:lnTo>
                  <a:lnTo>
                    <a:pt x="705" y="1008"/>
                  </a:lnTo>
                  <a:lnTo>
                    <a:pt x="700" y="1008"/>
                  </a:lnTo>
                  <a:lnTo>
                    <a:pt x="700" y="1008"/>
                  </a:lnTo>
                  <a:lnTo>
                    <a:pt x="696" y="1008"/>
                  </a:lnTo>
                  <a:lnTo>
                    <a:pt x="696" y="1008"/>
                  </a:lnTo>
                  <a:lnTo>
                    <a:pt x="691" y="1008"/>
                  </a:lnTo>
                  <a:lnTo>
                    <a:pt x="691" y="1008"/>
                  </a:lnTo>
                  <a:lnTo>
                    <a:pt x="686" y="1008"/>
                  </a:lnTo>
                  <a:lnTo>
                    <a:pt x="686" y="1008"/>
                  </a:lnTo>
                  <a:lnTo>
                    <a:pt x="682" y="1008"/>
                  </a:lnTo>
                  <a:lnTo>
                    <a:pt x="682" y="1008"/>
                  </a:lnTo>
                  <a:lnTo>
                    <a:pt x="677" y="1008"/>
                  </a:lnTo>
                  <a:lnTo>
                    <a:pt x="677" y="1008"/>
                  </a:lnTo>
                  <a:lnTo>
                    <a:pt x="673" y="1008"/>
                  </a:lnTo>
                  <a:lnTo>
                    <a:pt x="673" y="1008"/>
                  </a:lnTo>
                  <a:lnTo>
                    <a:pt x="668" y="1008"/>
                  </a:lnTo>
                  <a:lnTo>
                    <a:pt x="668" y="1008"/>
                  </a:lnTo>
                  <a:lnTo>
                    <a:pt x="663" y="1008"/>
                  </a:lnTo>
                  <a:lnTo>
                    <a:pt x="663" y="1008"/>
                  </a:lnTo>
                  <a:lnTo>
                    <a:pt x="663" y="1008"/>
                  </a:lnTo>
                  <a:lnTo>
                    <a:pt x="659" y="1008"/>
                  </a:lnTo>
                  <a:lnTo>
                    <a:pt x="659" y="1008"/>
                  </a:lnTo>
                  <a:lnTo>
                    <a:pt x="654" y="1008"/>
                  </a:lnTo>
                  <a:lnTo>
                    <a:pt x="654" y="1008"/>
                  </a:lnTo>
                  <a:lnTo>
                    <a:pt x="649" y="1008"/>
                  </a:lnTo>
                  <a:lnTo>
                    <a:pt x="649" y="1008"/>
                  </a:lnTo>
                  <a:lnTo>
                    <a:pt x="645" y="1008"/>
                  </a:lnTo>
                  <a:lnTo>
                    <a:pt x="645" y="1008"/>
                  </a:lnTo>
                  <a:lnTo>
                    <a:pt x="640" y="1008"/>
                  </a:lnTo>
                  <a:lnTo>
                    <a:pt x="640" y="1008"/>
                  </a:lnTo>
                  <a:lnTo>
                    <a:pt x="635" y="1008"/>
                  </a:lnTo>
                  <a:lnTo>
                    <a:pt x="635" y="1008"/>
                  </a:lnTo>
                  <a:lnTo>
                    <a:pt x="631" y="1008"/>
                  </a:lnTo>
                  <a:lnTo>
                    <a:pt x="631" y="1008"/>
                  </a:lnTo>
                  <a:lnTo>
                    <a:pt x="626" y="1008"/>
                  </a:lnTo>
                  <a:lnTo>
                    <a:pt x="626" y="1008"/>
                  </a:lnTo>
                  <a:lnTo>
                    <a:pt x="621" y="1008"/>
                  </a:lnTo>
                  <a:lnTo>
                    <a:pt x="621" y="1008"/>
                  </a:lnTo>
                  <a:lnTo>
                    <a:pt x="617" y="1008"/>
                  </a:lnTo>
                  <a:lnTo>
                    <a:pt x="617" y="1008"/>
                  </a:lnTo>
                  <a:lnTo>
                    <a:pt x="612" y="1008"/>
                  </a:lnTo>
                  <a:lnTo>
                    <a:pt x="612" y="1008"/>
                  </a:lnTo>
                  <a:lnTo>
                    <a:pt x="608" y="1008"/>
                  </a:lnTo>
                  <a:lnTo>
                    <a:pt x="608" y="1008"/>
                  </a:lnTo>
                  <a:lnTo>
                    <a:pt x="603" y="1008"/>
                  </a:lnTo>
                  <a:lnTo>
                    <a:pt x="603" y="1008"/>
                  </a:lnTo>
                  <a:lnTo>
                    <a:pt x="598" y="1008"/>
                  </a:lnTo>
                  <a:lnTo>
                    <a:pt x="598" y="1008"/>
                  </a:lnTo>
                  <a:lnTo>
                    <a:pt x="598" y="1008"/>
                  </a:lnTo>
                  <a:lnTo>
                    <a:pt x="594" y="1008"/>
                  </a:lnTo>
                  <a:lnTo>
                    <a:pt x="594" y="1008"/>
                  </a:lnTo>
                  <a:lnTo>
                    <a:pt x="589" y="1008"/>
                  </a:lnTo>
                  <a:lnTo>
                    <a:pt x="589" y="1008"/>
                  </a:lnTo>
                  <a:lnTo>
                    <a:pt x="584" y="1008"/>
                  </a:lnTo>
                  <a:lnTo>
                    <a:pt x="584" y="1008"/>
                  </a:lnTo>
                  <a:lnTo>
                    <a:pt x="580" y="1008"/>
                  </a:lnTo>
                  <a:lnTo>
                    <a:pt x="580" y="1008"/>
                  </a:lnTo>
                  <a:lnTo>
                    <a:pt x="575" y="1008"/>
                  </a:lnTo>
                  <a:lnTo>
                    <a:pt x="575" y="1008"/>
                  </a:lnTo>
                  <a:lnTo>
                    <a:pt x="570" y="1008"/>
                  </a:lnTo>
                  <a:lnTo>
                    <a:pt x="570" y="1008"/>
                  </a:lnTo>
                  <a:lnTo>
                    <a:pt x="566" y="1008"/>
                  </a:lnTo>
                  <a:lnTo>
                    <a:pt x="566" y="1008"/>
                  </a:lnTo>
                  <a:lnTo>
                    <a:pt x="561" y="1008"/>
                  </a:lnTo>
                  <a:lnTo>
                    <a:pt x="561" y="1008"/>
                  </a:lnTo>
                  <a:lnTo>
                    <a:pt x="557" y="1008"/>
                  </a:lnTo>
                  <a:lnTo>
                    <a:pt x="557" y="1008"/>
                  </a:lnTo>
                  <a:lnTo>
                    <a:pt x="552" y="1008"/>
                  </a:lnTo>
                  <a:lnTo>
                    <a:pt x="552" y="1008"/>
                  </a:lnTo>
                  <a:lnTo>
                    <a:pt x="547" y="1008"/>
                  </a:lnTo>
                  <a:lnTo>
                    <a:pt x="547" y="1008"/>
                  </a:lnTo>
                  <a:lnTo>
                    <a:pt x="543" y="1008"/>
                  </a:lnTo>
                  <a:lnTo>
                    <a:pt x="543" y="1008"/>
                  </a:lnTo>
                  <a:lnTo>
                    <a:pt x="538" y="1008"/>
                  </a:lnTo>
                  <a:lnTo>
                    <a:pt x="538" y="1008"/>
                  </a:lnTo>
                  <a:lnTo>
                    <a:pt x="533" y="1008"/>
                  </a:lnTo>
                  <a:lnTo>
                    <a:pt x="533" y="1008"/>
                  </a:lnTo>
                  <a:lnTo>
                    <a:pt x="529" y="1008"/>
                  </a:lnTo>
                  <a:lnTo>
                    <a:pt x="529" y="1008"/>
                  </a:lnTo>
                  <a:lnTo>
                    <a:pt x="529" y="1008"/>
                  </a:lnTo>
                  <a:lnTo>
                    <a:pt x="524" y="1008"/>
                  </a:lnTo>
                  <a:lnTo>
                    <a:pt x="524" y="1008"/>
                  </a:lnTo>
                  <a:lnTo>
                    <a:pt x="519" y="1008"/>
                  </a:lnTo>
                  <a:lnTo>
                    <a:pt x="519" y="1008"/>
                  </a:lnTo>
                  <a:lnTo>
                    <a:pt x="515" y="1008"/>
                  </a:lnTo>
                  <a:lnTo>
                    <a:pt x="515" y="1008"/>
                  </a:lnTo>
                  <a:lnTo>
                    <a:pt x="510" y="1008"/>
                  </a:lnTo>
                  <a:lnTo>
                    <a:pt x="510" y="1008"/>
                  </a:lnTo>
                  <a:lnTo>
                    <a:pt x="506" y="1008"/>
                  </a:lnTo>
                  <a:lnTo>
                    <a:pt x="506" y="1008"/>
                  </a:lnTo>
                  <a:lnTo>
                    <a:pt x="501" y="1008"/>
                  </a:lnTo>
                  <a:lnTo>
                    <a:pt x="501" y="1008"/>
                  </a:lnTo>
                  <a:lnTo>
                    <a:pt x="496" y="1008"/>
                  </a:lnTo>
                  <a:lnTo>
                    <a:pt x="496" y="1008"/>
                  </a:lnTo>
                  <a:lnTo>
                    <a:pt x="492" y="1008"/>
                  </a:lnTo>
                  <a:lnTo>
                    <a:pt x="492" y="1008"/>
                  </a:lnTo>
                  <a:lnTo>
                    <a:pt x="487" y="1008"/>
                  </a:lnTo>
                  <a:lnTo>
                    <a:pt x="487" y="1008"/>
                  </a:lnTo>
                  <a:lnTo>
                    <a:pt x="482" y="1008"/>
                  </a:lnTo>
                  <a:lnTo>
                    <a:pt x="482" y="1008"/>
                  </a:lnTo>
                  <a:lnTo>
                    <a:pt x="478" y="1008"/>
                  </a:lnTo>
                  <a:lnTo>
                    <a:pt x="478" y="1008"/>
                  </a:lnTo>
                  <a:lnTo>
                    <a:pt x="473" y="1008"/>
                  </a:lnTo>
                  <a:lnTo>
                    <a:pt x="473" y="1008"/>
                  </a:lnTo>
                  <a:lnTo>
                    <a:pt x="468" y="1008"/>
                  </a:lnTo>
                  <a:lnTo>
                    <a:pt x="468" y="1008"/>
                  </a:lnTo>
                  <a:lnTo>
                    <a:pt x="464" y="1008"/>
                  </a:lnTo>
                  <a:lnTo>
                    <a:pt x="464" y="1008"/>
                  </a:lnTo>
                  <a:lnTo>
                    <a:pt x="464" y="1008"/>
                  </a:lnTo>
                  <a:lnTo>
                    <a:pt x="459" y="1008"/>
                  </a:lnTo>
                  <a:lnTo>
                    <a:pt x="459" y="1008"/>
                  </a:lnTo>
                  <a:lnTo>
                    <a:pt x="455" y="1008"/>
                  </a:lnTo>
                  <a:lnTo>
                    <a:pt x="455" y="1008"/>
                  </a:lnTo>
                  <a:lnTo>
                    <a:pt x="450" y="1008"/>
                  </a:lnTo>
                  <a:lnTo>
                    <a:pt x="450" y="1008"/>
                  </a:lnTo>
                  <a:lnTo>
                    <a:pt x="445" y="1008"/>
                  </a:lnTo>
                  <a:lnTo>
                    <a:pt x="445" y="1008"/>
                  </a:lnTo>
                  <a:lnTo>
                    <a:pt x="441" y="1008"/>
                  </a:lnTo>
                  <a:lnTo>
                    <a:pt x="441" y="1008"/>
                  </a:lnTo>
                  <a:lnTo>
                    <a:pt x="436" y="1008"/>
                  </a:lnTo>
                  <a:lnTo>
                    <a:pt x="436" y="1008"/>
                  </a:lnTo>
                  <a:lnTo>
                    <a:pt x="431" y="1008"/>
                  </a:lnTo>
                  <a:lnTo>
                    <a:pt x="431" y="1008"/>
                  </a:lnTo>
                  <a:lnTo>
                    <a:pt x="427" y="1008"/>
                  </a:lnTo>
                  <a:lnTo>
                    <a:pt x="427" y="1008"/>
                  </a:lnTo>
                  <a:lnTo>
                    <a:pt x="422" y="1008"/>
                  </a:lnTo>
                  <a:lnTo>
                    <a:pt x="422" y="1008"/>
                  </a:lnTo>
                  <a:lnTo>
                    <a:pt x="417" y="1008"/>
                  </a:lnTo>
                  <a:lnTo>
                    <a:pt x="417" y="1008"/>
                  </a:lnTo>
                  <a:lnTo>
                    <a:pt x="413" y="1008"/>
                  </a:lnTo>
                  <a:lnTo>
                    <a:pt x="413" y="1008"/>
                  </a:lnTo>
                  <a:lnTo>
                    <a:pt x="408" y="1008"/>
                  </a:lnTo>
                  <a:lnTo>
                    <a:pt x="408" y="1008"/>
                  </a:lnTo>
                  <a:lnTo>
                    <a:pt x="404" y="1008"/>
                  </a:lnTo>
                  <a:lnTo>
                    <a:pt x="404" y="1008"/>
                  </a:lnTo>
                  <a:lnTo>
                    <a:pt x="399" y="1008"/>
                  </a:lnTo>
                  <a:lnTo>
                    <a:pt x="399" y="1008"/>
                  </a:lnTo>
                  <a:lnTo>
                    <a:pt x="399" y="1008"/>
                  </a:lnTo>
                  <a:lnTo>
                    <a:pt x="394" y="1008"/>
                  </a:lnTo>
                  <a:lnTo>
                    <a:pt x="394" y="1008"/>
                  </a:lnTo>
                  <a:lnTo>
                    <a:pt x="390" y="1008"/>
                  </a:lnTo>
                  <a:lnTo>
                    <a:pt x="390" y="1008"/>
                  </a:lnTo>
                  <a:lnTo>
                    <a:pt x="385" y="1008"/>
                  </a:lnTo>
                  <a:lnTo>
                    <a:pt x="385" y="1008"/>
                  </a:lnTo>
                  <a:lnTo>
                    <a:pt x="380" y="1008"/>
                  </a:lnTo>
                  <a:lnTo>
                    <a:pt x="380" y="1008"/>
                  </a:lnTo>
                  <a:lnTo>
                    <a:pt x="376" y="1008"/>
                  </a:lnTo>
                  <a:lnTo>
                    <a:pt x="376" y="1008"/>
                  </a:lnTo>
                  <a:lnTo>
                    <a:pt x="371" y="1008"/>
                  </a:lnTo>
                  <a:lnTo>
                    <a:pt x="371" y="1008"/>
                  </a:lnTo>
                  <a:lnTo>
                    <a:pt x="366" y="1008"/>
                  </a:lnTo>
                  <a:lnTo>
                    <a:pt x="366" y="1008"/>
                  </a:lnTo>
                  <a:lnTo>
                    <a:pt x="362" y="1008"/>
                  </a:lnTo>
                  <a:lnTo>
                    <a:pt x="362" y="1008"/>
                  </a:lnTo>
                  <a:lnTo>
                    <a:pt x="357" y="1008"/>
                  </a:lnTo>
                  <a:lnTo>
                    <a:pt x="357" y="1008"/>
                  </a:lnTo>
                  <a:lnTo>
                    <a:pt x="352" y="1008"/>
                  </a:lnTo>
                  <a:lnTo>
                    <a:pt x="352" y="1008"/>
                  </a:lnTo>
                  <a:lnTo>
                    <a:pt x="348" y="1008"/>
                  </a:lnTo>
                  <a:lnTo>
                    <a:pt x="348" y="1008"/>
                  </a:lnTo>
                  <a:lnTo>
                    <a:pt x="343" y="1008"/>
                  </a:lnTo>
                  <a:lnTo>
                    <a:pt x="343" y="1008"/>
                  </a:lnTo>
                  <a:lnTo>
                    <a:pt x="339" y="1008"/>
                  </a:lnTo>
                  <a:lnTo>
                    <a:pt x="339" y="1008"/>
                  </a:lnTo>
                  <a:lnTo>
                    <a:pt x="334" y="1008"/>
                  </a:lnTo>
                  <a:lnTo>
                    <a:pt x="334" y="1008"/>
                  </a:lnTo>
                  <a:lnTo>
                    <a:pt x="329" y="1008"/>
                  </a:lnTo>
                  <a:lnTo>
                    <a:pt x="329" y="1008"/>
                  </a:lnTo>
                  <a:lnTo>
                    <a:pt x="329" y="1008"/>
                  </a:lnTo>
                  <a:lnTo>
                    <a:pt x="325" y="1008"/>
                  </a:lnTo>
                  <a:lnTo>
                    <a:pt x="325" y="1008"/>
                  </a:lnTo>
                  <a:lnTo>
                    <a:pt x="320" y="1008"/>
                  </a:lnTo>
                  <a:lnTo>
                    <a:pt x="320" y="1008"/>
                  </a:lnTo>
                  <a:lnTo>
                    <a:pt x="315" y="1008"/>
                  </a:lnTo>
                  <a:lnTo>
                    <a:pt x="315" y="1008"/>
                  </a:lnTo>
                  <a:lnTo>
                    <a:pt x="311" y="1008"/>
                  </a:lnTo>
                  <a:lnTo>
                    <a:pt x="311" y="1008"/>
                  </a:lnTo>
                  <a:lnTo>
                    <a:pt x="306" y="1008"/>
                  </a:lnTo>
                  <a:lnTo>
                    <a:pt x="306" y="1008"/>
                  </a:lnTo>
                  <a:lnTo>
                    <a:pt x="301" y="1008"/>
                  </a:lnTo>
                  <a:lnTo>
                    <a:pt x="301" y="1008"/>
                  </a:lnTo>
                  <a:lnTo>
                    <a:pt x="297" y="1008"/>
                  </a:lnTo>
                  <a:lnTo>
                    <a:pt x="297" y="1008"/>
                  </a:lnTo>
                  <a:lnTo>
                    <a:pt x="292" y="1008"/>
                  </a:lnTo>
                  <a:lnTo>
                    <a:pt x="292" y="1008"/>
                  </a:lnTo>
                  <a:lnTo>
                    <a:pt x="288" y="1008"/>
                  </a:lnTo>
                  <a:lnTo>
                    <a:pt x="288" y="1008"/>
                  </a:lnTo>
                  <a:lnTo>
                    <a:pt x="283" y="1008"/>
                  </a:lnTo>
                  <a:lnTo>
                    <a:pt x="283" y="1008"/>
                  </a:lnTo>
                  <a:lnTo>
                    <a:pt x="278" y="1008"/>
                  </a:lnTo>
                  <a:lnTo>
                    <a:pt x="278" y="1008"/>
                  </a:lnTo>
                  <a:lnTo>
                    <a:pt x="274" y="1008"/>
                  </a:lnTo>
                  <a:lnTo>
                    <a:pt x="274" y="1008"/>
                  </a:lnTo>
                  <a:lnTo>
                    <a:pt x="269" y="1008"/>
                  </a:lnTo>
                  <a:lnTo>
                    <a:pt x="269" y="1008"/>
                  </a:lnTo>
                  <a:lnTo>
                    <a:pt x="264" y="1008"/>
                  </a:lnTo>
                  <a:lnTo>
                    <a:pt x="264" y="1008"/>
                  </a:lnTo>
                  <a:lnTo>
                    <a:pt x="264" y="1008"/>
                  </a:lnTo>
                  <a:lnTo>
                    <a:pt x="260" y="1008"/>
                  </a:lnTo>
                  <a:lnTo>
                    <a:pt x="260" y="1008"/>
                  </a:lnTo>
                  <a:lnTo>
                    <a:pt x="255" y="1008"/>
                  </a:lnTo>
                  <a:lnTo>
                    <a:pt x="255" y="907"/>
                  </a:lnTo>
                  <a:lnTo>
                    <a:pt x="250" y="907"/>
                  </a:lnTo>
                  <a:lnTo>
                    <a:pt x="250" y="907"/>
                  </a:lnTo>
                  <a:lnTo>
                    <a:pt x="246" y="907"/>
                  </a:lnTo>
                  <a:lnTo>
                    <a:pt x="246" y="907"/>
                  </a:lnTo>
                  <a:lnTo>
                    <a:pt x="241" y="907"/>
                  </a:lnTo>
                  <a:lnTo>
                    <a:pt x="241" y="907"/>
                  </a:lnTo>
                  <a:lnTo>
                    <a:pt x="237" y="907"/>
                  </a:lnTo>
                  <a:lnTo>
                    <a:pt x="237" y="907"/>
                  </a:lnTo>
                  <a:lnTo>
                    <a:pt x="232" y="907"/>
                  </a:lnTo>
                  <a:lnTo>
                    <a:pt x="232" y="907"/>
                  </a:lnTo>
                  <a:lnTo>
                    <a:pt x="227" y="907"/>
                  </a:lnTo>
                  <a:lnTo>
                    <a:pt x="227" y="907"/>
                  </a:lnTo>
                  <a:lnTo>
                    <a:pt x="223" y="907"/>
                  </a:lnTo>
                  <a:lnTo>
                    <a:pt x="223" y="907"/>
                  </a:lnTo>
                  <a:lnTo>
                    <a:pt x="218" y="907"/>
                  </a:lnTo>
                  <a:lnTo>
                    <a:pt x="218" y="907"/>
                  </a:lnTo>
                  <a:lnTo>
                    <a:pt x="213" y="907"/>
                  </a:lnTo>
                  <a:lnTo>
                    <a:pt x="213" y="907"/>
                  </a:lnTo>
                  <a:lnTo>
                    <a:pt x="209" y="907"/>
                  </a:lnTo>
                  <a:lnTo>
                    <a:pt x="209" y="907"/>
                  </a:lnTo>
                  <a:lnTo>
                    <a:pt x="204" y="907"/>
                  </a:lnTo>
                  <a:lnTo>
                    <a:pt x="204" y="907"/>
                  </a:lnTo>
                  <a:lnTo>
                    <a:pt x="199" y="907"/>
                  </a:lnTo>
                  <a:lnTo>
                    <a:pt x="199" y="907"/>
                  </a:lnTo>
                  <a:lnTo>
                    <a:pt x="199" y="907"/>
                  </a:lnTo>
                  <a:lnTo>
                    <a:pt x="195" y="907"/>
                  </a:lnTo>
                  <a:lnTo>
                    <a:pt x="195" y="907"/>
                  </a:lnTo>
                  <a:lnTo>
                    <a:pt x="190" y="907"/>
                  </a:lnTo>
                  <a:lnTo>
                    <a:pt x="190" y="907"/>
                  </a:lnTo>
                  <a:lnTo>
                    <a:pt x="186" y="907"/>
                  </a:lnTo>
                  <a:lnTo>
                    <a:pt x="186" y="907"/>
                  </a:lnTo>
                  <a:lnTo>
                    <a:pt x="181" y="907"/>
                  </a:lnTo>
                  <a:lnTo>
                    <a:pt x="181" y="907"/>
                  </a:lnTo>
                  <a:lnTo>
                    <a:pt x="176" y="907"/>
                  </a:lnTo>
                  <a:lnTo>
                    <a:pt x="176" y="907"/>
                  </a:lnTo>
                  <a:lnTo>
                    <a:pt x="172" y="907"/>
                  </a:lnTo>
                  <a:lnTo>
                    <a:pt x="172" y="907"/>
                  </a:lnTo>
                  <a:lnTo>
                    <a:pt x="167" y="907"/>
                  </a:lnTo>
                  <a:lnTo>
                    <a:pt x="167" y="907"/>
                  </a:lnTo>
                  <a:lnTo>
                    <a:pt x="162" y="907"/>
                  </a:lnTo>
                  <a:lnTo>
                    <a:pt x="162" y="907"/>
                  </a:lnTo>
                  <a:lnTo>
                    <a:pt x="158" y="907"/>
                  </a:lnTo>
                  <a:lnTo>
                    <a:pt x="158" y="907"/>
                  </a:lnTo>
                  <a:lnTo>
                    <a:pt x="153" y="907"/>
                  </a:lnTo>
                  <a:lnTo>
                    <a:pt x="153" y="907"/>
                  </a:lnTo>
                  <a:lnTo>
                    <a:pt x="148" y="907"/>
                  </a:lnTo>
                  <a:lnTo>
                    <a:pt x="148" y="907"/>
                  </a:lnTo>
                  <a:lnTo>
                    <a:pt x="144" y="907"/>
                  </a:lnTo>
                  <a:lnTo>
                    <a:pt x="144" y="907"/>
                  </a:lnTo>
                  <a:lnTo>
                    <a:pt x="139" y="1008"/>
                  </a:lnTo>
                  <a:lnTo>
                    <a:pt x="139" y="1008"/>
                  </a:lnTo>
                  <a:lnTo>
                    <a:pt x="135" y="1008"/>
                  </a:lnTo>
                  <a:lnTo>
                    <a:pt x="135" y="1008"/>
                  </a:lnTo>
                  <a:lnTo>
                    <a:pt x="135" y="1008"/>
                  </a:lnTo>
                  <a:lnTo>
                    <a:pt x="130" y="1008"/>
                  </a:lnTo>
                  <a:lnTo>
                    <a:pt x="130" y="1008"/>
                  </a:lnTo>
                  <a:lnTo>
                    <a:pt x="125" y="1008"/>
                  </a:lnTo>
                  <a:lnTo>
                    <a:pt x="125" y="1008"/>
                  </a:lnTo>
                  <a:lnTo>
                    <a:pt x="121" y="1008"/>
                  </a:lnTo>
                  <a:lnTo>
                    <a:pt x="121" y="1008"/>
                  </a:lnTo>
                  <a:lnTo>
                    <a:pt x="116" y="1008"/>
                  </a:lnTo>
                  <a:lnTo>
                    <a:pt x="116" y="1008"/>
                  </a:lnTo>
                  <a:lnTo>
                    <a:pt x="111" y="1008"/>
                  </a:lnTo>
                  <a:lnTo>
                    <a:pt x="111" y="1008"/>
                  </a:lnTo>
                  <a:lnTo>
                    <a:pt x="107" y="1008"/>
                  </a:lnTo>
                  <a:lnTo>
                    <a:pt x="107" y="1008"/>
                  </a:lnTo>
                  <a:lnTo>
                    <a:pt x="102" y="1008"/>
                  </a:lnTo>
                  <a:lnTo>
                    <a:pt x="102" y="1008"/>
                  </a:lnTo>
                  <a:lnTo>
                    <a:pt x="97" y="1008"/>
                  </a:lnTo>
                  <a:lnTo>
                    <a:pt x="97" y="1008"/>
                  </a:lnTo>
                  <a:lnTo>
                    <a:pt x="93" y="1008"/>
                  </a:lnTo>
                  <a:lnTo>
                    <a:pt x="93" y="1008"/>
                  </a:lnTo>
                  <a:lnTo>
                    <a:pt x="88" y="1008"/>
                  </a:lnTo>
                  <a:lnTo>
                    <a:pt x="88" y="1008"/>
                  </a:lnTo>
                  <a:lnTo>
                    <a:pt x="83" y="1008"/>
                  </a:lnTo>
                  <a:lnTo>
                    <a:pt x="83" y="1008"/>
                  </a:lnTo>
                  <a:lnTo>
                    <a:pt x="79" y="1008"/>
                  </a:lnTo>
                  <a:lnTo>
                    <a:pt x="79" y="1008"/>
                  </a:lnTo>
                  <a:lnTo>
                    <a:pt x="74" y="1008"/>
                  </a:lnTo>
                  <a:lnTo>
                    <a:pt x="74" y="1008"/>
                  </a:lnTo>
                  <a:lnTo>
                    <a:pt x="70" y="1008"/>
                  </a:lnTo>
                  <a:lnTo>
                    <a:pt x="70" y="1008"/>
                  </a:lnTo>
                  <a:lnTo>
                    <a:pt x="65" y="1008"/>
                  </a:lnTo>
                  <a:lnTo>
                    <a:pt x="65" y="1008"/>
                  </a:lnTo>
                  <a:lnTo>
                    <a:pt x="65" y="1008"/>
                  </a:lnTo>
                  <a:lnTo>
                    <a:pt x="60" y="1008"/>
                  </a:lnTo>
                  <a:lnTo>
                    <a:pt x="60" y="1008"/>
                  </a:lnTo>
                  <a:lnTo>
                    <a:pt x="56" y="1008"/>
                  </a:lnTo>
                  <a:lnTo>
                    <a:pt x="56" y="1008"/>
                  </a:lnTo>
                  <a:lnTo>
                    <a:pt x="51" y="1008"/>
                  </a:lnTo>
                  <a:lnTo>
                    <a:pt x="51" y="1008"/>
                  </a:lnTo>
                  <a:lnTo>
                    <a:pt x="46" y="1008"/>
                  </a:lnTo>
                  <a:lnTo>
                    <a:pt x="46" y="1008"/>
                  </a:lnTo>
                  <a:lnTo>
                    <a:pt x="42" y="1008"/>
                  </a:lnTo>
                  <a:lnTo>
                    <a:pt x="42" y="1008"/>
                  </a:lnTo>
                  <a:lnTo>
                    <a:pt x="37" y="1008"/>
                  </a:lnTo>
                  <a:lnTo>
                    <a:pt x="37" y="1008"/>
                  </a:lnTo>
                  <a:lnTo>
                    <a:pt x="32" y="1008"/>
                  </a:lnTo>
                  <a:lnTo>
                    <a:pt x="32" y="1008"/>
                  </a:lnTo>
                  <a:lnTo>
                    <a:pt x="28" y="1008"/>
                  </a:lnTo>
                  <a:lnTo>
                    <a:pt x="28" y="1008"/>
                  </a:lnTo>
                  <a:lnTo>
                    <a:pt x="23" y="1008"/>
                  </a:lnTo>
                  <a:lnTo>
                    <a:pt x="23" y="1008"/>
                  </a:lnTo>
                  <a:lnTo>
                    <a:pt x="19" y="1008"/>
                  </a:lnTo>
                  <a:lnTo>
                    <a:pt x="19" y="1008"/>
                  </a:lnTo>
                  <a:lnTo>
                    <a:pt x="14" y="1008"/>
                  </a:lnTo>
                  <a:lnTo>
                    <a:pt x="14" y="1008"/>
                  </a:lnTo>
                  <a:lnTo>
                    <a:pt x="9" y="1008"/>
                  </a:lnTo>
                  <a:lnTo>
                    <a:pt x="9" y="1008"/>
                  </a:lnTo>
                  <a:lnTo>
                    <a:pt x="5" y="1008"/>
                  </a:lnTo>
                  <a:lnTo>
                    <a:pt x="0" y="1008"/>
                  </a:lnTo>
                  <a:lnTo>
                    <a:pt x="0" y="1008"/>
                  </a:ln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2" name=""/>
            <p:cNvSpPr/>
            <p:nvPr/>
          </p:nvSpPr>
          <p:spPr>
            <a:xfrm rot="16200000">
              <a:off x="-268200" y="1745280"/>
              <a:ext cx="15094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900" spc="-1" strike="noStrike">
                  <a:solidFill>
                    <a:srgbClr val="000000"/>
                  </a:solidFill>
                  <a:latin typeface="Arial"/>
                </a:rPr>
                <a:t>Breakpoints per 50 nt window</a:t>
              </a:r>
              <a:endParaRPr b="0" lang="en-US" sz="9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3" name=""/>
            <p:cNvSpPr/>
            <p:nvPr/>
          </p:nvSpPr>
          <p:spPr>
            <a:xfrm>
              <a:off x="4800600" y="1038240"/>
              <a:ext cx="76320" cy="76320"/>
            </a:xfrm>
            <a:prstGeom prst="rect">
              <a:avLst/>
            </a:prstGeom>
            <a:solidFill>
              <a:srgbClr val="eaeaea"/>
            </a:solidFill>
            <a:ln w="9360">
              <a:solidFill>
                <a:srgbClr val="c0c0c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4" name=""/>
            <p:cNvSpPr/>
            <p:nvPr/>
          </p:nvSpPr>
          <p:spPr>
            <a:xfrm>
              <a:off x="4800600" y="914400"/>
              <a:ext cx="76320" cy="76320"/>
            </a:xfrm>
            <a:prstGeom prst="rect">
              <a:avLst/>
            </a:prstGeom>
            <a:solidFill>
              <a:srgbClr val="969696"/>
            </a:solidFill>
            <a:ln w="936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95" name=""/>
          <p:cNvSpPr/>
          <p:nvPr/>
        </p:nvSpPr>
        <p:spPr>
          <a:xfrm>
            <a:off x="620640" y="3492360"/>
            <a:ext cx="57610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Combined intra-subtype recombination breakpoint distributions detectable within eight subtype and circulating recombinant for gp41encoding nucleotide sequence datasets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9-09T09:58:09Z</dcterms:created>
  <dc:creator>darren martin</dc:creator>
  <dc:description/>
  <dc:language>en-US</dc:language>
  <cp:lastModifiedBy>Administrator</cp:lastModifiedBy>
  <dcterms:modified xsi:type="dcterms:W3CDTF">2008-11-23T14:30:10Z</dcterms:modified>
  <cp:revision>3</cp:revision>
  <dc:subject/>
  <dc:title>PowerPoint Presentation</dc:title>
</cp:coreProperties>
</file>